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36.xml" ContentType="application/vnd.openxmlformats-officedocument.presentationml.slideLayout+xml"/>
  <Override PartName="/ppt/theme/theme3.xml" ContentType="application/vnd.openxmlformats-officedocument.theme+xml"/>
  <Override PartName="/ppt/slideLayouts/slideLayout37.xml" ContentType="application/vnd.openxmlformats-officedocument.presentationml.slideLayout+xml"/>
  <Override PartName="/ppt/slideLayouts/slideLayout38.xml" ContentType="application/vnd.openxmlformats-officedocument.presentationml.slideLayout+xml"/>
  <Override PartName="/ppt/slideLayouts/slideLayout39.xml" ContentType="application/vnd.openxmlformats-officedocument.presentationml.slideLayout+xml"/>
  <Override PartName="/ppt/slideLayouts/slideLayout40.xml" ContentType="application/vnd.openxmlformats-officedocument.presentationml.slideLayout+xml"/>
  <Override PartName="/ppt/slideLayouts/slideLayout41.xml" ContentType="application/vnd.openxmlformats-officedocument.presentationml.slideLayout+xml"/>
  <Override PartName="/ppt/slideLayouts/slideLayout42.xml" ContentType="application/vnd.openxmlformats-officedocument.presentationml.slideLayout+xml"/>
  <Override PartName="/ppt/slideLayouts/slideLayout43.xml" ContentType="application/vnd.openxmlformats-officedocument.presentationml.slideLayout+xml"/>
  <Override PartName="/ppt/slideLayouts/slideLayout44.xml" ContentType="application/vnd.openxmlformats-officedocument.presentationml.slideLayout+xml"/>
  <Override PartName="/ppt/slideLayouts/slideLayout45.xml" ContentType="application/vnd.openxmlformats-officedocument.presentationml.slideLayout+xml"/>
  <Override PartName="/ppt/slideLayouts/slideLayout46.xml" ContentType="application/vnd.openxmlformats-officedocument.presentationml.slideLayout+xml"/>
  <Override PartName="/ppt/slideLayouts/slideLayout47.xml" ContentType="application/vnd.openxmlformats-officedocument.presentationml.slideLayout+xml"/>
  <Override PartName="/ppt/theme/theme4.xml" ContentType="application/vnd.openxmlformats-officedocument.theme+xml"/>
  <Override PartName="/ppt/slideLayouts/slideLayout48.xml" ContentType="application/vnd.openxmlformats-officedocument.presentationml.slideLayout+xml"/>
  <Override PartName="/ppt/slideLayouts/slideLayout49.xml" ContentType="application/vnd.openxmlformats-officedocument.presentationml.slideLayout+xml"/>
  <Override PartName="/ppt/slideLayouts/slideLayout50.xml" ContentType="application/vnd.openxmlformats-officedocument.presentationml.slideLayout+xml"/>
  <Override PartName="/ppt/slideLayouts/slideLayout51.xml" ContentType="application/vnd.openxmlformats-officedocument.presentationml.slideLayout+xml"/>
  <Override PartName="/ppt/slideLayouts/slideLayout52.xml" ContentType="application/vnd.openxmlformats-officedocument.presentationml.slideLayout+xml"/>
  <Override PartName="/ppt/slideLayouts/slideLayout53.xml" ContentType="application/vnd.openxmlformats-officedocument.presentationml.slideLayout+xml"/>
  <Override PartName="/ppt/slideLayouts/slideLayout54.xml" ContentType="application/vnd.openxmlformats-officedocument.presentationml.slideLayout+xml"/>
  <Override PartName="/ppt/slideLayouts/slideLayout55.xml" ContentType="application/vnd.openxmlformats-officedocument.presentationml.slideLayout+xml"/>
  <Override PartName="/ppt/slideLayouts/slideLayout56.xml" ContentType="application/vnd.openxmlformats-officedocument.presentationml.slideLayout+xml"/>
  <Override PartName="/ppt/slideLayouts/slideLayout57.xml" ContentType="application/vnd.openxmlformats-officedocument.presentationml.slideLayout+xml"/>
  <Override PartName="/ppt/slideLayouts/slideLayout58.xml" ContentType="application/vnd.openxmlformats-officedocument.presentationml.slideLayout+xml"/>
  <Override PartName="/ppt/theme/theme5.xml" ContentType="application/vnd.openxmlformats-officedocument.theme+xml"/>
  <Override PartName="/ppt/theme/theme6.xml" ContentType="application/vnd.openxmlformats-officedocument.theme+xml"/>
  <Override PartName="/ppt/theme/theme7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004" r:id="rId1"/>
    <p:sldMasterId id="2147484614" r:id="rId2"/>
    <p:sldMasterId id="2147483979" r:id="rId3"/>
    <p:sldMasterId id="2147483992" r:id="rId4"/>
    <p:sldMasterId id="2147484744" r:id="rId5"/>
  </p:sldMasterIdLst>
  <p:notesMasterIdLst>
    <p:notesMasterId r:id="rId12"/>
  </p:notesMasterIdLst>
  <p:handoutMasterIdLst>
    <p:handoutMasterId r:id="rId13"/>
  </p:handoutMasterIdLst>
  <p:sldIdLst>
    <p:sldId id="331" r:id="rId6"/>
    <p:sldId id="303" r:id="rId7"/>
    <p:sldId id="304" r:id="rId8"/>
    <p:sldId id="414" r:id="rId9"/>
    <p:sldId id="425" r:id="rId10"/>
    <p:sldId id="426" r:id="rId11"/>
  </p:sldIdLst>
  <p:sldSz cx="9144000" cy="6858000" type="screen4x3"/>
  <p:notesSz cx="6858000" cy="9144000"/>
  <p:defaultTextStyle>
    <a:defPPr>
      <a:defRPr lang="en-US"/>
    </a:defPPr>
    <a:lvl1pPr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50" charset="-128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50" charset="-128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50" charset="-128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50" charset="-128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50" charset="-128"/>
        <a:cs typeface="+mn-cs"/>
      </a:defRPr>
    </a:lvl5pPr>
    <a:lvl6pPr marL="2286000" algn="l" defTabSz="914400" rtl="0" eaLnBrk="1" latinLnBrk="0" hangingPunct="1">
      <a:defRPr kumimoji="1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50" charset="-128"/>
        <a:cs typeface="+mn-cs"/>
      </a:defRPr>
    </a:lvl6pPr>
    <a:lvl7pPr marL="2743200" algn="l" defTabSz="914400" rtl="0" eaLnBrk="1" latinLnBrk="0" hangingPunct="1">
      <a:defRPr kumimoji="1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50" charset="-128"/>
        <a:cs typeface="+mn-cs"/>
      </a:defRPr>
    </a:lvl7pPr>
    <a:lvl8pPr marL="3200400" algn="l" defTabSz="914400" rtl="0" eaLnBrk="1" latinLnBrk="0" hangingPunct="1">
      <a:defRPr kumimoji="1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50" charset="-128"/>
        <a:cs typeface="+mn-cs"/>
      </a:defRPr>
    </a:lvl8pPr>
    <a:lvl9pPr marL="3657600" algn="l" defTabSz="914400" rtl="0" eaLnBrk="1" latinLnBrk="0" hangingPunct="1">
      <a:defRPr kumimoji="1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50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髙橋 慶太" initials="髙橋" lastIdx="7" clrIdx="0">
    <p:extLst>
      <p:ext uri="{19B8F6BF-5375-455C-9EA6-DF929625EA0E}">
        <p15:presenceInfo xmlns:p15="http://schemas.microsoft.com/office/powerpoint/2012/main" userId="cc7f00d70c0a2ab5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66FF"/>
    <a:srgbClr val="FF2489"/>
    <a:srgbClr val="000080"/>
    <a:srgbClr val="FFCC00"/>
    <a:srgbClr val="9999FF"/>
    <a:srgbClr val="E7E8EA"/>
    <a:srgbClr val="000042"/>
    <a:srgbClr val="FF8585"/>
    <a:srgbClr val="1E211D"/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3460" autoAdjust="0"/>
  </p:normalViewPr>
  <p:slideViewPr>
    <p:cSldViewPr>
      <p:cViewPr>
        <p:scale>
          <a:sx n="100" d="100"/>
          <a:sy n="100" d="100"/>
        </p:scale>
        <p:origin x="324" y="-87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notesViewPr>
    <p:cSldViewPr>
      <p:cViewPr varScale="1">
        <p:scale>
          <a:sx n="117" d="100"/>
          <a:sy n="117" d="100"/>
        </p:scale>
        <p:origin x="2352" y="90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3.xml"/><Relationship Id="rId13" Type="http://schemas.openxmlformats.org/officeDocument/2006/relationships/handoutMaster" Target="handoutMasters/handoutMaster1.xml"/><Relationship Id="rId18" Type="http://schemas.openxmlformats.org/officeDocument/2006/relationships/tableStyles" Target="tableStyle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2.xml"/><Relationship Id="rId12" Type="http://schemas.openxmlformats.org/officeDocument/2006/relationships/notesMaster" Target="notesMasters/notesMaster1.xml"/><Relationship Id="rId17" Type="http://schemas.openxmlformats.org/officeDocument/2006/relationships/theme" Target="theme/theme1.xml"/><Relationship Id="rId2" Type="http://schemas.openxmlformats.org/officeDocument/2006/relationships/slideMaster" Target="slideMasters/slideMaster2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1.xml"/><Relationship Id="rId11" Type="http://schemas.openxmlformats.org/officeDocument/2006/relationships/slide" Target="slides/slide6.xml"/><Relationship Id="rId5" Type="http://schemas.openxmlformats.org/officeDocument/2006/relationships/slideMaster" Target="slideMasters/slideMaster5.xml"/><Relationship Id="rId15" Type="http://schemas.openxmlformats.org/officeDocument/2006/relationships/presProps" Target="presProps.xml"/><Relationship Id="rId10" Type="http://schemas.openxmlformats.org/officeDocument/2006/relationships/slide" Target="slides/slide5.xml"/><Relationship Id="rId4" Type="http://schemas.openxmlformats.org/officeDocument/2006/relationships/slideMaster" Target="slideMasters/slideMaster4.xml"/><Relationship Id="rId9" Type="http://schemas.openxmlformats.org/officeDocument/2006/relationships/slide" Target="slides/slide4.xml"/><Relationship Id="rId14" Type="http://schemas.openxmlformats.org/officeDocument/2006/relationships/commentAuthors" Target="commentAuthor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6.2464048142302983E-2"/>
          <c:y val="0.12794021753208115"/>
          <c:w val="0.90960250668707787"/>
          <c:h val="0.7291197019585996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リスク因子とAL!$C$4</c:f>
              <c:strCache>
                <c:ptCount val="1"/>
                <c:pt idx="0">
                  <c:v>AL率</c:v>
                </c:pt>
              </c:strCache>
            </c:strRef>
          </c:tx>
          <c:spPr>
            <a:solidFill>
              <a:schemeClr val="accent1">
                <a:lumMod val="75000"/>
              </a:schemeClr>
            </a:solidFill>
            <a:ln w="9525" cap="flat" cmpd="sng" algn="ctr">
              <a:solidFill>
                <a:schemeClr val="accent1">
                  <a:shade val="95000"/>
                </a:schemeClr>
              </a:solidFill>
              <a:round/>
            </a:ln>
            <a:effectLst/>
          </c:spPr>
          <c:invertIfNegative val="0"/>
          <c:cat>
            <c:numRef>
              <c:f>リスク因子とAL!$B$5:$B$8</c:f>
              <c:numCache>
                <c:formatCode>General</c:formatCode>
                <c:ptCount val="4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</c:numCache>
            </c:numRef>
          </c:cat>
          <c:val>
            <c:numRef>
              <c:f>リスク因子とAL!$C$5:$C$8</c:f>
              <c:numCache>
                <c:formatCode>General</c:formatCode>
                <c:ptCount val="4"/>
                <c:pt idx="0">
                  <c:v>0</c:v>
                </c:pt>
                <c:pt idx="1">
                  <c:v>5.8</c:v>
                </c:pt>
                <c:pt idx="2">
                  <c:v>36.6</c:v>
                </c:pt>
                <c:pt idx="3">
                  <c:v>7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CCF-40B8-9CD6-53EFC217889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4"/>
        <c:axId val="696966056"/>
        <c:axId val="696963760"/>
      </c:barChart>
      <c:catAx>
        <c:axId val="6969660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>
                    <a:lumMod val="50000"/>
                    <a:lumOff val="50000"/>
                  </a:schemeClr>
                </a:solidFill>
                <a:latin typeface="Times New Roman" panose="02020603050405020304" pitchFamily="18" charset="0"/>
                <a:ea typeface="+mn-ea"/>
                <a:cs typeface="+mn-cs"/>
              </a:defRPr>
            </a:pPr>
            <a:endParaRPr lang="ja-JP"/>
          </a:p>
        </c:txPr>
        <c:crossAx val="696963760"/>
        <c:crosses val="autoZero"/>
        <c:auto val="1"/>
        <c:lblAlgn val="ctr"/>
        <c:lblOffset val="100"/>
        <c:noMultiLvlLbl val="0"/>
      </c:catAx>
      <c:valAx>
        <c:axId val="696963760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>
                    <a:lumMod val="50000"/>
                    <a:lumOff val="50000"/>
                  </a:schemeClr>
                </a:solidFill>
                <a:latin typeface="Times New Roman" panose="02020603050405020304" pitchFamily="18" charset="0"/>
                <a:ea typeface="+mn-ea"/>
                <a:cs typeface="+mn-cs"/>
              </a:defRPr>
            </a:pPr>
            <a:endParaRPr lang="ja-JP"/>
          </a:p>
        </c:txPr>
        <c:crossAx val="69696605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6">
  <cs:axisTitle>
    <cs:lnRef idx="0"/>
    <cs:fillRef idx="0"/>
    <cs:effectRef idx="0"/>
    <cs:fontRef idx="minor">
      <a:schemeClr val="tx1">
        <a:lumMod val="50000"/>
        <a:lumOff val="50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>
  <cs:dataPoint3D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3D>
  <cs:dataPointLine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158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Marker>
  <cs:dataPointMarkerLayout symbol="circle" size="4"/>
  <cs:dataPointWireframe>
    <cs:lnRef idx="0">
      <cs:styleClr val="auto"/>
    </cs:lnRef>
    <cs:fillRef idx="2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50000"/>
        <a:lumOff val="50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50000"/>
            <a:lumOff val="50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tx1">
        <a:lumMod val="50000"/>
        <a:lumOff val="50000"/>
      </a:schemeClr>
    </cs:fontRef>
    <cs:defRPr sz="1400" kern="1200" cap="none" spc="20" baseline="0"/>
  </cs:title>
  <cs:trendline>
    <cs:lnRef idx="0">
      <cs:styleClr val="auto"/>
    </cs:lnRef>
    <cs:fillRef idx="2"/>
    <cs:effectRef idx="0"/>
    <cs:fontRef idx="minor">
      <a:schemeClr val="dk1"/>
    </cs:fontRef>
    <cs:spPr>
      <a:ln w="9525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50000"/>
            <a:lumOff val="50000"/>
          </a:schemeClr>
        </a:solidFill>
      </a:ln>
    </cs:spPr>
  </cs:upBar>
  <cs:valueAxis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05812</cdr:x>
      <cdr:y>0.08203</cdr:y>
    </cdr:from>
    <cdr:to>
      <cdr:x>0.15547</cdr:x>
      <cdr:y>0.14961</cdr:y>
    </cdr:to>
    <cdr:sp macro="" textlink="">
      <cdr:nvSpPr>
        <cdr:cNvPr id="2" name="テキスト ボックス 1">
          <a:extLst xmlns:a="http://schemas.openxmlformats.org/drawingml/2006/main">
            <a:ext uri="{FF2B5EF4-FFF2-40B4-BE49-F238E27FC236}">
              <a16:creationId xmlns:a16="http://schemas.microsoft.com/office/drawing/2014/main" id="{403E9E33-2660-FD38-41AB-634F9C52D42D}"/>
            </a:ext>
          </a:extLst>
        </cdr:cNvPr>
        <cdr:cNvSpPr txBox="1"/>
      </cdr:nvSpPr>
      <cdr:spPr>
        <a:xfrm xmlns:a="http://schemas.openxmlformats.org/drawingml/2006/main">
          <a:off x="449244" y="437003"/>
          <a:ext cx="752360" cy="36004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altLang="ja-JP" sz="1600" dirty="0">
              <a:latin typeface="Times New Roman" panose="02020603050405020304" pitchFamily="18" charset="0"/>
              <a:cs typeface="Times New Roman" panose="02020603050405020304" pitchFamily="18" charset="0"/>
            </a:rPr>
            <a:t>(%)</a:t>
          </a:r>
          <a:endParaRPr lang="ja-JP" altLang="en-US" sz="16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7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88501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</a:defRPr>
            </a:lvl1pPr>
          </a:lstStyle>
          <a:p>
            <a:pPr>
              <a:defRPr/>
            </a:pPr>
            <a:fld id="{29E7CC58-2B87-4304-B53C-E3F28221EDF2}" type="datetimeFigureOut">
              <a:rPr lang="ja-JP" altLang="en-US"/>
              <a:pPr>
                <a:defRPr/>
              </a:pPr>
              <a:t>2023/4/14</a:t>
            </a:fld>
            <a:endParaRPr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8684684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885010" y="8684684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latin typeface="Calibri" panose="020F0502020204030204" pitchFamily="34" charset="0"/>
              </a:defRPr>
            </a:lvl1pPr>
          </a:lstStyle>
          <a:p>
            <a:pPr>
              <a:defRPr/>
            </a:pPr>
            <a:fld id="{508EA00C-662F-4F23-BC37-528B8E163614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940543220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6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>
          <a:xfrm>
            <a:off x="388501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</a:defRPr>
            </a:lvl1pPr>
          </a:lstStyle>
          <a:p>
            <a:pPr>
              <a:defRPr/>
            </a:pPr>
            <a:fld id="{22D869A4-9185-422F-8F99-829D405117B7}" type="datetimeFigureOut">
              <a:rPr lang="ja-JP" altLang="en-US"/>
              <a:pPr>
                <a:defRPr/>
              </a:pPr>
              <a:t>2023/4/14</a:t>
            </a:fld>
            <a:endParaRPr lang="ja-JP" altLang="en-US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ja-JP" altLang="en-US" noProof="0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noProof="0"/>
              <a:t>マスタ テキストの書式設定</a:t>
            </a:r>
          </a:p>
          <a:p>
            <a:pPr lvl="1"/>
            <a:r>
              <a:rPr lang="ja-JP" altLang="en-US" noProof="0"/>
              <a:t>第 </a:t>
            </a:r>
            <a:r>
              <a:rPr lang="en-US" altLang="ja-JP" noProof="0"/>
              <a:t>2 </a:t>
            </a:r>
            <a:r>
              <a:rPr lang="ja-JP" altLang="en-US" noProof="0"/>
              <a:t>レベル</a:t>
            </a:r>
          </a:p>
          <a:p>
            <a:pPr lvl="2"/>
            <a:r>
              <a:rPr lang="ja-JP" altLang="en-US" noProof="0"/>
              <a:t>第 </a:t>
            </a:r>
            <a:r>
              <a:rPr lang="en-US" altLang="ja-JP" noProof="0"/>
              <a:t>3 </a:t>
            </a:r>
            <a:r>
              <a:rPr lang="ja-JP" altLang="en-US" noProof="0"/>
              <a:t>レベル</a:t>
            </a:r>
          </a:p>
          <a:p>
            <a:pPr lvl="3"/>
            <a:r>
              <a:rPr lang="ja-JP" altLang="en-US" noProof="0"/>
              <a:t>第 </a:t>
            </a:r>
            <a:r>
              <a:rPr lang="en-US" altLang="ja-JP" noProof="0"/>
              <a:t>4 </a:t>
            </a:r>
            <a:r>
              <a:rPr lang="ja-JP" altLang="en-US" noProof="0"/>
              <a:t>レベル</a:t>
            </a:r>
          </a:p>
          <a:p>
            <a:pPr lvl="4"/>
            <a:r>
              <a:rPr lang="ja-JP" altLang="en-US" noProof="0"/>
              <a:t>第 </a:t>
            </a:r>
            <a:r>
              <a:rPr lang="en-US" altLang="ja-JP" noProof="0"/>
              <a:t>5 </a:t>
            </a:r>
            <a:r>
              <a:rPr lang="ja-JP" altLang="en-US" noProof="0"/>
              <a:t>レベル</a:t>
            </a:r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>
          <a:xfrm>
            <a:off x="0" y="8684684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>
          <a:xfrm>
            <a:off x="3885010" y="8684684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latin typeface="Calibri" panose="020F0502020204030204" pitchFamily="34" charset="0"/>
              </a:defRPr>
            </a:lvl1pPr>
          </a:lstStyle>
          <a:p>
            <a:pPr>
              <a:defRPr/>
            </a:pPr>
            <a:fld id="{1AB373A0-1279-4E2C-AC6E-3542E84F72B8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353018209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986" name="スライド イメージ プレースホルダ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41987" name="ノート プレースホルダ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endParaRPr lang="en-US" altLang="ja-JP" b="1" dirty="0"/>
          </a:p>
        </p:txBody>
      </p:sp>
      <p:sp>
        <p:nvSpPr>
          <p:cNvPr id="41988" name="スライド番号プレースホルダ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fld id="{74117605-9890-4F54-813B-B5A2A730D8B9}" type="slidenum">
              <a:rPr lang="ja-JP" altLang="en-US" smtClean="0">
                <a:latin typeface="Calibri" panose="020F0502020204030204" pitchFamily="34" charset="0"/>
              </a:rPr>
              <a:pPr/>
              <a:t>1</a:t>
            </a:fld>
            <a:endParaRPr lang="ja-JP" altLang="en-US">
              <a:latin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0551380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058" name="スライド イメージ プレースホルダー 1">
            <a:extLst>
              <a:ext uri="{FF2B5EF4-FFF2-40B4-BE49-F238E27FC236}">
                <a16:creationId xmlns:a16="http://schemas.microsoft.com/office/drawing/2014/main" id="{5CACBADC-FA39-4F07-BBF2-35C89947D030}"/>
              </a:ext>
            </a:extLst>
          </p:cNvPr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45059" name="ノート プレースホルダー 2">
            <a:extLst>
              <a:ext uri="{FF2B5EF4-FFF2-40B4-BE49-F238E27FC236}">
                <a16:creationId xmlns:a16="http://schemas.microsoft.com/office/drawing/2014/main" id="{8792FD74-D0C9-4F8D-87A7-BEAEA67B6236}"/>
              </a:ext>
            </a:extLst>
          </p:cNvPr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endParaRPr lang="en-US" altLang="ja-JP" dirty="0"/>
          </a:p>
        </p:txBody>
      </p:sp>
      <p:sp>
        <p:nvSpPr>
          <p:cNvPr id="45060" name="スライド番号プレースホルダー 3">
            <a:extLst>
              <a:ext uri="{FF2B5EF4-FFF2-40B4-BE49-F238E27FC236}">
                <a16:creationId xmlns:a16="http://schemas.microsoft.com/office/drawing/2014/main" id="{3C26F6EE-CC2B-476B-BF86-C8EF059AFCD0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kumimoji="1" sz="21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 sz="21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 sz="21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 sz="21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 sz="21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1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1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1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1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fld id="{E921C185-EE72-4967-8982-B59E9704FA2A}" type="slidenum">
              <a:rPr lang="ja-JP" altLang="en-US" sz="1200"/>
              <a:pPr eaLnBrk="1" hangingPunct="1"/>
              <a:t>2</a:t>
            </a:fld>
            <a:endParaRPr lang="ja-JP" altLang="en-US" sz="1200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082" name="スライド イメージ プレースホルダー 1">
            <a:extLst>
              <a:ext uri="{FF2B5EF4-FFF2-40B4-BE49-F238E27FC236}">
                <a16:creationId xmlns:a16="http://schemas.microsoft.com/office/drawing/2014/main" id="{95725FB3-24DE-4A66-81D9-DA108DC5B7A4}"/>
              </a:ext>
            </a:extLst>
          </p:cNvPr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46083" name="ノート プレースホルダー 2">
            <a:extLst>
              <a:ext uri="{FF2B5EF4-FFF2-40B4-BE49-F238E27FC236}">
                <a16:creationId xmlns:a16="http://schemas.microsoft.com/office/drawing/2014/main" id="{095D50B4-A83B-4A6C-BDF8-209850E974F1}"/>
              </a:ext>
            </a:extLst>
          </p:cNvPr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lang="en-US" altLang="ja-JP" dirty="0"/>
          </a:p>
        </p:txBody>
      </p:sp>
      <p:sp>
        <p:nvSpPr>
          <p:cNvPr id="46084" name="スライド番号プレースホルダー 3">
            <a:extLst>
              <a:ext uri="{FF2B5EF4-FFF2-40B4-BE49-F238E27FC236}">
                <a16:creationId xmlns:a16="http://schemas.microsoft.com/office/drawing/2014/main" id="{55046733-9F06-4212-8156-80355D3CEAB6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kumimoji="1" sz="21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 sz="21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 sz="21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 sz="21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 sz="21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1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1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1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1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fld id="{CD069C01-14CC-4342-B349-31934737F9A7}" type="slidenum">
              <a:rPr lang="ja-JP" altLang="en-US" sz="1200"/>
              <a:pPr eaLnBrk="1" hangingPunct="1"/>
              <a:t>3</a:t>
            </a:fld>
            <a:endParaRPr lang="ja-JP" altLang="en-US" sz="1200"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l"/>
            <a:endParaRPr kumimoji="1" lang="en-US" altLang="ja-JP" b="1" u="none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1AB373A0-1279-4E2C-AC6E-3542E84F72B8}" type="slidenum">
              <a:rPr lang="ja-JP" altLang="en-US" smtClean="0"/>
              <a:pPr>
                <a:defRPr/>
              </a:pPr>
              <a:t>4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656603416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082" name="スライド イメージ プレースホルダー 1">
            <a:extLst>
              <a:ext uri="{FF2B5EF4-FFF2-40B4-BE49-F238E27FC236}">
                <a16:creationId xmlns:a16="http://schemas.microsoft.com/office/drawing/2014/main" id="{95725FB3-24DE-4A66-81D9-DA108DC5B7A4}"/>
              </a:ext>
            </a:extLst>
          </p:cNvPr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46083" name="ノート プレースホルダー 2">
            <a:extLst>
              <a:ext uri="{FF2B5EF4-FFF2-40B4-BE49-F238E27FC236}">
                <a16:creationId xmlns:a16="http://schemas.microsoft.com/office/drawing/2014/main" id="{095D50B4-A83B-4A6C-BDF8-209850E974F1}"/>
              </a:ext>
            </a:extLst>
          </p:cNvPr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lang="en-US" altLang="ja-JP" dirty="0"/>
          </a:p>
        </p:txBody>
      </p:sp>
      <p:sp>
        <p:nvSpPr>
          <p:cNvPr id="46084" name="スライド番号プレースホルダー 3">
            <a:extLst>
              <a:ext uri="{FF2B5EF4-FFF2-40B4-BE49-F238E27FC236}">
                <a16:creationId xmlns:a16="http://schemas.microsoft.com/office/drawing/2014/main" id="{55046733-9F06-4212-8156-80355D3CEAB6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kumimoji="1" sz="21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 sz="21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 sz="21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 sz="21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 sz="21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1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1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1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1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fld id="{CD069C01-14CC-4342-B349-31934737F9A7}" type="slidenum">
              <a:rPr lang="ja-JP" altLang="en-US" sz="1200"/>
              <a:pPr eaLnBrk="1" hangingPunct="1"/>
              <a:t>5</a:t>
            </a:fld>
            <a:endParaRPr lang="ja-JP" altLang="en-US" sz="1200"/>
          </a:p>
        </p:txBody>
      </p:sp>
    </p:spTree>
    <p:extLst>
      <p:ext uri="{BB962C8B-B14F-4D97-AF65-F5344CB8AC3E}">
        <p14:creationId xmlns:p14="http://schemas.microsoft.com/office/powerpoint/2010/main" val="405779947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4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20B7CE7-124B-4911-ABE1-0F4238735C70}" type="datetimeFigureOut">
              <a:rPr lang="ja-JP" altLang="en-US"/>
              <a:pPr>
                <a:defRPr/>
              </a:pPr>
              <a:t>2023/4/14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4ACA4AD-DACA-4BA1-A78C-F627B1F8CB1C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4261423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119429F-5FEC-4016-9667-0515F871E4E3}" type="datetimeFigureOut">
              <a:rPr lang="ja-JP" altLang="en-US"/>
              <a:pPr>
                <a:defRPr/>
              </a:pPr>
              <a:t>2023/4/14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41815EA-E89D-43B9-9BD2-A337FDD67B9C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0799950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5DA4E8C-D88F-4AED-A492-FF5CEE4DE047}" type="datetimeFigureOut">
              <a:rPr lang="ja-JP" altLang="en-US"/>
              <a:pPr>
                <a:defRPr/>
              </a:pPr>
              <a:t>2023/4/14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FE86F4D-3DBE-4435-995F-A45183F5CD7A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145582994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ユーザー設定レイアウ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CA941B50-C356-49E5-B579-74442CB60440}" type="datetimeFigureOut">
              <a:rPr lang="ja-JP" altLang="en-US" smtClean="0"/>
              <a:pPr>
                <a:defRPr/>
              </a:pPr>
              <a:t>2023/4/14</a:t>
            </a:fld>
            <a:endParaRPr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 algn="r" eaLnBrk="1" hangingPunct="1">
              <a:defRPr/>
            </a:lvl1pPr>
          </a:lstStyle>
          <a:p>
            <a:pPr>
              <a:defRPr/>
            </a:pPr>
            <a:r>
              <a:rPr lang="en-US" altLang="ja-JP" b="1" dirty="0">
                <a:solidFill>
                  <a:schemeClr val="tx1">
                    <a:lumMod val="95000"/>
                  </a:schemeClr>
                </a:solidFill>
                <a:latin typeface="Microsoft Uighur" panose="02000000000000000000" pitchFamily="2" charset="-78"/>
                <a:cs typeface="Microsoft Uighur" panose="02000000000000000000" pitchFamily="2" charset="-78"/>
              </a:rPr>
              <a:t>101</a:t>
            </a:r>
            <a:r>
              <a:rPr lang="en-US" altLang="ja-JP" b="1" baseline="30000" dirty="0">
                <a:solidFill>
                  <a:schemeClr val="tx1">
                    <a:lumMod val="95000"/>
                  </a:schemeClr>
                </a:solidFill>
                <a:latin typeface="Microsoft Uighur" panose="02000000000000000000" pitchFamily="2" charset="-78"/>
                <a:cs typeface="Microsoft Uighur" panose="02000000000000000000" pitchFamily="2" charset="-78"/>
              </a:rPr>
              <a:t>st</a:t>
            </a:r>
            <a:r>
              <a:rPr lang="en-US" altLang="ja-JP" b="1" dirty="0">
                <a:solidFill>
                  <a:schemeClr val="tx1">
                    <a:lumMod val="95000"/>
                  </a:schemeClr>
                </a:solidFill>
                <a:latin typeface="Microsoft Uighur" panose="02000000000000000000" pitchFamily="2" charset="-78"/>
                <a:cs typeface="Microsoft Uighur" panose="02000000000000000000" pitchFamily="2" charset="-78"/>
              </a:rPr>
              <a:t> ACS Clinical Congress 2015 (Chicago)</a:t>
            </a:r>
            <a:endParaRPr lang="ja-JP" altLang="en-US" b="1" dirty="0">
              <a:solidFill>
                <a:schemeClr val="tx1">
                  <a:lumMod val="95000"/>
                </a:schemeClr>
              </a:solidFill>
              <a:latin typeface="Microsoft Uighur" panose="02000000000000000000" pitchFamily="2" charset="-78"/>
              <a:cs typeface="Microsoft Uighur" panose="02000000000000000000" pitchFamily="2" charset="-78"/>
            </a:endParaRPr>
          </a:p>
        </p:txBody>
      </p:sp>
    </p:spTree>
    <p:extLst>
      <p:ext uri="{BB962C8B-B14F-4D97-AF65-F5344CB8AC3E}">
        <p14:creationId xmlns:p14="http://schemas.microsoft.com/office/powerpoint/2010/main" val="1885346853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D9F448-50E7-4A11-9766-5C4DEDB4FA24}" type="datetimeFigureOut">
              <a:rPr kumimoji="1" lang="ja-JP" altLang="en-US" smtClean="0"/>
              <a:t>2023/4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07A92-6826-4834-AAC6-0650C2993E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6489621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D9F448-50E7-4A11-9766-5C4DEDB4FA24}" type="datetimeFigureOut">
              <a:rPr kumimoji="1" lang="ja-JP" altLang="en-US" smtClean="0"/>
              <a:t>2023/4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07A92-6826-4834-AAC6-0650C2993E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24671759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623888" y="1709738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623888" y="4589463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D9F448-50E7-4A11-9766-5C4DEDB4FA24}" type="datetimeFigureOut">
              <a:rPr kumimoji="1" lang="ja-JP" altLang="en-US" smtClean="0"/>
              <a:t>2023/4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07A92-6826-4834-AAC6-0650C2993E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7605488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6715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825625"/>
            <a:ext cx="386715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D9F448-50E7-4A11-9766-5C4DEDB4FA24}" type="datetimeFigureOut">
              <a:rPr kumimoji="1" lang="ja-JP" altLang="en-US" smtClean="0"/>
              <a:t>2023/4/1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07A92-6826-4834-AAC6-0650C2993E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79307928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630238" y="365125"/>
            <a:ext cx="78867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630238" y="1681163"/>
            <a:ext cx="386873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30238" y="2505075"/>
            <a:ext cx="386873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7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7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D9F448-50E7-4A11-9766-5C4DEDB4FA24}" type="datetimeFigureOut">
              <a:rPr kumimoji="1" lang="ja-JP" altLang="en-US" smtClean="0"/>
              <a:t>2023/4/14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07A92-6826-4834-AAC6-0650C2993E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76312087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D9F448-50E7-4A11-9766-5C4DEDB4FA24}" type="datetimeFigureOut">
              <a:rPr kumimoji="1" lang="ja-JP" altLang="en-US" smtClean="0"/>
              <a:t>2023/4/14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07A92-6826-4834-AAC6-0650C2993E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9577348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D9F448-50E7-4A11-9766-5C4DEDB4FA24}" type="datetimeFigureOut">
              <a:rPr kumimoji="1" lang="ja-JP" altLang="en-US" smtClean="0"/>
              <a:t>2023/4/14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07A92-6826-4834-AAC6-0650C2993E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06230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B98203-ACB5-471F-BC44-5996C59C0386}" type="datetimeFigureOut">
              <a:rPr lang="ja-JP" altLang="en-US"/>
              <a:pPr>
                <a:defRPr/>
              </a:pPr>
              <a:t>2023/4/14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599A826-E70B-4CF7-BF54-604EA1FFCD8F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  <p:sp>
        <p:nvSpPr>
          <p:cNvPr id="7" name="角丸四角形 6"/>
          <p:cNvSpPr/>
          <p:nvPr userDrawn="1"/>
        </p:nvSpPr>
        <p:spPr>
          <a:xfrm>
            <a:off x="5355101" y="6545596"/>
            <a:ext cx="3886399" cy="273050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r" eaLnBrk="1" hangingPunct="1">
              <a:defRPr/>
            </a:pPr>
            <a:r>
              <a:rPr lang="en-US" altLang="ja-JP" b="1" dirty="0">
                <a:solidFill>
                  <a:schemeClr val="tx1">
                    <a:lumMod val="95000"/>
                  </a:schemeClr>
                </a:solidFill>
                <a:latin typeface="ParkAvenue BT" panose="03020602050506080705" pitchFamily="66" charset="0"/>
              </a:rPr>
              <a:t>104</a:t>
            </a:r>
            <a:r>
              <a:rPr lang="en-US" altLang="ja-JP" b="1" baseline="30000" dirty="0">
                <a:solidFill>
                  <a:schemeClr val="tx1">
                    <a:lumMod val="95000"/>
                  </a:schemeClr>
                </a:solidFill>
                <a:latin typeface="ParkAvenue BT" panose="03020602050506080705" pitchFamily="66" charset="0"/>
              </a:rPr>
              <a:t>st</a:t>
            </a:r>
            <a:r>
              <a:rPr lang="en-US" altLang="ja-JP" b="1" dirty="0">
                <a:solidFill>
                  <a:schemeClr val="tx1">
                    <a:lumMod val="95000"/>
                  </a:schemeClr>
                </a:solidFill>
                <a:latin typeface="ParkAvenue BT" panose="03020602050506080705" pitchFamily="66" charset="0"/>
              </a:rPr>
              <a:t> ACS Clinical Congress 2015 (Boston)</a:t>
            </a:r>
            <a:endParaRPr lang="ja-JP" altLang="en-US" b="1" dirty="0">
              <a:solidFill>
                <a:schemeClr val="tx1">
                  <a:lumMod val="95000"/>
                </a:schemeClr>
              </a:solidFill>
              <a:latin typeface="ParkAvenue BT" panose="03020602050506080705" pitchFamily="66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3493617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630238" y="457200"/>
            <a:ext cx="2949575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887788" y="987425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630238" y="2057400"/>
            <a:ext cx="2949575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D9F448-50E7-4A11-9766-5C4DEDB4FA24}" type="datetimeFigureOut">
              <a:rPr kumimoji="1" lang="ja-JP" altLang="en-US" smtClean="0"/>
              <a:t>2023/4/1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07A92-6826-4834-AAC6-0650C2993E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30933976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630238" y="457200"/>
            <a:ext cx="2949575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3887788" y="987425"/>
            <a:ext cx="462915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630238" y="2057400"/>
            <a:ext cx="2949575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D9F448-50E7-4A11-9766-5C4DEDB4FA24}" type="datetimeFigureOut">
              <a:rPr kumimoji="1" lang="ja-JP" altLang="en-US" smtClean="0"/>
              <a:t>2023/4/1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07A92-6826-4834-AAC6-0650C2993E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99117787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D9F448-50E7-4A11-9766-5C4DEDB4FA24}" type="datetimeFigureOut">
              <a:rPr kumimoji="1" lang="ja-JP" altLang="en-US" smtClean="0"/>
              <a:t>2023/4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07A92-6826-4834-AAC6-0650C2993E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1872501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762625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D9F448-50E7-4A11-9766-5C4DEDB4FA24}" type="datetimeFigureOut">
              <a:rPr kumimoji="1" lang="ja-JP" altLang="en-US" smtClean="0"/>
              <a:t>2023/4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07A92-6826-4834-AAC6-0650C2993E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82338537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0BC134D-C924-4CDB-B546-A83E4B489FFB}" type="datetimeFigureOut">
              <a:rPr lang="ja-JP" altLang="en-US"/>
              <a:pPr>
                <a:defRPr/>
              </a:pPr>
              <a:t>2023/4/14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 wrap="square" numCol="1" anchorCtr="0" compatLnSpc="1">
            <a:prstTxWarp prst="textNoShape">
              <a:avLst/>
            </a:prstTxWarp>
          </a:bodyPr>
          <a:lstStyle>
            <a:lvl1pPr>
              <a:defRPr>
                <a:solidFill>
                  <a:srgbClr val="FAC090"/>
                </a:solidFill>
              </a:defRPr>
            </a:lvl1pPr>
          </a:lstStyle>
          <a:p>
            <a:pPr>
              <a:defRPr/>
            </a:pPr>
            <a:fld id="{6E021A52-D19A-43A2-9877-219ED6B95FF0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583095592"/>
      </p:ext>
    </p:extLst>
  </p:cSld>
  <p:clrMapOvr>
    <a:overrideClrMapping bg1="dk1" tx1="lt1" bg2="dk2" tx2="lt2" accent1="accent1" accent2="accent2" accent3="accent3" accent4="accent4" accent5="accent5" accent6="accent6" hlink="hlink" folHlink="folHlink"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2A27A8F-30E3-425F-AE2A-3BC84A8D48BA}" type="datetimeFigureOut">
              <a:rPr lang="ja-JP" altLang="en-US"/>
              <a:pPr>
                <a:defRPr/>
              </a:pPr>
              <a:t>2023/4/14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 wrap="square" numCol="1" anchorCtr="0" compatLnSpc="1">
            <a:prstTxWarp prst="textNoShape">
              <a:avLst/>
            </a:prstTxWarp>
          </a:bodyPr>
          <a:lstStyle>
            <a:lvl1pPr>
              <a:defRPr>
                <a:solidFill>
                  <a:srgbClr val="FAC090"/>
                </a:solidFill>
              </a:defRPr>
            </a:lvl1pPr>
          </a:lstStyle>
          <a:p>
            <a:pPr>
              <a:defRPr/>
            </a:pPr>
            <a:fld id="{C0CBA753-ABEF-451B-BB95-B1B0E0112D60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188460346"/>
      </p:ext>
    </p:extLst>
  </p:cSld>
  <p:clrMapOvr>
    <a:overrideClrMapping bg1="dk1" tx1="lt1" bg2="dk2" tx2="lt2" accent1="accent1" accent2="accent2" accent3="accent3" accent4="accent4" accent5="accent5" accent6="accent6" hlink="hlink" folHlink="folHlink"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CF15771-7E89-4B3F-931C-77C80F3DF641}" type="datetimeFigureOut">
              <a:rPr lang="ja-JP" altLang="en-US"/>
              <a:pPr>
                <a:defRPr/>
              </a:pPr>
              <a:t>2023/4/14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 wrap="square" numCol="1" anchorCtr="0" compatLnSpc="1">
            <a:prstTxWarp prst="textNoShape">
              <a:avLst/>
            </a:prstTxWarp>
          </a:bodyPr>
          <a:lstStyle>
            <a:lvl1pPr>
              <a:defRPr>
                <a:solidFill>
                  <a:srgbClr val="FAC090"/>
                </a:solidFill>
              </a:defRPr>
            </a:lvl1pPr>
          </a:lstStyle>
          <a:p>
            <a:pPr>
              <a:defRPr/>
            </a:pPr>
            <a:fld id="{2FCAD168-B0F8-4D69-A5DC-96EEF1DBD401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413815777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BD43184-E3AC-4EB5-B737-0445A4D72DDC}" type="datetimeFigureOut">
              <a:rPr lang="ja-JP" altLang="en-US"/>
              <a:pPr>
                <a:defRPr/>
              </a:pPr>
              <a:t>2023/4/14</a:t>
            </a:fld>
            <a:endParaRPr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 wrap="square" numCol="1" anchorCtr="0" compatLnSpc="1">
            <a:prstTxWarp prst="textNoShape">
              <a:avLst/>
            </a:prstTxWarp>
          </a:bodyPr>
          <a:lstStyle>
            <a:lvl1pPr>
              <a:defRPr>
                <a:solidFill>
                  <a:srgbClr val="FAC090"/>
                </a:solidFill>
              </a:defRPr>
            </a:lvl1pPr>
          </a:lstStyle>
          <a:p>
            <a:pPr>
              <a:defRPr/>
            </a:pPr>
            <a:fld id="{EECA813A-6705-498C-863D-F1FEA2A893BC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012597913"/>
      </p:ext>
    </p:extLst>
  </p:cSld>
  <p:clrMapOvr>
    <a:overrideClrMapping bg1="dk1" tx1="lt1" bg2="dk2" tx2="lt2" accent1="accent1" accent2="accent2" accent3="accent3" accent4="accent4" accent5="accent5" accent6="accent6" hlink="hlink" folHlink="folHlink"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4E7D245-6D52-4761-A018-6493AAC20110}" type="datetimeFigureOut">
              <a:rPr lang="ja-JP" altLang="en-US"/>
              <a:pPr>
                <a:defRPr/>
              </a:pPr>
              <a:t>2023/4/14</a:t>
            </a:fld>
            <a:endParaRPr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 wrap="square" numCol="1" anchorCtr="0" compatLnSpc="1">
            <a:prstTxWarp prst="textNoShape">
              <a:avLst/>
            </a:prstTxWarp>
          </a:bodyPr>
          <a:lstStyle>
            <a:lvl1pPr>
              <a:defRPr>
                <a:solidFill>
                  <a:srgbClr val="FAC090"/>
                </a:solidFill>
              </a:defRPr>
            </a:lvl1pPr>
          </a:lstStyle>
          <a:p>
            <a:pPr>
              <a:defRPr/>
            </a:pPr>
            <a:fld id="{80AC0EF5-497F-4E11-8923-21532EBD8501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11626090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B61E1F0-10CC-4D08-8569-E9372F2529C1}" type="datetimeFigureOut">
              <a:rPr lang="ja-JP" altLang="en-US"/>
              <a:pPr>
                <a:defRPr/>
              </a:pPr>
              <a:t>2023/4/14</a:t>
            </a:fld>
            <a:endParaRPr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 wrap="square" numCol="1" anchorCtr="0" compatLnSpc="1">
            <a:prstTxWarp prst="textNoShape">
              <a:avLst/>
            </a:prstTxWarp>
          </a:bodyPr>
          <a:lstStyle>
            <a:lvl1pPr>
              <a:defRPr>
                <a:solidFill>
                  <a:srgbClr val="FAC090"/>
                </a:solidFill>
              </a:defRPr>
            </a:lvl1pPr>
          </a:lstStyle>
          <a:p>
            <a:pPr>
              <a:defRPr/>
            </a:pPr>
            <a:fld id="{E9E02806-8E6A-4283-86FF-88F2DC40FBBD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079633187"/>
      </p:ext>
    </p:extLst>
  </p:cSld>
  <p:clrMapOvr>
    <a:overrideClrMapping bg1="dk1" tx1="lt1" bg2="dk2" tx2="lt2" accent1="accent1" accent2="accent2" accent3="accent3" accent4="accent4" accent5="accent5" accent6="accent6" hlink="hlink" folHlink="folHlink"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5FF3BC6-2E21-452E-9C98-799039FB85B4}" type="datetimeFigureOut">
              <a:rPr lang="ja-JP" altLang="en-US"/>
              <a:pPr>
                <a:defRPr/>
              </a:pPr>
              <a:t>2023/4/14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722AA2-1832-417E-B3A7-00EAE39A14F0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609871446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6854E6E-8398-41AD-A787-578249D1D7E7}" type="datetimeFigureOut">
              <a:rPr lang="ja-JP" altLang="en-US"/>
              <a:pPr>
                <a:defRPr/>
              </a:pPr>
              <a:t>2023/4/14</a:t>
            </a:fld>
            <a:endParaRPr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 wrap="square" numCol="1" anchorCtr="0" compatLnSpc="1">
            <a:prstTxWarp prst="textNoShape">
              <a:avLst/>
            </a:prstTxWarp>
          </a:bodyPr>
          <a:lstStyle>
            <a:lvl1pPr>
              <a:defRPr>
                <a:solidFill>
                  <a:srgbClr val="FAC090"/>
                </a:solidFill>
              </a:defRPr>
            </a:lvl1pPr>
          </a:lstStyle>
          <a:p>
            <a:pPr>
              <a:defRPr/>
            </a:pPr>
            <a:fld id="{F883C7CB-669C-432C-A146-5ADB8EC34593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648805814"/>
      </p:ext>
    </p:extLst>
  </p:cSld>
  <p:clrMapOvr>
    <a:overrideClrMapping bg1="dk1" tx1="lt1" bg2="dk2" tx2="lt2" accent1="accent1" accent2="accent2" accent3="accent3" accent4="accent4" accent5="accent5" accent6="accent6" hlink="hlink" folHlink="folHlink"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A526ED6-BC17-476C-A099-E0A4C9D6099E}" type="datetimeFigureOut">
              <a:rPr lang="ja-JP" altLang="en-US"/>
              <a:pPr>
                <a:defRPr/>
              </a:pPr>
              <a:t>2023/4/14</a:t>
            </a:fld>
            <a:endParaRPr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 wrap="square" numCol="1" anchorCtr="0" compatLnSpc="1">
            <a:prstTxWarp prst="textNoShape">
              <a:avLst/>
            </a:prstTxWarp>
          </a:bodyPr>
          <a:lstStyle>
            <a:lvl1pPr>
              <a:defRPr>
                <a:solidFill>
                  <a:srgbClr val="FAC090"/>
                </a:solidFill>
              </a:defRPr>
            </a:lvl1pPr>
          </a:lstStyle>
          <a:p>
            <a:pPr>
              <a:defRPr/>
            </a:pPr>
            <a:fld id="{3978A9AB-7819-4066-8AA9-BB3C484A4B96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288047071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ja-JP" altLang="en-US" noProof="0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0029C57-2B7B-4C3E-BCFC-3CCAB150F193}" type="datetimeFigureOut">
              <a:rPr lang="ja-JP" altLang="en-US"/>
              <a:pPr>
                <a:defRPr/>
              </a:pPr>
              <a:t>2023/4/14</a:t>
            </a:fld>
            <a:endParaRPr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 wrap="square" numCol="1" anchorCtr="0" compatLnSpc="1">
            <a:prstTxWarp prst="textNoShape">
              <a:avLst/>
            </a:prstTxWarp>
          </a:bodyPr>
          <a:lstStyle>
            <a:lvl1pPr>
              <a:defRPr>
                <a:solidFill>
                  <a:srgbClr val="FAC090"/>
                </a:solidFill>
              </a:defRPr>
            </a:lvl1pPr>
          </a:lstStyle>
          <a:p>
            <a:pPr>
              <a:defRPr/>
            </a:pPr>
            <a:fld id="{336A8008-687B-4C6C-B856-C814CE4B6EE1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99498676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72C8A96-C7B8-4264-94EB-8C37EA120AF3}" type="datetimeFigureOut">
              <a:rPr lang="ja-JP" altLang="en-US"/>
              <a:pPr>
                <a:defRPr/>
              </a:pPr>
              <a:t>2023/4/14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 wrap="square" numCol="1" anchorCtr="0" compatLnSpc="1">
            <a:prstTxWarp prst="textNoShape">
              <a:avLst/>
            </a:prstTxWarp>
          </a:bodyPr>
          <a:lstStyle>
            <a:lvl1pPr>
              <a:defRPr>
                <a:solidFill>
                  <a:srgbClr val="FAC090"/>
                </a:solidFill>
              </a:defRPr>
            </a:lvl1pPr>
          </a:lstStyle>
          <a:p>
            <a:pPr>
              <a:defRPr/>
            </a:pPr>
            <a:fld id="{6E75962F-13C5-4A81-8463-F95FAE4F0D85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928189710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A7F1751-9822-4FDB-8910-ED91CC3A0941}" type="datetimeFigureOut">
              <a:rPr lang="ja-JP" altLang="en-US"/>
              <a:pPr>
                <a:defRPr/>
              </a:pPr>
              <a:t>2023/4/14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 wrap="square" numCol="1" anchorCtr="0" compatLnSpc="1">
            <a:prstTxWarp prst="textNoShape">
              <a:avLst/>
            </a:prstTxWarp>
          </a:bodyPr>
          <a:lstStyle>
            <a:lvl1pPr>
              <a:defRPr>
                <a:solidFill>
                  <a:srgbClr val="FAC090"/>
                </a:solidFill>
              </a:defRPr>
            </a:lvl1pPr>
          </a:lstStyle>
          <a:p>
            <a:pPr>
              <a:defRPr/>
            </a:pPr>
            <a:fld id="{93A5A4D5-89CA-42D2-BDA0-CD1CA3F22907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822508689"/>
      </p:ext>
    </p:extLst>
  </p:cSld>
  <p:clrMapOvr>
    <a:masterClrMapping/>
  </p:clrMapOvr>
</p:sldLayout>
</file>

<file path=ppt/slideLayouts/slideLayout3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ユーザー設定レイアウ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4640219-9252-478D-A8D6-6C8BF30385E9}" type="datetimeFigureOut">
              <a:rPr lang="ja-JP" altLang="en-US"/>
              <a:pPr>
                <a:defRPr/>
              </a:pPr>
              <a:t>2023/4/14</a:t>
            </a:fld>
            <a:endParaRPr lang="ja-JP" altLang="en-US"/>
          </a:p>
        </p:txBody>
      </p:sp>
      <p:sp>
        <p:nvSpPr>
          <p:cNvPr id="4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5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en-US" altLang="ja-JP" dirty="0"/>
              <a:t>ACS Clinical Congress (Chicago)</a:t>
            </a:r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215784575"/>
      </p:ext>
    </p:extLst>
  </p:cSld>
  <p:clrMapOvr>
    <a:masterClrMapping/>
  </p:clrMapOvr>
</p:sldLayout>
</file>

<file path=ppt/slideLayouts/slideLayout36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Disclosu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7992" y="1944707"/>
            <a:ext cx="7772400" cy="1271587"/>
          </a:xfrm>
        </p:spPr>
        <p:txBody>
          <a:bodyPr anchor="b">
            <a:normAutofit/>
          </a:bodyPr>
          <a:lstStyle>
            <a:lvl1pPr marL="0" indent="0" algn="ctr">
              <a:buNone/>
              <a:defRPr sz="3600" baseline="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12" name="Text Placeholder 11"/>
          <p:cNvSpPr>
            <a:spLocks noGrp="1"/>
          </p:cNvSpPr>
          <p:nvPr>
            <p:ph type="body" sz="quarter" idx="11"/>
          </p:nvPr>
        </p:nvSpPr>
        <p:spPr>
          <a:xfrm>
            <a:off x="687324" y="3429000"/>
            <a:ext cx="7769352" cy="2438400"/>
          </a:xfrm>
        </p:spPr>
        <p:txBody>
          <a:bodyPr>
            <a:normAutofit/>
          </a:bodyPr>
          <a:lstStyle>
            <a:lvl1pPr marL="0" indent="0" algn="ctr">
              <a:buNone/>
              <a:defRPr sz="2800" baseline="0"/>
            </a:lvl1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</p:spTree>
    <p:extLst>
      <p:ext uri="{BB962C8B-B14F-4D97-AF65-F5344CB8AC3E}">
        <p14:creationId xmlns:p14="http://schemas.microsoft.com/office/powerpoint/2010/main" val="3519862954"/>
      </p:ext>
    </p:extLst>
  </p:cSld>
  <p:clrMapOvr>
    <a:overrideClrMapping bg1="dk1" tx1="lt1" bg2="dk2" tx2="lt2" accent1="accent1" accent2="accent2" accent3="accent3" accent4="accent4" accent5="accent5" accent6="accent6" hlink="hlink" folHlink="folHlink"/>
  </p:clrMapOvr>
</p:sldLayout>
</file>

<file path=ppt/slideLayouts/slideLayout3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19B17CD-B728-4C59-8209-74913D20B612}" type="datetimeFigureOut">
              <a:rPr lang="ja-JP" altLang="en-US"/>
              <a:pPr>
                <a:defRPr/>
              </a:pPr>
              <a:t>2023/4/14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D5BAD04-68CC-4D71-BAA6-8C64EEB4AACA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828537288"/>
      </p:ext>
    </p:extLst>
  </p:cSld>
  <p:clrMapOvr>
    <a:masterClrMapping/>
  </p:clrMapOvr>
</p:sldLayout>
</file>

<file path=ppt/slideLayouts/slideLayout38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E7AEE28-85B5-43B3-A8E1-5768290A5176}" type="datetimeFigureOut">
              <a:rPr lang="ja-JP" altLang="en-US"/>
              <a:pPr>
                <a:defRPr/>
              </a:pPr>
              <a:t>2023/4/14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87F4CF6-5F31-4648-81AA-F1ECF3B0890F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198001867"/>
      </p:ext>
    </p:extLst>
  </p:cSld>
  <p:clrMapOvr>
    <a:masterClrMapping/>
  </p:clrMapOvr>
</p:sldLayout>
</file>

<file path=ppt/slideLayouts/slideLayout39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8D00C80-ED5A-4E13-89C0-6E91EFAA4C30}" type="datetimeFigureOut">
              <a:rPr lang="ja-JP" altLang="en-US"/>
              <a:pPr>
                <a:defRPr/>
              </a:pPr>
              <a:t>2023/4/14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158D8DC-534B-41B9-ADEC-285CDDA91EFD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5832491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D32EB1D-1A5B-453A-85A2-DDF4C24592D5}" type="datetimeFigureOut">
              <a:rPr lang="ja-JP" altLang="en-US"/>
              <a:pPr>
                <a:defRPr/>
              </a:pPr>
              <a:t>2023/4/14</a:t>
            </a:fld>
            <a:endParaRPr lang="ja-JP" altLang="en-US"/>
          </a:p>
        </p:txBody>
      </p:sp>
      <p:sp>
        <p:nvSpPr>
          <p:cNvPr id="6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7BD825F-F0BD-46C1-BB6B-4711A62F429C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855650387"/>
      </p:ext>
    </p:extLst>
  </p:cSld>
  <p:clrMapOvr>
    <a:masterClrMapping/>
  </p:clrMapOvr>
</p:sldLayout>
</file>

<file path=ppt/slideLayouts/slideLayout40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90AB8B5-F64E-4E4B-A02D-A4DFC40F3650}" type="datetimeFigureOut">
              <a:rPr lang="ja-JP" altLang="en-US"/>
              <a:pPr>
                <a:defRPr/>
              </a:pPr>
              <a:t>2023/4/14</a:t>
            </a:fld>
            <a:endParaRPr lang="ja-JP" altLang="en-US"/>
          </a:p>
        </p:txBody>
      </p:sp>
      <p:sp>
        <p:nvSpPr>
          <p:cNvPr id="6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7D25738-8DA7-4874-B548-1DFDCB78B968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456384473"/>
      </p:ext>
    </p:extLst>
  </p:cSld>
  <p:clrMapOvr>
    <a:masterClrMapping/>
  </p:clrMapOvr>
</p:sldLayout>
</file>

<file path=ppt/slideLayouts/slideLayout41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7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8FA9A57-C9AC-461C-982C-7A09C71A3D92}" type="datetimeFigureOut">
              <a:rPr lang="ja-JP" altLang="en-US"/>
              <a:pPr>
                <a:defRPr/>
              </a:pPr>
              <a:t>2023/4/14</a:t>
            </a:fld>
            <a:endParaRPr lang="ja-JP" altLang="en-US"/>
          </a:p>
        </p:txBody>
      </p:sp>
      <p:sp>
        <p:nvSpPr>
          <p:cNvPr id="8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9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5094812-2C32-4C93-981C-FC9610D3C5A3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810900876"/>
      </p:ext>
    </p:extLst>
  </p:cSld>
  <p:clrMapOvr>
    <a:masterClrMapping/>
  </p:clrMapOvr>
</p:sldLayout>
</file>

<file path=ppt/slideLayouts/slideLayout4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C47713-CF7C-4197-9F2B-67468B5B1C52}" type="datetimeFigureOut">
              <a:rPr lang="ja-JP" altLang="en-US"/>
              <a:pPr>
                <a:defRPr/>
              </a:pPr>
              <a:t>2023/4/14</a:t>
            </a:fld>
            <a:endParaRPr lang="ja-JP" altLang="en-US"/>
          </a:p>
        </p:txBody>
      </p:sp>
      <p:sp>
        <p:nvSpPr>
          <p:cNvPr id="4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5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25459E-1517-4D47-96CF-C9B8DF0FC997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992925903"/>
      </p:ext>
    </p:extLst>
  </p:cSld>
  <p:clrMapOvr>
    <a:masterClrMapping/>
  </p:clrMapOvr>
</p:sldLayout>
</file>

<file path=ppt/slideLayouts/slideLayout43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EB20D64-1667-4852-9949-3EF27AFF7D01}" type="datetimeFigureOut">
              <a:rPr lang="ja-JP" altLang="en-US"/>
              <a:pPr>
                <a:defRPr/>
              </a:pPr>
              <a:t>2023/4/14</a:t>
            </a:fld>
            <a:endParaRPr lang="ja-JP" altLang="en-US"/>
          </a:p>
        </p:txBody>
      </p:sp>
      <p:sp>
        <p:nvSpPr>
          <p:cNvPr id="3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4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2782187-14B0-4838-AAC0-C98763E51602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989479686"/>
      </p:ext>
    </p:extLst>
  </p:cSld>
  <p:clrMapOvr>
    <a:masterClrMapping/>
  </p:clrMapOvr>
</p:sldLayout>
</file>

<file path=ppt/slideLayouts/slideLayout44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64574DA-17B0-4FB8-BBF1-ECBB24826659}" type="datetimeFigureOut">
              <a:rPr lang="ja-JP" altLang="en-US"/>
              <a:pPr>
                <a:defRPr/>
              </a:pPr>
              <a:t>2023/4/14</a:t>
            </a:fld>
            <a:endParaRPr lang="ja-JP" altLang="en-US"/>
          </a:p>
        </p:txBody>
      </p:sp>
      <p:sp>
        <p:nvSpPr>
          <p:cNvPr id="6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F434BF5-724A-4306-8377-C695E5758348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10946705"/>
      </p:ext>
    </p:extLst>
  </p:cSld>
  <p:clrMapOvr>
    <a:masterClrMapping/>
  </p:clrMapOvr>
</p:sldLayout>
</file>

<file path=ppt/slideLayouts/slideLayout45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ja-JP" altLang="en-US" noProof="0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ED9B3B8-1B76-427D-8F18-0996E2900C19}" type="datetimeFigureOut">
              <a:rPr lang="ja-JP" altLang="en-US"/>
              <a:pPr>
                <a:defRPr/>
              </a:pPr>
              <a:t>2023/4/14</a:t>
            </a:fld>
            <a:endParaRPr lang="ja-JP" altLang="en-US"/>
          </a:p>
        </p:txBody>
      </p:sp>
      <p:sp>
        <p:nvSpPr>
          <p:cNvPr id="6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EA7FAAC-0F86-44AB-BD15-DA80BE92AD6D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366036688"/>
      </p:ext>
    </p:extLst>
  </p:cSld>
  <p:clrMapOvr>
    <a:masterClrMapping/>
  </p:clrMapOvr>
</p:sldLayout>
</file>

<file path=ppt/slideLayouts/slideLayout46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9FEEBD7-B4B0-46A7-8458-09E1FF770B7D}" type="datetimeFigureOut">
              <a:rPr lang="ja-JP" altLang="en-US"/>
              <a:pPr>
                <a:defRPr/>
              </a:pPr>
              <a:t>2023/4/14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A63424-8DDA-4B3D-B1FF-12117B83A560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436773478"/>
      </p:ext>
    </p:extLst>
  </p:cSld>
  <p:clrMapOvr>
    <a:masterClrMapping/>
  </p:clrMapOvr>
</p:sldLayout>
</file>

<file path=ppt/slideLayouts/slideLayout47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1E61445-8C01-4498-A5EC-FA8F39BEC127}" type="datetimeFigureOut">
              <a:rPr lang="ja-JP" altLang="en-US"/>
              <a:pPr>
                <a:defRPr/>
              </a:pPr>
              <a:t>2023/4/14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25E9E3C-1228-4FAD-97D0-4F852D70F167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742525062"/>
      </p:ext>
    </p:extLst>
  </p:cSld>
  <p:clrMapOvr>
    <a:masterClrMapping/>
  </p:clrMapOvr>
</p:sldLayout>
</file>

<file path=ppt/slideLayouts/slideLayout4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F0BC134D-C924-4CDB-B546-A83E4B489FFB}" type="datetimeFigureOut">
              <a:rPr lang="ja-JP" altLang="en-US" smtClean="0"/>
              <a:pPr>
                <a:defRPr/>
              </a:pPr>
              <a:t>2023/4/14</a:t>
            </a:fld>
            <a:endParaRPr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6E021A52-D19A-43A2-9877-219ED6B95FF0}" type="slidenum">
              <a:rPr lang="ja-JP" altLang="en-US" smtClean="0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546116651"/>
      </p:ext>
    </p:extLst>
  </p:cSld>
  <p:clrMapOvr>
    <a:masterClrMapping/>
  </p:clrMapOvr>
</p:sldLayout>
</file>

<file path=ppt/slideLayouts/slideLayout49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A2A27A8F-30E3-425F-AE2A-3BC84A8D48BA}" type="datetimeFigureOut">
              <a:rPr lang="ja-JP" altLang="en-US" smtClean="0"/>
              <a:pPr>
                <a:defRPr/>
              </a:pPr>
              <a:t>2023/4/14</a:t>
            </a:fld>
            <a:endParaRPr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C0CBA753-ABEF-451B-BB95-B1B0E0112D60}" type="slidenum">
              <a:rPr lang="ja-JP" altLang="en-US" smtClean="0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411017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7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3A69703-A6EE-4C2C-9FDE-91A44AAAC1D9}" type="datetimeFigureOut">
              <a:rPr lang="ja-JP" altLang="en-US"/>
              <a:pPr>
                <a:defRPr/>
              </a:pPr>
              <a:t>2023/4/14</a:t>
            </a:fld>
            <a:endParaRPr lang="ja-JP" altLang="en-US"/>
          </a:p>
        </p:txBody>
      </p:sp>
      <p:sp>
        <p:nvSpPr>
          <p:cNvPr id="8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9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CAD4BC5-443C-4A06-A4C4-10ACDCB7255B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335398061"/>
      </p:ext>
    </p:extLst>
  </p:cSld>
  <p:clrMapOvr>
    <a:masterClrMapping/>
  </p:clrMapOvr>
</p:sldLayout>
</file>

<file path=ppt/slideLayouts/slideLayout50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5CF15771-7E89-4B3F-931C-77C80F3DF641}" type="datetimeFigureOut">
              <a:rPr lang="ja-JP" altLang="en-US" smtClean="0"/>
              <a:pPr>
                <a:defRPr/>
              </a:pPr>
              <a:t>2023/4/14</a:t>
            </a:fld>
            <a:endParaRPr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2FCAD168-B0F8-4D69-A5DC-96EEF1DBD401}" type="slidenum">
              <a:rPr lang="ja-JP" altLang="en-US" smtClean="0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313305659"/>
      </p:ext>
    </p:extLst>
  </p:cSld>
  <p:clrMapOvr>
    <a:masterClrMapping/>
  </p:clrMapOvr>
</p:sldLayout>
</file>

<file path=ppt/slideLayouts/slideLayout51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ABD43184-E3AC-4EB5-B737-0445A4D72DDC}" type="datetimeFigureOut">
              <a:rPr lang="ja-JP" altLang="en-US" smtClean="0"/>
              <a:pPr>
                <a:defRPr/>
              </a:pPr>
              <a:t>2023/4/14</a:t>
            </a:fld>
            <a:endParaRPr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EECA813A-6705-498C-863D-F1FEA2A893BC}" type="slidenum">
              <a:rPr lang="ja-JP" altLang="en-US" smtClean="0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529339915"/>
      </p:ext>
    </p:extLst>
  </p:cSld>
  <p:clrMapOvr>
    <a:masterClrMapping/>
  </p:clrMapOvr>
</p:sldLayout>
</file>

<file path=ppt/slideLayouts/slideLayout52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F4E7D245-6D52-4761-A018-6493AAC20110}" type="datetimeFigureOut">
              <a:rPr lang="ja-JP" altLang="en-US" smtClean="0"/>
              <a:pPr>
                <a:defRPr/>
              </a:pPr>
              <a:t>2023/4/14</a:t>
            </a:fld>
            <a:endParaRPr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80AC0EF5-497F-4E11-8923-21532EBD8501}" type="slidenum">
              <a:rPr lang="ja-JP" altLang="en-US" smtClean="0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381153995"/>
      </p:ext>
    </p:extLst>
  </p:cSld>
  <p:clrMapOvr>
    <a:masterClrMapping/>
  </p:clrMapOvr>
</p:sldLayout>
</file>

<file path=ppt/slideLayouts/slideLayout5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7B61E1F0-10CC-4D08-8569-E9372F2529C1}" type="datetimeFigureOut">
              <a:rPr lang="ja-JP" altLang="en-US" smtClean="0"/>
              <a:pPr>
                <a:defRPr/>
              </a:pPr>
              <a:t>2023/4/14</a:t>
            </a:fld>
            <a:endParaRPr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E9E02806-8E6A-4283-86FF-88F2DC40FBBD}" type="slidenum">
              <a:rPr lang="ja-JP" altLang="en-US" smtClean="0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010213527"/>
      </p:ext>
    </p:extLst>
  </p:cSld>
  <p:clrMapOvr>
    <a:masterClrMapping/>
  </p:clrMapOvr>
</p:sldLayout>
</file>

<file path=ppt/slideLayouts/slideLayout54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F6854E6E-8398-41AD-A787-578249D1D7E7}" type="datetimeFigureOut">
              <a:rPr lang="ja-JP" altLang="en-US" smtClean="0"/>
              <a:pPr>
                <a:defRPr/>
              </a:pPr>
              <a:t>2023/4/14</a:t>
            </a:fld>
            <a:endParaRPr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F883C7CB-669C-432C-A146-5ADB8EC34593}" type="slidenum">
              <a:rPr lang="ja-JP" altLang="en-US" smtClean="0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118745457"/>
      </p:ext>
    </p:extLst>
  </p:cSld>
  <p:clrMapOvr>
    <a:masterClrMapping/>
  </p:clrMapOvr>
</p:sldLayout>
</file>

<file path=ppt/slideLayouts/slideLayout55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2F7599D0-53D4-49F1-AAC7-0467D860B1AC}" type="datetimeFigureOut">
              <a:rPr lang="ja-JP" altLang="en-US" smtClean="0"/>
              <a:pPr>
                <a:defRPr/>
              </a:pPr>
              <a:t>2023/4/14</a:t>
            </a:fld>
            <a:endParaRPr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r>
              <a:rPr lang="en-US" altLang="ja-JP" dirty="0"/>
              <a:t>ACS Clinical Congress (Chicago)</a:t>
            </a:r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858644397"/>
      </p:ext>
    </p:extLst>
  </p:cSld>
  <p:clrMapOvr>
    <a:masterClrMapping/>
  </p:clrMapOvr>
</p:sldLayout>
</file>

<file path=ppt/slideLayouts/slideLayout56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E0029C57-2B7B-4C3E-BCFC-3CCAB150F193}" type="datetimeFigureOut">
              <a:rPr lang="ja-JP" altLang="en-US" smtClean="0"/>
              <a:pPr>
                <a:defRPr/>
              </a:pPr>
              <a:t>2023/4/14</a:t>
            </a:fld>
            <a:endParaRPr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336A8008-687B-4C6C-B856-C814CE4B6EE1}" type="slidenum">
              <a:rPr lang="ja-JP" altLang="en-US" smtClean="0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341222981"/>
      </p:ext>
    </p:extLst>
  </p:cSld>
  <p:clrMapOvr>
    <a:masterClrMapping/>
  </p:clrMapOvr>
</p:sldLayout>
</file>

<file path=ppt/slideLayouts/slideLayout57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2F7599D0-53D4-49F1-AAC7-0467D860B1AC}" type="datetimeFigureOut">
              <a:rPr lang="ja-JP" altLang="en-US" smtClean="0"/>
              <a:pPr>
                <a:defRPr/>
              </a:pPr>
              <a:t>2023/4/14</a:t>
            </a:fld>
            <a:endParaRPr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r>
              <a:rPr lang="en-US" altLang="ja-JP" dirty="0"/>
              <a:t>ACS Clinical Congress (Chicago)</a:t>
            </a:r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558567881"/>
      </p:ext>
    </p:extLst>
  </p:cSld>
  <p:clrMapOvr>
    <a:masterClrMapping/>
  </p:clrMapOvr>
</p:sldLayout>
</file>

<file path=ppt/slideLayouts/slideLayout58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3A7F1751-9822-4FDB-8910-ED91CC3A0941}" type="datetimeFigureOut">
              <a:rPr lang="ja-JP" altLang="en-US" smtClean="0"/>
              <a:pPr>
                <a:defRPr/>
              </a:pPr>
              <a:t>2023/4/14</a:t>
            </a:fld>
            <a:endParaRPr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93A5A4D5-89CA-42D2-BDA0-CD1CA3F22907}" type="slidenum">
              <a:rPr lang="ja-JP" altLang="en-US" smtClean="0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6671913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2548A58-ABEC-4751-B426-E04C0C0D86C5}" type="datetimeFigureOut">
              <a:rPr lang="ja-JP" altLang="en-US"/>
              <a:pPr>
                <a:defRPr/>
              </a:pPr>
              <a:t>2023/4/14</a:t>
            </a:fld>
            <a:endParaRPr lang="ja-JP" altLang="en-US"/>
          </a:p>
        </p:txBody>
      </p:sp>
      <p:sp>
        <p:nvSpPr>
          <p:cNvPr id="4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5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B7B0655-6A77-4CF5-A3B9-24BDB2E074A8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7446173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76839BF-7D9D-4260-B0E5-52A9741A578A}" type="datetimeFigureOut">
              <a:rPr lang="ja-JP" altLang="en-US"/>
              <a:pPr>
                <a:defRPr/>
              </a:pPr>
              <a:t>2023/4/14</a:t>
            </a:fld>
            <a:endParaRPr lang="ja-JP" altLang="en-US"/>
          </a:p>
        </p:txBody>
      </p:sp>
      <p:sp>
        <p:nvSpPr>
          <p:cNvPr id="3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4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F8CA4ED-565A-4928-AD52-9876EF19C2A3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  <p:sp>
        <p:nvSpPr>
          <p:cNvPr id="5" name="角丸四角形 4"/>
          <p:cNvSpPr/>
          <p:nvPr userDrawn="1"/>
        </p:nvSpPr>
        <p:spPr>
          <a:xfrm>
            <a:off x="5355101" y="6545596"/>
            <a:ext cx="3886399" cy="273050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r" eaLnBrk="1" hangingPunct="1">
              <a:defRPr/>
            </a:pPr>
            <a:r>
              <a:rPr lang="en-US" altLang="ja-JP" b="1" dirty="0">
                <a:solidFill>
                  <a:schemeClr val="tx1">
                    <a:lumMod val="95000"/>
                  </a:schemeClr>
                </a:solidFill>
                <a:latin typeface="ParkAvenue BT" panose="03020602050506080705" pitchFamily="66" charset="0"/>
              </a:rPr>
              <a:t>104</a:t>
            </a:r>
            <a:r>
              <a:rPr lang="en-US" altLang="ja-JP" b="1" baseline="30000" dirty="0">
                <a:solidFill>
                  <a:schemeClr val="tx1">
                    <a:lumMod val="95000"/>
                  </a:schemeClr>
                </a:solidFill>
                <a:latin typeface="ParkAvenue BT" panose="03020602050506080705" pitchFamily="66" charset="0"/>
              </a:rPr>
              <a:t>st</a:t>
            </a:r>
            <a:r>
              <a:rPr lang="en-US" altLang="ja-JP" b="1" dirty="0">
                <a:solidFill>
                  <a:schemeClr val="tx1">
                    <a:lumMod val="95000"/>
                  </a:schemeClr>
                </a:solidFill>
                <a:latin typeface="ParkAvenue BT" panose="03020602050506080705" pitchFamily="66" charset="0"/>
              </a:rPr>
              <a:t> ACS Clinical Congress 2015 (Boston)</a:t>
            </a:r>
            <a:endParaRPr lang="ja-JP" altLang="en-US" b="1" dirty="0">
              <a:solidFill>
                <a:schemeClr val="tx1">
                  <a:lumMod val="95000"/>
                </a:schemeClr>
              </a:solidFill>
              <a:latin typeface="ParkAvenue BT" panose="03020602050506080705" pitchFamily="66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779836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ED991E7-CB27-4B35-8B0B-FE98B52917F4}" type="datetimeFigureOut">
              <a:rPr lang="ja-JP" altLang="en-US"/>
              <a:pPr>
                <a:defRPr/>
              </a:pPr>
              <a:t>2023/4/14</a:t>
            </a:fld>
            <a:endParaRPr lang="ja-JP" altLang="en-US"/>
          </a:p>
        </p:txBody>
      </p:sp>
      <p:sp>
        <p:nvSpPr>
          <p:cNvPr id="6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3AB5841-C286-402A-A7BF-DF8BF1156510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7879074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ja-JP" altLang="en-US" noProof="0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7058637-993A-46BE-817D-AC2066B85070}" type="datetimeFigureOut">
              <a:rPr lang="ja-JP" altLang="en-US"/>
              <a:pPr>
                <a:defRPr/>
              </a:pPr>
              <a:t>2023/4/14</a:t>
            </a:fld>
            <a:endParaRPr lang="ja-JP" altLang="en-US"/>
          </a:p>
        </p:txBody>
      </p:sp>
      <p:sp>
        <p:nvSpPr>
          <p:cNvPr id="6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48F23D4-0D95-4D08-ADE0-129E477B99FD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5307412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image" Target="NUL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13" Type="http://schemas.openxmlformats.org/officeDocument/2006/relationships/slideLayout" Target="../slideLayouts/slideLayout36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slideLayout" Target="../slideLayouts/slideLayout35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Relationship Id="rId14" Type="http://schemas.openxmlformats.org/officeDocument/2006/relationships/theme" Target="../theme/theme3.xml"/></Relationships>
</file>

<file path=ppt/slideMasters/_rels/slideMaster4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44.xml"/><Relationship Id="rId3" Type="http://schemas.openxmlformats.org/officeDocument/2006/relationships/slideLayout" Target="../slideLayouts/slideLayout39.xml"/><Relationship Id="rId7" Type="http://schemas.openxmlformats.org/officeDocument/2006/relationships/slideLayout" Target="../slideLayouts/slideLayout43.xml"/><Relationship Id="rId12" Type="http://schemas.openxmlformats.org/officeDocument/2006/relationships/theme" Target="../theme/theme4.xml"/><Relationship Id="rId2" Type="http://schemas.openxmlformats.org/officeDocument/2006/relationships/slideLayout" Target="../slideLayouts/slideLayout38.xml"/><Relationship Id="rId1" Type="http://schemas.openxmlformats.org/officeDocument/2006/relationships/slideLayout" Target="../slideLayouts/slideLayout37.xml"/><Relationship Id="rId6" Type="http://schemas.openxmlformats.org/officeDocument/2006/relationships/slideLayout" Target="../slideLayouts/slideLayout42.xml"/><Relationship Id="rId11" Type="http://schemas.openxmlformats.org/officeDocument/2006/relationships/slideLayout" Target="../slideLayouts/slideLayout47.xml"/><Relationship Id="rId5" Type="http://schemas.openxmlformats.org/officeDocument/2006/relationships/slideLayout" Target="../slideLayouts/slideLayout41.xml"/><Relationship Id="rId10" Type="http://schemas.openxmlformats.org/officeDocument/2006/relationships/slideLayout" Target="../slideLayouts/slideLayout46.xml"/><Relationship Id="rId4" Type="http://schemas.openxmlformats.org/officeDocument/2006/relationships/slideLayout" Target="../slideLayouts/slideLayout40.xml"/><Relationship Id="rId9" Type="http://schemas.openxmlformats.org/officeDocument/2006/relationships/slideLayout" Target="../slideLayouts/slideLayout45.xml"/></Relationships>
</file>

<file path=ppt/slideMasters/_rels/slideMaster5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55.xml"/><Relationship Id="rId3" Type="http://schemas.openxmlformats.org/officeDocument/2006/relationships/slideLayout" Target="../slideLayouts/slideLayout50.xml"/><Relationship Id="rId7" Type="http://schemas.openxmlformats.org/officeDocument/2006/relationships/slideLayout" Target="../slideLayouts/slideLayout54.xml"/><Relationship Id="rId12" Type="http://schemas.openxmlformats.org/officeDocument/2006/relationships/theme" Target="../theme/theme5.xml"/><Relationship Id="rId2" Type="http://schemas.openxmlformats.org/officeDocument/2006/relationships/slideLayout" Target="../slideLayouts/slideLayout49.xml"/><Relationship Id="rId1" Type="http://schemas.openxmlformats.org/officeDocument/2006/relationships/slideLayout" Target="../slideLayouts/slideLayout48.xml"/><Relationship Id="rId6" Type="http://schemas.openxmlformats.org/officeDocument/2006/relationships/slideLayout" Target="../slideLayouts/slideLayout53.xml"/><Relationship Id="rId11" Type="http://schemas.openxmlformats.org/officeDocument/2006/relationships/slideLayout" Target="../slideLayouts/slideLayout58.xml"/><Relationship Id="rId5" Type="http://schemas.openxmlformats.org/officeDocument/2006/relationships/slideLayout" Target="../slideLayouts/slideLayout52.xml"/><Relationship Id="rId10" Type="http://schemas.openxmlformats.org/officeDocument/2006/relationships/slideLayout" Target="../slideLayouts/slideLayout57.xml"/><Relationship Id="rId4" Type="http://schemas.openxmlformats.org/officeDocument/2006/relationships/slideLayout" Target="../slideLayouts/slideLayout51.xml"/><Relationship Id="rId9" Type="http://schemas.openxmlformats.org/officeDocument/2006/relationships/slideLayout" Target="../slideLayouts/slideLayout56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gradFill flip="none" rotWithShape="1">
          <a:gsLst>
            <a:gs pos="0">
              <a:schemeClr val="bg2">
                <a:tint val="80000"/>
                <a:satMod val="300000"/>
              </a:schemeClr>
            </a:gs>
            <a:gs pos="100000">
              <a:schemeClr val="bg2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  <a:tileRect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タイトル プレースホルダー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ー タイトルの書式設定</a:t>
            </a:r>
          </a:p>
        </p:txBody>
      </p:sp>
      <p:sp>
        <p:nvSpPr>
          <p:cNvPr id="1027" name="テキスト プレースホルダー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</a:defRPr>
            </a:lvl1pPr>
          </a:lstStyle>
          <a:p>
            <a:pPr>
              <a:defRPr/>
            </a:pPr>
            <a:fld id="{CA941B50-C356-49E5-B579-74442CB60440}" type="datetimeFigureOut">
              <a:rPr lang="ja-JP" altLang="en-US"/>
              <a:pPr>
                <a:defRPr/>
              </a:pPr>
              <a:t>2023/4/14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C918BDD1-99D2-42DE-9EEB-28F3519A6AD1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  <p:pic>
        <p:nvPicPr>
          <p:cNvPr id="9" name="図 8"/>
          <p:cNvPicPr>
            <a:picLocks noChangeAspect="1"/>
          </p:cNvPicPr>
          <p:nvPr userDrawn="1"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165" y="90046"/>
            <a:ext cx="672723" cy="551147"/>
          </a:xfrm>
          <a:prstGeom prst="rect">
            <a:avLst/>
          </a:prstGeom>
        </p:spPr>
      </p:pic>
    </p:spTree>
  </p:cSld>
  <p:clrMap bg1="lt1" tx1="dk1" bg2="lt2" tx2="dk2" accent1="accent1" accent2="accent2" accent3="accent3" accent4="accent4" accent5="accent5" accent6="accent6" hlink="hlink" folHlink="folHlink"/>
  <p:sldLayoutIdLst>
    <p:sldLayoutId id="2147484548" r:id="rId1"/>
    <p:sldLayoutId id="2147484549" r:id="rId2"/>
    <p:sldLayoutId id="2147484550" r:id="rId3"/>
    <p:sldLayoutId id="2147484551" r:id="rId4"/>
    <p:sldLayoutId id="2147484552" r:id="rId5"/>
    <p:sldLayoutId id="2147484553" r:id="rId6"/>
    <p:sldLayoutId id="2147484554" r:id="rId7"/>
    <p:sldLayoutId id="2147484555" r:id="rId8"/>
    <p:sldLayoutId id="2147484556" r:id="rId9"/>
    <p:sldLayoutId id="2147484557" r:id="rId10"/>
    <p:sldLayoutId id="2147484558" r:id="rId11"/>
    <p:sldLayoutId id="2147484626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gradFill flip="none" rotWithShape="1">
          <a:gsLst>
            <a:gs pos="0">
              <a:schemeClr val="bg2">
                <a:tint val="80000"/>
                <a:satMod val="300000"/>
              </a:schemeClr>
            </a:gs>
            <a:gs pos="100000">
              <a:schemeClr val="bg2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  <a:tileRect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628650" y="365125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628650" y="6356350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D9F448-50E7-4A11-9766-5C4DEDB4FA24}" type="datetimeFigureOut">
              <a:rPr kumimoji="1" lang="ja-JP" altLang="en-US" smtClean="0"/>
              <a:t>2023/4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028950" y="6356350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457950" y="6356350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E07A92-6826-4834-AAC6-0650C2993E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564294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4615" r:id="rId1"/>
    <p:sldLayoutId id="2147484616" r:id="rId2"/>
    <p:sldLayoutId id="2147484617" r:id="rId3"/>
    <p:sldLayoutId id="2147484618" r:id="rId4"/>
    <p:sldLayoutId id="2147484619" r:id="rId5"/>
    <p:sldLayoutId id="2147484620" r:id="rId6"/>
    <p:sldLayoutId id="2147484621" r:id="rId7"/>
    <p:sldLayoutId id="2147484622" r:id="rId8"/>
    <p:sldLayoutId id="2147484623" r:id="rId9"/>
    <p:sldLayoutId id="2147484624" r:id="rId10"/>
    <p:sldLayoutId id="2147484625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gradFill flip="none" rotWithShape="1">
          <a:gsLst>
            <a:gs pos="0">
              <a:schemeClr val="bg2">
                <a:tint val="80000"/>
                <a:satMod val="300000"/>
              </a:schemeClr>
            </a:gs>
            <a:gs pos="100000">
              <a:schemeClr val="bg2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  <a:tileRect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タイトル プレースホルダー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ー タイトルの書式設定</a:t>
            </a:r>
          </a:p>
        </p:txBody>
      </p:sp>
      <p:sp>
        <p:nvSpPr>
          <p:cNvPr id="2051" name="テキスト プレースホルダー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</a:defRPr>
            </a:lvl1pPr>
          </a:lstStyle>
          <a:p>
            <a:pPr>
              <a:defRPr/>
            </a:pPr>
            <a:fld id="{2F7599D0-53D4-49F1-AAC7-0467D860B1AC}" type="datetimeFigureOut">
              <a:rPr lang="ja-JP" altLang="en-US"/>
              <a:pPr>
                <a:defRPr/>
              </a:pPr>
              <a:t>2023/4/14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011863" y="6356350"/>
            <a:ext cx="2674937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accent6">
                    <a:lumMod val="60000"/>
                    <a:lumOff val="40000"/>
                  </a:schemeClr>
                </a:solidFill>
                <a:latin typeface="MV Boli" pitchFamily="2" charset="0"/>
                <a:cs typeface="MV Boli" pitchFamily="2" charset="0"/>
              </a:defRPr>
            </a:lvl1pPr>
          </a:lstStyle>
          <a:p>
            <a:pPr>
              <a:defRPr/>
            </a:pPr>
            <a:r>
              <a:rPr lang="en-US" altLang="ja-JP" dirty="0"/>
              <a:t>ACS Clinical Congress (Chicago)</a:t>
            </a:r>
            <a:endParaRPr lang="ja-JP" altLang="en-US" dirty="0"/>
          </a:p>
        </p:txBody>
      </p:sp>
    </p:spTree>
  </p:cSld>
  <p:clrMap bg1="dk1" tx1="lt1" bg2="dk2" tx2="lt2" accent1="accent1" accent2="accent2" accent3="accent3" accent4="accent4" accent5="accent5" accent6="accent6" hlink="hlink" folHlink="folHlink"/>
  <p:sldLayoutIdLst>
    <p:sldLayoutId id="2147484571" r:id="rId1"/>
    <p:sldLayoutId id="2147484572" r:id="rId2"/>
    <p:sldLayoutId id="2147484573" r:id="rId3"/>
    <p:sldLayoutId id="2147484574" r:id="rId4"/>
    <p:sldLayoutId id="2147484575" r:id="rId5"/>
    <p:sldLayoutId id="2147484576" r:id="rId6"/>
    <p:sldLayoutId id="2147484577" r:id="rId7"/>
    <p:sldLayoutId id="2147484578" r:id="rId8"/>
    <p:sldLayoutId id="2147484579" r:id="rId9"/>
    <p:sldLayoutId id="2147484580" r:id="rId10"/>
    <p:sldLayoutId id="2147484581" r:id="rId11"/>
    <p:sldLayoutId id="2147484559" r:id="rId12"/>
    <p:sldLayoutId id="2147484613" r:id="rId13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4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gradFill flip="none" rotWithShape="1">
          <a:gsLst>
            <a:gs pos="0">
              <a:schemeClr val="bg2">
                <a:tint val="80000"/>
                <a:satMod val="300000"/>
              </a:schemeClr>
            </a:gs>
            <a:gs pos="100000">
              <a:schemeClr val="bg2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  <a:tileRect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タイトル プレースホルダー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ー タイトルの書式設定</a:t>
            </a:r>
          </a:p>
        </p:txBody>
      </p:sp>
      <p:sp>
        <p:nvSpPr>
          <p:cNvPr id="3075" name="テキスト プレースホルダー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</a:defRPr>
            </a:lvl1pPr>
          </a:lstStyle>
          <a:p>
            <a:pPr>
              <a:defRPr/>
            </a:pPr>
            <a:fld id="{FD7D85FB-4F6A-4BCD-9AA3-C600EE11A100}" type="datetimeFigureOut">
              <a:rPr lang="ja-JP" altLang="en-US"/>
              <a:pPr>
                <a:defRPr/>
              </a:pPr>
              <a:t>2023/4/14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EEA1FE4E-61D8-43FB-977C-EA3CCDFEC41F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560" r:id="rId1"/>
    <p:sldLayoutId id="2147484561" r:id="rId2"/>
    <p:sldLayoutId id="2147484562" r:id="rId3"/>
    <p:sldLayoutId id="2147484563" r:id="rId4"/>
    <p:sldLayoutId id="2147484564" r:id="rId5"/>
    <p:sldLayoutId id="2147484565" r:id="rId6"/>
    <p:sldLayoutId id="2147484566" r:id="rId7"/>
    <p:sldLayoutId id="2147484567" r:id="rId8"/>
    <p:sldLayoutId id="2147484568" r:id="rId9"/>
    <p:sldLayoutId id="2147484569" r:id="rId10"/>
    <p:sldLayoutId id="2147484570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5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CA941B50-C356-49E5-B579-74442CB60440}" type="datetimeFigureOut">
              <a:rPr lang="ja-JP" altLang="en-US" smtClean="0"/>
              <a:pPr>
                <a:defRPr/>
              </a:pPr>
              <a:t>2023/4/14</a:t>
            </a:fld>
            <a:endParaRPr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C918BDD1-99D2-42DE-9EEB-28F3519A6AD1}" type="slidenum">
              <a:rPr lang="ja-JP" altLang="en-US" smtClean="0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41083890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4745" r:id="rId1"/>
    <p:sldLayoutId id="2147484746" r:id="rId2"/>
    <p:sldLayoutId id="2147484747" r:id="rId3"/>
    <p:sldLayoutId id="2147484748" r:id="rId4"/>
    <p:sldLayoutId id="2147484749" r:id="rId5"/>
    <p:sldLayoutId id="2147484750" r:id="rId6"/>
    <p:sldLayoutId id="2147484751" r:id="rId7"/>
    <p:sldLayoutId id="2147484752" r:id="rId8"/>
    <p:sldLayoutId id="2147484753" r:id="rId9"/>
    <p:sldLayoutId id="2147484754" r:id="rId10"/>
    <p:sldLayoutId id="2147484755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54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48.xml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48.xml"/><Relationship Id="rId4" Type="http://schemas.openxmlformats.org/officeDocument/2006/relationships/image" Target="../media/image4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53.xml"/><Relationship Id="rId4" Type="http://schemas.openxmlformats.org/officeDocument/2006/relationships/image" Target="../media/image6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48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49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54159D58-5A2D-49D6-8D7A-B1D7B2CCCD14}"/>
              </a:ext>
            </a:extLst>
          </p:cNvPr>
          <p:cNvSpPr txBox="1"/>
          <p:nvPr/>
        </p:nvSpPr>
        <p:spPr>
          <a:xfrm>
            <a:off x="1464720" y="1607596"/>
            <a:ext cx="5421417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cs typeface="Arial" panose="020B0604020202020204" pitchFamily="34" charset="0"/>
              </a:rPr>
              <a:t>Esophageal cancer patients who underwent subtotal esophagectomy</a:t>
            </a:r>
            <a:r>
              <a:rPr lang="ja-JP" altLang="en-US" sz="1200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cs typeface="Arial" panose="020B0604020202020204" pitchFamily="34" charset="0"/>
              </a:rPr>
              <a:t> </a:t>
            </a:r>
            <a:r>
              <a:rPr lang="en-US" altLang="ja-JP" sz="1200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cs typeface="Arial" panose="020B0604020202020204" pitchFamily="34" charset="0"/>
              </a:rPr>
              <a:t>with</a:t>
            </a:r>
            <a:r>
              <a:rPr lang="ja-JP" altLang="en-US" sz="1200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cs typeface="Arial" panose="020B0604020202020204" pitchFamily="34" charset="0"/>
              </a:rPr>
              <a:t> </a:t>
            </a:r>
            <a:r>
              <a:rPr lang="en-US" altLang="ja-JP" sz="1200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cs typeface="Arial" panose="020B0604020202020204" pitchFamily="34" charset="0"/>
              </a:rPr>
              <a:t>gastric tube  reconstruction</a:t>
            </a:r>
          </a:p>
          <a:p>
            <a:pPr algn="ctr"/>
            <a:r>
              <a:rPr lang="en-US" altLang="ja-JP" sz="1200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cs typeface="Arial" panose="020B0604020202020204" pitchFamily="34" charset="0"/>
              </a:rPr>
              <a:t>(n= 246, 2008-2020)</a:t>
            </a:r>
          </a:p>
        </p:txBody>
      </p:sp>
      <p:sp>
        <p:nvSpPr>
          <p:cNvPr id="6" name="矢印: 下 5">
            <a:extLst>
              <a:ext uri="{FF2B5EF4-FFF2-40B4-BE49-F238E27FC236}">
                <a16:creationId xmlns:a16="http://schemas.microsoft.com/office/drawing/2014/main" id="{444F4092-C406-4E2B-9358-5AD90E878136}"/>
              </a:ext>
            </a:extLst>
          </p:cNvPr>
          <p:cNvSpPr/>
          <p:nvPr/>
        </p:nvSpPr>
        <p:spPr>
          <a:xfrm rot="3274935">
            <a:off x="3100067" y="3673051"/>
            <a:ext cx="405573" cy="1487609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7FDAA441-A788-41E4-9C10-CFD89ADF3EC9}"/>
              </a:ext>
            </a:extLst>
          </p:cNvPr>
          <p:cNvSpPr txBox="1"/>
          <p:nvPr/>
        </p:nvSpPr>
        <p:spPr>
          <a:xfrm>
            <a:off x="551204" y="5028976"/>
            <a:ext cx="3349257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cs typeface="Arial" panose="020B0604020202020204" pitchFamily="34" charset="0"/>
              </a:rPr>
              <a:t>Anastomotic leakage (-) </a:t>
            </a:r>
          </a:p>
          <a:p>
            <a:pPr algn="ctr"/>
            <a:r>
              <a:rPr lang="en-US" altLang="ja-JP" sz="1200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cs typeface="Arial" panose="020B0604020202020204" pitchFamily="34" charset="0"/>
              </a:rPr>
              <a:t>(n= 179)</a:t>
            </a: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34A17766-BF43-050D-3E88-F0EFBF1547DC}"/>
              </a:ext>
            </a:extLst>
          </p:cNvPr>
          <p:cNvSpPr txBox="1"/>
          <p:nvPr/>
        </p:nvSpPr>
        <p:spPr>
          <a:xfrm>
            <a:off x="4860032" y="5013176"/>
            <a:ext cx="3096344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cs typeface="Arial" panose="020B0604020202020204" pitchFamily="34" charset="0"/>
              </a:rPr>
              <a:t>  Anastomotic leakage  (+)</a:t>
            </a:r>
          </a:p>
          <a:p>
            <a:pPr algn="ctr"/>
            <a:r>
              <a:rPr lang="en-US" altLang="ja-JP" sz="1200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cs typeface="Arial" panose="020B0604020202020204" pitchFamily="34" charset="0"/>
              </a:rPr>
              <a:t>(n= 23)</a:t>
            </a:r>
          </a:p>
        </p:txBody>
      </p:sp>
      <p:sp>
        <p:nvSpPr>
          <p:cNvPr id="8" name="矢印: 下 7">
            <a:extLst>
              <a:ext uri="{FF2B5EF4-FFF2-40B4-BE49-F238E27FC236}">
                <a16:creationId xmlns:a16="http://schemas.microsoft.com/office/drawing/2014/main" id="{393DC581-0717-BED5-B19F-A3F1179C43A7}"/>
              </a:ext>
            </a:extLst>
          </p:cNvPr>
          <p:cNvSpPr/>
          <p:nvPr/>
        </p:nvSpPr>
        <p:spPr>
          <a:xfrm>
            <a:off x="3900461" y="2382921"/>
            <a:ext cx="382779" cy="1597829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矢印: 下 8">
            <a:extLst>
              <a:ext uri="{FF2B5EF4-FFF2-40B4-BE49-F238E27FC236}">
                <a16:creationId xmlns:a16="http://schemas.microsoft.com/office/drawing/2014/main" id="{20CE6ACB-6B0F-FCBE-73B5-D04B8122ABEE}"/>
              </a:ext>
            </a:extLst>
          </p:cNvPr>
          <p:cNvSpPr/>
          <p:nvPr/>
        </p:nvSpPr>
        <p:spPr>
          <a:xfrm rot="18442880">
            <a:off x="4687594" y="3680844"/>
            <a:ext cx="405573" cy="1487609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矢印: 下 9">
            <a:extLst>
              <a:ext uri="{FF2B5EF4-FFF2-40B4-BE49-F238E27FC236}">
                <a16:creationId xmlns:a16="http://schemas.microsoft.com/office/drawing/2014/main" id="{6890CA2B-A849-1E70-8872-CF7CDB6FD845}"/>
              </a:ext>
            </a:extLst>
          </p:cNvPr>
          <p:cNvSpPr/>
          <p:nvPr/>
        </p:nvSpPr>
        <p:spPr>
          <a:xfrm rot="16200000">
            <a:off x="4284125" y="2851120"/>
            <a:ext cx="323195" cy="540587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286FDC59-3838-1280-6313-DFF30156CAE2}"/>
              </a:ext>
            </a:extLst>
          </p:cNvPr>
          <p:cNvSpPr txBox="1"/>
          <p:nvPr/>
        </p:nvSpPr>
        <p:spPr>
          <a:xfrm>
            <a:off x="4737358" y="2879066"/>
            <a:ext cx="3096344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ja-JP" sz="1000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cs typeface="Arial" panose="020B0604020202020204" pitchFamily="34" charset="0"/>
              </a:rPr>
              <a:t>Exclusion</a:t>
            </a:r>
          </a:p>
          <a:p>
            <a:r>
              <a:rPr lang="ja-JP" altLang="en-US" sz="1000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cs typeface="Arial" panose="020B0604020202020204" pitchFamily="34" charset="0"/>
              </a:rPr>
              <a:t>・</a:t>
            </a:r>
            <a:r>
              <a:rPr lang="en-US" altLang="ja-JP" sz="1000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cs typeface="Arial" panose="020B0604020202020204" pitchFamily="34" charset="0"/>
              </a:rPr>
              <a:t>Posterior mediastinal reconstruction (n = 25)</a:t>
            </a:r>
          </a:p>
          <a:p>
            <a:r>
              <a:rPr lang="ja-JP" altLang="en-US" sz="1000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cs typeface="Arial" panose="020B0604020202020204" pitchFamily="34" charset="0"/>
              </a:rPr>
              <a:t>・</a:t>
            </a:r>
            <a:r>
              <a:rPr lang="en-US" altLang="ja-JP" sz="1000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cs typeface="Arial" panose="020B0604020202020204" pitchFamily="34" charset="0"/>
              </a:rPr>
              <a:t>Subcutaneous reconstruction (n = 15)</a:t>
            </a:r>
          </a:p>
          <a:p>
            <a:r>
              <a:rPr lang="ja-JP" altLang="en-US" sz="1000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cs typeface="Arial" panose="020B0604020202020204" pitchFamily="34" charset="0"/>
              </a:rPr>
              <a:t>・</a:t>
            </a:r>
            <a:r>
              <a:rPr lang="en-US" altLang="ja-JP" sz="1000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cs typeface="Arial" panose="020B0604020202020204" pitchFamily="34" charset="0"/>
              </a:rPr>
              <a:t>No perioperative CT (n= 2) and TG (n = 2)</a:t>
            </a: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FB836C8D-241E-3C73-6E07-FED3E692C56E}"/>
              </a:ext>
            </a:extLst>
          </p:cNvPr>
          <p:cNvSpPr txBox="1"/>
          <p:nvPr/>
        </p:nvSpPr>
        <p:spPr>
          <a:xfrm>
            <a:off x="179512" y="188640"/>
            <a:ext cx="23996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/>
              <a:t>Supplementary Figure 1</a:t>
            </a:r>
            <a:endParaRPr kumimoji="1" lang="ja-JP" altLang="en-US" sz="1200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1749" name="グループ化 16">
            <a:extLst>
              <a:ext uri="{FF2B5EF4-FFF2-40B4-BE49-F238E27FC236}">
                <a16:creationId xmlns:a16="http://schemas.microsoft.com/office/drawing/2014/main" id="{96D2B61B-DBA1-4BC7-B978-BAF546259D5E}"/>
              </a:ext>
            </a:extLst>
          </p:cNvPr>
          <p:cNvGrpSpPr>
            <a:grpSpLocks/>
          </p:cNvGrpSpPr>
          <p:nvPr/>
        </p:nvGrpSpPr>
        <p:grpSpPr bwMode="auto">
          <a:xfrm>
            <a:off x="5124658" y="2121457"/>
            <a:ext cx="3011877" cy="3222911"/>
            <a:chOff x="6601884" y="1751387"/>
            <a:chExt cx="2505540" cy="2681734"/>
          </a:xfrm>
        </p:grpSpPr>
        <p:pic>
          <p:nvPicPr>
            <p:cNvPr id="31763" name="図 17">
              <a:extLst>
                <a:ext uri="{FF2B5EF4-FFF2-40B4-BE49-F238E27FC236}">
                  <a16:creationId xmlns:a16="http://schemas.microsoft.com/office/drawing/2014/main" id="{D3E1CEA1-1499-41EC-8D34-94A688EB05D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112" t="8627" r="19693" b="8896"/>
            <a:stretch/>
          </p:blipFill>
          <p:spPr bwMode="auto">
            <a:xfrm>
              <a:off x="6601884" y="2000538"/>
              <a:ext cx="1922885" cy="2432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0" name="正方形/長方形 19">
              <a:extLst>
                <a:ext uri="{FF2B5EF4-FFF2-40B4-BE49-F238E27FC236}">
                  <a16:creationId xmlns:a16="http://schemas.microsoft.com/office/drawing/2014/main" id="{5D3E57F9-BDE9-4529-8CD1-9AFCB77FA625}"/>
                </a:ext>
              </a:extLst>
            </p:cNvPr>
            <p:cNvSpPr/>
            <p:nvPr/>
          </p:nvSpPr>
          <p:spPr>
            <a:xfrm>
              <a:off x="8316632" y="1751387"/>
              <a:ext cx="790792" cy="95051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1750" name="テキスト ボックス 24">
            <a:extLst>
              <a:ext uri="{FF2B5EF4-FFF2-40B4-BE49-F238E27FC236}">
                <a16:creationId xmlns:a16="http://schemas.microsoft.com/office/drawing/2014/main" id="{786F4C5E-9D13-4AE3-8BC1-E78738FDE57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04369" y="5614593"/>
            <a:ext cx="1349541" cy="276999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square">
            <a:spAutoFit/>
          </a:bodyPr>
          <a:lstStyle>
            <a:lvl1pPr eaLnBrk="0" hangingPunct="0">
              <a:defRPr kumimoji="1" sz="21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 sz="21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 sz="21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 sz="21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 sz="21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1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1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1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1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50" charset="-128"/>
              </a:defRPr>
            </a:lvl9pPr>
          </a:lstStyle>
          <a:p>
            <a:pPr algn="ctr" eaLnBrk="1" hangingPunct="1"/>
            <a:r>
              <a:rPr lang="en-US" altLang="ja-JP" sz="1200" b="1" dirty="0">
                <a:latin typeface="Arial" panose="020B0604020202020204" pitchFamily="34" charset="0"/>
                <a:ea typeface="HGS創英角ｺﾞｼｯｸUB" panose="020B0900000000000000" pitchFamily="50" charset="-128"/>
                <a:cs typeface="Arial" panose="020B0604020202020204" pitchFamily="34" charset="0"/>
              </a:rPr>
              <a:t>PTD: 18.2mm</a:t>
            </a:r>
            <a:endParaRPr lang="ja-JP" altLang="en-US" sz="1200" b="1" baseline="30000" dirty="0">
              <a:latin typeface="Arial" panose="020B0604020202020204" pitchFamily="34" charset="0"/>
              <a:ea typeface="HGS創英角ｺﾞｼｯｸUB" panose="020B09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31751" name="テキスト ボックス 25">
            <a:extLst>
              <a:ext uri="{FF2B5EF4-FFF2-40B4-BE49-F238E27FC236}">
                <a16:creationId xmlns:a16="http://schemas.microsoft.com/office/drawing/2014/main" id="{C412AA92-6A52-4CF0-8BF3-B13BFA6E795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77084" y="5505298"/>
            <a:ext cx="1206621" cy="276999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square">
            <a:spAutoFit/>
          </a:bodyPr>
          <a:lstStyle>
            <a:lvl1pPr eaLnBrk="0" hangingPunct="0">
              <a:defRPr kumimoji="1" sz="21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 sz="21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 sz="21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 sz="21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 sz="21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1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1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1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1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50" charset="-128"/>
              </a:defRPr>
            </a:lvl9pPr>
          </a:lstStyle>
          <a:p>
            <a:pPr algn="ctr" eaLnBrk="1" hangingPunct="1"/>
            <a:r>
              <a:rPr lang="en-US" altLang="ja-JP" sz="1200" b="1" dirty="0">
                <a:latin typeface="Arial" panose="020B0604020202020204" pitchFamily="34" charset="0"/>
                <a:ea typeface="HGS創英角ｺﾞｼｯｸUB" panose="020B0900000000000000" pitchFamily="50" charset="-128"/>
                <a:cs typeface="Arial" panose="020B0604020202020204" pitchFamily="34" charset="0"/>
              </a:rPr>
              <a:t>PTD: 7.2mm</a:t>
            </a:r>
            <a:endParaRPr lang="ja-JP" altLang="en-US" sz="1200" b="1" baseline="30000" dirty="0">
              <a:latin typeface="Arial" panose="020B0604020202020204" pitchFamily="34" charset="0"/>
              <a:ea typeface="HGS創英角ｺﾞｼｯｸUB" panose="020B09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29" name="正方形/長方形 28">
            <a:extLst>
              <a:ext uri="{FF2B5EF4-FFF2-40B4-BE49-F238E27FC236}">
                <a16:creationId xmlns:a16="http://schemas.microsoft.com/office/drawing/2014/main" id="{7920F1D7-5340-43E5-8FD5-9079C6DDD2C5}"/>
              </a:ext>
            </a:extLst>
          </p:cNvPr>
          <p:cNvSpPr/>
          <p:nvPr/>
        </p:nvSpPr>
        <p:spPr>
          <a:xfrm>
            <a:off x="1466081" y="2815162"/>
            <a:ext cx="730715" cy="911718"/>
          </a:xfrm>
          <a:prstGeom prst="rect">
            <a:avLst/>
          </a:prstGeom>
          <a:noFill/>
          <a:ln>
            <a:solidFill>
              <a:srgbClr val="FF2489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下矢印 29">
            <a:extLst>
              <a:ext uri="{FF2B5EF4-FFF2-40B4-BE49-F238E27FC236}">
                <a16:creationId xmlns:a16="http://schemas.microsoft.com/office/drawing/2014/main" id="{2247DC74-2428-4A5F-91D9-43BAE7B44626}"/>
              </a:ext>
            </a:extLst>
          </p:cNvPr>
          <p:cNvSpPr/>
          <p:nvPr/>
        </p:nvSpPr>
        <p:spPr>
          <a:xfrm rot="16200000">
            <a:off x="2257131" y="3028344"/>
            <a:ext cx="244019" cy="303012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1755" name="図 31">
            <a:extLst>
              <a:ext uri="{FF2B5EF4-FFF2-40B4-BE49-F238E27FC236}">
                <a16:creationId xmlns:a16="http://schemas.microsoft.com/office/drawing/2014/main" id="{2D9BA616-455E-4C62-A3AE-9029164AE4E1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156" t="20392" r="48302" b="50000"/>
          <a:stretch/>
        </p:blipFill>
        <p:spPr bwMode="auto">
          <a:xfrm>
            <a:off x="7162980" y="2081245"/>
            <a:ext cx="1297858" cy="1966898"/>
          </a:xfrm>
          <a:prstGeom prst="rect">
            <a:avLst/>
          </a:prstGeom>
          <a:noFill/>
          <a:ln w="28575">
            <a:solidFill>
              <a:srgbClr val="FF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5" name="正方形/長方形 34">
            <a:extLst>
              <a:ext uri="{FF2B5EF4-FFF2-40B4-BE49-F238E27FC236}">
                <a16:creationId xmlns:a16="http://schemas.microsoft.com/office/drawing/2014/main" id="{493B4CAE-1103-47FC-A9B5-9D8C08B35512}"/>
              </a:ext>
            </a:extLst>
          </p:cNvPr>
          <p:cNvSpPr/>
          <p:nvPr/>
        </p:nvSpPr>
        <p:spPr>
          <a:xfrm>
            <a:off x="6058191" y="2510809"/>
            <a:ext cx="729375" cy="91305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下矢印 35">
            <a:extLst>
              <a:ext uri="{FF2B5EF4-FFF2-40B4-BE49-F238E27FC236}">
                <a16:creationId xmlns:a16="http://schemas.microsoft.com/office/drawing/2014/main" id="{9F5307AD-5AEE-4E90-9C30-36997A6969FF}"/>
              </a:ext>
            </a:extLst>
          </p:cNvPr>
          <p:cNvSpPr/>
          <p:nvPr/>
        </p:nvSpPr>
        <p:spPr>
          <a:xfrm rot="16200000">
            <a:off x="6861309" y="2723990"/>
            <a:ext cx="242678" cy="304354"/>
          </a:xfrm>
          <a:prstGeom prst="down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8" name="直線コネクタ 37">
            <a:extLst>
              <a:ext uri="{FF2B5EF4-FFF2-40B4-BE49-F238E27FC236}">
                <a16:creationId xmlns:a16="http://schemas.microsoft.com/office/drawing/2014/main" id="{5586D819-B5D0-414F-A140-399D48DDE48F}"/>
              </a:ext>
            </a:extLst>
          </p:cNvPr>
          <p:cNvCxnSpPr/>
          <p:nvPr/>
        </p:nvCxnSpPr>
        <p:spPr>
          <a:xfrm flipV="1">
            <a:off x="3199686" y="3248228"/>
            <a:ext cx="233293" cy="80446"/>
          </a:xfrm>
          <a:prstGeom prst="line">
            <a:avLst/>
          </a:prstGeom>
          <a:ln w="19050">
            <a:solidFill>
              <a:srgbClr val="FF2489"/>
            </a:solidFill>
            <a:headEnd type="triangl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直線コネクタ 43">
            <a:extLst>
              <a:ext uri="{FF2B5EF4-FFF2-40B4-BE49-F238E27FC236}">
                <a16:creationId xmlns:a16="http://schemas.microsoft.com/office/drawing/2014/main" id="{EF062339-578B-4F5C-AE61-0DE28D240EDF}"/>
              </a:ext>
            </a:extLst>
          </p:cNvPr>
          <p:cNvCxnSpPr>
            <a:cxnSpLocks/>
          </p:cNvCxnSpPr>
          <p:nvPr/>
        </p:nvCxnSpPr>
        <p:spPr>
          <a:xfrm flipV="1">
            <a:off x="7542939" y="2614048"/>
            <a:ext cx="197413" cy="51330"/>
          </a:xfrm>
          <a:prstGeom prst="line">
            <a:avLst/>
          </a:prstGeom>
          <a:ln w="19050">
            <a:solidFill>
              <a:srgbClr val="FF0000"/>
            </a:solidFill>
            <a:headEnd type="triangl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1D37DF6A-0968-4D30-A70A-3E79A31BD36A}"/>
              </a:ext>
            </a:extLst>
          </p:cNvPr>
          <p:cNvSpPr/>
          <p:nvPr/>
        </p:nvSpPr>
        <p:spPr>
          <a:xfrm>
            <a:off x="3181918" y="3494258"/>
            <a:ext cx="547031" cy="301672"/>
          </a:xfrm>
          <a:prstGeom prst="rect">
            <a:avLst/>
          </a:prstGeom>
          <a:solidFill>
            <a:schemeClr val="accent1"/>
          </a:solidFill>
          <a:ln w="12700">
            <a:solidFill>
              <a:srgbClr val="FF2489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altLang="ja-JP" sz="1182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D</a:t>
            </a:r>
            <a:endParaRPr lang="ja-JP" altLang="en-US" sz="1182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正方形/長方形 24">
            <a:extLst>
              <a:ext uri="{FF2B5EF4-FFF2-40B4-BE49-F238E27FC236}">
                <a16:creationId xmlns:a16="http://schemas.microsoft.com/office/drawing/2014/main" id="{7DB9F021-18E6-405E-9005-CE453486CAA2}"/>
              </a:ext>
            </a:extLst>
          </p:cNvPr>
          <p:cNvSpPr/>
          <p:nvPr/>
        </p:nvSpPr>
        <p:spPr>
          <a:xfrm>
            <a:off x="7811909" y="2841457"/>
            <a:ext cx="547031" cy="301671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altLang="ja-JP" sz="11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TD</a:t>
            </a:r>
            <a:endParaRPr lang="ja-JP" altLang="en-US" sz="11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B7B9D2B9-476C-4F2E-879F-BEBFC92042B4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826" t="6805" r="21645" b="27316"/>
          <a:stretch/>
        </p:blipFill>
        <p:spPr>
          <a:xfrm>
            <a:off x="1043607" y="2251403"/>
            <a:ext cx="2834937" cy="3212759"/>
          </a:xfrm>
          <a:prstGeom prst="rect">
            <a:avLst/>
          </a:prstGeom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0858EAF9-2E4D-4E1F-9A43-FC688493E411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285" t="7181" r="45141" b="64765"/>
          <a:stretch/>
        </p:blipFill>
        <p:spPr>
          <a:xfrm>
            <a:off x="3162482" y="2029246"/>
            <a:ext cx="1435433" cy="2057187"/>
          </a:xfrm>
          <a:prstGeom prst="rect">
            <a:avLst/>
          </a:prstGeom>
          <a:ln w="28575">
            <a:solidFill>
              <a:srgbClr val="FF0000"/>
            </a:solidFill>
          </a:ln>
        </p:spPr>
      </p:pic>
      <p:sp>
        <p:nvSpPr>
          <p:cNvPr id="33" name="正方形/長方形 32">
            <a:extLst>
              <a:ext uri="{FF2B5EF4-FFF2-40B4-BE49-F238E27FC236}">
                <a16:creationId xmlns:a16="http://schemas.microsoft.com/office/drawing/2014/main" id="{753E2D1D-134A-485C-8E12-02989DF774EC}"/>
              </a:ext>
            </a:extLst>
          </p:cNvPr>
          <p:cNvSpPr/>
          <p:nvPr/>
        </p:nvSpPr>
        <p:spPr>
          <a:xfrm>
            <a:off x="1789203" y="2251403"/>
            <a:ext cx="887586" cy="105045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下矢印 35">
            <a:extLst>
              <a:ext uri="{FF2B5EF4-FFF2-40B4-BE49-F238E27FC236}">
                <a16:creationId xmlns:a16="http://schemas.microsoft.com/office/drawing/2014/main" id="{E0FEB9E4-1CF4-46AE-AA0F-DC064680DD5D}"/>
              </a:ext>
            </a:extLst>
          </p:cNvPr>
          <p:cNvSpPr/>
          <p:nvPr/>
        </p:nvSpPr>
        <p:spPr>
          <a:xfrm rot="16200000">
            <a:off x="2799320" y="2612343"/>
            <a:ext cx="242678" cy="304354"/>
          </a:xfrm>
          <a:prstGeom prst="down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正方形/長方形 36">
            <a:extLst>
              <a:ext uri="{FF2B5EF4-FFF2-40B4-BE49-F238E27FC236}">
                <a16:creationId xmlns:a16="http://schemas.microsoft.com/office/drawing/2014/main" id="{71F08218-0DDC-4E50-B968-AACDB6EBA753}"/>
              </a:ext>
            </a:extLst>
          </p:cNvPr>
          <p:cNvSpPr/>
          <p:nvPr/>
        </p:nvSpPr>
        <p:spPr>
          <a:xfrm>
            <a:off x="3706927" y="2895768"/>
            <a:ext cx="547031" cy="301671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altLang="ja-JP" sz="11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TD</a:t>
            </a:r>
            <a:endParaRPr lang="ja-JP" altLang="en-US" sz="11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9" name="直線コネクタ 38">
            <a:extLst>
              <a:ext uri="{FF2B5EF4-FFF2-40B4-BE49-F238E27FC236}">
                <a16:creationId xmlns:a16="http://schemas.microsoft.com/office/drawing/2014/main" id="{F12FB6AE-1256-4CB4-AEDD-1126FFDC7CC7}"/>
              </a:ext>
            </a:extLst>
          </p:cNvPr>
          <p:cNvCxnSpPr>
            <a:cxnSpLocks/>
          </p:cNvCxnSpPr>
          <p:nvPr/>
        </p:nvCxnSpPr>
        <p:spPr>
          <a:xfrm flipV="1">
            <a:off x="3517432" y="2505446"/>
            <a:ext cx="361112" cy="108602"/>
          </a:xfrm>
          <a:prstGeom prst="line">
            <a:avLst/>
          </a:prstGeom>
          <a:ln w="19050">
            <a:solidFill>
              <a:srgbClr val="FF0000"/>
            </a:solidFill>
            <a:headEnd type="triangl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7F7B5F41-F605-D714-911F-D47778D26182}"/>
              </a:ext>
            </a:extLst>
          </p:cNvPr>
          <p:cNvSpPr txBox="1"/>
          <p:nvPr/>
        </p:nvSpPr>
        <p:spPr>
          <a:xfrm>
            <a:off x="189675" y="190640"/>
            <a:ext cx="23409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/>
              <a:t>Supplementary Figure 2</a:t>
            </a:r>
          </a:p>
        </p:txBody>
      </p:sp>
      <p:sp>
        <p:nvSpPr>
          <p:cNvPr id="6" name="テキスト ボックス 37">
            <a:extLst>
              <a:ext uri="{FF2B5EF4-FFF2-40B4-BE49-F238E27FC236}">
                <a16:creationId xmlns:a16="http://schemas.microsoft.com/office/drawing/2014/main" id="{CFA0A80C-F597-68E6-E6CA-57EDBD96684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26396" y="2242804"/>
            <a:ext cx="717766" cy="262642"/>
          </a:xfrm>
          <a:prstGeom prst="rect">
            <a:avLst/>
          </a:prstGeom>
          <a:solidFill>
            <a:schemeClr val="bg1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wrap="square" lIns="77221" tIns="38611" rIns="77221" bIns="38611">
            <a:spAutoFit/>
          </a:bodyPr>
          <a:lstStyle>
            <a:lvl1pPr>
              <a:spcBef>
                <a:spcPct val="20000"/>
              </a:spcBef>
              <a:buClr>
                <a:srgbClr val="ACC2C9"/>
              </a:buClr>
              <a:buFont typeface="Arial" panose="020B0604020202020204" pitchFamily="34" charset="0"/>
              <a:buChar char="•"/>
              <a:defRPr kumimoji="1" sz="2400">
                <a:solidFill>
                  <a:schemeClr val="tx2"/>
                </a:solidFill>
                <a:latin typeface="Tw Cen MT"/>
              </a:defRPr>
            </a:lvl1pPr>
            <a:lvl2pPr marL="742950" indent="-285750">
              <a:spcBef>
                <a:spcPct val="20000"/>
              </a:spcBef>
              <a:buClr>
                <a:srgbClr val="ACC2C9"/>
              </a:buClr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Tw Cen MT"/>
              </a:defRPr>
            </a:lvl2pPr>
            <a:lvl3pPr marL="1143000" indent="-228600">
              <a:spcBef>
                <a:spcPct val="20000"/>
              </a:spcBef>
              <a:buClr>
                <a:schemeClr val="accent2"/>
              </a:buClr>
              <a:buFont typeface="Arial" panose="020B0604020202020204" pitchFamily="34" charset="0"/>
              <a:buChar char="•"/>
              <a:defRPr kumimoji="1" sz="2000">
                <a:solidFill>
                  <a:schemeClr val="tx2"/>
                </a:solidFill>
                <a:latin typeface="Tw Cen MT"/>
              </a:defRPr>
            </a:lvl3pPr>
            <a:lvl4pPr marL="1600200" indent="-228600">
              <a:spcBef>
                <a:spcPct val="20000"/>
              </a:spcBef>
              <a:buClr>
                <a:srgbClr val="99987F"/>
              </a:buClr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Tw Cen MT"/>
              </a:defRPr>
            </a:lvl4pPr>
            <a:lvl5pPr marL="2057400" indent="-228600">
              <a:spcBef>
                <a:spcPct val="20000"/>
              </a:spcBef>
              <a:buClr>
                <a:srgbClr val="90AC97"/>
              </a:buClr>
              <a:buFont typeface="Arial" panose="020B0604020202020204" pitchFamily="34" charset="0"/>
              <a:buChar char="•"/>
              <a:defRPr kumimoji="1" sz="1600">
                <a:solidFill>
                  <a:schemeClr val="tx2"/>
                </a:solidFill>
                <a:latin typeface="Tw Cen MT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90AC97"/>
              </a:buClr>
              <a:buFont typeface="Arial" panose="020B0604020202020204" pitchFamily="34" charset="0"/>
              <a:buChar char="•"/>
              <a:defRPr kumimoji="1" sz="1600">
                <a:solidFill>
                  <a:schemeClr val="tx2"/>
                </a:solidFill>
                <a:latin typeface="Tw Cen MT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90AC97"/>
              </a:buClr>
              <a:buFont typeface="Arial" panose="020B0604020202020204" pitchFamily="34" charset="0"/>
              <a:buChar char="•"/>
              <a:defRPr kumimoji="1" sz="1600">
                <a:solidFill>
                  <a:schemeClr val="tx2"/>
                </a:solidFill>
                <a:latin typeface="Tw Cen MT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90AC97"/>
              </a:buClr>
              <a:buFont typeface="Arial" panose="020B0604020202020204" pitchFamily="34" charset="0"/>
              <a:buChar char="•"/>
              <a:defRPr kumimoji="1" sz="1600">
                <a:solidFill>
                  <a:schemeClr val="tx2"/>
                </a:solidFill>
                <a:latin typeface="Tw Cen MT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90AC97"/>
              </a:buClr>
              <a:buFont typeface="Arial" panose="020B0604020202020204" pitchFamily="34" charset="0"/>
              <a:buChar char="•"/>
              <a:defRPr kumimoji="1" sz="1600">
                <a:solidFill>
                  <a:schemeClr val="tx2"/>
                </a:solidFill>
                <a:latin typeface="Tw Cen MT"/>
              </a:defRPr>
            </a:lvl9pPr>
          </a:lstStyle>
          <a:p>
            <a:pPr>
              <a:spcBef>
                <a:spcPct val="0"/>
              </a:spcBef>
              <a:buClrTx/>
              <a:buFontTx/>
              <a:buNone/>
            </a:pPr>
            <a:r>
              <a:rPr lang="en-US" altLang="ja-JP" sz="1200" b="1" dirty="0">
                <a:solidFill>
                  <a:schemeClr val="tx1"/>
                </a:solidFill>
                <a:latin typeface="Arial" panose="020B0604020202020204" pitchFamily="34" charset="0"/>
                <a:ea typeface="HGP創英角ｺﾞｼｯｸUB" panose="020B0900000000000000" pitchFamily="50" charset="-128"/>
                <a:cs typeface="Arial" panose="020B0604020202020204" pitchFamily="34" charset="0"/>
              </a:rPr>
              <a:t>Case 1</a:t>
            </a:r>
            <a:endParaRPr lang="ja-JP" altLang="en-US" sz="1200" b="1" dirty="0">
              <a:solidFill>
                <a:schemeClr val="tx1"/>
              </a:solidFill>
              <a:latin typeface="Arial" panose="020B0604020202020204" pitchFamily="34" charset="0"/>
              <a:ea typeface="HGP創英角ｺﾞｼｯｸUB" panose="020B09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8" name="テキスト ボックス 37">
            <a:extLst>
              <a:ext uri="{FF2B5EF4-FFF2-40B4-BE49-F238E27FC236}">
                <a16:creationId xmlns:a16="http://schemas.microsoft.com/office/drawing/2014/main" id="{89F0C141-7E98-3732-CDD6-2740F359EDD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24250" y="2419227"/>
            <a:ext cx="717766" cy="262642"/>
          </a:xfrm>
          <a:prstGeom prst="rect">
            <a:avLst/>
          </a:prstGeom>
          <a:solidFill>
            <a:schemeClr val="bg1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wrap="square" lIns="77221" tIns="38611" rIns="77221" bIns="38611">
            <a:spAutoFit/>
          </a:bodyPr>
          <a:lstStyle>
            <a:lvl1pPr>
              <a:spcBef>
                <a:spcPct val="20000"/>
              </a:spcBef>
              <a:buClr>
                <a:srgbClr val="ACC2C9"/>
              </a:buClr>
              <a:buFont typeface="Arial" panose="020B0604020202020204" pitchFamily="34" charset="0"/>
              <a:buChar char="•"/>
              <a:defRPr kumimoji="1" sz="2400">
                <a:solidFill>
                  <a:schemeClr val="tx2"/>
                </a:solidFill>
                <a:latin typeface="Tw Cen MT"/>
              </a:defRPr>
            </a:lvl1pPr>
            <a:lvl2pPr marL="742950" indent="-285750">
              <a:spcBef>
                <a:spcPct val="20000"/>
              </a:spcBef>
              <a:buClr>
                <a:srgbClr val="ACC2C9"/>
              </a:buClr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Tw Cen MT"/>
              </a:defRPr>
            </a:lvl2pPr>
            <a:lvl3pPr marL="1143000" indent="-228600">
              <a:spcBef>
                <a:spcPct val="20000"/>
              </a:spcBef>
              <a:buClr>
                <a:schemeClr val="accent2"/>
              </a:buClr>
              <a:buFont typeface="Arial" panose="020B0604020202020204" pitchFamily="34" charset="0"/>
              <a:buChar char="•"/>
              <a:defRPr kumimoji="1" sz="2000">
                <a:solidFill>
                  <a:schemeClr val="tx2"/>
                </a:solidFill>
                <a:latin typeface="Tw Cen MT"/>
              </a:defRPr>
            </a:lvl3pPr>
            <a:lvl4pPr marL="1600200" indent="-228600">
              <a:spcBef>
                <a:spcPct val="20000"/>
              </a:spcBef>
              <a:buClr>
                <a:srgbClr val="99987F"/>
              </a:buClr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Tw Cen MT"/>
              </a:defRPr>
            </a:lvl4pPr>
            <a:lvl5pPr marL="2057400" indent="-228600">
              <a:spcBef>
                <a:spcPct val="20000"/>
              </a:spcBef>
              <a:buClr>
                <a:srgbClr val="90AC97"/>
              </a:buClr>
              <a:buFont typeface="Arial" panose="020B0604020202020204" pitchFamily="34" charset="0"/>
              <a:buChar char="•"/>
              <a:defRPr kumimoji="1" sz="1600">
                <a:solidFill>
                  <a:schemeClr val="tx2"/>
                </a:solidFill>
                <a:latin typeface="Tw Cen MT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90AC97"/>
              </a:buClr>
              <a:buFont typeface="Arial" panose="020B0604020202020204" pitchFamily="34" charset="0"/>
              <a:buChar char="•"/>
              <a:defRPr kumimoji="1" sz="1600">
                <a:solidFill>
                  <a:schemeClr val="tx2"/>
                </a:solidFill>
                <a:latin typeface="Tw Cen MT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90AC97"/>
              </a:buClr>
              <a:buFont typeface="Arial" panose="020B0604020202020204" pitchFamily="34" charset="0"/>
              <a:buChar char="•"/>
              <a:defRPr kumimoji="1" sz="1600">
                <a:solidFill>
                  <a:schemeClr val="tx2"/>
                </a:solidFill>
                <a:latin typeface="Tw Cen MT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90AC97"/>
              </a:buClr>
              <a:buFont typeface="Arial" panose="020B0604020202020204" pitchFamily="34" charset="0"/>
              <a:buChar char="•"/>
              <a:defRPr kumimoji="1" sz="1600">
                <a:solidFill>
                  <a:schemeClr val="tx2"/>
                </a:solidFill>
                <a:latin typeface="Tw Cen MT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90AC97"/>
              </a:buClr>
              <a:buFont typeface="Arial" panose="020B0604020202020204" pitchFamily="34" charset="0"/>
              <a:buChar char="•"/>
              <a:defRPr kumimoji="1" sz="1600">
                <a:solidFill>
                  <a:schemeClr val="tx2"/>
                </a:solidFill>
                <a:latin typeface="Tw Cen MT"/>
              </a:defRPr>
            </a:lvl9pPr>
          </a:lstStyle>
          <a:p>
            <a:pPr>
              <a:spcBef>
                <a:spcPct val="0"/>
              </a:spcBef>
              <a:buClrTx/>
              <a:buFontTx/>
              <a:buNone/>
            </a:pPr>
            <a:r>
              <a:rPr lang="en-US" altLang="ja-JP" sz="1200" b="1" dirty="0">
                <a:solidFill>
                  <a:schemeClr val="tx1"/>
                </a:solidFill>
                <a:latin typeface="Arial" panose="020B0604020202020204" pitchFamily="34" charset="0"/>
                <a:ea typeface="HGP創英角ｺﾞｼｯｸUB" panose="020B0900000000000000" pitchFamily="50" charset="-128"/>
                <a:cs typeface="Arial" panose="020B0604020202020204" pitchFamily="34" charset="0"/>
              </a:rPr>
              <a:t>Case 2</a:t>
            </a:r>
            <a:endParaRPr lang="ja-JP" altLang="en-US" sz="1200" b="1" dirty="0">
              <a:solidFill>
                <a:schemeClr val="tx1"/>
              </a:solidFill>
              <a:latin typeface="Arial" panose="020B0604020202020204" pitchFamily="34" charset="0"/>
              <a:ea typeface="HGP創英角ｺﾞｼｯｸUB" panose="020B0900000000000000" pitchFamily="50" charset="-128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2770" name="図 65" descr="前畑俊術後sag.bmp">
            <a:extLst>
              <a:ext uri="{FF2B5EF4-FFF2-40B4-BE49-F238E27FC236}">
                <a16:creationId xmlns:a16="http://schemas.microsoft.com/office/drawing/2014/main" id="{084B3633-425D-4846-999A-CEFF7B9BD8EF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598" t="5043" r="18684" b="6097"/>
          <a:stretch/>
        </p:blipFill>
        <p:spPr bwMode="auto">
          <a:xfrm>
            <a:off x="1099722" y="1919116"/>
            <a:ext cx="2250262" cy="3189404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2773" name="テキスト ボックス 24">
            <a:extLst>
              <a:ext uri="{FF2B5EF4-FFF2-40B4-BE49-F238E27FC236}">
                <a16:creationId xmlns:a16="http://schemas.microsoft.com/office/drawing/2014/main" id="{B30F055D-4A90-4DC6-AEA9-BC6C706E161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42388" y="5179457"/>
            <a:ext cx="1164929" cy="276999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square">
            <a:spAutoFit/>
          </a:bodyPr>
          <a:lstStyle>
            <a:lvl1pPr eaLnBrk="0" hangingPunct="0">
              <a:defRPr kumimoji="1" sz="21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 sz="21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 sz="21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 sz="21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 sz="21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1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1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1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1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50" charset="-128"/>
              </a:defRPr>
            </a:lvl9pPr>
          </a:lstStyle>
          <a:p>
            <a:pPr algn="ctr" eaLnBrk="1" hangingPunct="1"/>
            <a:r>
              <a:rPr lang="en-US" altLang="ja-JP" sz="1200" b="1" dirty="0">
                <a:latin typeface="Arial" panose="020B0604020202020204" pitchFamily="34" charset="0"/>
                <a:ea typeface="HGS創英角ｺﾞｼｯｸUB" panose="020B0900000000000000" pitchFamily="50" charset="-128"/>
                <a:cs typeface="Arial" panose="020B0604020202020204" pitchFamily="34" charset="0"/>
              </a:rPr>
              <a:t>AH: -15.6mm</a:t>
            </a:r>
            <a:endParaRPr lang="ja-JP" altLang="en-US" sz="1200" b="1" baseline="30000" dirty="0">
              <a:latin typeface="Arial" panose="020B0604020202020204" pitchFamily="34" charset="0"/>
              <a:ea typeface="HGS創英角ｺﾞｼｯｸUB" panose="020B09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32774" name="テキスト ボックス 25">
            <a:extLst>
              <a:ext uri="{FF2B5EF4-FFF2-40B4-BE49-F238E27FC236}">
                <a16:creationId xmlns:a16="http://schemas.microsoft.com/office/drawing/2014/main" id="{C8E0CB14-DBC9-4308-9A8A-20113015CEC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063281" y="5179457"/>
            <a:ext cx="1069176" cy="276999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square">
            <a:spAutoFit/>
          </a:bodyPr>
          <a:lstStyle>
            <a:lvl1pPr eaLnBrk="0" hangingPunct="0">
              <a:defRPr kumimoji="1" sz="21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 sz="21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 sz="21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 sz="21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 sz="21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1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1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1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1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50" charset="-128"/>
              </a:defRPr>
            </a:lvl9pPr>
          </a:lstStyle>
          <a:p>
            <a:pPr algn="ctr" eaLnBrk="1" hangingPunct="1"/>
            <a:r>
              <a:rPr lang="en-US" altLang="ja-JP" sz="1200" b="1" dirty="0">
                <a:latin typeface="Arial" panose="020B0604020202020204" pitchFamily="34" charset="0"/>
                <a:ea typeface="HGS創英角ｺﾞｼｯｸUB" panose="020B0900000000000000" pitchFamily="50" charset="-128"/>
                <a:cs typeface="Arial" panose="020B0604020202020204" pitchFamily="34" charset="0"/>
              </a:rPr>
              <a:t>AH: 26.5mm</a:t>
            </a:r>
            <a:endParaRPr lang="ja-JP" altLang="en-US" sz="1200" b="1" baseline="30000" dirty="0">
              <a:latin typeface="Arial" panose="020B0604020202020204" pitchFamily="34" charset="0"/>
              <a:ea typeface="HGS創英角ｺﾞｼｯｸUB" panose="020B0900000000000000" pitchFamily="50" charset="-128"/>
              <a:cs typeface="Arial" panose="020B0604020202020204" pitchFamily="34" charset="0"/>
            </a:endParaRPr>
          </a:p>
        </p:txBody>
      </p:sp>
      <p:pic>
        <p:nvPicPr>
          <p:cNvPr id="32776" name="図 30" descr="阿部術後sag1.bmp">
            <a:extLst>
              <a:ext uri="{FF2B5EF4-FFF2-40B4-BE49-F238E27FC236}">
                <a16:creationId xmlns:a16="http://schemas.microsoft.com/office/drawing/2014/main" id="{AA68A8DA-A46F-46C0-8619-79EF6EE0BB68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273" t="5043" r="20358" b="6097"/>
          <a:stretch/>
        </p:blipFill>
        <p:spPr bwMode="auto">
          <a:xfrm>
            <a:off x="5383987" y="1919116"/>
            <a:ext cx="2274393" cy="3189408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4" name="フリーフォーム 33">
            <a:extLst>
              <a:ext uri="{FF2B5EF4-FFF2-40B4-BE49-F238E27FC236}">
                <a16:creationId xmlns:a16="http://schemas.microsoft.com/office/drawing/2014/main" id="{2E4D52C1-51E8-4DD6-AB5E-764A965CFCAF}"/>
              </a:ext>
            </a:extLst>
          </p:cNvPr>
          <p:cNvSpPr/>
          <p:nvPr/>
        </p:nvSpPr>
        <p:spPr>
          <a:xfrm>
            <a:off x="5740828" y="2758435"/>
            <a:ext cx="644907" cy="2007121"/>
          </a:xfrm>
          <a:custGeom>
            <a:avLst/>
            <a:gdLst>
              <a:gd name="connsiteX0" fmla="*/ 718943 w 762834"/>
              <a:gd name="connsiteY0" fmla="*/ 56404 h 2375323"/>
              <a:gd name="connsiteX1" fmla="*/ 740888 w 762834"/>
              <a:gd name="connsiteY1" fmla="*/ 78350 h 2375323"/>
              <a:gd name="connsiteX2" fmla="*/ 748203 w 762834"/>
              <a:gd name="connsiteY2" fmla="*/ 114926 h 2375323"/>
              <a:gd name="connsiteX3" fmla="*/ 762834 w 762834"/>
              <a:gd name="connsiteY3" fmla="*/ 195393 h 2375323"/>
              <a:gd name="connsiteX4" fmla="*/ 755519 w 762834"/>
              <a:gd name="connsiteY4" fmla="*/ 239284 h 2375323"/>
              <a:gd name="connsiteX5" fmla="*/ 711627 w 762834"/>
              <a:gd name="connsiteY5" fmla="*/ 297806 h 2375323"/>
              <a:gd name="connsiteX6" fmla="*/ 675051 w 762834"/>
              <a:gd name="connsiteY6" fmla="*/ 327067 h 2375323"/>
              <a:gd name="connsiteX7" fmla="*/ 645791 w 762834"/>
              <a:gd name="connsiteY7" fmla="*/ 363643 h 2375323"/>
              <a:gd name="connsiteX8" fmla="*/ 623845 w 762834"/>
              <a:gd name="connsiteY8" fmla="*/ 370958 h 2375323"/>
              <a:gd name="connsiteX9" fmla="*/ 616530 w 762834"/>
              <a:gd name="connsiteY9" fmla="*/ 392903 h 2375323"/>
              <a:gd name="connsiteX10" fmla="*/ 601899 w 762834"/>
              <a:gd name="connsiteY10" fmla="*/ 407534 h 2375323"/>
              <a:gd name="connsiteX11" fmla="*/ 587269 w 762834"/>
              <a:gd name="connsiteY11" fmla="*/ 429479 h 2375323"/>
              <a:gd name="connsiteX12" fmla="*/ 579954 w 762834"/>
              <a:gd name="connsiteY12" fmla="*/ 451425 h 2375323"/>
              <a:gd name="connsiteX13" fmla="*/ 572639 w 762834"/>
              <a:gd name="connsiteY13" fmla="*/ 495316 h 2375323"/>
              <a:gd name="connsiteX14" fmla="*/ 558008 w 762834"/>
              <a:gd name="connsiteY14" fmla="*/ 509947 h 2375323"/>
              <a:gd name="connsiteX15" fmla="*/ 543378 w 762834"/>
              <a:gd name="connsiteY15" fmla="*/ 692827 h 2375323"/>
              <a:gd name="connsiteX16" fmla="*/ 514117 w 762834"/>
              <a:gd name="connsiteY16" fmla="*/ 758663 h 2375323"/>
              <a:gd name="connsiteX17" fmla="*/ 506802 w 762834"/>
              <a:gd name="connsiteY17" fmla="*/ 780609 h 2375323"/>
              <a:gd name="connsiteX18" fmla="*/ 499487 w 762834"/>
              <a:gd name="connsiteY18" fmla="*/ 875707 h 2375323"/>
              <a:gd name="connsiteX19" fmla="*/ 484856 w 762834"/>
              <a:gd name="connsiteY19" fmla="*/ 890337 h 2375323"/>
              <a:gd name="connsiteX20" fmla="*/ 477541 w 762834"/>
              <a:gd name="connsiteY20" fmla="*/ 912283 h 2375323"/>
              <a:gd name="connsiteX21" fmla="*/ 477541 w 762834"/>
              <a:gd name="connsiteY21" fmla="*/ 1087847 h 2375323"/>
              <a:gd name="connsiteX22" fmla="*/ 484856 w 762834"/>
              <a:gd name="connsiteY22" fmla="*/ 1365825 h 2375323"/>
              <a:gd name="connsiteX23" fmla="*/ 499487 w 762834"/>
              <a:gd name="connsiteY23" fmla="*/ 1380455 h 2375323"/>
              <a:gd name="connsiteX24" fmla="*/ 521432 w 762834"/>
              <a:gd name="connsiteY24" fmla="*/ 1424347 h 2375323"/>
              <a:gd name="connsiteX25" fmla="*/ 514117 w 762834"/>
              <a:gd name="connsiteY25" fmla="*/ 1460923 h 2375323"/>
              <a:gd name="connsiteX26" fmla="*/ 484856 w 762834"/>
              <a:gd name="connsiteY26" fmla="*/ 1512129 h 2375323"/>
              <a:gd name="connsiteX27" fmla="*/ 462911 w 762834"/>
              <a:gd name="connsiteY27" fmla="*/ 1621857 h 2375323"/>
              <a:gd name="connsiteX28" fmla="*/ 455595 w 762834"/>
              <a:gd name="connsiteY28" fmla="*/ 1687694 h 2375323"/>
              <a:gd name="connsiteX29" fmla="*/ 426335 w 762834"/>
              <a:gd name="connsiteY29" fmla="*/ 1760846 h 2375323"/>
              <a:gd name="connsiteX30" fmla="*/ 419019 w 762834"/>
              <a:gd name="connsiteY30" fmla="*/ 1782791 h 2375323"/>
              <a:gd name="connsiteX31" fmla="*/ 411704 w 762834"/>
              <a:gd name="connsiteY31" fmla="*/ 1943726 h 2375323"/>
              <a:gd name="connsiteX32" fmla="*/ 389759 w 762834"/>
              <a:gd name="connsiteY32" fmla="*/ 1958356 h 2375323"/>
              <a:gd name="connsiteX33" fmla="*/ 345867 w 762834"/>
              <a:gd name="connsiteY33" fmla="*/ 2016878 h 2375323"/>
              <a:gd name="connsiteX34" fmla="*/ 316607 w 762834"/>
              <a:gd name="connsiteY34" fmla="*/ 2082715 h 2375323"/>
              <a:gd name="connsiteX35" fmla="*/ 294661 w 762834"/>
              <a:gd name="connsiteY35" fmla="*/ 2199758 h 2375323"/>
              <a:gd name="connsiteX36" fmla="*/ 265400 w 762834"/>
              <a:gd name="connsiteY36" fmla="*/ 2265595 h 2375323"/>
              <a:gd name="connsiteX37" fmla="*/ 250770 w 762834"/>
              <a:gd name="connsiteY37" fmla="*/ 2316801 h 2375323"/>
              <a:gd name="connsiteX38" fmla="*/ 199563 w 762834"/>
              <a:gd name="connsiteY38" fmla="*/ 2353377 h 2375323"/>
              <a:gd name="connsiteX39" fmla="*/ 155672 w 762834"/>
              <a:gd name="connsiteY39" fmla="*/ 2375323 h 2375323"/>
              <a:gd name="connsiteX40" fmla="*/ 119096 w 762834"/>
              <a:gd name="connsiteY40" fmla="*/ 2368007 h 2375323"/>
              <a:gd name="connsiteX41" fmla="*/ 104466 w 762834"/>
              <a:gd name="connsiteY41" fmla="*/ 2346062 h 2375323"/>
              <a:gd name="connsiteX42" fmla="*/ 97151 w 762834"/>
              <a:gd name="connsiteY42" fmla="*/ 2324116 h 2375323"/>
              <a:gd name="connsiteX43" fmla="*/ 82520 w 762834"/>
              <a:gd name="connsiteY43" fmla="*/ 2309486 h 2375323"/>
              <a:gd name="connsiteX44" fmla="*/ 53259 w 762834"/>
              <a:gd name="connsiteY44" fmla="*/ 2250964 h 2375323"/>
              <a:gd name="connsiteX45" fmla="*/ 45944 w 762834"/>
              <a:gd name="connsiteY45" fmla="*/ 2229019 h 2375323"/>
              <a:gd name="connsiteX46" fmla="*/ 38629 w 762834"/>
              <a:gd name="connsiteY46" fmla="*/ 2163182 h 2375323"/>
              <a:gd name="connsiteX47" fmla="*/ 23999 w 762834"/>
              <a:gd name="connsiteY47" fmla="*/ 2148551 h 2375323"/>
              <a:gd name="connsiteX48" fmla="*/ 23999 w 762834"/>
              <a:gd name="connsiteY48" fmla="*/ 2024193 h 2375323"/>
              <a:gd name="connsiteX49" fmla="*/ 89835 w 762834"/>
              <a:gd name="connsiteY49" fmla="*/ 1987617 h 2375323"/>
              <a:gd name="connsiteX50" fmla="*/ 104466 w 762834"/>
              <a:gd name="connsiteY50" fmla="*/ 1965671 h 2375323"/>
              <a:gd name="connsiteX51" fmla="*/ 119096 w 762834"/>
              <a:gd name="connsiteY51" fmla="*/ 1870574 h 2375323"/>
              <a:gd name="connsiteX52" fmla="*/ 133727 w 762834"/>
              <a:gd name="connsiteY52" fmla="*/ 1848628 h 2375323"/>
              <a:gd name="connsiteX53" fmla="*/ 155672 w 762834"/>
              <a:gd name="connsiteY53" fmla="*/ 1812052 h 2375323"/>
              <a:gd name="connsiteX54" fmla="*/ 162987 w 762834"/>
              <a:gd name="connsiteY54" fmla="*/ 1790107 h 2375323"/>
              <a:gd name="connsiteX55" fmla="*/ 170303 w 762834"/>
              <a:gd name="connsiteY55" fmla="*/ 1577966 h 2375323"/>
              <a:gd name="connsiteX56" fmla="*/ 184933 w 762834"/>
              <a:gd name="connsiteY56" fmla="*/ 1534075 h 2375323"/>
              <a:gd name="connsiteX57" fmla="*/ 192248 w 762834"/>
              <a:gd name="connsiteY57" fmla="*/ 1482868 h 2375323"/>
              <a:gd name="connsiteX58" fmla="*/ 206879 w 762834"/>
              <a:gd name="connsiteY58" fmla="*/ 1387771 h 2375323"/>
              <a:gd name="connsiteX59" fmla="*/ 221509 w 762834"/>
              <a:gd name="connsiteY59" fmla="*/ 1321934 h 2375323"/>
              <a:gd name="connsiteX60" fmla="*/ 236139 w 762834"/>
              <a:gd name="connsiteY60" fmla="*/ 1307303 h 2375323"/>
              <a:gd name="connsiteX61" fmla="*/ 258085 w 762834"/>
              <a:gd name="connsiteY61" fmla="*/ 1095163 h 2375323"/>
              <a:gd name="connsiteX62" fmla="*/ 265400 w 762834"/>
              <a:gd name="connsiteY62" fmla="*/ 1073217 h 2375323"/>
              <a:gd name="connsiteX63" fmla="*/ 280031 w 762834"/>
              <a:gd name="connsiteY63" fmla="*/ 1051271 h 2375323"/>
              <a:gd name="connsiteX64" fmla="*/ 287346 w 762834"/>
              <a:gd name="connsiteY64" fmla="*/ 992750 h 2375323"/>
              <a:gd name="connsiteX65" fmla="*/ 301976 w 762834"/>
              <a:gd name="connsiteY65" fmla="*/ 948859 h 2375323"/>
              <a:gd name="connsiteX66" fmla="*/ 316607 w 762834"/>
              <a:gd name="connsiteY66" fmla="*/ 875707 h 2375323"/>
              <a:gd name="connsiteX67" fmla="*/ 331237 w 762834"/>
              <a:gd name="connsiteY67" fmla="*/ 861076 h 2375323"/>
              <a:gd name="connsiteX68" fmla="*/ 360498 w 762834"/>
              <a:gd name="connsiteY68" fmla="*/ 824500 h 2375323"/>
              <a:gd name="connsiteX69" fmla="*/ 389759 w 762834"/>
              <a:gd name="connsiteY69" fmla="*/ 765979 h 2375323"/>
              <a:gd name="connsiteX70" fmla="*/ 397074 w 762834"/>
              <a:gd name="connsiteY70" fmla="*/ 663566 h 2375323"/>
              <a:gd name="connsiteX71" fmla="*/ 419019 w 762834"/>
              <a:gd name="connsiteY71" fmla="*/ 553838 h 2375323"/>
              <a:gd name="connsiteX72" fmla="*/ 426335 w 762834"/>
              <a:gd name="connsiteY72" fmla="*/ 531892 h 2375323"/>
              <a:gd name="connsiteX73" fmla="*/ 433650 w 762834"/>
              <a:gd name="connsiteY73" fmla="*/ 509947 h 2375323"/>
              <a:gd name="connsiteX74" fmla="*/ 448280 w 762834"/>
              <a:gd name="connsiteY74" fmla="*/ 495316 h 2375323"/>
              <a:gd name="connsiteX75" fmla="*/ 462911 w 762834"/>
              <a:gd name="connsiteY75" fmla="*/ 451425 h 2375323"/>
              <a:gd name="connsiteX76" fmla="*/ 470226 w 762834"/>
              <a:gd name="connsiteY76" fmla="*/ 400219 h 2375323"/>
              <a:gd name="connsiteX77" fmla="*/ 484856 w 762834"/>
              <a:gd name="connsiteY77" fmla="*/ 385588 h 2375323"/>
              <a:gd name="connsiteX78" fmla="*/ 506802 w 762834"/>
              <a:gd name="connsiteY78" fmla="*/ 349012 h 2375323"/>
              <a:gd name="connsiteX79" fmla="*/ 521432 w 762834"/>
              <a:gd name="connsiteY79" fmla="*/ 290491 h 2375323"/>
              <a:gd name="connsiteX80" fmla="*/ 536063 w 762834"/>
              <a:gd name="connsiteY80" fmla="*/ 246599 h 2375323"/>
              <a:gd name="connsiteX81" fmla="*/ 543378 w 762834"/>
              <a:gd name="connsiteY81" fmla="*/ 195393 h 2375323"/>
              <a:gd name="connsiteX82" fmla="*/ 558008 w 762834"/>
              <a:gd name="connsiteY82" fmla="*/ 166132 h 2375323"/>
              <a:gd name="connsiteX83" fmla="*/ 579954 w 762834"/>
              <a:gd name="connsiteY83" fmla="*/ 100295 h 2375323"/>
              <a:gd name="connsiteX84" fmla="*/ 587269 w 762834"/>
              <a:gd name="connsiteY84" fmla="*/ 12513 h 2375323"/>
              <a:gd name="connsiteX85" fmla="*/ 631160 w 762834"/>
              <a:gd name="connsiteY85" fmla="*/ 19828 h 2375323"/>
              <a:gd name="connsiteX86" fmla="*/ 653106 w 762834"/>
              <a:gd name="connsiteY86" fmla="*/ 27143 h 2375323"/>
              <a:gd name="connsiteX87" fmla="*/ 682367 w 762834"/>
              <a:gd name="connsiteY87" fmla="*/ 34459 h 2375323"/>
              <a:gd name="connsiteX88" fmla="*/ 718943 w 762834"/>
              <a:gd name="connsiteY88" fmla="*/ 56404 h 237532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</a:cxnLst>
            <a:rect l="l" t="t" r="r" b="b"/>
            <a:pathLst>
              <a:path w="762834" h="2375323">
                <a:moveTo>
                  <a:pt x="718943" y="56404"/>
                </a:moveTo>
                <a:cubicBezTo>
                  <a:pt x="728696" y="63719"/>
                  <a:pt x="736262" y="69097"/>
                  <a:pt x="740888" y="78350"/>
                </a:cubicBezTo>
                <a:cubicBezTo>
                  <a:pt x="746448" y="89471"/>
                  <a:pt x="746312" y="102637"/>
                  <a:pt x="748203" y="114926"/>
                </a:cubicBezTo>
                <a:cubicBezTo>
                  <a:pt x="760020" y="191732"/>
                  <a:pt x="747912" y="150626"/>
                  <a:pt x="762834" y="195393"/>
                </a:cubicBezTo>
                <a:cubicBezTo>
                  <a:pt x="760396" y="210023"/>
                  <a:pt x="761224" y="225593"/>
                  <a:pt x="755519" y="239284"/>
                </a:cubicBezTo>
                <a:cubicBezTo>
                  <a:pt x="749668" y="253325"/>
                  <a:pt x="728008" y="284701"/>
                  <a:pt x="711627" y="297806"/>
                </a:cubicBezTo>
                <a:cubicBezTo>
                  <a:pt x="690503" y="314705"/>
                  <a:pt x="690752" y="307441"/>
                  <a:pt x="675051" y="327067"/>
                </a:cubicBezTo>
                <a:cubicBezTo>
                  <a:pt x="665852" y="338566"/>
                  <a:pt x="659376" y="355492"/>
                  <a:pt x="645791" y="363643"/>
                </a:cubicBezTo>
                <a:cubicBezTo>
                  <a:pt x="639179" y="367610"/>
                  <a:pt x="631160" y="368520"/>
                  <a:pt x="623845" y="370958"/>
                </a:cubicBezTo>
                <a:cubicBezTo>
                  <a:pt x="621407" y="378273"/>
                  <a:pt x="620497" y="386291"/>
                  <a:pt x="616530" y="392903"/>
                </a:cubicBezTo>
                <a:cubicBezTo>
                  <a:pt x="612981" y="398817"/>
                  <a:pt x="606208" y="402148"/>
                  <a:pt x="601899" y="407534"/>
                </a:cubicBezTo>
                <a:cubicBezTo>
                  <a:pt x="596407" y="414399"/>
                  <a:pt x="592146" y="422164"/>
                  <a:pt x="587269" y="429479"/>
                </a:cubicBezTo>
                <a:cubicBezTo>
                  <a:pt x="584831" y="436794"/>
                  <a:pt x="581627" y="443898"/>
                  <a:pt x="579954" y="451425"/>
                </a:cubicBezTo>
                <a:cubicBezTo>
                  <a:pt x="576737" y="465904"/>
                  <a:pt x="577847" y="481428"/>
                  <a:pt x="572639" y="495316"/>
                </a:cubicBezTo>
                <a:cubicBezTo>
                  <a:pt x="570217" y="501774"/>
                  <a:pt x="562885" y="505070"/>
                  <a:pt x="558008" y="509947"/>
                </a:cubicBezTo>
                <a:cubicBezTo>
                  <a:pt x="531510" y="589441"/>
                  <a:pt x="566375" y="478194"/>
                  <a:pt x="543378" y="692827"/>
                </a:cubicBezTo>
                <a:cubicBezTo>
                  <a:pt x="540044" y="723942"/>
                  <a:pt x="529276" y="735924"/>
                  <a:pt x="514117" y="758663"/>
                </a:cubicBezTo>
                <a:cubicBezTo>
                  <a:pt x="511679" y="765978"/>
                  <a:pt x="507758" y="772958"/>
                  <a:pt x="506802" y="780609"/>
                </a:cubicBezTo>
                <a:cubicBezTo>
                  <a:pt x="502859" y="812156"/>
                  <a:pt x="505722" y="844531"/>
                  <a:pt x="499487" y="875707"/>
                </a:cubicBezTo>
                <a:cubicBezTo>
                  <a:pt x="498134" y="882470"/>
                  <a:pt x="489733" y="885460"/>
                  <a:pt x="484856" y="890337"/>
                </a:cubicBezTo>
                <a:cubicBezTo>
                  <a:pt x="482418" y="897652"/>
                  <a:pt x="479053" y="904722"/>
                  <a:pt x="477541" y="912283"/>
                </a:cubicBezTo>
                <a:cubicBezTo>
                  <a:pt x="463155" y="984216"/>
                  <a:pt x="472101" y="995359"/>
                  <a:pt x="477541" y="1087847"/>
                </a:cubicBezTo>
                <a:cubicBezTo>
                  <a:pt x="479979" y="1180506"/>
                  <a:pt x="477923" y="1273393"/>
                  <a:pt x="484856" y="1365825"/>
                </a:cubicBezTo>
                <a:cubicBezTo>
                  <a:pt x="485372" y="1372703"/>
                  <a:pt x="495939" y="1374541"/>
                  <a:pt x="499487" y="1380455"/>
                </a:cubicBezTo>
                <a:cubicBezTo>
                  <a:pt x="590401" y="1531975"/>
                  <a:pt x="410378" y="1257759"/>
                  <a:pt x="521432" y="1424347"/>
                </a:cubicBezTo>
                <a:cubicBezTo>
                  <a:pt x="518994" y="1436539"/>
                  <a:pt x="518049" y="1449128"/>
                  <a:pt x="514117" y="1460923"/>
                </a:cubicBezTo>
                <a:cubicBezTo>
                  <a:pt x="507930" y="1479485"/>
                  <a:pt x="495559" y="1496075"/>
                  <a:pt x="484856" y="1512129"/>
                </a:cubicBezTo>
                <a:cubicBezTo>
                  <a:pt x="470227" y="1556019"/>
                  <a:pt x="470861" y="1550312"/>
                  <a:pt x="462911" y="1621857"/>
                </a:cubicBezTo>
                <a:cubicBezTo>
                  <a:pt x="460472" y="1643803"/>
                  <a:pt x="459925" y="1666042"/>
                  <a:pt x="455595" y="1687694"/>
                </a:cubicBezTo>
                <a:cubicBezTo>
                  <a:pt x="447271" y="1729316"/>
                  <a:pt x="440965" y="1726711"/>
                  <a:pt x="426335" y="1760846"/>
                </a:cubicBezTo>
                <a:cubicBezTo>
                  <a:pt x="423298" y="1767933"/>
                  <a:pt x="421458" y="1775476"/>
                  <a:pt x="419019" y="1782791"/>
                </a:cubicBezTo>
                <a:cubicBezTo>
                  <a:pt x="416581" y="1836436"/>
                  <a:pt x="420532" y="1890756"/>
                  <a:pt x="411704" y="1943726"/>
                </a:cubicBezTo>
                <a:cubicBezTo>
                  <a:pt x="410259" y="1952398"/>
                  <a:pt x="395548" y="1951740"/>
                  <a:pt x="389759" y="1958356"/>
                </a:cubicBezTo>
                <a:cubicBezTo>
                  <a:pt x="273957" y="2090701"/>
                  <a:pt x="405376" y="1957369"/>
                  <a:pt x="345867" y="2016878"/>
                </a:cubicBezTo>
                <a:cubicBezTo>
                  <a:pt x="328457" y="2069110"/>
                  <a:pt x="339791" y="2047937"/>
                  <a:pt x="316607" y="2082715"/>
                </a:cubicBezTo>
                <a:cubicBezTo>
                  <a:pt x="313341" y="2102312"/>
                  <a:pt x="298556" y="2193916"/>
                  <a:pt x="294661" y="2199758"/>
                </a:cubicBezTo>
                <a:cubicBezTo>
                  <a:pt x="275447" y="2228579"/>
                  <a:pt x="275846" y="2223810"/>
                  <a:pt x="265400" y="2265595"/>
                </a:cubicBezTo>
                <a:cubicBezTo>
                  <a:pt x="264635" y="2268654"/>
                  <a:pt x="254806" y="2311151"/>
                  <a:pt x="250770" y="2316801"/>
                </a:cubicBezTo>
                <a:cubicBezTo>
                  <a:pt x="229074" y="2347175"/>
                  <a:pt x="227318" y="2344126"/>
                  <a:pt x="199563" y="2353377"/>
                </a:cubicBezTo>
                <a:cubicBezTo>
                  <a:pt x="188468" y="2360773"/>
                  <a:pt x="170814" y="2375323"/>
                  <a:pt x="155672" y="2375323"/>
                </a:cubicBezTo>
                <a:cubicBezTo>
                  <a:pt x="143238" y="2375323"/>
                  <a:pt x="131288" y="2370446"/>
                  <a:pt x="119096" y="2368007"/>
                </a:cubicBezTo>
                <a:cubicBezTo>
                  <a:pt x="114219" y="2360692"/>
                  <a:pt x="108398" y="2353925"/>
                  <a:pt x="104466" y="2346062"/>
                </a:cubicBezTo>
                <a:cubicBezTo>
                  <a:pt x="101018" y="2339165"/>
                  <a:pt x="101118" y="2330728"/>
                  <a:pt x="97151" y="2324116"/>
                </a:cubicBezTo>
                <a:cubicBezTo>
                  <a:pt x="93603" y="2318202"/>
                  <a:pt x="87397" y="2314363"/>
                  <a:pt x="82520" y="2309486"/>
                </a:cubicBezTo>
                <a:cubicBezTo>
                  <a:pt x="65709" y="2259052"/>
                  <a:pt x="78795" y="2276500"/>
                  <a:pt x="53259" y="2250964"/>
                </a:cubicBezTo>
                <a:cubicBezTo>
                  <a:pt x="50821" y="2243649"/>
                  <a:pt x="47212" y="2236625"/>
                  <a:pt x="45944" y="2229019"/>
                </a:cubicBezTo>
                <a:cubicBezTo>
                  <a:pt x="42314" y="2207239"/>
                  <a:pt x="44439" y="2184485"/>
                  <a:pt x="38629" y="2163182"/>
                </a:cubicBezTo>
                <a:cubicBezTo>
                  <a:pt x="36814" y="2156528"/>
                  <a:pt x="28876" y="2153428"/>
                  <a:pt x="23999" y="2148551"/>
                </a:cubicBezTo>
                <a:cubicBezTo>
                  <a:pt x="9494" y="2105041"/>
                  <a:pt x="0" y="2085904"/>
                  <a:pt x="23999" y="2024193"/>
                </a:cubicBezTo>
                <a:cubicBezTo>
                  <a:pt x="31492" y="2004926"/>
                  <a:pt x="69983" y="1994234"/>
                  <a:pt x="89835" y="1987617"/>
                </a:cubicBezTo>
                <a:cubicBezTo>
                  <a:pt x="94712" y="1980302"/>
                  <a:pt x="101940" y="1974092"/>
                  <a:pt x="104466" y="1965671"/>
                </a:cubicBezTo>
                <a:cubicBezTo>
                  <a:pt x="111229" y="1943129"/>
                  <a:pt x="111226" y="1894184"/>
                  <a:pt x="119096" y="1870574"/>
                </a:cubicBezTo>
                <a:cubicBezTo>
                  <a:pt x="121876" y="1862233"/>
                  <a:pt x="128850" y="1855943"/>
                  <a:pt x="133727" y="1848628"/>
                </a:cubicBezTo>
                <a:cubicBezTo>
                  <a:pt x="154449" y="1786462"/>
                  <a:pt x="125549" y="1862259"/>
                  <a:pt x="155672" y="1812052"/>
                </a:cubicBezTo>
                <a:cubicBezTo>
                  <a:pt x="159639" y="1805440"/>
                  <a:pt x="160549" y="1797422"/>
                  <a:pt x="162987" y="1790107"/>
                </a:cubicBezTo>
                <a:cubicBezTo>
                  <a:pt x="165426" y="1719393"/>
                  <a:pt x="164260" y="1648463"/>
                  <a:pt x="170303" y="1577966"/>
                </a:cubicBezTo>
                <a:cubicBezTo>
                  <a:pt x="171620" y="1562601"/>
                  <a:pt x="184933" y="1534075"/>
                  <a:pt x="184933" y="1534075"/>
                </a:cubicBezTo>
                <a:cubicBezTo>
                  <a:pt x="187371" y="1517006"/>
                  <a:pt x="190233" y="1499992"/>
                  <a:pt x="192248" y="1482868"/>
                </a:cubicBezTo>
                <a:cubicBezTo>
                  <a:pt x="202534" y="1395432"/>
                  <a:pt x="191119" y="1435044"/>
                  <a:pt x="206879" y="1387771"/>
                </a:cubicBezTo>
                <a:cubicBezTo>
                  <a:pt x="208356" y="1378906"/>
                  <a:pt x="213197" y="1335787"/>
                  <a:pt x="221509" y="1321934"/>
                </a:cubicBezTo>
                <a:cubicBezTo>
                  <a:pt x="225057" y="1316020"/>
                  <a:pt x="231262" y="1312180"/>
                  <a:pt x="236139" y="1307303"/>
                </a:cubicBezTo>
                <a:cubicBezTo>
                  <a:pt x="244088" y="1207946"/>
                  <a:pt x="237168" y="1168374"/>
                  <a:pt x="258085" y="1095163"/>
                </a:cubicBezTo>
                <a:cubicBezTo>
                  <a:pt x="260203" y="1087749"/>
                  <a:pt x="261952" y="1080114"/>
                  <a:pt x="265400" y="1073217"/>
                </a:cubicBezTo>
                <a:cubicBezTo>
                  <a:pt x="269332" y="1065353"/>
                  <a:pt x="275154" y="1058586"/>
                  <a:pt x="280031" y="1051271"/>
                </a:cubicBezTo>
                <a:cubicBezTo>
                  <a:pt x="282469" y="1031764"/>
                  <a:pt x="283227" y="1011972"/>
                  <a:pt x="287346" y="992750"/>
                </a:cubicBezTo>
                <a:cubicBezTo>
                  <a:pt x="290577" y="977671"/>
                  <a:pt x="301976" y="948859"/>
                  <a:pt x="301976" y="948859"/>
                </a:cubicBezTo>
                <a:cubicBezTo>
                  <a:pt x="303246" y="939972"/>
                  <a:pt x="307029" y="891670"/>
                  <a:pt x="316607" y="875707"/>
                </a:cubicBezTo>
                <a:cubicBezTo>
                  <a:pt x="320155" y="869793"/>
                  <a:pt x="326929" y="866462"/>
                  <a:pt x="331237" y="861076"/>
                </a:cubicBezTo>
                <a:cubicBezTo>
                  <a:pt x="368144" y="814941"/>
                  <a:pt x="325175" y="859823"/>
                  <a:pt x="360498" y="824500"/>
                </a:cubicBezTo>
                <a:cubicBezTo>
                  <a:pt x="377309" y="774066"/>
                  <a:pt x="364223" y="791513"/>
                  <a:pt x="389759" y="765979"/>
                </a:cubicBezTo>
                <a:cubicBezTo>
                  <a:pt x="410605" y="703437"/>
                  <a:pt x="406302" y="737390"/>
                  <a:pt x="397074" y="663566"/>
                </a:cubicBezTo>
                <a:cubicBezTo>
                  <a:pt x="406091" y="582407"/>
                  <a:pt x="397407" y="618673"/>
                  <a:pt x="419019" y="553838"/>
                </a:cubicBezTo>
                <a:lnTo>
                  <a:pt x="426335" y="531892"/>
                </a:lnTo>
                <a:cubicBezTo>
                  <a:pt x="428773" y="524577"/>
                  <a:pt x="428198" y="515399"/>
                  <a:pt x="433650" y="509947"/>
                </a:cubicBezTo>
                <a:lnTo>
                  <a:pt x="448280" y="495316"/>
                </a:lnTo>
                <a:cubicBezTo>
                  <a:pt x="453157" y="480686"/>
                  <a:pt x="460730" y="466692"/>
                  <a:pt x="462911" y="451425"/>
                </a:cubicBezTo>
                <a:cubicBezTo>
                  <a:pt x="465349" y="434356"/>
                  <a:pt x="464774" y="416576"/>
                  <a:pt x="470226" y="400219"/>
                </a:cubicBezTo>
                <a:cubicBezTo>
                  <a:pt x="472407" y="393676"/>
                  <a:pt x="479979" y="390465"/>
                  <a:pt x="484856" y="385588"/>
                </a:cubicBezTo>
                <a:cubicBezTo>
                  <a:pt x="505577" y="323424"/>
                  <a:pt x="476678" y="399218"/>
                  <a:pt x="506802" y="349012"/>
                </a:cubicBezTo>
                <a:cubicBezTo>
                  <a:pt x="514201" y="336681"/>
                  <a:pt x="518810" y="300105"/>
                  <a:pt x="521432" y="290491"/>
                </a:cubicBezTo>
                <a:cubicBezTo>
                  <a:pt x="525490" y="275612"/>
                  <a:pt x="536063" y="246599"/>
                  <a:pt x="536063" y="246599"/>
                </a:cubicBezTo>
                <a:cubicBezTo>
                  <a:pt x="538501" y="229530"/>
                  <a:pt x="538841" y="212027"/>
                  <a:pt x="543378" y="195393"/>
                </a:cubicBezTo>
                <a:cubicBezTo>
                  <a:pt x="546247" y="184872"/>
                  <a:pt x="554875" y="176577"/>
                  <a:pt x="558008" y="166132"/>
                </a:cubicBezTo>
                <a:cubicBezTo>
                  <a:pt x="579510" y="94457"/>
                  <a:pt x="549543" y="145911"/>
                  <a:pt x="579954" y="100295"/>
                </a:cubicBezTo>
                <a:cubicBezTo>
                  <a:pt x="582392" y="71034"/>
                  <a:pt x="571505" y="37285"/>
                  <a:pt x="587269" y="12513"/>
                </a:cubicBezTo>
                <a:cubicBezTo>
                  <a:pt x="595232" y="0"/>
                  <a:pt x="616681" y="16611"/>
                  <a:pt x="631160" y="19828"/>
                </a:cubicBezTo>
                <a:cubicBezTo>
                  <a:pt x="638687" y="21501"/>
                  <a:pt x="645692" y="25025"/>
                  <a:pt x="653106" y="27143"/>
                </a:cubicBezTo>
                <a:cubicBezTo>
                  <a:pt x="662773" y="29905"/>
                  <a:pt x="672613" y="32020"/>
                  <a:pt x="682367" y="34459"/>
                </a:cubicBezTo>
                <a:cubicBezTo>
                  <a:pt x="708849" y="52113"/>
                  <a:pt x="709190" y="49089"/>
                  <a:pt x="718943" y="56404"/>
                </a:cubicBezTo>
                <a:close/>
              </a:path>
            </a:pathLst>
          </a:custGeom>
          <a:solidFill>
            <a:srgbClr val="FFFF00">
              <a:alpha val="5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 sz="1200" b="1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正方形/長方形 34">
            <a:extLst>
              <a:ext uri="{FF2B5EF4-FFF2-40B4-BE49-F238E27FC236}">
                <a16:creationId xmlns:a16="http://schemas.microsoft.com/office/drawing/2014/main" id="{2C1FF616-E2E9-443E-86F0-84733B7A1A1A}"/>
              </a:ext>
            </a:extLst>
          </p:cNvPr>
          <p:cNvSpPr/>
          <p:nvPr/>
        </p:nvSpPr>
        <p:spPr>
          <a:xfrm>
            <a:off x="5724739" y="2286487"/>
            <a:ext cx="729375" cy="91171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 sz="1200" b="1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下矢印 35">
            <a:extLst>
              <a:ext uri="{FF2B5EF4-FFF2-40B4-BE49-F238E27FC236}">
                <a16:creationId xmlns:a16="http://schemas.microsoft.com/office/drawing/2014/main" id="{7347130D-7552-4104-A5CC-E23998212552}"/>
              </a:ext>
            </a:extLst>
          </p:cNvPr>
          <p:cNvSpPr/>
          <p:nvPr/>
        </p:nvSpPr>
        <p:spPr>
          <a:xfrm rot="16200000">
            <a:off x="6515789" y="2498327"/>
            <a:ext cx="242678" cy="304353"/>
          </a:xfrm>
          <a:prstGeom prst="down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 sz="1200" b="1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正方形/長方形 28">
            <a:extLst>
              <a:ext uri="{FF2B5EF4-FFF2-40B4-BE49-F238E27FC236}">
                <a16:creationId xmlns:a16="http://schemas.microsoft.com/office/drawing/2014/main" id="{84A01AEF-E025-4DFF-9C57-960C5D683A7D}"/>
              </a:ext>
            </a:extLst>
          </p:cNvPr>
          <p:cNvSpPr/>
          <p:nvPr/>
        </p:nvSpPr>
        <p:spPr>
          <a:xfrm>
            <a:off x="1406144" y="2346821"/>
            <a:ext cx="730715" cy="91171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 sz="1200" b="1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下矢印 29">
            <a:extLst>
              <a:ext uri="{FF2B5EF4-FFF2-40B4-BE49-F238E27FC236}">
                <a16:creationId xmlns:a16="http://schemas.microsoft.com/office/drawing/2014/main" id="{4EC9CBA9-ACAD-4DCF-A5C9-AA680270A3C7}"/>
              </a:ext>
            </a:extLst>
          </p:cNvPr>
          <p:cNvSpPr/>
          <p:nvPr/>
        </p:nvSpPr>
        <p:spPr>
          <a:xfrm rot="16200000">
            <a:off x="2197194" y="2560003"/>
            <a:ext cx="244019" cy="303012"/>
          </a:xfrm>
          <a:prstGeom prst="down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 sz="1200" b="1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2783" name="図 39" descr="阿部術後sag1.bmp">
            <a:extLst>
              <a:ext uri="{FF2B5EF4-FFF2-40B4-BE49-F238E27FC236}">
                <a16:creationId xmlns:a16="http://schemas.microsoft.com/office/drawing/2014/main" id="{E64790ED-7530-42D5-AB0C-5F106BF9E4FA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068" t="15254" r="54237" b="57626"/>
          <a:stretch/>
        </p:blipFill>
        <p:spPr bwMode="auto">
          <a:xfrm>
            <a:off x="6860886" y="1941910"/>
            <a:ext cx="1159852" cy="1681316"/>
          </a:xfrm>
          <a:prstGeom prst="rect">
            <a:avLst/>
          </a:prstGeom>
          <a:noFill/>
          <a:ln w="28575">
            <a:solidFill>
              <a:srgbClr val="FF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44" name="直線コネクタ 43">
            <a:extLst>
              <a:ext uri="{FF2B5EF4-FFF2-40B4-BE49-F238E27FC236}">
                <a16:creationId xmlns:a16="http://schemas.microsoft.com/office/drawing/2014/main" id="{B496BD3E-7586-4192-BD8C-B3DB649CC8EA}"/>
              </a:ext>
            </a:extLst>
          </p:cNvPr>
          <p:cNvCxnSpPr>
            <a:cxnSpLocks/>
          </p:cNvCxnSpPr>
          <p:nvPr/>
        </p:nvCxnSpPr>
        <p:spPr>
          <a:xfrm flipV="1">
            <a:off x="7485682" y="2698100"/>
            <a:ext cx="96627" cy="312581"/>
          </a:xfrm>
          <a:prstGeom prst="line">
            <a:avLst/>
          </a:prstGeom>
          <a:ln w="19050">
            <a:solidFill>
              <a:srgbClr val="FF0000"/>
            </a:solidFill>
            <a:headEnd type="triangl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直線コネクタ 54">
            <a:extLst>
              <a:ext uri="{FF2B5EF4-FFF2-40B4-BE49-F238E27FC236}">
                <a16:creationId xmlns:a16="http://schemas.microsoft.com/office/drawing/2014/main" id="{87CC98D8-7221-4DE1-85E7-49BE18DB858C}"/>
              </a:ext>
            </a:extLst>
          </p:cNvPr>
          <p:cNvCxnSpPr>
            <a:cxnSpLocks/>
          </p:cNvCxnSpPr>
          <p:nvPr/>
        </p:nvCxnSpPr>
        <p:spPr>
          <a:xfrm>
            <a:off x="7257403" y="2940963"/>
            <a:ext cx="547031" cy="199775"/>
          </a:xfrm>
          <a:prstGeom prst="line">
            <a:avLst/>
          </a:prstGeom>
          <a:ln w="28575">
            <a:solidFill>
              <a:srgbClr val="FF0000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直線コネクタ 56">
            <a:extLst>
              <a:ext uri="{FF2B5EF4-FFF2-40B4-BE49-F238E27FC236}">
                <a16:creationId xmlns:a16="http://schemas.microsoft.com/office/drawing/2014/main" id="{5E091364-092F-4997-B803-93A4DB908320}"/>
              </a:ext>
            </a:extLst>
          </p:cNvPr>
          <p:cNvCxnSpPr/>
          <p:nvPr/>
        </p:nvCxnSpPr>
        <p:spPr>
          <a:xfrm flipH="1" flipV="1">
            <a:off x="7582309" y="2680670"/>
            <a:ext cx="182344" cy="60334"/>
          </a:xfrm>
          <a:prstGeom prst="line">
            <a:avLst/>
          </a:prstGeom>
          <a:ln w="28575">
            <a:solidFill>
              <a:srgbClr val="FF0000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フリーフォーム 67">
            <a:extLst>
              <a:ext uri="{FF2B5EF4-FFF2-40B4-BE49-F238E27FC236}">
                <a16:creationId xmlns:a16="http://schemas.microsoft.com/office/drawing/2014/main" id="{2520BB56-577B-4144-8296-BFD221C4D842}"/>
              </a:ext>
            </a:extLst>
          </p:cNvPr>
          <p:cNvSpPr/>
          <p:nvPr/>
        </p:nvSpPr>
        <p:spPr>
          <a:xfrm>
            <a:off x="1415386" y="2650503"/>
            <a:ext cx="593957" cy="2092930"/>
          </a:xfrm>
          <a:custGeom>
            <a:avLst/>
            <a:gdLst>
              <a:gd name="connsiteX0" fmla="*/ 532738 w 703565"/>
              <a:gd name="connsiteY0" fmla="*/ 44787 h 2478587"/>
              <a:gd name="connsiteX1" fmla="*/ 508884 w 703565"/>
              <a:gd name="connsiteY1" fmla="*/ 92495 h 2478587"/>
              <a:gd name="connsiteX2" fmla="*/ 492981 w 703565"/>
              <a:gd name="connsiteY2" fmla="*/ 140203 h 2478587"/>
              <a:gd name="connsiteX3" fmla="*/ 469127 w 703565"/>
              <a:gd name="connsiteY3" fmla="*/ 187911 h 2478587"/>
              <a:gd name="connsiteX4" fmla="*/ 445273 w 703565"/>
              <a:gd name="connsiteY4" fmla="*/ 195862 h 2478587"/>
              <a:gd name="connsiteX5" fmla="*/ 429371 w 703565"/>
              <a:gd name="connsiteY5" fmla="*/ 219716 h 2478587"/>
              <a:gd name="connsiteX6" fmla="*/ 413468 w 703565"/>
              <a:gd name="connsiteY6" fmla="*/ 267424 h 2478587"/>
              <a:gd name="connsiteX7" fmla="*/ 405517 w 703565"/>
              <a:gd name="connsiteY7" fmla="*/ 291278 h 2478587"/>
              <a:gd name="connsiteX8" fmla="*/ 397565 w 703565"/>
              <a:gd name="connsiteY8" fmla="*/ 331034 h 2478587"/>
              <a:gd name="connsiteX9" fmla="*/ 389614 w 703565"/>
              <a:gd name="connsiteY9" fmla="*/ 354888 h 2478587"/>
              <a:gd name="connsiteX10" fmla="*/ 365760 w 703565"/>
              <a:gd name="connsiteY10" fmla="*/ 434401 h 2478587"/>
              <a:gd name="connsiteX11" fmla="*/ 357809 w 703565"/>
              <a:gd name="connsiteY11" fmla="*/ 458255 h 2478587"/>
              <a:gd name="connsiteX12" fmla="*/ 333955 w 703565"/>
              <a:gd name="connsiteY12" fmla="*/ 482109 h 2478587"/>
              <a:gd name="connsiteX13" fmla="*/ 294198 w 703565"/>
              <a:gd name="connsiteY13" fmla="*/ 553671 h 2478587"/>
              <a:gd name="connsiteX14" fmla="*/ 278296 w 703565"/>
              <a:gd name="connsiteY14" fmla="*/ 577525 h 2478587"/>
              <a:gd name="connsiteX15" fmla="*/ 270345 w 703565"/>
              <a:gd name="connsiteY15" fmla="*/ 657038 h 2478587"/>
              <a:gd name="connsiteX16" fmla="*/ 246491 w 703565"/>
              <a:gd name="connsiteY16" fmla="*/ 672940 h 2478587"/>
              <a:gd name="connsiteX17" fmla="*/ 238539 w 703565"/>
              <a:gd name="connsiteY17" fmla="*/ 696794 h 2478587"/>
              <a:gd name="connsiteX18" fmla="*/ 222637 w 703565"/>
              <a:gd name="connsiteY18" fmla="*/ 720648 h 2478587"/>
              <a:gd name="connsiteX19" fmla="*/ 198783 w 703565"/>
              <a:gd name="connsiteY19" fmla="*/ 800161 h 2478587"/>
              <a:gd name="connsiteX20" fmla="*/ 159026 w 703565"/>
              <a:gd name="connsiteY20" fmla="*/ 871723 h 2478587"/>
              <a:gd name="connsiteX21" fmla="*/ 135172 w 703565"/>
              <a:gd name="connsiteY21" fmla="*/ 951236 h 2478587"/>
              <a:gd name="connsiteX22" fmla="*/ 127221 w 703565"/>
              <a:gd name="connsiteY22" fmla="*/ 975090 h 2478587"/>
              <a:gd name="connsiteX23" fmla="*/ 103367 w 703565"/>
              <a:gd name="connsiteY23" fmla="*/ 1078457 h 2478587"/>
              <a:gd name="connsiteX24" fmla="*/ 103367 w 703565"/>
              <a:gd name="connsiteY24" fmla="*/ 1078457 h 2478587"/>
              <a:gd name="connsiteX25" fmla="*/ 79513 w 703565"/>
              <a:gd name="connsiteY25" fmla="*/ 1142067 h 2478587"/>
              <a:gd name="connsiteX26" fmla="*/ 95416 w 703565"/>
              <a:gd name="connsiteY26" fmla="*/ 1189775 h 2478587"/>
              <a:gd name="connsiteX27" fmla="*/ 79513 w 703565"/>
              <a:gd name="connsiteY27" fmla="*/ 1301093 h 2478587"/>
              <a:gd name="connsiteX28" fmla="*/ 71562 w 703565"/>
              <a:gd name="connsiteY28" fmla="*/ 1468071 h 2478587"/>
              <a:gd name="connsiteX29" fmla="*/ 63611 w 703565"/>
              <a:gd name="connsiteY29" fmla="*/ 1786123 h 2478587"/>
              <a:gd name="connsiteX30" fmla="*/ 47708 w 703565"/>
              <a:gd name="connsiteY30" fmla="*/ 1833831 h 2478587"/>
              <a:gd name="connsiteX31" fmla="*/ 23854 w 703565"/>
              <a:gd name="connsiteY31" fmla="*/ 1849733 h 2478587"/>
              <a:gd name="connsiteX32" fmla="*/ 0 w 703565"/>
              <a:gd name="connsiteY32" fmla="*/ 1937198 h 2478587"/>
              <a:gd name="connsiteX33" fmla="*/ 15903 w 703565"/>
              <a:gd name="connsiteY33" fmla="*/ 2040565 h 2478587"/>
              <a:gd name="connsiteX34" fmla="*/ 31805 w 703565"/>
              <a:gd name="connsiteY34" fmla="*/ 2064419 h 2478587"/>
              <a:gd name="connsiteX35" fmla="*/ 39757 w 703565"/>
              <a:gd name="connsiteY35" fmla="*/ 2175737 h 2478587"/>
              <a:gd name="connsiteX36" fmla="*/ 47708 w 703565"/>
              <a:gd name="connsiteY36" fmla="*/ 2199591 h 2478587"/>
              <a:gd name="connsiteX37" fmla="*/ 55659 w 703565"/>
              <a:gd name="connsiteY37" fmla="*/ 2287055 h 2478587"/>
              <a:gd name="connsiteX38" fmla="*/ 87465 w 703565"/>
              <a:gd name="connsiteY38" fmla="*/ 2358617 h 2478587"/>
              <a:gd name="connsiteX39" fmla="*/ 95416 w 703565"/>
              <a:gd name="connsiteY39" fmla="*/ 2382471 h 2478587"/>
              <a:gd name="connsiteX40" fmla="*/ 103367 w 703565"/>
              <a:gd name="connsiteY40" fmla="*/ 2438130 h 2478587"/>
              <a:gd name="connsiteX41" fmla="*/ 143124 w 703565"/>
              <a:gd name="connsiteY41" fmla="*/ 2477886 h 2478587"/>
              <a:gd name="connsiteX42" fmla="*/ 182880 w 703565"/>
              <a:gd name="connsiteY42" fmla="*/ 2469935 h 2478587"/>
              <a:gd name="connsiteX43" fmla="*/ 190832 w 703565"/>
              <a:gd name="connsiteY43" fmla="*/ 2438130 h 2478587"/>
              <a:gd name="connsiteX44" fmla="*/ 198783 w 703565"/>
              <a:gd name="connsiteY44" fmla="*/ 2414276 h 2478587"/>
              <a:gd name="connsiteX45" fmla="*/ 206734 w 703565"/>
              <a:gd name="connsiteY45" fmla="*/ 2350666 h 2478587"/>
              <a:gd name="connsiteX46" fmla="*/ 222637 w 703565"/>
              <a:gd name="connsiteY46" fmla="*/ 2302958 h 2478587"/>
              <a:gd name="connsiteX47" fmla="*/ 230588 w 703565"/>
              <a:gd name="connsiteY47" fmla="*/ 2239347 h 2478587"/>
              <a:gd name="connsiteX48" fmla="*/ 238539 w 703565"/>
              <a:gd name="connsiteY48" fmla="*/ 2215493 h 2478587"/>
              <a:gd name="connsiteX49" fmla="*/ 246491 w 703565"/>
              <a:gd name="connsiteY49" fmla="*/ 2024662 h 2478587"/>
              <a:gd name="connsiteX50" fmla="*/ 262393 w 703565"/>
              <a:gd name="connsiteY50" fmla="*/ 1976954 h 2478587"/>
              <a:gd name="connsiteX51" fmla="*/ 286247 w 703565"/>
              <a:gd name="connsiteY51" fmla="*/ 1929246 h 2478587"/>
              <a:gd name="connsiteX52" fmla="*/ 294198 w 703565"/>
              <a:gd name="connsiteY52" fmla="*/ 1905393 h 2478587"/>
              <a:gd name="connsiteX53" fmla="*/ 310101 w 703565"/>
              <a:gd name="connsiteY53" fmla="*/ 1794074 h 2478587"/>
              <a:gd name="connsiteX54" fmla="*/ 326004 w 703565"/>
              <a:gd name="connsiteY54" fmla="*/ 1746366 h 2478587"/>
              <a:gd name="connsiteX55" fmla="*/ 349858 w 703565"/>
              <a:gd name="connsiteY55" fmla="*/ 1579389 h 2478587"/>
              <a:gd name="connsiteX56" fmla="*/ 373712 w 703565"/>
              <a:gd name="connsiteY56" fmla="*/ 1507827 h 2478587"/>
              <a:gd name="connsiteX57" fmla="*/ 381663 w 703565"/>
              <a:gd name="connsiteY57" fmla="*/ 1483973 h 2478587"/>
              <a:gd name="connsiteX58" fmla="*/ 405517 w 703565"/>
              <a:gd name="connsiteY58" fmla="*/ 1356753 h 2478587"/>
              <a:gd name="connsiteX59" fmla="*/ 421419 w 703565"/>
              <a:gd name="connsiteY59" fmla="*/ 1309045 h 2478587"/>
              <a:gd name="connsiteX60" fmla="*/ 429371 w 703565"/>
              <a:gd name="connsiteY60" fmla="*/ 1285191 h 2478587"/>
              <a:gd name="connsiteX61" fmla="*/ 445273 w 703565"/>
              <a:gd name="connsiteY61" fmla="*/ 1110262 h 2478587"/>
              <a:gd name="connsiteX62" fmla="*/ 453225 w 703565"/>
              <a:gd name="connsiteY62" fmla="*/ 1086408 h 2478587"/>
              <a:gd name="connsiteX63" fmla="*/ 461176 w 703565"/>
              <a:gd name="connsiteY63" fmla="*/ 625233 h 2478587"/>
              <a:gd name="connsiteX64" fmla="*/ 469127 w 703565"/>
              <a:gd name="connsiteY64" fmla="*/ 601379 h 2478587"/>
              <a:gd name="connsiteX65" fmla="*/ 477078 w 703565"/>
              <a:gd name="connsiteY65" fmla="*/ 569573 h 2478587"/>
              <a:gd name="connsiteX66" fmla="*/ 492981 w 703565"/>
              <a:gd name="connsiteY66" fmla="*/ 474158 h 2478587"/>
              <a:gd name="connsiteX67" fmla="*/ 524786 w 703565"/>
              <a:gd name="connsiteY67" fmla="*/ 426450 h 2478587"/>
              <a:gd name="connsiteX68" fmla="*/ 540689 w 703565"/>
              <a:gd name="connsiteY68" fmla="*/ 402596 h 2478587"/>
              <a:gd name="connsiteX69" fmla="*/ 564543 w 703565"/>
              <a:gd name="connsiteY69" fmla="*/ 323083 h 2478587"/>
              <a:gd name="connsiteX70" fmla="*/ 588397 w 703565"/>
              <a:gd name="connsiteY70" fmla="*/ 275375 h 2478587"/>
              <a:gd name="connsiteX71" fmla="*/ 604299 w 703565"/>
              <a:gd name="connsiteY71" fmla="*/ 251521 h 2478587"/>
              <a:gd name="connsiteX72" fmla="*/ 620202 w 703565"/>
              <a:gd name="connsiteY72" fmla="*/ 203813 h 2478587"/>
              <a:gd name="connsiteX73" fmla="*/ 628153 w 703565"/>
              <a:gd name="connsiteY73" fmla="*/ 179960 h 2478587"/>
              <a:gd name="connsiteX74" fmla="*/ 675861 w 703565"/>
              <a:gd name="connsiteY74" fmla="*/ 148154 h 2478587"/>
              <a:gd name="connsiteX75" fmla="*/ 683812 w 703565"/>
              <a:gd name="connsiteY75" fmla="*/ 100446 h 2478587"/>
              <a:gd name="connsiteX76" fmla="*/ 659958 w 703565"/>
              <a:gd name="connsiteY76" fmla="*/ 92495 h 2478587"/>
              <a:gd name="connsiteX77" fmla="*/ 636105 w 703565"/>
              <a:gd name="connsiteY77" fmla="*/ 76593 h 2478587"/>
              <a:gd name="connsiteX78" fmla="*/ 596348 w 703565"/>
              <a:gd name="connsiteY78" fmla="*/ 68641 h 2478587"/>
              <a:gd name="connsiteX79" fmla="*/ 532738 w 703565"/>
              <a:gd name="connsiteY79" fmla="*/ 44787 h 247858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</a:cxnLst>
            <a:rect l="l" t="t" r="r" b="b"/>
            <a:pathLst>
              <a:path w="703565" h="2478587">
                <a:moveTo>
                  <a:pt x="532738" y="44787"/>
                </a:moveTo>
                <a:cubicBezTo>
                  <a:pt x="518161" y="48763"/>
                  <a:pt x="549993" y="0"/>
                  <a:pt x="508884" y="92495"/>
                </a:cubicBezTo>
                <a:cubicBezTo>
                  <a:pt x="502076" y="107813"/>
                  <a:pt x="498282" y="124300"/>
                  <a:pt x="492981" y="140203"/>
                </a:cubicBezTo>
                <a:cubicBezTo>
                  <a:pt x="487743" y="155918"/>
                  <a:pt x="483141" y="176700"/>
                  <a:pt x="469127" y="187911"/>
                </a:cubicBezTo>
                <a:cubicBezTo>
                  <a:pt x="462582" y="193147"/>
                  <a:pt x="453224" y="193212"/>
                  <a:pt x="445273" y="195862"/>
                </a:cubicBezTo>
                <a:cubicBezTo>
                  <a:pt x="439972" y="203813"/>
                  <a:pt x="433252" y="210983"/>
                  <a:pt x="429371" y="219716"/>
                </a:cubicBezTo>
                <a:cubicBezTo>
                  <a:pt x="422563" y="235034"/>
                  <a:pt x="418769" y="251521"/>
                  <a:pt x="413468" y="267424"/>
                </a:cubicBezTo>
                <a:cubicBezTo>
                  <a:pt x="410818" y="275375"/>
                  <a:pt x="407161" y="283059"/>
                  <a:pt x="405517" y="291278"/>
                </a:cubicBezTo>
                <a:cubicBezTo>
                  <a:pt x="402866" y="304530"/>
                  <a:pt x="400843" y="317923"/>
                  <a:pt x="397565" y="331034"/>
                </a:cubicBezTo>
                <a:cubicBezTo>
                  <a:pt x="395532" y="339165"/>
                  <a:pt x="391916" y="346829"/>
                  <a:pt x="389614" y="354888"/>
                </a:cubicBezTo>
                <a:cubicBezTo>
                  <a:pt x="365582" y="439001"/>
                  <a:pt x="403549" y="321033"/>
                  <a:pt x="365760" y="434401"/>
                </a:cubicBezTo>
                <a:cubicBezTo>
                  <a:pt x="363110" y="442352"/>
                  <a:pt x="363736" y="452328"/>
                  <a:pt x="357809" y="458255"/>
                </a:cubicBezTo>
                <a:lnTo>
                  <a:pt x="333955" y="482109"/>
                </a:lnTo>
                <a:cubicBezTo>
                  <a:pt x="319960" y="524096"/>
                  <a:pt x="330654" y="498987"/>
                  <a:pt x="294198" y="553671"/>
                </a:cubicBezTo>
                <a:lnTo>
                  <a:pt x="278296" y="577525"/>
                </a:lnTo>
                <a:cubicBezTo>
                  <a:pt x="275646" y="604029"/>
                  <a:pt x="278768" y="631768"/>
                  <a:pt x="270345" y="657038"/>
                </a:cubicBezTo>
                <a:cubicBezTo>
                  <a:pt x="267323" y="666104"/>
                  <a:pt x="252461" y="665478"/>
                  <a:pt x="246491" y="672940"/>
                </a:cubicBezTo>
                <a:cubicBezTo>
                  <a:pt x="241255" y="679485"/>
                  <a:pt x="242287" y="689297"/>
                  <a:pt x="238539" y="696794"/>
                </a:cubicBezTo>
                <a:cubicBezTo>
                  <a:pt x="234265" y="705341"/>
                  <a:pt x="227938" y="712697"/>
                  <a:pt x="222637" y="720648"/>
                </a:cubicBezTo>
                <a:cubicBezTo>
                  <a:pt x="218193" y="738424"/>
                  <a:pt x="206523" y="788550"/>
                  <a:pt x="198783" y="800161"/>
                </a:cubicBezTo>
                <a:cubicBezTo>
                  <a:pt x="170311" y="842870"/>
                  <a:pt x="169522" y="834988"/>
                  <a:pt x="159026" y="871723"/>
                </a:cubicBezTo>
                <a:cubicBezTo>
                  <a:pt x="134984" y="955868"/>
                  <a:pt x="172978" y="837819"/>
                  <a:pt x="135172" y="951236"/>
                </a:cubicBezTo>
                <a:lnTo>
                  <a:pt x="127221" y="975090"/>
                </a:lnTo>
                <a:cubicBezTo>
                  <a:pt x="116899" y="1047343"/>
                  <a:pt x="125197" y="1012969"/>
                  <a:pt x="103367" y="1078457"/>
                </a:cubicBezTo>
                <a:lnTo>
                  <a:pt x="103367" y="1078457"/>
                </a:lnTo>
                <a:cubicBezTo>
                  <a:pt x="93542" y="1127584"/>
                  <a:pt x="102913" y="1106968"/>
                  <a:pt x="79513" y="1142067"/>
                </a:cubicBezTo>
                <a:cubicBezTo>
                  <a:pt x="84814" y="1157970"/>
                  <a:pt x="96934" y="1173081"/>
                  <a:pt x="95416" y="1189775"/>
                </a:cubicBezTo>
                <a:cubicBezTo>
                  <a:pt x="86706" y="1285587"/>
                  <a:pt x="96724" y="1249467"/>
                  <a:pt x="79513" y="1301093"/>
                </a:cubicBezTo>
                <a:cubicBezTo>
                  <a:pt x="76863" y="1356752"/>
                  <a:pt x="73388" y="1412379"/>
                  <a:pt x="71562" y="1468071"/>
                </a:cubicBezTo>
                <a:cubicBezTo>
                  <a:pt x="68087" y="1574065"/>
                  <a:pt x="70513" y="1680297"/>
                  <a:pt x="63611" y="1786123"/>
                </a:cubicBezTo>
                <a:cubicBezTo>
                  <a:pt x="62520" y="1802850"/>
                  <a:pt x="61656" y="1824533"/>
                  <a:pt x="47708" y="1833831"/>
                </a:cubicBezTo>
                <a:lnTo>
                  <a:pt x="23854" y="1849733"/>
                </a:lnTo>
                <a:cubicBezTo>
                  <a:pt x="5919" y="1921475"/>
                  <a:pt x="14864" y="1892610"/>
                  <a:pt x="0" y="1937198"/>
                </a:cubicBezTo>
                <a:cubicBezTo>
                  <a:pt x="2280" y="1960000"/>
                  <a:pt x="1576" y="2011910"/>
                  <a:pt x="15903" y="2040565"/>
                </a:cubicBezTo>
                <a:cubicBezTo>
                  <a:pt x="20177" y="2049112"/>
                  <a:pt x="26504" y="2056468"/>
                  <a:pt x="31805" y="2064419"/>
                </a:cubicBezTo>
                <a:cubicBezTo>
                  <a:pt x="34456" y="2101525"/>
                  <a:pt x="35410" y="2138791"/>
                  <a:pt x="39757" y="2175737"/>
                </a:cubicBezTo>
                <a:cubicBezTo>
                  <a:pt x="40736" y="2184061"/>
                  <a:pt x="46523" y="2191294"/>
                  <a:pt x="47708" y="2199591"/>
                </a:cubicBezTo>
                <a:cubicBezTo>
                  <a:pt x="51848" y="2228572"/>
                  <a:pt x="50571" y="2258226"/>
                  <a:pt x="55659" y="2287055"/>
                </a:cubicBezTo>
                <a:cubicBezTo>
                  <a:pt x="62472" y="2325661"/>
                  <a:pt x="69169" y="2331173"/>
                  <a:pt x="87465" y="2358617"/>
                </a:cubicBezTo>
                <a:cubicBezTo>
                  <a:pt x="90115" y="2366568"/>
                  <a:pt x="93772" y="2374252"/>
                  <a:pt x="95416" y="2382471"/>
                </a:cubicBezTo>
                <a:cubicBezTo>
                  <a:pt x="99091" y="2400848"/>
                  <a:pt x="97982" y="2420179"/>
                  <a:pt x="103367" y="2438130"/>
                </a:cubicBezTo>
                <a:cubicBezTo>
                  <a:pt x="109993" y="2460217"/>
                  <a:pt x="125896" y="2466401"/>
                  <a:pt x="143124" y="2477886"/>
                </a:cubicBezTo>
                <a:cubicBezTo>
                  <a:pt x="156376" y="2475236"/>
                  <a:pt x="172498" y="2478587"/>
                  <a:pt x="182880" y="2469935"/>
                </a:cubicBezTo>
                <a:cubicBezTo>
                  <a:pt x="191275" y="2462939"/>
                  <a:pt x="187830" y="2448638"/>
                  <a:pt x="190832" y="2438130"/>
                </a:cubicBezTo>
                <a:cubicBezTo>
                  <a:pt x="193135" y="2430071"/>
                  <a:pt x="196133" y="2422227"/>
                  <a:pt x="198783" y="2414276"/>
                </a:cubicBezTo>
                <a:cubicBezTo>
                  <a:pt x="201433" y="2393073"/>
                  <a:pt x="202257" y="2371560"/>
                  <a:pt x="206734" y="2350666"/>
                </a:cubicBezTo>
                <a:cubicBezTo>
                  <a:pt x="210246" y="2334275"/>
                  <a:pt x="222637" y="2302958"/>
                  <a:pt x="222637" y="2302958"/>
                </a:cubicBezTo>
                <a:cubicBezTo>
                  <a:pt x="225287" y="2281754"/>
                  <a:pt x="226766" y="2260371"/>
                  <a:pt x="230588" y="2239347"/>
                </a:cubicBezTo>
                <a:cubicBezTo>
                  <a:pt x="232087" y="2231101"/>
                  <a:pt x="237920" y="2223852"/>
                  <a:pt x="238539" y="2215493"/>
                </a:cubicBezTo>
                <a:cubicBezTo>
                  <a:pt x="243242" y="2152001"/>
                  <a:pt x="240156" y="2088012"/>
                  <a:pt x="246491" y="2024662"/>
                </a:cubicBezTo>
                <a:cubicBezTo>
                  <a:pt x="248159" y="2007982"/>
                  <a:pt x="257092" y="1992857"/>
                  <a:pt x="262393" y="1976954"/>
                </a:cubicBezTo>
                <a:cubicBezTo>
                  <a:pt x="282377" y="1917002"/>
                  <a:pt x="255424" y="1990894"/>
                  <a:pt x="286247" y="1929246"/>
                </a:cubicBezTo>
                <a:cubicBezTo>
                  <a:pt x="289995" y="1921750"/>
                  <a:pt x="291548" y="1913344"/>
                  <a:pt x="294198" y="1905393"/>
                </a:cubicBezTo>
                <a:cubicBezTo>
                  <a:pt x="299723" y="1850145"/>
                  <a:pt x="297132" y="1837305"/>
                  <a:pt x="310101" y="1794074"/>
                </a:cubicBezTo>
                <a:cubicBezTo>
                  <a:pt x="314918" y="1778018"/>
                  <a:pt x="326004" y="1746366"/>
                  <a:pt x="326004" y="1746366"/>
                </a:cubicBezTo>
                <a:cubicBezTo>
                  <a:pt x="335070" y="1610366"/>
                  <a:pt x="321355" y="1664899"/>
                  <a:pt x="349858" y="1579389"/>
                </a:cubicBezTo>
                <a:lnTo>
                  <a:pt x="373712" y="1507827"/>
                </a:lnTo>
                <a:lnTo>
                  <a:pt x="381663" y="1483973"/>
                </a:lnTo>
                <a:cubicBezTo>
                  <a:pt x="391282" y="1387776"/>
                  <a:pt x="381190" y="1429732"/>
                  <a:pt x="405517" y="1356753"/>
                </a:cubicBezTo>
                <a:lnTo>
                  <a:pt x="421419" y="1309045"/>
                </a:lnTo>
                <a:lnTo>
                  <a:pt x="429371" y="1285191"/>
                </a:lnTo>
                <a:cubicBezTo>
                  <a:pt x="432791" y="1233886"/>
                  <a:pt x="434405" y="1164602"/>
                  <a:pt x="445273" y="1110262"/>
                </a:cubicBezTo>
                <a:cubicBezTo>
                  <a:pt x="446917" y="1102043"/>
                  <a:pt x="450574" y="1094359"/>
                  <a:pt x="453225" y="1086408"/>
                </a:cubicBezTo>
                <a:cubicBezTo>
                  <a:pt x="455875" y="932683"/>
                  <a:pt x="456138" y="778898"/>
                  <a:pt x="461176" y="625233"/>
                </a:cubicBezTo>
                <a:cubicBezTo>
                  <a:pt x="461451" y="616856"/>
                  <a:pt x="466825" y="609438"/>
                  <a:pt x="469127" y="601379"/>
                </a:cubicBezTo>
                <a:cubicBezTo>
                  <a:pt x="472129" y="590871"/>
                  <a:pt x="475123" y="580325"/>
                  <a:pt x="477078" y="569573"/>
                </a:cubicBezTo>
                <a:cubicBezTo>
                  <a:pt x="477742" y="565921"/>
                  <a:pt x="487988" y="485142"/>
                  <a:pt x="492981" y="474158"/>
                </a:cubicBezTo>
                <a:cubicBezTo>
                  <a:pt x="500890" y="456759"/>
                  <a:pt x="514184" y="442353"/>
                  <a:pt x="524786" y="426450"/>
                </a:cubicBezTo>
                <a:lnTo>
                  <a:pt x="540689" y="402596"/>
                </a:lnTo>
                <a:cubicBezTo>
                  <a:pt x="545134" y="384815"/>
                  <a:pt x="556798" y="334701"/>
                  <a:pt x="564543" y="323083"/>
                </a:cubicBezTo>
                <a:cubicBezTo>
                  <a:pt x="610115" y="254722"/>
                  <a:pt x="555477" y="341214"/>
                  <a:pt x="588397" y="275375"/>
                </a:cubicBezTo>
                <a:cubicBezTo>
                  <a:pt x="592671" y="266828"/>
                  <a:pt x="600418" y="260254"/>
                  <a:pt x="604299" y="251521"/>
                </a:cubicBezTo>
                <a:cubicBezTo>
                  <a:pt x="611107" y="236203"/>
                  <a:pt x="614901" y="219716"/>
                  <a:pt x="620202" y="203813"/>
                </a:cubicBezTo>
                <a:cubicBezTo>
                  <a:pt x="622852" y="195862"/>
                  <a:pt x="621180" y="184609"/>
                  <a:pt x="628153" y="179960"/>
                </a:cubicBezTo>
                <a:lnTo>
                  <a:pt x="675861" y="148154"/>
                </a:lnTo>
                <a:cubicBezTo>
                  <a:pt x="686404" y="132340"/>
                  <a:pt x="703565" y="120198"/>
                  <a:pt x="683812" y="100446"/>
                </a:cubicBezTo>
                <a:cubicBezTo>
                  <a:pt x="677885" y="94520"/>
                  <a:pt x="667909" y="95145"/>
                  <a:pt x="659958" y="92495"/>
                </a:cubicBezTo>
                <a:cubicBezTo>
                  <a:pt x="652007" y="87194"/>
                  <a:pt x="645052" y="79948"/>
                  <a:pt x="636105" y="76593"/>
                </a:cubicBezTo>
                <a:cubicBezTo>
                  <a:pt x="623451" y="71848"/>
                  <a:pt x="609387" y="72197"/>
                  <a:pt x="596348" y="68641"/>
                </a:cubicBezTo>
                <a:cubicBezTo>
                  <a:pt x="557232" y="57973"/>
                  <a:pt x="547315" y="40811"/>
                  <a:pt x="532738" y="44787"/>
                </a:cubicBezTo>
                <a:close/>
              </a:path>
            </a:pathLst>
          </a:custGeom>
          <a:solidFill>
            <a:srgbClr val="FFFF00">
              <a:alpha val="5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 sz="1200" b="1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2790" name="図 68" descr="前畑俊術後sag.bmp">
            <a:extLst>
              <a:ext uri="{FF2B5EF4-FFF2-40B4-BE49-F238E27FC236}">
                <a16:creationId xmlns:a16="http://schemas.microsoft.com/office/drawing/2014/main" id="{A59DE2E2-5540-41CD-A4BF-F978E583A95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815" t="16949" r="52542" b="59322"/>
          <a:stretch>
            <a:fillRect/>
          </a:stretch>
        </p:blipFill>
        <p:spPr bwMode="auto">
          <a:xfrm>
            <a:off x="2510738" y="1941910"/>
            <a:ext cx="1276406" cy="1625004"/>
          </a:xfrm>
          <a:prstGeom prst="rect">
            <a:avLst/>
          </a:prstGeom>
          <a:noFill/>
          <a:ln w="28575">
            <a:solidFill>
              <a:srgbClr val="FF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53" name="直線コネクタ 52">
            <a:extLst>
              <a:ext uri="{FF2B5EF4-FFF2-40B4-BE49-F238E27FC236}">
                <a16:creationId xmlns:a16="http://schemas.microsoft.com/office/drawing/2014/main" id="{60EC97B8-E475-4161-A550-B3596C0842EA}"/>
              </a:ext>
            </a:extLst>
          </p:cNvPr>
          <p:cNvCxnSpPr/>
          <p:nvPr/>
        </p:nvCxnSpPr>
        <p:spPr>
          <a:xfrm>
            <a:off x="3300448" y="2610950"/>
            <a:ext cx="244019" cy="60335"/>
          </a:xfrm>
          <a:prstGeom prst="line">
            <a:avLst/>
          </a:prstGeom>
          <a:ln w="28575">
            <a:solidFill>
              <a:srgbClr val="FF0000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直線コネクタ 49">
            <a:extLst>
              <a:ext uri="{FF2B5EF4-FFF2-40B4-BE49-F238E27FC236}">
                <a16:creationId xmlns:a16="http://schemas.microsoft.com/office/drawing/2014/main" id="{CA72DB77-B0B0-49F2-8E81-F9F703297D14}"/>
              </a:ext>
            </a:extLst>
          </p:cNvPr>
          <p:cNvCxnSpPr>
            <a:cxnSpLocks/>
          </p:cNvCxnSpPr>
          <p:nvPr/>
        </p:nvCxnSpPr>
        <p:spPr>
          <a:xfrm>
            <a:off x="3174507" y="2286487"/>
            <a:ext cx="412627" cy="124839"/>
          </a:xfrm>
          <a:prstGeom prst="line">
            <a:avLst/>
          </a:prstGeom>
          <a:ln w="28575">
            <a:solidFill>
              <a:srgbClr val="FF0000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直線コネクタ 72">
            <a:extLst>
              <a:ext uri="{FF2B5EF4-FFF2-40B4-BE49-F238E27FC236}">
                <a16:creationId xmlns:a16="http://schemas.microsoft.com/office/drawing/2014/main" id="{D715B2EA-F3B1-4CF5-B6E6-02031FABA0C9}"/>
              </a:ext>
            </a:extLst>
          </p:cNvPr>
          <p:cNvCxnSpPr>
            <a:cxnSpLocks/>
          </p:cNvCxnSpPr>
          <p:nvPr/>
        </p:nvCxnSpPr>
        <p:spPr>
          <a:xfrm flipV="1">
            <a:off x="3360073" y="2361274"/>
            <a:ext cx="90364" cy="260959"/>
          </a:xfrm>
          <a:prstGeom prst="line">
            <a:avLst/>
          </a:prstGeom>
          <a:ln w="19050">
            <a:solidFill>
              <a:srgbClr val="FF0000"/>
            </a:solidFill>
            <a:headEnd type="triangl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テキスト ボックス 37">
            <a:extLst>
              <a:ext uri="{FF2B5EF4-FFF2-40B4-BE49-F238E27FC236}">
                <a16:creationId xmlns:a16="http://schemas.microsoft.com/office/drawing/2014/main" id="{C6051C02-40BD-6393-6591-BAFB1FCA904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94674" y="1919116"/>
            <a:ext cx="717766" cy="262642"/>
          </a:xfrm>
          <a:prstGeom prst="rect">
            <a:avLst/>
          </a:prstGeom>
          <a:solidFill>
            <a:schemeClr val="bg1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wrap="square" lIns="77221" tIns="38611" rIns="77221" bIns="38611">
            <a:spAutoFit/>
          </a:bodyPr>
          <a:lstStyle>
            <a:lvl1pPr>
              <a:spcBef>
                <a:spcPct val="20000"/>
              </a:spcBef>
              <a:buClr>
                <a:srgbClr val="ACC2C9"/>
              </a:buClr>
              <a:buFont typeface="Arial" panose="020B0604020202020204" pitchFamily="34" charset="0"/>
              <a:buChar char="•"/>
              <a:defRPr kumimoji="1" sz="2400">
                <a:solidFill>
                  <a:schemeClr val="tx2"/>
                </a:solidFill>
                <a:latin typeface="Tw Cen MT"/>
              </a:defRPr>
            </a:lvl1pPr>
            <a:lvl2pPr marL="742950" indent="-285750">
              <a:spcBef>
                <a:spcPct val="20000"/>
              </a:spcBef>
              <a:buClr>
                <a:srgbClr val="ACC2C9"/>
              </a:buClr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Tw Cen MT"/>
              </a:defRPr>
            </a:lvl2pPr>
            <a:lvl3pPr marL="1143000" indent="-228600">
              <a:spcBef>
                <a:spcPct val="20000"/>
              </a:spcBef>
              <a:buClr>
                <a:schemeClr val="accent2"/>
              </a:buClr>
              <a:buFont typeface="Arial" panose="020B0604020202020204" pitchFamily="34" charset="0"/>
              <a:buChar char="•"/>
              <a:defRPr kumimoji="1" sz="2000">
                <a:solidFill>
                  <a:schemeClr val="tx2"/>
                </a:solidFill>
                <a:latin typeface="Tw Cen MT"/>
              </a:defRPr>
            </a:lvl3pPr>
            <a:lvl4pPr marL="1600200" indent="-228600">
              <a:spcBef>
                <a:spcPct val="20000"/>
              </a:spcBef>
              <a:buClr>
                <a:srgbClr val="99987F"/>
              </a:buClr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Tw Cen MT"/>
              </a:defRPr>
            </a:lvl4pPr>
            <a:lvl5pPr marL="2057400" indent="-228600">
              <a:spcBef>
                <a:spcPct val="20000"/>
              </a:spcBef>
              <a:buClr>
                <a:srgbClr val="90AC97"/>
              </a:buClr>
              <a:buFont typeface="Arial" panose="020B0604020202020204" pitchFamily="34" charset="0"/>
              <a:buChar char="•"/>
              <a:defRPr kumimoji="1" sz="1600">
                <a:solidFill>
                  <a:schemeClr val="tx2"/>
                </a:solidFill>
                <a:latin typeface="Tw Cen MT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90AC97"/>
              </a:buClr>
              <a:buFont typeface="Arial" panose="020B0604020202020204" pitchFamily="34" charset="0"/>
              <a:buChar char="•"/>
              <a:defRPr kumimoji="1" sz="1600">
                <a:solidFill>
                  <a:schemeClr val="tx2"/>
                </a:solidFill>
                <a:latin typeface="Tw Cen MT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90AC97"/>
              </a:buClr>
              <a:buFont typeface="Arial" panose="020B0604020202020204" pitchFamily="34" charset="0"/>
              <a:buChar char="•"/>
              <a:defRPr kumimoji="1" sz="1600">
                <a:solidFill>
                  <a:schemeClr val="tx2"/>
                </a:solidFill>
                <a:latin typeface="Tw Cen MT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90AC97"/>
              </a:buClr>
              <a:buFont typeface="Arial" panose="020B0604020202020204" pitchFamily="34" charset="0"/>
              <a:buChar char="•"/>
              <a:defRPr kumimoji="1" sz="1600">
                <a:solidFill>
                  <a:schemeClr val="tx2"/>
                </a:solidFill>
                <a:latin typeface="Tw Cen MT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90AC97"/>
              </a:buClr>
              <a:buFont typeface="Arial" panose="020B0604020202020204" pitchFamily="34" charset="0"/>
              <a:buChar char="•"/>
              <a:defRPr kumimoji="1" sz="1600">
                <a:solidFill>
                  <a:schemeClr val="tx2"/>
                </a:solidFill>
                <a:latin typeface="Tw Cen MT"/>
              </a:defRPr>
            </a:lvl9pPr>
          </a:lstStyle>
          <a:p>
            <a:pPr>
              <a:spcBef>
                <a:spcPct val="0"/>
              </a:spcBef>
              <a:buClrTx/>
              <a:buFontTx/>
              <a:buNone/>
            </a:pPr>
            <a:r>
              <a:rPr lang="en-US" altLang="ja-JP" sz="1200" b="1" dirty="0">
                <a:solidFill>
                  <a:schemeClr val="tx1"/>
                </a:solidFill>
                <a:latin typeface="Arial" panose="020B0604020202020204" pitchFamily="34" charset="0"/>
                <a:ea typeface="HGP創英角ｺﾞｼｯｸUB" panose="020B0900000000000000" pitchFamily="50" charset="-128"/>
                <a:cs typeface="Arial" panose="020B0604020202020204" pitchFamily="34" charset="0"/>
              </a:rPr>
              <a:t>Case 1</a:t>
            </a:r>
            <a:endParaRPr lang="ja-JP" altLang="en-US" sz="1200" b="1" dirty="0">
              <a:solidFill>
                <a:schemeClr val="tx1"/>
              </a:solidFill>
              <a:latin typeface="Arial" panose="020B0604020202020204" pitchFamily="34" charset="0"/>
              <a:ea typeface="HGP創英角ｺﾞｼｯｸUB" panose="020B09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5" name="テキスト ボックス 37">
            <a:extLst>
              <a:ext uri="{FF2B5EF4-FFF2-40B4-BE49-F238E27FC236}">
                <a16:creationId xmlns:a16="http://schemas.microsoft.com/office/drawing/2014/main" id="{748BDCB1-491C-3C1E-205F-63E32FEEB04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71660" y="1919116"/>
            <a:ext cx="717766" cy="262642"/>
          </a:xfrm>
          <a:prstGeom prst="rect">
            <a:avLst/>
          </a:prstGeom>
          <a:solidFill>
            <a:schemeClr val="bg1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wrap="square" lIns="77221" tIns="38611" rIns="77221" bIns="38611">
            <a:spAutoFit/>
          </a:bodyPr>
          <a:lstStyle>
            <a:lvl1pPr>
              <a:spcBef>
                <a:spcPct val="20000"/>
              </a:spcBef>
              <a:buClr>
                <a:srgbClr val="ACC2C9"/>
              </a:buClr>
              <a:buFont typeface="Arial" panose="020B0604020202020204" pitchFamily="34" charset="0"/>
              <a:buChar char="•"/>
              <a:defRPr kumimoji="1" sz="2400">
                <a:solidFill>
                  <a:schemeClr val="tx2"/>
                </a:solidFill>
                <a:latin typeface="Tw Cen MT"/>
              </a:defRPr>
            </a:lvl1pPr>
            <a:lvl2pPr marL="742950" indent="-285750">
              <a:spcBef>
                <a:spcPct val="20000"/>
              </a:spcBef>
              <a:buClr>
                <a:srgbClr val="ACC2C9"/>
              </a:buClr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Tw Cen MT"/>
              </a:defRPr>
            </a:lvl2pPr>
            <a:lvl3pPr marL="1143000" indent="-228600">
              <a:spcBef>
                <a:spcPct val="20000"/>
              </a:spcBef>
              <a:buClr>
                <a:schemeClr val="accent2"/>
              </a:buClr>
              <a:buFont typeface="Arial" panose="020B0604020202020204" pitchFamily="34" charset="0"/>
              <a:buChar char="•"/>
              <a:defRPr kumimoji="1" sz="2000">
                <a:solidFill>
                  <a:schemeClr val="tx2"/>
                </a:solidFill>
                <a:latin typeface="Tw Cen MT"/>
              </a:defRPr>
            </a:lvl3pPr>
            <a:lvl4pPr marL="1600200" indent="-228600">
              <a:spcBef>
                <a:spcPct val="20000"/>
              </a:spcBef>
              <a:buClr>
                <a:srgbClr val="99987F"/>
              </a:buClr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Tw Cen MT"/>
              </a:defRPr>
            </a:lvl4pPr>
            <a:lvl5pPr marL="2057400" indent="-228600">
              <a:spcBef>
                <a:spcPct val="20000"/>
              </a:spcBef>
              <a:buClr>
                <a:srgbClr val="90AC97"/>
              </a:buClr>
              <a:buFont typeface="Arial" panose="020B0604020202020204" pitchFamily="34" charset="0"/>
              <a:buChar char="•"/>
              <a:defRPr kumimoji="1" sz="1600">
                <a:solidFill>
                  <a:schemeClr val="tx2"/>
                </a:solidFill>
                <a:latin typeface="Tw Cen MT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90AC97"/>
              </a:buClr>
              <a:buFont typeface="Arial" panose="020B0604020202020204" pitchFamily="34" charset="0"/>
              <a:buChar char="•"/>
              <a:defRPr kumimoji="1" sz="1600">
                <a:solidFill>
                  <a:schemeClr val="tx2"/>
                </a:solidFill>
                <a:latin typeface="Tw Cen MT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90AC97"/>
              </a:buClr>
              <a:buFont typeface="Arial" panose="020B0604020202020204" pitchFamily="34" charset="0"/>
              <a:buChar char="•"/>
              <a:defRPr kumimoji="1" sz="1600">
                <a:solidFill>
                  <a:schemeClr val="tx2"/>
                </a:solidFill>
                <a:latin typeface="Tw Cen MT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90AC97"/>
              </a:buClr>
              <a:buFont typeface="Arial" panose="020B0604020202020204" pitchFamily="34" charset="0"/>
              <a:buChar char="•"/>
              <a:defRPr kumimoji="1" sz="1600">
                <a:solidFill>
                  <a:schemeClr val="tx2"/>
                </a:solidFill>
                <a:latin typeface="Tw Cen MT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90AC97"/>
              </a:buClr>
              <a:buFont typeface="Arial" panose="020B0604020202020204" pitchFamily="34" charset="0"/>
              <a:buChar char="•"/>
              <a:defRPr kumimoji="1" sz="1600">
                <a:solidFill>
                  <a:schemeClr val="tx2"/>
                </a:solidFill>
                <a:latin typeface="Tw Cen MT"/>
              </a:defRPr>
            </a:lvl9pPr>
          </a:lstStyle>
          <a:p>
            <a:pPr>
              <a:spcBef>
                <a:spcPct val="0"/>
              </a:spcBef>
              <a:buClrTx/>
              <a:buFontTx/>
              <a:buNone/>
            </a:pPr>
            <a:r>
              <a:rPr lang="en-US" altLang="ja-JP" sz="1200" b="1" dirty="0">
                <a:solidFill>
                  <a:schemeClr val="tx1"/>
                </a:solidFill>
                <a:latin typeface="Arial" panose="020B0604020202020204" pitchFamily="34" charset="0"/>
                <a:ea typeface="HGP創英角ｺﾞｼｯｸUB" panose="020B0900000000000000" pitchFamily="50" charset="-128"/>
                <a:cs typeface="Arial" panose="020B0604020202020204" pitchFamily="34" charset="0"/>
              </a:rPr>
              <a:t>Case 2</a:t>
            </a:r>
            <a:endParaRPr lang="ja-JP" altLang="en-US" sz="1200" b="1" dirty="0">
              <a:solidFill>
                <a:schemeClr val="tx1"/>
              </a:solidFill>
              <a:latin typeface="Arial" panose="020B0604020202020204" pitchFamily="34" charset="0"/>
              <a:ea typeface="HGP創英角ｺﾞｼｯｸUB" panose="020B09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6" name="テキスト ボックス 37">
            <a:extLst>
              <a:ext uri="{FF2B5EF4-FFF2-40B4-BE49-F238E27FC236}">
                <a16:creationId xmlns:a16="http://schemas.microsoft.com/office/drawing/2014/main" id="{2C5F47C5-211F-05BC-B997-AB8B4E076A7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14844" y="2326857"/>
            <a:ext cx="393854" cy="262642"/>
          </a:xfrm>
          <a:prstGeom prst="rect">
            <a:avLst/>
          </a:prstGeom>
          <a:solidFill>
            <a:schemeClr val="bg1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wrap="square" lIns="77221" tIns="38611" rIns="77221" bIns="38611">
            <a:spAutoFit/>
          </a:bodyPr>
          <a:lstStyle>
            <a:lvl1pPr>
              <a:spcBef>
                <a:spcPct val="20000"/>
              </a:spcBef>
              <a:buClr>
                <a:srgbClr val="ACC2C9"/>
              </a:buClr>
              <a:buFont typeface="Arial" panose="020B0604020202020204" pitchFamily="34" charset="0"/>
              <a:buChar char="•"/>
              <a:defRPr kumimoji="1" sz="2400">
                <a:solidFill>
                  <a:schemeClr val="tx2"/>
                </a:solidFill>
                <a:latin typeface="Tw Cen MT"/>
              </a:defRPr>
            </a:lvl1pPr>
            <a:lvl2pPr marL="742950" indent="-285750">
              <a:spcBef>
                <a:spcPct val="20000"/>
              </a:spcBef>
              <a:buClr>
                <a:srgbClr val="ACC2C9"/>
              </a:buClr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Tw Cen MT"/>
              </a:defRPr>
            </a:lvl2pPr>
            <a:lvl3pPr marL="1143000" indent="-228600">
              <a:spcBef>
                <a:spcPct val="20000"/>
              </a:spcBef>
              <a:buClr>
                <a:schemeClr val="accent2"/>
              </a:buClr>
              <a:buFont typeface="Arial" panose="020B0604020202020204" pitchFamily="34" charset="0"/>
              <a:buChar char="•"/>
              <a:defRPr kumimoji="1" sz="2000">
                <a:solidFill>
                  <a:schemeClr val="tx2"/>
                </a:solidFill>
                <a:latin typeface="Tw Cen MT"/>
              </a:defRPr>
            </a:lvl3pPr>
            <a:lvl4pPr marL="1600200" indent="-228600">
              <a:spcBef>
                <a:spcPct val="20000"/>
              </a:spcBef>
              <a:buClr>
                <a:srgbClr val="99987F"/>
              </a:buClr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Tw Cen MT"/>
              </a:defRPr>
            </a:lvl4pPr>
            <a:lvl5pPr marL="2057400" indent="-228600">
              <a:spcBef>
                <a:spcPct val="20000"/>
              </a:spcBef>
              <a:buClr>
                <a:srgbClr val="90AC97"/>
              </a:buClr>
              <a:buFont typeface="Arial" panose="020B0604020202020204" pitchFamily="34" charset="0"/>
              <a:buChar char="•"/>
              <a:defRPr kumimoji="1" sz="1600">
                <a:solidFill>
                  <a:schemeClr val="tx2"/>
                </a:solidFill>
                <a:latin typeface="Tw Cen MT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90AC97"/>
              </a:buClr>
              <a:buFont typeface="Arial" panose="020B0604020202020204" pitchFamily="34" charset="0"/>
              <a:buChar char="•"/>
              <a:defRPr kumimoji="1" sz="1600">
                <a:solidFill>
                  <a:schemeClr val="tx2"/>
                </a:solidFill>
                <a:latin typeface="Tw Cen MT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90AC97"/>
              </a:buClr>
              <a:buFont typeface="Arial" panose="020B0604020202020204" pitchFamily="34" charset="0"/>
              <a:buChar char="•"/>
              <a:defRPr kumimoji="1" sz="1600">
                <a:solidFill>
                  <a:schemeClr val="tx2"/>
                </a:solidFill>
                <a:latin typeface="Tw Cen MT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90AC97"/>
              </a:buClr>
              <a:buFont typeface="Arial" panose="020B0604020202020204" pitchFamily="34" charset="0"/>
              <a:buChar char="•"/>
              <a:defRPr kumimoji="1" sz="1600">
                <a:solidFill>
                  <a:schemeClr val="tx2"/>
                </a:solidFill>
                <a:latin typeface="Tw Cen MT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90AC97"/>
              </a:buClr>
              <a:buFont typeface="Arial" panose="020B0604020202020204" pitchFamily="34" charset="0"/>
              <a:buChar char="•"/>
              <a:defRPr kumimoji="1" sz="1600">
                <a:solidFill>
                  <a:schemeClr val="tx2"/>
                </a:solidFill>
                <a:latin typeface="Tw Cen MT"/>
              </a:defRPr>
            </a:lvl9pPr>
          </a:lstStyle>
          <a:p>
            <a:pPr>
              <a:spcBef>
                <a:spcPct val="0"/>
              </a:spcBef>
              <a:buClrTx/>
              <a:buFontTx/>
              <a:buNone/>
            </a:pPr>
            <a:r>
              <a:rPr lang="en-US" altLang="ja-JP" sz="1200" b="1" dirty="0">
                <a:solidFill>
                  <a:schemeClr val="tx1"/>
                </a:solidFill>
                <a:latin typeface="Arial" panose="020B0604020202020204" pitchFamily="34" charset="0"/>
                <a:ea typeface="HGP創英角ｺﾞｼｯｸUB" panose="020B0900000000000000" pitchFamily="50" charset="-128"/>
                <a:cs typeface="Arial" panose="020B0604020202020204" pitchFamily="34" charset="0"/>
              </a:rPr>
              <a:t>AH</a:t>
            </a:r>
            <a:endParaRPr lang="ja-JP" altLang="en-US" sz="1200" b="1" dirty="0">
              <a:solidFill>
                <a:schemeClr val="tx1"/>
              </a:solidFill>
              <a:latin typeface="Arial" panose="020B0604020202020204" pitchFamily="34" charset="0"/>
              <a:ea typeface="HGP創英角ｺﾞｼｯｸUB" panose="020B09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7" name="二等辺三角形 6">
            <a:extLst>
              <a:ext uri="{FF2B5EF4-FFF2-40B4-BE49-F238E27FC236}">
                <a16:creationId xmlns:a16="http://schemas.microsoft.com/office/drawing/2014/main" id="{18192F33-D4D2-0939-6F04-4F1C7EE11DDC}"/>
              </a:ext>
            </a:extLst>
          </p:cNvPr>
          <p:cNvSpPr/>
          <p:nvPr/>
        </p:nvSpPr>
        <p:spPr>
          <a:xfrm rot="20698522">
            <a:off x="3527138" y="2754782"/>
            <a:ext cx="132514" cy="198857"/>
          </a:xfrm>
          <a:prstGeom prst="triangl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513FDDE4-8F86-AB19-16AD-37AEC0326617}"/>
              </a:ext>
            </a:extLst>
          </p:cNvPr>
          <p:cNvSpPr txBox="1"/>
          <p:nvPr/>
        </p:nvSpPr>
        <p:spPr>
          <a:xfrm>
            <a:off x="3412148" y="3000981"/>
            <a:ext cx="1159852" cy="27699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>
                <a:cs typeface="Arial" panose="020B0604020202020204" pitchFamily="34" charset="0"/>
              </a:rPr>
              <a:t>Anastomosis</a:t>
            </a:r>
            <a:endParaRPr kumimoji="1" lang="ja-JP" altLang="en-US" sz="1200" b="1" dirty="0">
              <a:cs typeface="Arial" panose="020B0604020202020204" pitchFamily="34" charset="0"/>
            </a:endParaRPr>
          </a:p>
        </p:txBody>
      </p:sp>
      <p:sp>
        <p:nvSpPr>
          <p:cNvPr id="9" name="二等辺三角形 8">
            <a:extLst>
              <a:ext uri="{FF2B5EF4-FFF2-40B4-BE49-F238E27FC236}">
                <a16:creationId xmlns:a16="http://schemas.microsoft.com/office/drawing/2014/main" id="{EB6B57BC-D4C9-0755-6B28-F573BA055912}"/>
              </a:ext>
            </a:extLst>
          </p:cNvPr>
          <p:cNvSpPr/>
          <p:nvPr/>
        </p:nvSpPr>
        <p:spPr>
          <a:xfrm rot="16200000">
            <a:off x="3506859" y="2373534"/>
            <a:ext cx="132514" cy="198857"/>
          </a:xfrm>
          <a:prstGeom prst="triangl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" name="二等辺三角形 9">
            <a:extLst>
              <a:ext uri="{FF2B5EF4-FFF2-40B4-BE49-F238E27FC236}">
                <a16:creationId xmlns:a16="http://schemas.microsoft.com/office/drawing/2014/main" id="{09C9D342-C743-EE64-4500-C2135CD5E4DD}"/>
              </a:ext>
            </a:extLst>
          </p:cNvPr>
          <p:cNvSpPr/>
          <p:nvPr/>
        </p:nvSpPr>
        <p:spPr>
          <a:xfrm rot="6803468">
            <a:off x="1279553" y="3514675"/>
            <a:ext cx="132514" cy="198857"/>
          </a:xfrm>
          <a:prstGeom prst="triangl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AF65A7BB-BB14-AA4F-E4BC-0D467BFC0E6A}"/>
              </a:ext>
            </a:extLst>
          </p:cNvPr>
          <p:cNvSpPr txBox="1"/>
          <p:nvPr/>
        </p:nvSpPr>
        <p:spPr>
          <a:xfrm>
            <a:off x="472379" y="3362878"/>
            <a:ext cx="717766" cy="46166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>
                <a:cs typeface="Arial" panose="020B0604020202020204" pitchFamily="34" charset="0"/>
              </a:rPr>
              <a:t>Gastric</a:t>
            </a:r>
          </a:p>
          <a:p>
            <a:pPr algn="ctr"/>
            <a:r>
              <a:rPr lang="en-US" altLang="ja-JP" sz="1200" b="1" dirty="0">
                <a:cs typeface="Arial" panose="020B0604020202020204" pitchFamily="34" charset="0"/>
              </a:rPr>
              <a:t>tube</a:t>
            </a:r>
            <a:endParaRPr kumimoji="1" lang="ja-JP" altLang="en-US" sz="1200" b="1" dirty="0">
              <a:cs typeface="Arial" panose="020B0604020202020204" pitchFamily="34" charset="0"/>
            </a:endParaRPr>
          </a:p>
        </p:txBody>
      </p:sp>
      <p:sp>
        <p:nvSpPr>
          <p:cNvPr id="12" name="テキスト ボックス 37">
            <a:extLst>
              <a:ext uri="{FF2B5EF4-FFF2-40B4-BE49-F238E27FC236}">
                <a16:creationId xmlns:a16="http://schemas.microsoft.com/office/drawing/2014/main" id="{428B0A8B-DC82-D6B6-DDB1-E589D7523A2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827335" y="2586415"/>
            <a:ext cx="393854" cy="262642"/>
          </a:xfrm>
          <a:prstGeom prst="rect">
            <a:avLst/>
          </a:prstGeom>
          <a:solidFill>
            <a:schemeClr val="bg1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wrap="square" lIns="77221" tIns="38611" rIns="77221" bIns="38611">
            <a:spAutoFit/>
          </a:bodyPr>
          <a:lstStyle>
            <a:lvl1pPr>
              <a:spcBef>
                <a:spcPct val="20000"/>
              </a:spcBef>
              <a:buClr>
                <a:srgbClr val="ACC2C9"/>
              </a:buClr>
              <a:buFont typeface="Arial" panose="020B0604020202020204" pitchFamily="34" charset="0"/>
              <a:buChar char="•"/>
              <a:defRPr kumimoji="1" sz="2400">
                <a:solidFill>
                  <a:schemeClr val="tx2"/>
                </a:solidFill>
                <a:latin typeface="Tw Cen MT"/>
              </a:defRPr>
            </a:lvl1pPr>
            <a:lvl2pPr marL="742950" indent="-285750">
              <a:spcBef>
                <a:spcPct val="20000"/>
              </a:spcBef>
              <a:buClr>
                <a:srgbClr val="ACC2C9"/>
              </a:buClr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Tw Cen MT"/>
              </a:defRPr>
            </a:lvl2pPr>
            <a:lvl3pPr marL="1143000" indent="-228600">
              <a:spcBef>
                <a:spcPct val="20000"/>
              </a:spcBef>
              <a:buClr>
                <a:schemeClr val="accent2"/>
              </a:buClr>
              <a:buFont typeface="Arial" panose="020B0604020202020204" pitchFamily="34" charset="0"/>
              <a:buChar char="•"/>
              <a:defRPr kumimoji="1" sz="2000">
                <a:solidFill>
                  <a:schemeClr val="tx2"/>
                </a:solidFill>
                <a:latin typeface="Tw Cen MT"/>
              </a:defRPr>
            </a:lvl3pPr>
            <a:lvl4pPr marL="1600200" indent="-228600">
              <a:spcBef>
                <a:spcPct val="20000"/>
              </a:spcBef>
              <a:buClr>
                <a:srgbClr val="99987F"/>
              </a:buClr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Tw Cen MT"/>
              </a:defRPr>
            </a:lvl4pPr>
            <a:lvl5pPr marL="2057400" indent="-228600">
              <a:spcBef>
                <a:spcPct val="20000"/>
              </a:spcBef>
              <a:buClr>
                <a:srgbClr val="90AC97"/>
              </a:buClr>
              <a:buFont typeface="Arial" panose="020B0604020202020204" pitchFamily="34" charset="0"/>
              <a:buChar char="•"/>
              <a:defRPr kumimoji="1" sz="1600">
                <a:solidFill>
                  <a:schemeClr val="tx2"/>
                </a:solidFill>
                <a:latin typeface="Tw Cen MT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90AC97"/>
              </a:buClr>
              <a:buFont typeface="Arial" panose="020B0604020202020204" pitchFamily="34" charset="0"/>
              <a:buChar char="•"/>
              <a:defRPr kumimoji="1" sz="1600">
                <a:solidFill>
                  <a:schemeClr val="tx2"/>
                </a:solidFill>
                <a:latin typeface="Tw Cen MT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90AC97"/>
              </a:buClr>
              <a:buFont typeface="Arial" panose="020B0604020202020204" pitchFamily="34" charset="0"/>
              <a:buChar char="•"/>
              <a:defRPr kumimoji="1" sz="1600">
                <a:solidFill>
                  <a:schemeClr val="tx2"/>
                </a:solidFill>
                <a:latin typeface="Tw Cen MT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90AC97"/>
              </a:buClr>
              <a:buFont typeface="Arial" panose="020B0604020202020204" pitchFamily="34" charset="0"/>
              <a:buChar char="•"/>
              <a:defRPr kumimoji="1" sz="1600">
                <a:solidFill>
                  <a:schemeClr val="tx2"/>
                </a:solidFill>
                <a:latin typeface="Tw Cen MT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90AC97"/>
              </a:buClr>
              <a:buFont typeface="Arial" panose="020B0604020202020204" pitchFamily="34" charset="0"/>
              <a:buChar char="•"/>
              <a:defRPr kumimoji="1" sz="1600">
                <a:solidFill>
                  <a:schemeClr val="tx2"/>
                </a:solidFill>
                <a:latin typeface="Tw Cen MT"/>
              </a:defRPr>
            </a:lvl9pPr>
          </a:lstStyle>
          <a:p>
            <a:pPr>
              <a:spcBef>
                <a:spcPct val="0"/>
              </a:spcBef>
              <a:buClrTx/>
              <a:buFontTx/>
              <a:buNone/>
            </a:pPr>
            <a:r>
              <a:rPr lang="en-US" altLang="ja-JP" sz="1200" b="1" dirty="0">
                <a:solidFill>
                  <a:schemeClr val="tx1"/>
                </a:solidFill>
                <a:latin typeface="Arial" panose="020B0604020202020204" pitchFamily="34" charset="0"/>
                <a:ea typeface="HGP創英角ｺﾞｼｯｸUB" panose="020B0900000000000000" pitchFamily="50" charset="-128"/>
                <a:cs typeface="Arial" panose="020B0604020202020204" pitchFamily="34" charset="0"/>
              </a:rPr>
              <a:t>AH</a:t>
            </a:r>
            <a:endParaRPr lang="ja-JP" altLang="en-US" sz="1200" b="1" dirty="0">
              <a:solidFill>
                <a:schemeClr val="tx1"/>
              </a:solidFill>
              <a:latin typeface="Arial" panose="020B0604020202020204" pitchFamily="34" charset="0"/>
              <a:ea typeface="HGP創英角ｺﾞｼｯｸUB" panose="020B09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3" name="二等辺三角形 12">
            <a:extLst>
              <a:ext uri="{FF2B5EF4-FFF2-40B4-BE49-F238E27FC236}">
                <a16:creationId xmlns:a16="http://schemas.microsoft.com/office/drawing/2014/main" id="{A2D142F8-F107-4889-C7FF-8B9AC27BC2A0}"/>
              </a:ext>
            </a:extLst>
          </p:cNvPr>
          <p:cNvSpPr/>
          <p:nvPr/>
        </p:nvSpPr>
        <p:spPr>
          <a:xfrm rot="6830613">
            <a:off x="7324985" y="2698424"/>
            <a:ext cx="132514" cy="198857"/>
          </a:xfrm>
          <a:prstGeom prst="triangl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" name="二等辺三角形 13">
            <a:extLst>
              <a:ext uri="{FF2B5EF4-FFF2-40B4-BE49-F238E27FC236}">
                <a16:creationId xmlns:a16="http://schemas.microsoft.com/office/drawing/2014/main" id="{A4439258-1EDB-119B-6329-075B96C62484}"/>
              </a:ext>
            </a:extLst>
          </p:cNvPr>
          <p:cNvSpPr/>
          <p:nvPr/>
        </p:nvSpPr>
        <p:spPr>
          <a:xfrm rot="11920265">
            <a:off x="7701824" y="2456450"/>
            <a:ext cx="132514" cy="198857"/>
          </a:xfrm>
          <a:prstGeom prst="triangl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6D392025-892D-088C-C908-CE57E72B6CA8}"/>
              </a:ext>
            </a:extLst>
          </p:cNvPr>
          <p:cNvSpPr txBox="1"/>
          <p:nvPr/>
        </p:nvSpPr>
        <p:spPr>
          <a:xfrm>
            <a:off x="7417656" y="2080981"/>
            <a:ext cx="1159852" cy="27699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>
                <a:cs typeface="Arial" panose="020B0604020202020204" pitchFamily="34" charset="0"/>
              </a:rPr>
              <a:t>Anastomosis</a:t>
            </a:r>
            <a:endParaRPr kumimoji="1" lang="ja-JP" altLang="en-US" sz="1200" b="1" dirty="0">
              <a:cs typeface="Arial" panose="020B0604020202020204" pitchFamily="34" charset="0"/>
            </a:endParaRPr>
          </a:p>
        </p:txBody>
      </p:sp>
      <p:sp>
        <p:nvSpPr>
          <p:cNvPr id="16" name="二等辺三角形 15">
            <a:extLst>
              <a:ext uri="{FF2B5EF4-FFF2-40B4-BE49-F238E27FC236}">
                <a16:creationId xmlns:a16="http://schemas.microsoft.com/office/drawing/2014/main" id="{44ECE5C3-8FD2-387F-7594-A6A9D4142549}"/>
              </a:ext>
            </a:extLst>
          </p:cNvPr>
          <p:cNvSpPr/>
          <p:nvPr/>
        </p:nvSpPr>
        <p:spPr>
          <a:xfrm rot="6803468">
            <a:off x="5745636" y="3566105"/>
            <a:ext cx="132514" cy="198857"/>
          </a:xfrm>
          <a:prstGeom prst="triangl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8383FCB0-0E8A-C0ED-C81F-BF3DA553F44E}"/>
              </a:ext>
            </a:extLst>
          </p:cNvPr>
          <p:cNvSpPr txBox="1"/>
          <p:nvPr/>
        </p:nvSpPr>
        <p:spPr>
          <a:xfrm>
            <a:off x="4938462" y="3414308"/>
            <a:ext cx="717766" cy="46166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>
                <a:cs typeface="Arial" panose="020B0604020202020204" pitchFamily="34" charset="0"/>
              </a:rPr>
              <a:t>Gastric</a:t>
            </a:r>
          </a:p>
          <a:p>
            <a:pPr algn="ctr"/>
            <a:r>
              <a:rPr lang="en-US" altLang="ja-JP" sz="1200" b="1" dirty="0">
                <a:cs typeface="Arial" panose="020B0604020202020204" pitchFamily="34" charset="0"/>
              </a:rPr>
              <a:t>tube</a:t>
            </a:r>
            <a:endParaRPr kumimoji="1" lang="ja-JP" altLang="en-US" sz="1200" b="1" dirty="0"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35992065-406B-5BE3-78F3-16B08A4573F0}"/>
              </a:ext>
            </a:extLst>
          </p:cNvPr>
          <p:cNvSpPr txBox="1"/>
          <p:nvPr/>
        </p:nvSpPr>
        <p:spPr>
          <a:xfrm>
            <a:off x="189675" y="190640"/>
            <a:ext cx="23210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/>
              <a:t>Supplementary Figure 3</a:t>
            </a: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1" name="AutoShape 12"/>
          <p:cNvSpPr>
            <a:spLocks noChangeArrowheads="1"/>
          </p:cNvSpPr>
          <p:nvPr/>
        </p:nvSpPr>
        <p:spPr bwMode="auto">
          <a:xfrm rot="6922928">
            <a:off x="3837577" y="461977"/>
            <a:ext cx="1728367" cy="5770360"/>
          </a:xfrm>
          <a:custGeom>
            <a:avLst/>
            <a:gdLst>
              <a:gd name="G0" fmla="+- 9367 0 0"/>
              <a:gd name="G1" fmla="+- 21600 0 9367"/>
              <a:gd name="G2" fmla="*/ 9367 1 2"/>
              <a:gd name="G3" fmla="+- 21600 0 G2"/>
              <a:gd name="G4" fmla="+/ 9367 21600 2"/>
              <a:gd name="G5" fmla="+/ G1 0 2"/>
              <a:gd name="G6" fmla="*/ 21600 21600 9367"/>
              <a:gd name="G7" fmla="*/ G6 1 2"/>
              <a:gd name="G8" fmla="+- 21600 0 G7"/>
              <a:gd name="G9" fmla="*/ 21600 1 2"/>
              <a:gd name="G10" fmla="+- 9367 0 G9"/>
              <a:gd name="G11" fmla="?: G10 G8 0"/>
              <a:gd name="G12" fmla="?: G10 G7 21600"/>
              <a:gd name="T0" fmla="*/ 16916 w 21600"/>
              <a:gd name="T1" fmla="*/ 10800 h 21600"/>
              <a:gd name="T2" fmla="*/ 10800 w 21600"/>
              <a:gd name="T3" fmla="*/ 21600 h 21600"/>
              <a:gd name="T4" fmla="*/ 4684 w 21600"/>
              <a:gd name="T5" fmla="*/ 10800 h 21600"/>
              <a:gd name="T6" fmla="*/ 10800 w 21600"/>
              <a:gd name="T7" fmla="*/ 0 h 21600"/>
              <a:gd name="T8" fmla="*/ 6484 w 21600"/>
              <a:gd name="T9" fmla="*/ 6484 h 21600"/>
              <a:gd name="T10" fmla="*/ 15116 w 21600"/>
              <a:gd name="T11" fmla="*/ 15116 h 2160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T8" t="T9" r="T10" b="T11"/>
            <a:pathLst>
              <a:path w="21600" h="21600">
                <a:moveTo>
                  <a:pt x="0" y="0"/>
                </a:moveTo>
                <a:lnTo>
                  <a:pt x="9367" y="21600"/>
                </a:lnTo>
                <a:lnTo>
                  <a:pt x="12233" y="21600"/>
                </a:lnTo>
                <a:lnTo>
                  <a:pt x="21600" y="0"/>
                </a:lnTo>
                <a:close/>
              </a:path>
            </a:pathLst>
          </a:custGeom>
          <a:gradFill>
            <a:gsLst>
              <a:gs pos="17000">
                <a:srgbClr val="FFFFDA"/>
              </a:gs>
              <a:gs pos="0">
                <a:srgbClr val="FFFFDA"/>
              </a:gs>
              <a:gs pos="0">
                <a:srgbClr val="FFFF00">
                  <a:tint val="23500"/>
                  <a:satMod val="160000"/>
                </a:srgbClr>
              </a:gs>
              <a:gs pos="0">
                <a:srgbClr val="FFFF97"/>
              </a:gs>
              <a:gs pos="16000">
                <a:srgbClr val="FFFFB1"/>
              </a:gs>
              <a:gs pos="83000">
                <a:srgbClr val="FFFF00">
                  <a:tint val="66000"/>
                  <a:satMod val="160000"/>
                  <a:alpha val="0"/>
                </a:srgbClr>
              </a:gs>
              <a:gs pos="1000">
                <a:srgbClr val="FFFF00">
                  <a:tint val="23500"/>
                  <a:satMod val="160000"/>
                </a:srgbClr>
              </a:gs>
            </a:gsLst>
            <a:lin ang="13500000" scaled="1"/>
          </a:gradFill>
          <a:ln w="9525">
            <a:noFill/>
            <a:miter lim="800000"/>
            <a:headEnd/>
            <a:tailEnd/>
          </a:ln>
          <a:effectLst/>
        </p:spPr>
        <p:txBody>
          <a:bodyPr wrap="none" lIns="77204" tIns="38602" rIns="77204" bIns="38602" anchor="ctr"/>
          <a:lstStyle/>
          <a:p>
            <a:pPr eaLnBrk="1" hangingPunct="1">
              <a:defRPr/>
            </a:pPr>
            <a:endParaRPr lang="ja-JP" altLang="en-US" dirty="0">
              <a:latin typeface="Calibri" panose="020F0502020204030204" pitchFamily="34" charset="0"/>
              <a:ea typeface="ＭＳ Ｐゴシック" charset="-128"/>
            </a:endParaRPr>
          </a:p>
        </p:txBody>
      </p:sp>
      <p:sp>
        <p:nvSpPr>
          <p:cNvPr id="311" name="テキスト ボックス 54"/>
          <p:cNvSpPr txBox="1">
            <a:spLocks noChangeArrowheads="1"/>
          </p:cNvSpPr>
          <p:nvPr/>
        </p:nvSpPr>
        <p:spPr bwMode="auto">
          <a:xfrm>
            <a:off x="3060922" y="1986543"/>
            <a:ext cx="5505984" cy="2626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lIns="77204" tIns="38602" rIns="77204" bIns="38602">
            <a:spAutoFit/>
          </a:bodyPr>
          <a:lstStyle>
            <a:lvl1pPr>
              <a:spcBef>
                <a:spcPct val="20000"/>
              </a:spcBef>
              <a:buClr>
                <a:srgbClr val="ACC2C9"/>
              </a:buClr>
              <a:buFont typeface="Arial" panose="020B0604020202020204" pitchFamily="34" charset="0"/>
              <a:buChar char="•"/>
              <a:defRPr kumimoji="1" sz="2400">
                <a:solidFill>
                  <a:schemeClr val="tx2"/>
                </a:solidFill>
                <a:latin typeface="Tw Cen MT"/>
              </a:defRPr>
            </a:lvl1pPr>
            <a:lvl2pPr marL="742950" indent="-285750">
              <a:spcBef>
                <a:spcPct val="20000"/>
              </a:spcBef>
              <a:buClr>
                <a:srgbClr val="ACC2C9"/>
              </a:buClr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Tw Cen MT"/>
              </a:defRPr>
            </a:lvl2pPr>
            <a:lvl3pPr marL="1143000" indent="-228600">
              <a:spcBef>
                <a:spcPct val="20000"/>
              </a:spcBef>
              <a:buClr>
                <a:schemeClr val="accent2"/>
              </a:buClr>
              <a:buFont typeface="Arial" panose="020B0604020202020204" pitchFamily="34" charset="0"/>
              <a:buChar char="•"/>
              <a:defRPr kumimoji="1" sz="2000">
                <a:solidFill>
                  <a:schemeClr val="tx2"/>
                </a:solidFill>
                <a:latin typeface="Tw Cen MT"/>
              </a:defRPr>
            </a:lvl3pPr>
            <a:lvl4pPr marL="1600200" indent="-228600">
              <a:spcBef>
                <a:spcPct val="20000"/>
              </a:spcBef>
              <a:buClr>
                <a:srgbClr val="99987F"/>
              </a:buClr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Tw Cen MT"/>
              </a:defRPr>
            </a:lvl4pPr>
            <a:lvl5pPr marL="2057400" indent="-228600">
              <a:spcBef>
                <a:spcPct val="20000"/>
              </a:spcBef>
              <a:buClr>
                <a:srgbClr val="90AC97"/>
              </a:buClr>
              <a:buFont typeface="Arial" panose="020B0604020202020204" pitchFamily="34" charset="0"/>
              <a:buChar char="•"/>
              <a:defRPr kumimoji="1" sz="1600">
                <a:solidFill>
                  <a:schemeClr val="tx2"/>
                </a:solidFill>
                <a:latin typeface="Tw Cen MT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90AC97"/>
              </a:buClr>
              <a:buFont typeface="Arial" panose="020B0604020202020204" pitchFamily="34" charset="0"/>
              <a:buChar char="•"/>
              <a:defRPr kumimoji="1" sz="1600">
                <a:solidFill>
                  <a:schemeClr val="tx2"/>
                </a:solidFill>
                <a:latin typeface="Tw Cen MT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90AC97"/>
              </a:buClr>
              <a:buFont typeface="Arial" panose="020B0604020202020204" pitchFamily="34" charset="0"/>
              <a:buChar char="•"/>
              <a:defRPr kumimoji="1" sz="1600">
                <a:solidFill>
                  <a:schemeClr val="tx2"/>
                </a:solidFill>
                <a:latin typeface="Tw Cen MT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90AC97"/>
              </a:buClr>
              <a:buFont typeface="Arial" panose="020B0604020202020204" pitchFamily="34" charset="0"/>
              <a:buChar char="•"/>
              <a:defRPr kumimoji="1" sz="1600">
                <a:solidFill>
                  <a:schemeClr val="tx2"/>
                </a:solidFill>
                <a:latin typeface="Tw Cen MT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90AC97"/>
              </a:buClr>
              <a:buFont typeface="Arial" panose="020B0604020202020204" pitchFamily="34" charset="0"/>
              <a:buChar char="•"/>
              <a:defRPr kumimoji="1" sz="1600">
                <a:solidFill>
                  <a:schemeClr val="tx2"/>
                </a:solidFill>
                <a:latin typeface="Tw Cen MT"/>
              </a:defRPr>
            </a:lvl9pPr>
          </a:lstStyle>
          <a:p>
            <a:pPr eaLnBrk="1" hangingPunct="1">
              <a:spcBef>
                <a:spcPct val="0"/>
              </a:spcBef>
              <a:buClrTx/>
              <a:buFont typeface="Arial" panose="020B0604020202020204" pitchFamily="34" charset="0"/>
              <a:buNone/>
            </a:pPr>
            <a:r>
              <a:rPr lang="en-US" altLang="ja-JP" sz="1200" b="1" dirty="0">
                <a:solidFill>
                  <a:schemeClr val="tx1"/>
                </a:solidFill>
                <a:latin typeface="Arial" panose="020B0604020202020204" pitchFamily="34" charset="0"/>
                <a:ea typeface="HGP創英角ﾎﾟｯﾌﾟ体" panose="040B0A00000000000000" pitchFamily="50" charset="-128"/>
                <a:cs typeface="Arial" panose="020B0604020202020204" pitchFamily="34" charset="0"/>
              </a:rPr>
              <a:t> </a:t>
            </a:r>
            <a:r>
              <a:rPr lang="en-US" altLang="ja-JP" sz="1200" b="1" u="sng" dirty="0">
                <a:solidFill>
                  <a:schemeClr val="tx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anose="020B0604020202020204" pitchFamily="34" charset="0"/>
                <a:ea typeface="HGP創英角ﾎﾟｯﾌﾟ体" panose="040B0A00000000000000" pitchFamily="50" charset="-128"/>
                <a:cs typeface="Arial" panose="020B0604020202020204" pitchFamily="34" charset="0"/>
              </a:rPr>
              <a:t>Anastomotic Viability Index (AVI)</a:t>
            </a:r>
            <a:r>
              <a:rPr lang="en-US" altLang="ja-JP" sz="1200" b="1" dirty="0">
                <a:solidFill>
                  <a:schemeClr val="tx1"/>
                </a:solidFill>
                <a:latin typeface="Arial" panose="020B0604020202020204" pitchFamily="34" charset="0"/>
                <a:ea typeface="HGP創英角ﾎﾟｯﾌﾟ体" panose="040B0A00000000000000" pitchFamily="50" charset="-128"/>
                <a:cs typeface="Arial" panose="020B0604020202020204" pitchFamily="34" charset="0"/>
              </a:rPr>
              <a:t> = </a:t>
            </a:r>
            <a:r>
              <a:rPr lang="en-US" altLang="ja-JP" sz="1200" b="1" i="1" dirty="0">
                <a:solidFill>
                  <a:schemeClr val="tx1"/>
                </a:solidFill>
                <a:latin typeface="Arial" panose="020B0604020202020204" pitchFamily="34" charset="0"/>
                <a:ea typeface="HGP創英角ﾎﾟｯﾌﾟ体" panose="040B0A00000000000000" pitchFamily="50" charset="-128"/>
                <a:cs typeface="Arial" panose="020B0604020202020204" pitchFamily="34" charset="0"/>
              </a:rPr>
              <a:t>GEA</a:t>
            </a:r>
            <a:r>
              <a:rPr lang="ja-JP" altLang="en-US" sz="1200" b="1" i="1" dirty="0">
                <a:solidFill>
                  <a:schemeClr val="tx1"/>
                </a:solidFill>
                <a:latin typeface="Arial" panose="020B0604020202020204" pitchFamily="34" charset="0"/>
                <a:ea typeface="HGP創英角ﾎﾟｯﾌﾟ体" panose="040B0A00000000000000" pitchFamily="50" charset="-128"/>
                <a:cs typeface="Arial" panose="020B0604020202020204" pitchFamily="34" charset="0"/>
              </a:rPr>
              <a:t> </a:t>
            </a:r>
            <a:r>
              <a:rPr lang="en-US" altLang="ja-JP" sz="1200" b="1" i="1" dirty="0">
                <a:solidFill>
                  <a:schemeClr val="tx1"/>
                </a:solidFill>
                <a:latin typeface="Arial" panose="020B0604020202020204" pitchFamily="34" charset="0"/>
                <a:ea typeface="HGP創英角ﾎﾟｯﾌﾟ体" panose="040B0A00000000000000" pitchFamily="50" charset="-128"/>
                <a:cs typeface="Arial" panose="020B0604020202020204" pitchFamily="34" charset="0"/>
              </a:rPr>
              <a:t>length rate</a:t>
            </a:r>
            <a:r>
              <a:rPr lang="ja-JP" altLang="en-US" sz="1200" b="1" i="1" dirty="0">
                <a:solidFill>
                  <a:schemeClr val="tx1"/>
                </a:solidFill>
                <a:latin typeface="Arial" panose="020B0604020202020204" pitchFamily="34" charset="0"/>
                <a:ea typeface="HGP創英角ﾎﾟｯﾌﾟ体" panose="040B0A00000000000000" pitchFamily="50" charset="-128"/>
                <a:cs typeface="Arial" panose="020B0604020202020204" pitchFamily="34" charset="0"/>
              </a:rPr>
              <a:t>　</a:t>
            </a:r>
            <a:r>
              <a:rPr lang="en-US" altLang="ja-JP" sz="1200" b="1" i="1" dirty="0">
                <a:solidFill>
                  <a:schemeClr val="tx1"/>
                </a:solidFill>
                <a:latin typeface="Arial" panose="020B0604020202020204" pitchFamily="34" charset="0"/>
                <a:ea typeface="HGP創英角ﾎﾟｯﾌﾟ体" panose="040B0A00000000000000" pitchFamily="50" charset="-128"/>
                <a:cs typeface="Arial" panose="020B0604020202020204" pitchFamily="34" charset="0"/>
              </a:rPr>
              <a:t>x  Temp. retain rate</a:t>
            </a:r>
          </a:p>
        </p:txBody>
      </p:sp>
      <p:pic>
        <p:nvPicPr>
          <p:cNvPr id="9" name="図 8">
            <a:extLst>
              <a:ext uri="{FF2B5EF4-FFF2-40B4-BE49-F238E27FC236}">
                <a16:creationId xmlns:a16="http://schemas.microsoft.com/office/drawing/2014/main" id="{DBAED4E6-D4AA-65E4-EA2D-5D07058C542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6998" t="14008" r="11087" b="12934"/>
          <a:stretch/>
        </p:blipFill>
        <p:spPr>
          <a:xfrm>
            <a:off x="385783" y="885694"/>
            <a:ext cx="1916656" cy="2059752"/>
          </a:xfrm>
          <a:prstGeom prst="rect">
            <a:avLst/>
          </a:prstGeom>
        </p:spPr>
      </p:pic>
      <p:pic>
        <p:nvPicPr>
          <p:cNvPr id="358" name="図 357">
            <a:extLst>
              <a:ext uri="{FF2B5EF4-FFF2-40B4-BE49-F238E27FC236}">
                <a16:creationId xmlns:a16="http://schemas.microsoft.com/office/drawing/2014/main" id="{EA306726-563A-9C72-9C60-884B9B60079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93978" y="4062474"/>
            <a:ext cx="7600950" cy="1436819"/>
          </a:xfrm>
          <a:prstGeom prst="rect">
            <a:avLst/>
          </a:prstGeom>
        </p:spPr>
      </p:pic>
      <p:sp>
        <p:nvSpPr>
          <p:cNvPr id="359" name="正方形/長方形 358">
            <a:extLst>
              <a:ext uri="{FF2B5EF4-FFF2-40B4-BE49-F238E27FC236}">
                <a16:creationId xmlns:a16="http://schemas.microsoft.com/office/drawing/2014/main" id="{F37E5E58-8C6B-CBE5-CA18-DA3E26B797C4}"/>
              </a:ext>
            </a:extLst>
          </p:cNvPr>
          <p:cNvSpPr/>
          <p:nvPr/>
        </p:nvSpPr>
        <p:spPr>
          <a:xfrm>
            <a:off x="6846522" y="5685217"/>
            <a:ext cx="1090067" cy="102841"/>
          </a:xfrm>
          <a:prstGeom prst="rect">
            <a:avLst/>
          </a:prstGeom>
          <a:solidFill>
            <a:srgbClr val="FFC000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2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0" name="正方形/長方形 359">
            <a:extLst>
              <a:ext uri="{FF2B5EF4-FFF2-40B4-BE49-F238E27FC236}">
                <a16:creationId xmlns:a16="http://schemas.microsoft.com/office/drawing/2014/main" id="{8C0EE047-2096-4E27-5E67-AE33268AD6A9}"/>
              </a:ext>
            </a:extLst>
          </p:cNvPr>
          <p:cNvSpPr/>
          <p:nvPr/>
        </p:nvSpPr>
        <p:spPr>
          <a:xfrm>
            <a:off x="6495837" y="5685217"/>
            <a:ext cx="1090067" cy="102841"/>
          </a:xfrm>
          <a:prstGeom prst="rect">
            <a:avLst/>
          </a:prstGeom>
          <a:solidFill>
            <a:srgbClr val="FFC000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2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1" name="正方形/長方形 360">
            <a:extLst>
              <a:ext uri="{FF2B5EF4-FFF2-40B4-BE49-F238E27FC236}">
                <a16:creationId xmlns:a16="http://schemas.microsoft.com/office/drawing/2014/main" id="{2B50AEF6-D8DD-146B-6383-B5E9068D625B}"/>
              </a:ext>
            </a:extLst>
          </p:cNvPr>
          <p:cNvSpPr/>
          <p:nvPr/>
        </p:nvSpPr>
        <p:spPr>
          <a:xfrm>
            <a:off x="6168274" y="5685217"/>
            <a:ext cx="1090067" cy="102841"/>
          </a:xfrm>
          <a:prstGeom prst="rect">
            <a:avLst/>
          </a:prstGeom>
          <a:solidFill>
            <a:srgbClr val="FFC000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2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62" name="グループ化 56">
            <a:extLst>
              <a:ext uri="{FF2B5EF4-FFF2-40B4-BE49-F238E27FC236}">
                <a16:creationId xmlns:a16="http://schemas.microsoft.com/office/drawing/2014/main" id="{59B18181-8CC7-BE08-8C03-F05F240E8954}"/>
              </a:ext>
            </a:extLst>
          </p:cNvPr>
          <p:cNvGrpSpPr>
            <a:grpSpLocks/>
          </p:cNvGrpSpPr>
          <p:nvPr/>
        </p:nvGrpSpPr>
        <p:grpSpPr bwMode="auto">
          <a:xfrm>
            <a:off x="2079413" y="5205444"/>
            <a:ext cx="3685245" cy="291287"/>
            <a:chOff x="1115616" y="5639755"/>
            <a:chExt cx="3372118" cy="460196"/>
          </a:xfrm>
        </p:grpSpPr>
        <p:sp>
          <p:nvSpPr>
            <p:cNvPr id="363" name="Text Box 102">
              <a:extLst>
                <a:ext uri="{FF2B5EF4-FFF2-40B4-BE49-F238E27FC236}">
                  <a16:creationId xmlns:a16="http://schemas.microsoft.com/office/drawing/2014/main" id="{F390CA1B-D50D-B9F4-BC2E-462DF3C1B56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264634" y="5662328"/>
              <a:ext cx="1223100" cy="43762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 eaLnBrk="1" hangingPunct="1">
                <a:spcBef>
                  <a:spcPct val="50000"/>
                </a:spcBef>
                <a:defRPr/>
              </a:pPr>
              <a:r>
                <a:rPr lang="ja-JP" altLang="en-US" sz="1200" b="1" dirty="0">
                  <a:effectLst>
                    <a:outerShdw blurRad="38100" dist="38100" dir="2700000" algn="tl">
                      <a:srgbClr val="000000"/>
                    </a:outerShdw>
                  </a:effectLst>
                  <a:ea typeface="HGP創英角ﾎﾟｯﾌﾟ体" pitchFamily="50" charset="-128"/>
                  <a:cs typeface="Arial" panose="020B0604020202020204" pitchFamily="34" charset="0"/>
                </a:rPr>
                <a:t>（</a:t>
              </a:r>
              <a:r>
                <a:rPr lang="en-US" altLang="ja-JP" sz="1200" b="1" dirty="0">
                  <a:effectLst>
                    <a:outerShdw blurRad="38100" dist="38100" dir="2700000" algn="tl">
                      <a:srgbClr val="000000"/>
                    </a:outerShdw>
                  </a:effectLst>
                  <a:ea typeface="HGP創英角ﾎﾟｯﾌﾟ体" pitchFamily="50" charset="-128"/>
                  <a:cs typeface="Arial" panose="020B0604020202020204" pitchFamily="34" charset="0"/>
                </a:rPr>
                <a:t>RGEA</a:t>
              </a:r>
              <a:r>
                <a:rPr lang="ja-JP" altLang="en-US" sz="1200" b="1" dirty="0">
                  <a:effectLst>
                    <a:outerShdw blurRad="38100" dist="38100" dir="2700000" algn="tl">
                      <a:srgbClr val="000000"/>
                    </a:outerShdw>
                  </a:effectLst>
                  <a:ea typeface="HGP創英角ﾎﾟｯﾌﾟ体" pitchFamily="50" charset="-128"/>
                  <a:cs typeface="Arial" panose="020B0604020202020204" pitchFamily="34" charset="0"/>
                </a:rPr>
                <a:t>）</a:t>
              </a:r>
            </a:p>
          </p:txBody>
        </p:sp>
        <p:sp>
          <p:nvSpPr>
            <p:cNvPr id="364" name="Text Box 103">
              <a:extLst>
                <a:ext uri="{FF2B5EF4-FFF2-40B4-BE49-F238E27FC236}">
                  <a16:creationId xmlns:a16="http://schemas.microsoft.com/office/drawing/2014/main" id="{401A4ED6-FF55-D693-4537-F4636C9950F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115616" y="5639755"/>
              <a:ext cx="2864553" cy="43762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 eaLnBrk="1" hangingPunct="1">
                <a:spcBef>
                  <a:spcPct val="50000"/>
                </a:spcBef>
                <a:defRPr/>
              </a:pPr>
              <a:r>
                <a:rPr lang="en-US" altLang="ja-JP" sz="1200" b="1" dirty="0">
                  <a:effectLst>
                    <a:outerShdw blurRad="38100" dist="38100" dir="2700000" algn="tl">
                      <a:srgbClr val="000000"/>
                    </a:outerShdw>
                  </a:effectLst>
                  <a:ea typeface="HGP創英角ﾎﾟｯﾌﾟ体" pitchFamily="50" charset="-128"/>
                  <a:cs typeface="Arial" panose="020B0604020202020204" pitchFamily="34" charset="0"/>
                </a:rPr>
                <a:t>Right Gastroepiploic Artery</a:t>
              </a:r>
              <a:endParaRPr lang="ja-JP" altLang="en-US" sz="1200" b="1" dirty="0">
                <a:effectLst>
                  <a:outerShdw blurRad="38100" dist="38100" dir="2700000" algn="tl">
                    <a:srgbClr val="000000"/>
                  </a:outerShdw>
                </a:effectLst>
                <a:ea typeface="HGP創英角ﾎﾟｯﾌﾟ体" pitchFamily="50" charset="-128"/>
                <a:cs typeface="Arial" panose="020B0604020202020204" pitchFamily="34" charset="0"/>
              </a:endParaRPr>
            </a:p>
          </p:txBody>
        </p:sp>
      </p:grpSp>
      <p:grpSp>
        <p:nvGrpSpPr>
          <p:cNvPr id="365" name="グループ化 1">
            <a:extLst>
              <a:ext uri="{FF2B5EF4-FFF2-40B4-BE49-F238E27FC236}">
                <a16:creationId xmlns:a16="http://schemas.microsoft.com/office/drawing/2014/main" id="{48800C0A-61F9-6FB9-398A-76DB225E05EC}"/>
              </a:ext>
            </a:extLst>
          </p:cNvPr>
          <p:cNvGrpSpPr>
            <a:grpSpLocks/>
          </p:cNvGrpSpPr>
          <p:nvPr/>
        </p:nvGrpSpPr>
        <p:grpSpPr bwMode="auto">
          <a:xfrm>
            <a:off x="2017500" y="4708558"/>
            <a:ext cx="5208588" cy="720725"/>
            <a:chOff x="2187575" y="4900613"/>
            <a:chExt cx="5208588" cy="720725"/>
          </a:xfrm>
        </p:grpSpPr>
        <p:sp>
          <p:nvSpPr>
            <p:cNvPr id="366" name="フリーフォーム 277">
              <a:extLst>
                <a:ext uri="{FF2B5EF4-FFF2-40B4-BE49-F238E27FC236}">
                  <a16:creationId xmlns:a16="http://schemas.microsoft.com/office/drawing/2014/main" id="{AAA26583-CE74-95BD-14EA-BF239BF5052C}"/>
                </a:ext>
              </a:extLst>
            </p:cNvPr>
            <p:cNvSpPr/>
            <p:nvPr/>
          </p:nvSpPr>
          <p:spPr bwMode="auto">
            <a:xfrm>
              <a:off x="2187575" y="4953000"/>
              <a:ext cx="3476625" cy="652463"/>
            </a:xfrm>
            <a:custGeom>
              <a:avLst/>
              <a:gdLst>
                <a:gd name="connsiteX0" fmla="*/ 9564 w 3477159"/>
                <a:gd name="connsiteY0" fmla="*/ 653143 h 653143"/>
                <a:gd name="connsiteX1" fmla="*/ 33315 w 3477159"/>
                <a:gd name="connsiteY1" fmla="*/ 380011 h 653143"/>
                <a:gd name="connsiteX2" fmla="*/ 282697 w 3477159"/>
                <a:gd name="connsiteY2" fmla="*/ 320634 h 653143"/>
                <a:gd name="connsiteX3" fmla="*/ 1244598 w 3477159"/>
                <a:gd name="connsiteY3" fmla="*/ 380011 h 653143"/>
                <a:gd name="connsiteX4" fmla="*/ 2182748 w 3477159"/>
                <a:gd name="connsiteY4" fmla="*/ 344385 h 653143"/>
                <a:gd name="connsiteX5" fmla="*/ 3144650 w 3477159"/>
                <a:gd name="connsiteY5" fmla="*/ 356260 h 653143"/>
                <a:gd name="connsiteX6" fmla="*/ 3477159 w 3477159"/>
                <a:gd name="connsiteY6" fmla="*/ 0 h 65314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3477159" h="653143">
                  <a:moveTo>
                    <a:pt x="9564" y="653143"/>
                  </a:moveTo>
                  <a:cubicBezTo>
                    <a:pt x="-1322" y="544286"/>
                    <a:pt x="-12207" y="435429"/>
                    <a:pt x="33315" y="380011"/>
                  </a:cubicBezTo>
                  <a:cubicBezTo>
                    <a:pt x="78837" y="324593"/>
                    <a:pt x="80817" y="320634"/>
                    <a:pt x="282697" y="320634"/>
                  </a:cubicBezTo>
                  <a:cubicBezTo>
                    <a:pt x="484577" y="320634"/>
                    <a:pt x="927923" y="376053"/>
                    <a:pt x="1244598" y="380011"/>
                  </a:cubicBezTo>
                  <a:cubicBezTo>
                    <a:pt x="1561273" y="383969"/>
                    <a:pt x="2182748" y="344385"/>
                    <a:pt x="2182748" y="344385"/>
                  </a:cubicBezTo>
                  <a:cubicBezTo>
                    <a:pt x="2499423" y="340426"/>
                    <a:pt x="2928915" y="413658"/>
                    <a:pt x="3144650" y="356260"/>
                  </a:cubicBezTo>
                  <a:cubicBezTo>
                    <a:pt x="3360385" y="298862"/>
                    <a:pt x="3418772" y="149431"/>
                    <a:pt x="3477159" y="0"/>
                  </a:cubicBezTo>
                </a:path>
              </a:pathLst>
            </a:cu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7" name="フリーフォーム 278">
              <a:extLst>
                <a:ext uri="{FF2B5EF4-FFF2-40B4-BE49-F238E27FC236}">
                  <a16:creationId xmlns:a16="http://schemas.microsoft.com/office/drawing/2014/main" id="{72054BE9-3285-C4A0-53C3-1ED549013502}"/>
                </a:ext>
              </a:extLst>
            </p:cNvPr>
            <p:cNvSpPr/>
            <p:nvPr/>
          </p:nvSpPr>
          <p:spPr bwMode="auto">
            <a:xfrm>
              <a:off x="5949950" y="4997256"/>
              <a:ext cx="1317625" cy="461963"/>
            </a:xfrm>
            <a:custGeom>
              <a:avLst/>
              <a:gdLst>
                <a:gd name="connsiteX0" fmla="*/ 0 w 1318161"/>
                <a:gd name="connsiteY0" fmla="*/ 0 h 463138"/>
                <a:gd name="connsiteX1" fmla="*/ 59376 w 1318161"/>
                <a:gd name="connsiteY1" fmla="*/ 273133 h 463138"/>
                <a:gd name="connsiteX2" fmla="*/ 273132 w 1318161"/>
                <a:gd name="connsiteY2" fmla="*/ 320634 h 463138"/>
                <a:gd name="connsiteX3" fmla="*/ 985652 w 1318161"/>
                <a:gd name="connsiteY3" fmla="*/ 308759 h 463138"/>
                <a:gd name="connsiteX4" fmla="*/ 1187532 w 1318161"/>
                <a:gd name="connsiteY4" fmla="*/ 344385 h 463138"/>
                <a:gd name="connsiteX5" fmla="*/ 1318161 w 1318161"/>
                <a:gd name="connsiteY5" fmla="*/ 463138 h 46313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</a:cxnLst>
              <a:rect l="l" t="t" r="r" b="b"/>
              <a:pathLst>
                <a:path w="1318161" h="463138">
                  <a:moveTo>
                    <a:pt x="0" y="0"/>
                  </a:moveTo>
                  <a:cubicBezTo>
                    <a:pt x="6927" y="109847"/>
                    <a:pt x="13854" y="219694"/>
                    <a:pt x="59376" y="273133"/>
                  </a:cubicBezTo>
                  <a:cubicBezTo>
                    <a:pt x="104898" y="326572"/>
                    <a:pt x="118753" y="314696"/>
                    <a:pt x="273132" y="320634"/>
                  </a:cubicBezTo>
                  <a:cubicBezTo>
                    <a:pt x="427511" y="326572"/>
                    <a:pt x="833252" y="304800"/>
                    <a:pt x="985652" y="308759"/>
                  </a:cubicBezTo>
                  <a:cubicBezTo>
                    <a:pt x="1138052" y="312718"/>
                    <a:pt x="1132114" y="318655"/>
                    <a:pt x="1187532" y="344385"/>
                  </a:cubicBezTo>
                  <a:cubicBezTo>
                    <a:pt x="1242950" y="370115"/>
                    <a:pt x="1280555" y="416626"/>
                    <a:pt x="1318161" y="463138"/>
                  </a:cubicBezTo>
                </a:path>
              </a:pathLst>
            </a:cu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8" name="円弧 367">
              <a:extLst>
                <a:ext uri="{FF2B5EF4-FFF2-40B4-BE49-F238E27FC236}">
                  <a16:creationId xmlns:a16="http://schemas.microsoft.com/office/drawing/2014/main" id="{074B45DA-6577-2FC1-ABE3-54D554FEC95C}"/>
                </a:ext>
              </a:extLst>
            </p:cNvPr>
            <p:cNvSpPr/>
            <p:nvPr/>
          </p:nvSpPr>
          <p:spPr bwMode="auto">
            <a:xfrm>
              <a:off x="2320925" y="5064125"/>
              <a:ext cx="360363" cy="455613"/>
            </a:xfrm>
            <a:prstGeom prst="arc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9" name="円弧 368">
              <a:extLst>
                <a:ext uri="{FF2B5EF4-FFF2-40B4-BE49-F238E27FC236}">
                  <a16:creationId xmlns:a16="http://schemas.microsoft.com/office/drawing/2014/main" id="{71CCA2DA-5B45-EA5C-C126-4AEA9F179FDE}"/>
                </a:ext>
              </a:extLst>
            </p:cNvPr>
            <p:cNvSpPr/>
            <p:nvPr/>
          </p:nvSpPr>
          <p:spPr bwMode="auto">
            <a:xfrm>
              <a:off x="2616200" y="5041900"/>
              <a:ext cx="360363" cy="511175"/>
            </a:xfrm>
            <a:prstGeom prst="arc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0" name="円弧 369">
              <a:extLst>
                <a:ext uri="{FF2B5EF4-FFF2-40B4-BE49-F238E27FC236}">
                  <a16:creationId xmlns:a16="http://schemas.microsoft.com/office/drawing/2014/main" id="{039425C4-9A9E-754A-7F38-6C54EEA1FE93}"/>
                </a:ext>
              </a:extLst>
            </p:cNvPr>
            <p:cNvSpPr/>
            <p:nvPr/>
          </p:nvSpPr>
          <p:spPr bwMode="auto">
            <a:xfrm>
              <a:off x="2898775" y="5075238"/>
              <a:ext cx="360363" cy="511175"/>
            </a:xfrm>
            <a:prstGeom prst="arc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1" name="円弧 370">
              <a:extLst>
                <a:ext uri="{FF2B5EF4-FFF2-40B4-BE49-F238E27FC236}">
                  <a16:creationId xmlns:a16="http://schemas.microsoft.com/office/drawing/2014/main" id="{2ACA1435-B0E9-D7B1-245D-B47A40287E9E}"/>
                </a:ext>
              </a:extLst>
            </p:cNvPr>
            <p:cNvSpPr/>
            <p:nvPr/>
          </p:nvSpPr>
          <p:spPr bwMode="auto">
            <a:xfrm>
              <a:off x="3124200" y="5064125"/>
              <a:ext cx="360363" cy="511175"/>
            </a:xfrm>
            <a:prstGeom prst="arc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2" name="円弧 371">
              <a:extLst>
                <a:ext uri="{FF2B5EF4-FFF2-40B4-BE49-F238E27FC236}">
                  <a16:creationId xmlns:a16="http://schemas.microsoft.com/office/drawing/2014/main" id="{8BB769FA-FA78-9EA6-1E61-245FFB790143}"/>
                </a:ext>
              </a:extLst>
            </p:cNvPr>
            <p:cNvSpPr/>
            <p:nvPr/>
          </p:nvSpPr>
          <p:spPr bwMode="auto">
            <a:xfrm>
              <a:off x="3373438" y="5018088"/>
              <a:ext cx="360362" cy="592137"/>
            </a:xfrm>
            <a:prstGeom prst="arc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3" name="円弧 372">
              <a:extLst>
                <a:ext uri="{FF2B5EF4-FFF2-40B4-BE49-F238E27FC236}">
                  <a16:creationId xmlns:a16="http://schemas.microsoft.com/office/drawing/2014/main" id="{BF8AC59B-661C-9A07-4A92-CF6C2E980D4A}"/>
                </a:ext>
              </a:extLst>
            </p:cNvPr>
            <p:cNvSpPr/>
            <p:nvPr/>
          </p:nvSpPr>
          <p:spPr bwMode="auto">
            <a:xfrm>
              <a:off x="3641725" y="5018088"/>
              <a:ext cx="454025" cy="581025"/>
            </a:xfrm>
            <a:prstGeom prst="arc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4" name="円弧 373">
              <a:extLst>
                <a:ext uri="{FF2B5EF4-FFF2-40B4-BE49-F238E27FC236}">
                  <a16:creationId xmlns:a16="http://schemas.microsoft.com/office/drawing/2014/main" id="{444F12E4-77E5-B4F5-EB62-EA0E6753F24F}"/>
                </a:ext>
              </a:extLst>
            </p:cNvPr>
            <p:cNvSpPr/>
            <p:nvPr/>
          </p:nvSpPr>
          <p:spPr bwMode="auto">
            <a:xfrm>
              <a:off x="3970338" y="5016500"/>
              <a:ext cx="454025" cy="581025"/>
            </a:xfrm>
            <a:prstGeom prst="arc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5" name="円弧 374">
              <a:extLst>
                <a:ext uri="{FF2B5EF4-FFF2-40B4-BE49-F238E27FC236}">
                  <a16:creationId xmlns:a16="http://schemas.microsoft.com/office/drawing/2014/main" id="{9E972233-6E04-3185-D70B-7DAB0BF1B862}"/>
                </a:ext>
              </a:extLst>
            </p:cNvPr>
            <p:cNvSpPr/>
            <p:nvPr/>
          </p:nvSpPr>
          <p:spPr bwMode="auto">
            <a:xfrm>
              <a:off x="4291013" y="5027613"/>
              <a:ext cx="452437" cy="581025"/>
            </a:xfrm>
            <a:prstGeom prst="arc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6" name="円弧 375">
              <a:extLst>
                <a:ext uri="{FF2B5EF4-FFF2-40B4-BE49-F238E27FC236}">
                  <a16:creationId xmlns:a16="http://schemas.microsoft.com/office/drawing/2014/main" id="{C84C1FB2-1D5E-8F8A-380E-F7131AD62571}"/>
                </a:ext>
              </a:extLst>
            </p:cNvPr>
            <p:cNvSpPr/>
            <p:nvPr/>
          </p:nvSpPr>
          <p:spPr bwMode="auto">
            <a:xfrm>
              <a:off x="4581525" y="5040313"/>
              <a:ext cx="454025" cy="581025"/>
            </a:xfrm>
            <a:prstGeom prst="arc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7" name="円弧 376">
              <a:extLst>
                <a:ext uri="{FF2B5EF4-FFF2-40B4-BE49-F238E27FC236}">
                  <a16:creationId xmlns:a16="http://schemas.microsoft.com/office/drawing/2014/main" id="{760F2135-9C56-6356-760B-076F9F785D1A}"/>
                </a:ext>
              </a:extLst>
            </p:cNvPr>
            <p:cNvSpPr/>
            <p:nvPr/>
          </p:nvSpPr>
          <p:spPr bwMode="auto">
            <a:xfrm>
              <a:off x="4892675" y="5016500"/>
              <a:ext cx="454025" cy="581025"/>
            </a:xfrm>
            <a:prstGeom prst="arc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8" name="フリーフォーム 289">
              <a:extLst>
                <a:ext uri="{FF2B5EF4-FFF2-40B4-BE49-F238E27FC236}">
                  <a16:creationId xmlns:a16="http://schemas.microsoft.com/office/drawing/2014/main" id="{0F13AFDA-8153-AF33-A963-CC4444F6E28D}"/>
                </a:ext>
              </a:extLst>
            </p:cNvPr>
            <p:cNvSpPr/>
            <p:nvPr/>
          </p:nvSpPr>
          <p:spPr bwMode="auto">
            <a:xfrm>
              <a:off x="5403850" y="5284788"/>
              <a:ext cx="703263" cy="142875"/>
            </a:xfrm>
            <a:custGeom>
              <a:avLst/>
              <a:gdLst>
                <a:gd name="connsiteX0" fmla="*/ 0 w 629392"/>
                <a:gd name="connsiteY0" fmla="*/ 0 h 142685"/>
                <a:gd name="connsiteX1" fmla="*/ 178130 w 629392"/>
                <a:gd name="connsiteY1" fmla="*/ 142504 h 142685"/>
                <a:gd name="connsiteX2" fmla="*/ 629392 w 629392"/>
                <a:gd name="connsiteY2" fmla="*/ 23751 h 14268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629392" h="142685">
                  <a:moveTo>
                    <a:pt x="0" y="0"/>
                  </a:moveTo>
                  <a:cubicBezTo>
                    <a:pt x="36615" y="69272"/>
                    <a:pt x="73231" y="138545"/>
                    <a:pt x="178130" y="142504"/>
                  </a:cubicBezTo>
                  <a:cubicBezTo>
                    <a:pt x="283029" y="146463"/>
                    <a:pt x="456210" y="85107"/>
                    <a:pt x="629392" y="23751"/>
                  </a:cubicBezTo>
                </a:path>
              </a:pathLst>
            </a:custGeom>
            <a:noFill/>
            <a:ln w="19050"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9" name="円弧 378">
              <a:extLst>
                <a:ext uri="{FF2B5EF4-FFF2-40B4-BE49-F238E27FC236}">
                  <a16:creationId xmlns:a16="http://schemas.microsoft.com/office/drawing/2014/main" id="{D6CF0AD5-FF62-525D-EEBD-03EB58202C17}"/>
                </a:ext>
              </a:extLst>
            </p:cNvPr>
            <p:cNvSpPr/>
            <p:nvPr/>
          </p:nvSpPr>
          <p:spPr bwMode="auto">
            <a:xfrm rot="19112594" flipH="1">
              <a:off x="6230938" y="4924425"/>
              <a:ext cx="393700" cy="528638"/>
            </a:xfrm>
            <a:prstGeom prst="arc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0" name="円弧 379">
              <a:extLst>
                <a:ext uri="{FF2B5EF4-FFF2-40B4-BE49-F238E27FC236}">
                  <a16:creationId xmlns:a16="http://schemas.microsoft.com/office/drawing/2014/main" id="{1AD9E9B4-FB1C-FFBF-C145-831F23C1D895}"/>
                </a:ext>
              </a:extLst>
            </p:cNvPr>
            <p:cNvSpPr/>
            <p:nvPr/>
          </p:nvSpPr>
          <p:spPr bwMode="auto">
            <a:xfrm rot="19112594" flipH="1">
              <a:off x="6526213" y="4900613"/>
              <a:ext cx="393700" cy="527050"/>
            </a:xfrm>
            <a:prstGeom prst="arc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1" name="円弧 380">
              <a:extLst>
                <a:ext uri="{FF2B5EF4-FFF2-40B4-BE49-F238E27FC236}">
                  <a16:creationId xmlns:a16="http://schemas.microsoft.com/office/drawing/2014/main" id="{BC51CFB0-0A43-357D-9313-BD850F2222A6}"/>
                </a:ext>
              </a:extLst>
            </p:cNvPr>
            <p:cNvSpPr/>
            <p:nvPr/>
          </p:nvSpPr>
          <p:spPr bwMode="auto">
            <a:xfrm rot="19112594" flipH="1">
              <a:off x="6805613" y="4911725"/>
              <a:ext cx="392112" cy="528638"/>
            </a:xfrm>
            <a:prstGeom prst="arc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2" name="円弧 381">
              <a:extLst>
                <a:ext uri="{FF2B5EF4-FFF2-40B4-BE49-F238E27FC236}">
                  <a16:creationId xmlns:a16="http://schemas.microsoft.com/office/drawing/2014/main" id="{512EC6EE-AA4F-53EC-3B4F-C7B71B422DEC}"/>
                </a:ext>
              </a:extLst>
            </p:cNvPr>
            <p:cNvSpPr/>
            <p:nvPr/>
          </p:nvSpPr>
          <p:spPr bwMode="auto">
            <a:xfrm rot="19112594" flipH="1">
              <a:off x="7002463" y="4911725"/>
              <a:ext cx="393700" cy="528638"/>
            </a:xfrm>
            <a:prstGeom prst="arc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83" name="グループ化 28">
            <a:extLst>
              <a:ext uri="{FF2B5EF4-FFF2-40B4-BE49-F238E27FC236}">
                <a16:creationId xmlns:a16="http://schemas.microsoft.com/office/drawing/2014/main" id="{4F58BE98-5C4D-0E51-2178-1ED7BE80372A}"/>
              </a:ext>
            </a:extLst>
          </p:cNvPr>
          <p:cNvGrpSpPr>
            <a:grpSpLocks/>
          </p:cNvGrpSpPr>
          <p:nvPr/>
        </p:nvGrpSpPr>
        <p:grpSpPr bwMode="auto">
          <a:xfrm>
            <a:off x="1595225" y="3168683"/>
            <a:ext cx="1833563" cy="1371600"/>
            <a:chOff x="1765139" y="3360717"/>
            <a:chExt cx="1833084" cy="1371299"/>
          </a:xfrm>
        </p:grpSpPr>
        <p:sp>
          <p:nvSpPr>
            <p:cNvPr id="384" name="フリーフォーム 295">
              <a:extLst>
                <a:ext uri="{FF2B5EF4-FFF2-40B4-BE49-F238E27FC236}">
                  <a16:creationId xmlns:a16="http://schemas.microsoft.com/office/drawing/2014/main" id="{645999A5-2C1D-0B2E-0464-D6A116BA6DAB}"/>
                </a:ext>
              </a:extLst>
            </p:cNvPr>
            <p:cNvSpPr/>
            <p:nvPr/>
          </p:nvSpPr>
          <p:spPr>
            <a:xfrm>
              <a:off x="1765139" y="3360717"/>
              <a:ext cx="1833084" cy="1091960"/>
            </a:xfrm>
            <a:custGeom>
              <a:avLst/>
              <a:gdLst>
                <a:gd name="connsiteX0" fmla="*/ 16160 w 1833084"/>
                <a:gd name="connsiteY0" fmla="*/ 0 h 1092530"/>
                <a:gd name="connsiteX1" fmla="*/ 75536 w 1833084"/>
                <a:gd name="connsiteY1" fmla="*/ 546265 h 1092530"/>
                <a:gd name="connsiteX2" fmla="*/ 609926 w 1833084"/>
                <a:gd name="connsiteY2" fmla="*/ 712519 h 1092530"/>
                <a:gd name="connsiteX3" fmla="*/ 1488700 w 1833084"/>
                <a:gd name="connsiteY3" fmla="*/ 795647 h 1092530"/>
                <a:gd name="connsiteX4" fmla="*/ 1833084 w 1833084"/>
                <a:gd name="connsiteY4" fmla="*/ 1092530 h 109253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833084" h="1092530">
                  <a:moveTo>
                    <a:pt x="16160" y="0"/>
                  </a:moveTo>
                  <a:cubicBezTo>
                    <a:pt x="-3633" y="213756"/>
                    <a:pt x="-23425" y="427512"/>
                    <a:pt x="75536" y="546265"/>
                  </a:cubicBezTo>
                  <a:cubicBezTo>
                    <a:pt x="174497" y="665018"/>
                    <a:pt x="374399" y="670955"/>
                    <a:pt x="609926" y="712519"/>
                  </a:cubicBezTo>
                  <a:cubicBezTo>
                    <a:pt x="845453" y="754083"/>
                    <a:pt x="1284840" y="732312"/>
                    <a:pt x="1488700" y="795647"/>
                  </a:cubicBezTo>
                  <a:cubicBezTo>
                    <a:pt x="1692560" y="858982"/>
                    <a:pt x="1762822" y="975756"/>
                    <a:pt x="1833084" y="1092530"/>
                  </a:cubicBezTo>
                </a:path>
              </a:pathLst>
            </a:cu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 sz="1200">
                <a:solidFill>
                  <a:schemeClr val="tx1"/>
                </a:solidFill>
                <a:latin typeface="Calibri" panose="020F0502020204030204" pitchFamily="34" charset="0"/>
              </a:endParaRPr>
            </a:p>
          </p:txBody>
        </p:sp>
        <p:sp>
          <p:nvSpPr>
            <p:cNvPr id="385" name="円弧 384">
              <a:extLst>
                <a:ext uri="{FF2B5EF4-FFF2-40B4-BE49-F238E27FC236}">
                  <a16:creationId xmlns:a16="http://schemas.microsoft.com/office/drawing/2014/main" id="{09E9A74A-6997-4470-0C7E-20CC1933AF8C}"/>
                </a:ext>
              </a:extLst>
            </p:cNvPr>
            <p:cNvSpPr/>
            <p:nvPr/>
          </p:nvSpPr>
          <p:spPr>
            <a:xfrm>
              <a:off x="2923711" y="4138421"/>
              <a:ext cx="358681" cy="593595"/>
            </a:xfrm>
            <a:prstGeom prst="arc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 sz="1200">
                <a:latin typeface="Calibri" panose="020F0502020204030204" pitchFamily="34" charset="0"/>
              </a:endParaRPr>
            </a:p>
          </p:txBody>
        </p:sp>
        <p:sp>
          <p:nvSpPr>
            <p:cNvPr id="386" name="円弧 385">
              <a:extLst>
                <a:ext uri="{FF2B5EF4-FFF2-40B4-BE49-F238E27FC236}">
                  <a16:creationId xmlns:a16="http://schemas.microsoft.com/office/drawing/2014/main" id="{ED37B5B9-9280-7074-7AAE-5768EE1B6E5B}"/>
                </a:ext>
              </a:extLst>
            </p:cNvPr>
            <p:cNvSpPr/>
            <p:nvPr/>
          </p:nvSpPr>
          <p:spPr>
            <a:xfrm>
              <a:off x="2615817" y="4113027"/>
              <a:ext cx="360269" cy="593595"/>
            </a:xfrm>
            <a:prstGeom prst="arc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 sz="1200">
                <a:latin typeface="Calibri" panose="020F0502020204030204" pitchFamily="34" charset="0"/>
              </a:endParaRPr>
            </a:p>
          </p:txBody>
        </p:sp>
        <p:sp>
          <p:nvSpPr>
            <p:cNvPr id="387" name="円弧 386">
              <a:extLst>
                <a:ext uri="{FF2B5EF4-FFF2-40B4-BE49-F238E27FC236}">
                  <a16:creationId xmlns:a16="http://schemas.microsoft.com/office/drawing/2014/main" id="{7A697AE5-8788-1DFB-AC9F-89A443094E1F}"/>
                </a:ext>
              </a:extLst>
            </p:cNvPr>
            <p:cNvSpPr/>
            <p:nvPr/>
          </p:nvSpPr>
          <p:spPr>
            <a:xfrm>
              <a:off x="2255549" y="4089219"/>
              <a:ext cx="360268" cy="593595"/>
            </a:xfrm>
            <a:prstGeom prst="arc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 sz="1200">
                <a:latin typeface="Calibri" panose="020F0502020204030204" pitchFamily="34" charset="0"/>
              </a:endParaRPr>
            </a:p>
          </p:txBody>
        </p:sp>
        <p:sp>
          <p:nvSpPr>
            <p:cNvPr id="388" name="円弧 387">
              <a:extLst>
                <a:ext uri="{FF2B5EF4-FFF2-40B4-BE49-F238E27FC236}">
                  <a16:creationId xmlns:a16="http://schemas.microsoft.com/office/drawing/2014/main" id="{3B5013C4-D64C-A7E9-941B-9183C226711E}"/>
                </a:ext>
              </a:extLst>
            </p:cNvPr>
            <p:cNvSpPr/>
            <p:nvPr/>
          </p:nvSpPr>
          <p:spPr>
            <a:xfrm>
              <a:off x="1827036" y="4016210"/>
              <a:ext cx="428513" cy="688824"/>
            </a:xfrm>
            <a:prstGeom prst="arc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 sz="1200">
                <a:latin typeface="Calibri" panose="020F0502020204030204" pitchFamily="34" charset="0"/>
              </a:endParaRPr>
            </a:p>
          </p:txBody>
        </p:sp>
      </p:grpSp>
      <p:grpSp>
        <p:nvGrpSpPr>
          <p:cNvPr id="389" name="グループ化 56">
            <a:extLst>
              <a:ext uri="{FF2B5EF4-FFF2-40B4-BE49-F238E27FC236}">
                <a16:creationId xmlns:a16="http://schemas.microsoft.com/office/drawing/2014/main" id="{C5DC6F4A-CDEE-5490-3DA1-566F6FA8728C}"/>
              </a:ext>
            </a:extLst>
          </p:cNvPr>
          <p:cNvGrpSpPr>
            <a:grpSpLocks/>
          </p:cNvGrpSpPr>
          <p:nvPr/>
        </p:nvGrpSpPr>
        <p:grpSpPr bwMode="auto">
          <a:xfrm>
            <a:off x="5891000" y="5107910"/>
            <a:ext cx="3543300" cy="286524"/>
            <a:chOff x="1115616" y="5373603"/>
            <a:chExt cx="3340176" cy="451253"/>
          </a:xfrm>
        </p:grpSpPr>
        <p:sp>
          <p:nvSpPr>
            <p:cNvPr id="390" name="Text Box 102">
              <a:extLst>
                <a:ext uri="{FF2B5EF4-FFF2-40B4-BE49-F238E27FC236}">
                  <a16:creationId xmlns:a16="http://schemas.microsoft.com/office/drawing/2014/main" id="{EA63A7FA-4A3D-84D8-28AE-AEF91876D9B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231659" y="5388604"/>
              <a:ext cx="1224133" cy="43625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 eaLnBrk="1" hangingPunct="1">
                <a:spcBef>
                  <a:spcPct val="50000"/>
                </a:spcBef>
                <a:defRPr/>
              </a:pPr>
              <a:r>
                <a:rPr lang="ja-JP" altLang="en-US" sz="1200" b="1" dirty="0">
                  <a:effectLst>
                    <a:outerShdw blurRad="38100" dist="38100" dir="2700000" algn="tl">
                      <a:srgbClr val="000000"/>
                    </a:outerShdw>
                  </a:effectLst>
                  <a:ea typeface="HGP創英角ﾎﾟｯﾌﾟ体" pitchFamily="50" charset="-128"/>
                  <a:cs typeface="Arial" panose="020B0604020202020204" pitchFamily="34" charset="0"/>
                </a:rPr>
                <a:t>（</a:t>
              </a:r>
              <a:r>
                <a:rPr lang="en-US" altLang="ja-JP" sz="1200" b="1" dirty="0">
                  <a:effectLst>
                    <a:outerShdw blurRad="38100" dist="38100" dir="2700000" algn="tl">
                      <a:srgbClr val="000000"/>
                    </a:outerShdw>
                  </a:effectLst>
                  <a:ea typeface="HGP創英角ﾎﾟｯﾌﾟ体" pitchFamily="50" charset="-128"/>
                  <a:cs typeface="Arial" panose="020B0604020202020204" pitchFamily="34" charset="0"/>
                </a:rPr>
                <a:t>LGEA</a:t>
              </a:r>
              <a:r>
                <a:rPr lang="ja-JP" altLang="en-US" sz="1200" b="1" dirty="0">
                  <a:effectLst>
                    <a:outerShdw blurRad="38100" dist="38100" dir="2700000" algn="tl">
                      <a:srgbClr val="000000"/>
                    </a:outerShdw>
                  </a:effectLst>
                  <a:ea typeface="HGP創英角ﾎﾟｯﾌﾟ体" pitchFamily="50" charset="-128"/>
                  <a:cs typeface="Arial" panose="020B0604020202020204" pitchFamily="34" charset="0"/>
                </a:rPr>
                <a:t>）</a:t>
              </a:r>
            </a:p>
          </p:txBody>
        </p:sp>
        <p:sp>
          <p:nvSpPr>
            <p:cNvPr id="391" name="Text Box 103">
              <a:extLst>
                <a:ext uri="{FF2B5EF4-FFF2-40B4-BE49-F238E27FC236}">
                  <a16:creationId xmlns:a16="http://schemas.microsoft.com/office/drawing/2014/main" id="{5218A625-D08A-7834-D2B8-338102F0D75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115616" y="5373603"/>
              <a:ext cx="2864291" cy="43625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 eaLnBrk="1" hangingPunct="1">
                <a:spcBef>
                  <a:spcPct val="50000"/>
                </a:spcBef>
                <a:defRPr/>
              </a:pPr>
              <a:r>
                <a:rPr lang="en-US" altLang="ja-JP" sz="1200" b="1" dirty="0">
                  <a:effectLst>
                    <a:outerShdw blurRad="38100" dist="38100" dir="2700000" algn="tl">
                      <a:srgbClr val="000000"/>
                    </a:outerShdw>
                  </a:effectLst>
                  <a:ea typeface="HGP創英角ﾎﾟｯﾌﾟ体" pitchFamily="50" charset="-128"/>
                  <a:cs typeface="Arial" panose="020B0604020202020204" pitchFamily="34" charset="0"/>
                </a:rPr>
                <a:t>Left Gastroepiploic Artery</a:t>
              </a:r>
              <a:endParaRPr lang="ja-JP" altLang="en-US" sz="1200" b="1" dirty="0">
                <a:effectLst>
                  <a:outerShdw blurRad="38100" dist="38100" dir="2700000" algn="tl">
                    <a:srgbClr val="000000"/>
                  </a:outerShdw>
                </a:effectLst>
                <a:ea typeface="HGP創英角ﾎﾟｯﾌﾟ体" pitchFamily="50" charset="-128"/>
                <a:cs typeface="Arial" panose="020B0604020202020204" pitchFamily="34" charset="0"/>
              </a:endParaRPr>
            </a:p>
          </p:txBody>
        </p:sp>
      </p:grpSp>
      <p:sp>
        <p:nvSpPr>
          <p:cNvPr id="394" name="Text Box 103">
            <a:extLst>
              <a:ext uri="{FF2B5EF4-FFF2-40B4-BE49-F238E27FC236}">
                <a16:creationId xmlns:a16="http://schemas.microsoft.com/office/drawing/2014/main" id="{958765B5-274A-B770-3430-6ACE916032C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7621" y="3648022"/>
            <a:ext cx="241935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 eaLnBrk="1" hangingPunct="1">
              <a:spcBef>
                <a:spcPct val="50000"/>
              </a:spcBef>
              <a:defRPr/>
            </a:pPr>
            <a:r>
              <a:rPr lang="en-US" altLang="ja-JP" sz="1200" b="1" dirty="0">
                <a:effectLst>
                  <a:outerShdw blurRad="38100" dist="38100" dir="2700000" algn="tl">
                    <a:srgbClr val="000000"/>
                  </a:outerShdw>
                </a:effectLst>
                <a:ea typeface="HGP創英角ﾎﾟｯﾌﾟ体" pitchFamily="50" charset="-128"/>
                <a:cs typeface="Arial" panose="020B0604020202020204" pitchFamily="34" charset="0"/>
              </a:rPr>
              <a:t>Right Gastric Artery</a:t>
            </a:r>
            <a:endParaRPr lang="ja-JP" altLang="en-US" sz="1200" b="1" dirty="0">
              <a:effectLst>
                <a:outerShdw blurRad="38100" dist="38100" dir="2700000" algn="tl">
                  <a:srgbClr val="000000"/>
                </a:outerShdw>
              </a:effectLst>
              <a:ea typeface="HGP創英角ﾎﾟｯﾌﾟ体" pitchFamily="50" charset="-128"/>
              <a:cs typeface="Arial" panose="020B0604020202020204" pitchFamily="34" charset="0"/>
            </a:endParaRPr>
          </a:p>
        </p:txBody>
      </p:sp>
      <p:sp>
        <p:nvSpPr>
          <p:cNvPr id="395" name="テキスト ボックス 2">
            <a:extLst>
              <a:ext uri="{FF2B5EF4-FFF2-40B4-BE49-F238E27FC236}">
                <a16:creationId xmlns:a16="http://schemas.microsoft.com/office/drawing/2014/main" id="{92D7E4BF-F14E-5736-9C62-A8A11505852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48109" y="4417901"/>
            <a:ext cx="1070160" cy="265800"/>
          </a:xfrm>
          <a:prstGeom prst="rect">
            <a:avLst/>
          </a:prstGeom>
          <a:solidFill>
            <a:schemeClr val="bg1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wrap="square" lIns="77213" tIns="38606" rIns="77213" bIns="38606">
            <a:spAutoFit/>
          </a:bodyPr>
          <a:lstStyle>
            <a:lvl1pPr>
              <a:spcBef>
                <a:spcPct val="20000"/>
              </a:spcBef>
              <a:buClr>
                <a:srgbClr val="ACC2C9"/>
              </a:buClr>
              <a:buFont typeface="Arial" panose="020B0604020202020204" pitchFamily="34" charset="0"/>
              <a:buChar char="•"/>
              <a:defRPr kumimoji="1" sz="2400">
                <a:solidFill>
                  <a:schemeClr val="tx2"/>
                </a:solidFill>
                <a:latin typeface="Tw Cen MT"/>
              </a:defRPr>
            </a:lvl1pPr>
            <a:lvl2pPr marL="742950" indent="-285750">
              <a:spcBef>
                <a:spcPct val="20000"/>
              </a:spcBef>
              <a:buClr>
                <a:srgbClr val="ACC2C9"/>
              </a:buClr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Tw Cen MT"/>
              </a:defRPr>
            </a:lvl2pPr>
            <a:lvl3pPr marL="1143000" indent="-228600">
              <a:spcBef>
                <a:spcPct val="20000"/>
              </a:spcBef>
              <a:buClr>
                <a:schemeClr val="accent2"/>
              </a:buClr>
              <a:buFont typeface="Arial" panose="020B0604020202020204" pitchFamily="34" charset="0"/>
              <a:buChar char="•"/>
              <a:defRPr kumimoji="1" sz="2000">
                <a:solidFill>
                  <a:schemeClr val="tx2"/>
                </a:solidFill>
                <a:latin typeface="Tw Cen MT"/>
              </a:defRPr>
            </a:lvl3pPr>
            <a:lvl4pPr marL="1600200" indent="-228600">
              <a:spcBef>
                <a:spcPct val="20000"/>
              </a:spcBef>
              <a:buClr>
                <a:srgbClr val="99987F"/>
              </a:buClr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Tw Cen MT"/>
              </a:defRPr>
            </a:lvl4pPr>
            <a:lvl5pPr marL="2057400" indent="-228600">
              <a:spcBef>
                <a:spcPct val="20000"/>
              </a:spcBef>
              <a:buClr>
                <a:srgbClr val="90AC97"/>
              </a:buClr>
              <a:buFont typeface="Arial" panose="020B0604020202020204" pitchFamily="34" charset="0"/>
              <a:buChar char="•"/>
              <a:defRPr kumimoji="1" sz="1600">
                <a:solidFill>
                  <a:schemeClr val="tx2"/>
                </a:solidFill>
                <a:latin typeface="Tw Cen MT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90AC97"/>
              </a:buClr>
              <a:buFont typeface="Arial" panose="020B0604020202020204" pitchFamily="34" charset="0"/>
              <a:buChar char="•"/>
              <a:defRPr kumimoji="1" sz="1600">
                <a:solidFill>
                  <a:schemeClr val="tx2"/>
                </a:solidFill>
                <a:latin typeface="Tw Cen MT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90AC97"/>
              </a:buClr>
              <a:buFont typeface="Arial" panose="020B0604020202020204" pitchFamily="34" charset="0"/>
              <a:buChar char="•"/>
              <a:defRPr kumimoji="1" sz="1600">
                <a:solidFill>
                  <a:schemeClr val="tx2"/>
                </a:solidFill>
                <a:latin typeface="Tw Cen MT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90AC97"/>
              </a:buClr>
              <a:buFont typeface="Arial" panose="020B0604020202020204" pitchFamily="34" charset="0"/>
              <a:buChar char="•"/>
              <a:defRPr kumimoji="1" sz="1600">
                <a:solidFill>
                  <a:schemeClr val="tx2"/>
                </a:solidFill>
                <a:latin typeface="Tw Cen MT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90AC97"/>
              </a:buClr>
              <a:buFont typeface="Arial" panose="020B0604020202020204" pitchFamily="34" charset="0"/>
              <a:buChar char="•"/>
              <a:defRPr kumimoji="1" sz="1600">
                <a:solidFill>
                  <a:schemeClr val="tx2"/>
                </a:solidFill>
                <a:latin typeface="Tw Cen MT"/>
              </a:defRPr>
            </a:lvl9pPr>
          </a:lstStyle>
          <a:p>
            <a:pPr>
              <a:spcBef>
                <a:spcPct val="0"/>
              </a:spcBef>
              <a:buClrTx/>
              <a:buFontTx/>
              <a:buNone/>
            </a:pPr>
            <a:r>
              <a:rPr lang="en-US" altLang="ja-JP" sz="1200" b="1" dirty="0">
                <a:solidFill>
                  <a:schemeClr val="tx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anose="020B0604020202020204" pitchFamily="34" charset="0"/>
                <a:ea typeface="HGP創英角ﾎﾟｯﾌﾟ体" panose="040B0A00000000000000" pitchFamily="50" charset="-128"/>
                <a:cs typeface="Arial" panose="020B0604020202020204" pitchFamily="34" charset="0"/>
              </a:rPr>
              <a:t>Gastric tube </a:t>
            </a:r>
            <a:endParaRPr lang="ja-JP" altLang="en-US" sz="1200" b="1" dirty="0">
              <a:solidFill>
                <a:schemeClr val="tx1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Arial" panose="020B0604020202020204" pitchFamily="34" charset="0"/>
              <a:ea typeface="HGP創英角ﾎﾟｯﾌﾟ体" panose="040B0A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396" name="星 5 316">
            <a:extLst>
              <a:ext uri="{FF2B5EF4-FFF2-40B4-BE49-F238E27FC236}">
                <a16:creationId xmlns:a16="http://schemas.microsoft.com/office/drawing/2014/main" id="{271ADEB0-7451-6C11-83BD-36B8F9274947}"/>
              </a:ext>
            </a:extLst>
          </p:cNvPr>
          <p:cNvSpPr/>
          <p:nvPr/>
        </p:nvSpPr>
        <p:spPr>
          <a:xfrm>
            <a:off x="8145496" y="3258541"/>
            <a:ext cx="330200" cy="368300"/>
          </a:xfrm>
          <a:prstGeom prst="star5">
            <a:avLst/>
          </a:prstGeom>
          <a:solidFill>
            <a:srgbClr val="FFFF00"/>
          </a:solidFill>
          <a:ln w="127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7" name="テキスト ボックス 8">
            <a:extLst>
              <a:ext uri="{FF2B5EF4-FFF2-40B4-BE49-F238E27FC236}">
                <a16:creationId xmlns:a16="http://schemas.microsoft.com/office/drawing/2014/main" id="{948AC144-526D-22F5-5058-3EAA117A9EE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36807" y="3330904"/>
            <a:ext cx="281943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lr>
                <a:srgbClr val="ACC2C9"/>
              </a:buClr>
              <a:buFont typeface="Arial" panose="020B0604020202020204" pitchFamily="34" charset="0"/>
              <a:buChar char="•"/>
              <a:defRPr kumimoji="1" sz="2400">
                <a:solidFill>
                  <a:schemeClr val="tx2"/>
                </a:solidFill>
                <a:latin typeface="Tw Cen MT"/>
              </a:defRPr>
            </a:lvl1pPr>
            <a:lvl2pPr marL="742950" indent="-285750">
              <a:spcBef>
                <a:spcPct val="20000"/>
              </a:spcBef>
              <a:buClr>
                <a:srgbClr val="ACC2C9"/>
              </a:buClr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Tw Cen MT"/>
              </a:defRPr>
            </a:lvl2pPr>
            <a:lvl3pPr marL="1143000" indent="-228600">
              <a:spcBef>
                <a:spcPct val="20000"/>
              </a:spcBef>
              <a:buClr>
                <a:schemeClr val="accent2"/>
              </a:buClr>
              <a:buFont typeface="Arial" panose="020B0604020202020204" pitchFamily="34" charset="0"/>
              <a:buChar char="•"/>
              <a:defRPr kumimoji="1" sz="2000">
                <a:solidFill>
                  <a:schemeClr val="tx2"/>
                </a:solidFill>
                <a:latin typeface="Tw Cen MT"/>
              </a:defRPr>
            </a:lvl3pPr>
            <a:lvl4pPr marL="1600200" indent="-228600">
              <a:spcBef>
                <a:spcPct val="20000"/>
              </a:spcBef>
              <a:buClr>
                <a:srgbClr val="99987F"/>
              </a:buClr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Tw Cen MT"/>
              </a:defRPr>
            </a:lvl4pPr>
            <a:lvl5pPr marL="2057400" indent="-228600">
              <a:spcBef>
                <a:spcPct val="20000"/>
              </a:spcBef>
              <a:buClr>
                <a:srgbClr val="90AC97"/>
              </a:buClr>
              <a:buFont typeface="Arial" panose="020B0604020202020204" pitchFamily="34" charset="0"/>
              <a:buChar char="•"/>
              <a:defRPr kumimoji="1" sz="1600">
                <a:solidFill>
                  <a:schemeClr val="tx2"/>
                </a:solidFill>
                <a:latin typeface="Tw Cen MT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90AC97"/>
              </a:buClr>
              <a:buFont typeface="Arial" panose="020B0604020202020204" pitchFamily="34" charset="0"/>
              <a:buChar char="•"/>
              <a:defRPr kumimoji="1" sz="1600">
                <a:solidFill>
                  <a:schemeClr val="tx2"/>
                </a:solidFill>
                <a:latin typeface="Tw Cen MT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90AC97"/>
              </a:buClr>
              <a:buFont typeface="Arial" panose="020B0604020202020204" pitchFamily="34" charset="0"/>
              <a:buChar char="•"/>
              <a:defRPr kumimoji="1" sz="1600">
                <a:solidFill>
                  <a:schemeClr val="tx2"/>
                </a:solidFill>
                <a:latin typeface="Tw Cen MT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90AC97"/>
              </a:buClr>
              <a:buFont typeface="Arial" panose="020B0604020202020204" pitchFamily="34" charset="0"/>
              <a:buChar char="•"/>
              <a:defRPr kumimoji="1" sz="1600">
                <a:solidFill>
                  <a:schemeClr val="tx2"/>
                </a:solidFill>
                <a:latin typeface="Tw Cen MT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90AC97"/>
              </a:buClr>
              <a:buFont typeface="Arial" panose="020B0604020202020204" pitchFamily="34" charset="0"/>
              <a:buChar char="•"/>
              <a:defRPr kumimoji="1" sz="1600">
                <a:solidFill>
                  <a:schemeClr val="tx2"/>
                </a:solidFill>
                <a:latin typeface="Tw Cen MT"/>
              </a:defRPr>
            </a:lvl9pPr>
          </a:lstStyle>
          <a:p>
            <a:pPr>
              <a:spcBef>
                <a:spcPct val="0"/>
              </a:spcBef>
              <a:buClrTx/>
              <a:buFontTx/>
              <a:buNone/>
            </a:pPr>
            <a:r>
              <a:rPr lang="en-US" altLang="ja-JP" sz="1200" b="1" dirty="0">
                <a:solidFill>
                  <a:schemeClr val="tx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rPr>
              <a:t>Expected location of anastomosis:</a:t>
            </a:r>
            <a:endParaRPr lang="ja-JP" altLang="en-US" sz="1200" b="1" dirty="0">
              <a:solidFill>
                <a:schemeClr val="tx1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8" name="正方形/長方形 397">
            <a:extLst>
              <a:ext uri="{FF2B5EF4-FFF2-40B4-BE49-F238E27FC236}">
                <a16:creationId xmlns:a16="http://schemas.microsoft.com/office/drawing/2014/main" id="{7146CE06-FBC8-6226-895D-179DFC6752E7}"/>
              </a:ext>
            </a:extLst>
          </p:cNvPr>
          <p:cNvSpPr/>
          <p:nvPr/>
        </p:nvSpPr>
        <p:spPr>
          <a:xfrm>
            <a:off x="2017500" y="5685217"/>
            <a:ext cx="3444875" cy="102841"/>
          </a:xfrm>
          <a:prstGeom prst="rect">
            <a:avLst/>
          </a:prstGeom>
          <a:solidFill>
            <a:srgbClr val="FF0000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2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9" name="正方形/長方形 398">
            <a:extLst>
              <a:ext uri="{FF2B5EF4-FFF2-40B4-BE49-F238E27FC236}">
                <a16:creationId xmlns:a16="http://schemas.microsoft.com/office/drawing/2014/main" id="{1B14DC78-0278-766B-84D0-A9543916A453}"/>
              </a:ext>
            </a:extLst>
          </p:cNvPr>
          <p:cNvSpPr/>
          <p:nvPr/>
        </p:nvSpPr>
        <p:spPr>
          <a:xfrm>
            <a:off x="5813914" y="5685217"/>
            <a:ext cx="1090067" cy="102841"/>
          </a:xfrm>
          <a:prstGeom prst="rect">
            <a:avLst/>
          </a:prstGeom>
          <a:solidFill>
            <a:srgbClr val="FFC000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2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0" name="正方形/長方形 399">
            <a:extLst>
              <a:ext uri="{FF2B5EF4-FFF2-40B4-BE49-F238E27FC236}">
                <a16:creationId xmlns:a16="http://schemas.microsoft.com/office/drawing/2014/main" id="{34BD40BA-905A-0F16-214A-50BBC3713982}"/>
              </a:ext>
            </a:extLst>
          </p:cNvPr>
          <p:cNvSpPr/>
          <p:nvPr/>
        </p:nvSpPr>
        <p:spPr>
          <a:xfrm>
            <a:off x="5463821" y="5685217"/>
            <a:ext cx="1090067" cy="102841"/>
          </a:xfrm>
          <a:prstGeom prst="rect">
            <a:avLst/>
          </a:prstGeom>
          <a:solidFill>
            <a:srgbClr val="FFC000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2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1" name="正方形/長方形 400">
            <a:extLst>
              <a:ext uri="{FF2B5EF4-FFF2-40B4-BE49-F238E27FC236}">
                <a16:creationId xmlns:a16="http://schemas.microsoft.com/office/drawing/2014/main" id="{3242EBFC-1F84-2C73-62AF-C80222E2CAC3}"/>
              </a:ext>
            </a:extLst>
          </p:cNvPr>
          <p:cNvSpPr/>
          <p:nvPr/>
        </p:nvSpPr>
        <p:spPr>
          <a:xfrm>
            <a:off x="4133349" y="5894782"/>
            <a:ext cx="1342740" cy="27699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>
            <a:spAutoFit/>
          </a:bodyPr>
          <a:lstStyle/>
          <a:p>
            <a:r>
              <a:rPr lang="en-US" altLang="ja-JP" sz="1200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ea typeface="HGP創英角ﾎﾟｯﾌﾟ体" panose="040B0A00000000000000" pitchFamily="50" charset="-128"/>
                <a:cs typeface="Arial" panose="020B0604020202020204" pitchFamily="34" charset="0"/>
              </a:rPr>
              <a:t>GEA</a:t>
            </a:r>
            <a:r>
              <a:rPr lang="ja-JP" altLang="en-US" sz="1200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ea typeface="HGP創英角ﾎﾟｯﾌﾟ体" panose="040B0A00000000000000" pitchFamily="50" charset="-128"/>
                <a:cs typeface="Arial" panose="020B0604020202020204" pitchFamily="34" charset="0"/>
              </a:rPr>
              <a:t> </a:t>
            </a:r>
            <a:r>
              <a:rPr lang="en-US" altLang="ja-JP" sz="1200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ea typeface="HGP創英角ﾎﾟｯﾌﾟ体" panose="040B0A00000000000000" pitchFamily="50" charset="-128"/>
                <a:cs typeface="Arial" panose="020B0604020202020204" pitchFamily="34" charset="0"/>
              </a:rPr>
              <a:t>length rate</a:t>
            </a:r>
            <a:endParaRPr lang="ja-JP" altLang="en-US" sz="1200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cs typeface="Arial" panose="020B0604020202020204" pitchFamily="34" charset="0"/>
            </a:endParaRPr>
          </a:p>
        </p:txBody>
      </p:sp>
      <p:sp>
        <p:nvSpPr>
          <p:cNvPr id="402" name="テキスト ボックス 401">
            <a:extLst>
              <a:ext uri="{FF2B5EF4-FFF2-40B4-BE49-F238E27FC236}">
                <a16:creationId xmlns:a16="http://schemas.microsoft.com/office/drawing/2014/main" id="{6A7E413F-E750-977D-FD45-B0ADDA2E73A6}"/>
              </a:ext>
            </a:extLst>
          </p:cNvPr>
          <p:cNvSpPr txBox="1"/>
          <p:nvPr/>
        </p:nvSpPr>
        <p:spPr>
          <a:xfrm>
            <a:off x="2109575" y="4389054"/>
            <a:ext cx="1450205" cy="27699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cs typeface="Arial" panose="020B0604020202020204" pitchFamily="34" charset="0"/>
              </a:rPr>
              <a:t>Control region</a:t>
            </a:r>
            <a:endParaRPr kumimoji="1" lang="ja-JP" altLang="en-US" sz="1200" b="1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cs typeface="Arial" panose="020B0604020202020204" pitchFamily="34" charset="0"/>
            </a:endParaRPr>
          </a:p>
        </p:txBody>
      </p:sp>
      <p:sp>
        <p:nvSpPr>
          <p:cNvPr id="408" name="正方形/長方形 407">
            <a:extLst>
              <a:ext uri="{FF2B5EF4-FFF2-40B4-BE49-F238E27FC236}">
                <a16:creationId xmlns:a16="http://schemas.microsoft.com/office/drawing/2014/main" id="{0B0B3611-0C69-C27A-A4E6-2D373F6D957F}"/>
              </a:ext>
            </a:extLst>
          </p:cNvPr>
          <p:cNvSpPr/>
          <p:nvPr/>
        </p:nvSpPr>
        <p:spPr>
          <a:xfrm>
            <a:off x="6395657" y="3886681"/>
            <a:ext cx="1412374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>
            <a:spAutoFit/>
          </a:bodyPr>
          <a:lstStyle/>
          <a:p>
            <a:r>
              <a:rPr lang="en-US" altLang="ja-JP" sz="1200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ea typeface="HGP創英角ﾎﾟｯﾌﾟ体" panose="040B0A00000000000000" pitchFamily="50" charset="-128"/>
                <a:cs typeface="Arial" panose="020B0604020202020204" pitchFamily="34" charset="0"/>
              </a:rPr>
              <a:t>Temp. retain rate</a:t>
            </a:r>
            <a:endParaRPr lang="ja-JP" altLang="en-US" sz="1200" b="1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cs typeface="Arial" panose="020B0604020202020204" pitchFamily="34" charset="0"/>
            </a:endParaRPr>
          </a:p>
        </p:txBody>
      </p:sp>
      <p:grpSp>
        <p:nvGrpSpPr>
          <p:cNvPr id="414" name="グループ化 10">
            <a:extLst>
              <a:ext uri="{FF2B5EF4-FFF2-40B4-BE49-F238E27FC236}">
                <a16:creationId xmlns:a16="http://schemas.microsoft.com/office/drawing/2014/main" id="{82D4FB06-6AD9-8ACD-25F1-3369575591B6}"/>
              </a:ext>
            </a:extLst>
          </p:cNvPr>
          <p:cNvGrpSpPr>
            <a:grpSpLocks/>
          </p:cNvGrpSpPr>
          <p:nvPr/>
        </p:nvGrpSpPr>
        <p:grpSpPr bwMode="auto">
          <a:xfrm>
            <a:off x="3433623" y="4142508"/>
            <a:ext cx="4776788" cy="758825"/>
            <a:chOff x="3487878" y="4052314"/>
            <a:chExt cx="5236552" cy="830563"/>
          </a:xfrm>
        </p:grpSpPr>
        <p:sp>
          <p:nvSpPr>
            <p:cNvPr id="415" name="円弧 414">
              <a:extLst>
                <a:ext uri="{FF2B5EF4-FFF2-40B4-BE49-F238E27FC236}">
                  <a16:creationId xmlns:a16="http://schemas.microsoft.com/office/drawing/2014/main" id="{39C8B841-65D9-E44C-E38A-215AAC4FBD12}"/>
                </a:ext>
              </a:extLst>
            </p:cNvPr>
            <p:cNvSpPr/>
            <p:nvPr/>
          </p:nvSpPr>
          <p:spPr>
            <a:xfrm>
              <a:off x="8440761" y="4665680"/>
              <a:ext cx="45248" cy="139006"/>
            </a:xfrm>
            <a:prstGeom prst="arc">
              <a:avLst/>
            </a:prstGeom>
            <a:ln w="28575">
              <a:solidFill>
                <a:srgbClr val="7030A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 sz="12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6" name="円弧 415">
              <a:extLst>
                <a:ext uri="{FF2B5EF4-FFF2-40B4-BE49-F238E27FC236}">
                  <a16:creationId xmlns:a16="http://schemas.microsoft.com/office/drawing/2014/main" id="{AF11A5A6-FD5E-913E-73B4-E581AD9E9351}"/>
                </a:ext>
              </a:extLst>
            </p:cNvPr>
            <p:cNvSpPr/>
            <p:nvPr/>
          </p:nvSpPr>
          <p:spPr>
            <a:xfrm>
              <a:off x="8526036" y="4696957"/>
              <a:ext cx="45248" cy="139006"/>
            </a:xfrm>
            <a:prstGeom prst="arc">
              <a:avLst/>
            </a:prstGeom>
            <a:ln w="28575">
              <a:solidFill>
                <a:srgbClr val="7030A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 sz="12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7" name="円弧 416">
              <a:extLst>
                <a:ext uri="{FF2B5EF4-FFF2-40B4-BE49-F238E27FC236}">
                  <a16:creationId xmlns:a16="http://schemas.microsoft.com/office/drawing/2014/main" id="{A352E16F-7EF2-059C-AFFE-597E5DBCFB3C}"/>
                </a:ext>
              </a:extLst>
            </p:cNvPr>
            <p:cNvSpPr/>
            <p:nvPr/>
          </p:nvSpPr>
          <p:spPr>
            <a:xfrm>
              <a:off x="8592167" y="4714332"/>
              <a:ext cx="46987" cy="139006"/>
            </a:xfrm>
            <a:prstGeom prst="arc">
              <a:avLst/>
            </a:prstGeom>
            <a:ln w="28575">
              <a:solidFill>
                <a:srgbClr val="7030A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 sz="12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8" name="円弧 417">
              <a:extLst>
                <a:ext uri="{FF2B5EF4-FFF2-40B4-BE49-F238E27FC236}">
                  <a16:creationId xmlns:a16="http://schemas.microsoft.com/office/drawing/2014/main" id="{A8553E30-A08A-C4DD-3DAB-E59E33A5D4E9}"/>
                </a:ext>
              </a:extLst>
            </p:cNvPr>
            <p:cNvSpPr/>
            <p:nvPr/>
          </p:nvSpPr>
          <p:spPr>
            <a:xfrm>
              <a:off x="8679182" y="4743871"/>
              <a:ext cx="45248" cy="139006"/>
            </a:xfrm>
            <a:prstGeom prst="arc">
              <a:avLst/>
            </a:prstGeom>
            <a:ln w="28575">
              <a:solidFill>
                <a:srgbClr val="7030A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 sz="12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9" name="円弧 418">
              <a:extLst>
                <a:ext uri="{FF2B5EF4-FFF2-40B4-BE49-F238E27FC236}">
                  <a16:creationId xmlns:a16="http://schemas.microsoft.com/office/drawing/2014/main" id="{1426B1FF-7E1D-3704-E629-FD540E9FC33B}"/>
                </a:ext>
              </a:extLst>
            </p:cNvPr>
            <p:cNvSpPr/>
            <p:nvPr/>
          </p:nvSpPr>
          <p:spPr>
            <a:xfrm>
              <a:off x="8117066" y="4580538"/>
              <a:ext cx="45248" cy="139006"/>
            </a:xfrm>
            <a:prstGeom prst="arc">
              <a:avLst/>
            </a:prstGeom>
            <a:ln w="28575">
              <a:solidFill>
                <a:srgbClr val="7030A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 sz="12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0" name="円弧 419">
              <a:extLst>
                <a:ext uri="{FF2B5EF4-FFF2-40B4-BE49-F238E27FC236}">
                  <a16:creationId xmlns:a16="http://schemas.microsoft.com/office/drawing/2014/main" id="{A3554C78-6787-7BA0-1287-E0D028680174}"/>
                </a:ext>
              </a:extLst>
            </p:cNvPr>
            <p:cNvSpPr/>
            <p:nvPr/>
          </p:nvSpPr>
          <p:spPr>
            <a:xfrm>
              <a:off x="8202341" y="4610078"/>
              <a:ext cx="45248" cy="139006"/>
            </a:xfrm>
            <a:prstGeom prst="arc">
              <a:avLst/>
            </a:prstGeom>
            <a:ln w="28575">
              <a:solidFill>
                <a:srgbClr val="7030A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 sz="12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1" name="円弧 420">
              <a:extLst>
                <a:ext uri="{FF2B5EF4-FFF2-40B4-BE49-F238E27FC236}">
                  <a16:creationId xmlns:a16="http://schemas.microsoft.com/office/drawing/2014/main" id="{405CEC2C-9F07-1FDA-6F7F-3B909F22E81E}"/>
                </a:ext>
              </a:extLst>
            </p:cNvPr>
            <p:cNvSpPr/>
            <p:nvPr/>
          </p:nvSpPr>
          <p:spPr>
            <a:xfrm>
              <a:off x="8268472" y="4629190"/>
              <a:ext cx="46987" cy="137269"/>
            </a:xfrm>
            <a:prstGeom prst="arc">
              <a:avLst/>
            </a:prstGeom>
            <a:ln w="28575">
              <a:solidFill>
                <a:srgbClr val="7030A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 sz="12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2" name="円弧 421">
              <a:extLst>
                <a:ext uri="{FF2B5EF4-FFF2-40B4-BE49-F238E27FC236}">
                  <a16:creationId xmlns:a16="http://schemas.microsoft.com/office/drawing/2014/main" id="{CFDB3B35-492F-B8C8-B8B0-1F81A6B277A1}"/>
                </a:ext>
              </a:extLst>
            </p:cNvPr>
            <p:cNvSpPr/>
            <p:nvPr/>
          </p:nvSpPr>
          <p:spPr>
            <a:xfrm>
              <a:off x="8355487" y="4648304"/>
              <a:ext cx="45248" cy="139006"/>
            </a:xfrm>
            <a:prstGeom prst="arc">
              <a:avLst/>
            </a:prstGeom>
            <a:ln w="28575">
              <a:solidFill>
                <a:srgbClr val="7030A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 sz="12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3" name="円弧 422">
              <a:extLst>
                <a:ext uri="{FF2B5EF4-FFF2-40B4-BE49-F238E27FC236}">
                  <a16:creationId xmlns:a16="http://schemas.microsoft.com/office/drawing/2014/main" id="{01681938-EEB9-A81B-1D65-4B2DA1BA6994}"/>
                </a:ext>
              </a:extLst>
            </p:cNvPr>
            <p:cNvSpPr/>
            <p:nvPr/>
          </p:nvSpPr>
          <p:spPr>
            <a:xfrm>
              <a:off x="7793371" y="4514510"/>
              <a:ext cx="45248" cy="139006"/>
            </a:xfrm>
            <a:prstGeom prst="arc">
              <a:avLst/>
            </a:prstGeom>
            <a:ln w="28575">
              <a:solidFill>
                <a:srgbClr val="7030A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 sz="12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4" name="円弧 423">
              <a:extLst>
                <a:ext uri="{FF2B5EF4-FFF2-40B4-BE49-F238E27FC236}">
                  <a16:creationId xmlns:a16="http://schemas.microsoft.com/office/drawing/2014/main" id="{FCAB2E85-E4BB-B582-E5EF-1D0E8A54C413}"/>
                </a:ext>
              </a:extLst>
            </p:cNvPr>
            <p:cNvSpPr/>
            <p:nvPr/>
          </p:nvSpPr>
          <p:spPr>
            <a:xfrm>
              <a:off x="7878646" y="4544050"/>
              <a:ext cx="45248" cy="139006"/>
            </a:xfrm>
            <a:prstGeom prst="arc">
              <a:avLst/>
            </a:prstGeom>
            <a:ln w="28575">
              <a:solidFill>
                <a:srgbClr val="7030A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 sz="12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5" name="円弧 424">
              <a:extLst>
                <a:ext uri="{FF2B5EF4-FFF2-40B4-BE49-F238E27FC236}">
                  <a16:creationId xmlns:a16="http://schemas.microsoft.com/office/drawing/2014/main" id="{21450A8F-A3F4-3F77-D99C-287CA062C550}"/>
                </a:ext>
              </a:extLst>
            </p:cNvPr>
            <p:cNvSpPr/>
            <p:nvPr/>
          </p:nvSpPr>
          <p:spPr>
            <a:xfrm>
              <a:off x="7944777" y="4542311"/>
              <a:ext cx="46987" cy="139006"/>
            </a:xfrm>
            <a:prstGeom prst="arc">
              <a:avLst/>
            </a:prstGeom>
            <a:ln w="28575">
              <a:solidFill>
                <a:srgbClr val="7030A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 sz="12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6" name="円弧 425">
              <a:extLst>
                <a:ext uri="{FF2B5EF4-FFF2-40B4-BE49-F238E27FC236}">
                  <a16:creationId xmlns:a16="http://schemas.microsoft.com/office/drawing/2014/main" id="{6D06DF5A-1998-CD51-6036-BFCD6CB4AB95}"/>
                </a:ext>
              </a:extLst>
            </p:cNvPr>
            <p:cNvSpPr/>
            <p:nvPr/>
          </p:nvSpPr>
          <p:spPr>
            <a:xfrm>
              <a:off x="8031792" y="4571851"/>
              <a:ext cx="45248" cy="139006"/>
            </a:xfrm>
            <a:prstGeom prst="arc">
              <a:avLst/>
            </a:prstGeom>
            <a:ln w="28575">
              <a:solidFill>
                <a:srgbClr val="7030A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 sz="12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7" name="円弧 426">
              <a:extLst>
                <a:ext uri="{FF2B5EF4-FFF2-40B4-BE49-F238E27FC236}">
                  <a16:creationId xmlns:a16="http://schemas.microsoft.com/office/drawing/2014/main" id="{7E694DD0-7313-CC21-C061-95BE7CAD3E4D}"/>
                </a:ext>
              </a:extLst>
            </p:cNvPr>
            <p:cNvSpPr/>
            <p:nvPr/>
          </p:nvSpPr>
          <p:spPr>
            <a:xfrm>
              <a:off x="7469676" y="4438057"/>
              <a:ext cx="45248" cy="139006"/>
            </a:xfrm>
            <a:prstGeom prst="arc">
              <a:avLst/>
            </a:prstGeom>
            <a:ln w="28575">
              <a:solidFill>
                <a:srgbClr val="7030A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 sz="12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8" name="円弧 427">
              <a:extLst>
                <a:ext uri="{FF2B5EF4-FFF2-40B4-BE49-F238E27FC236}">
                  <a16:creationId xmlns:a16="http://schemas.microsoft.com/office/drawing/2014/main" id="{78F49B00-7E0A-E3FA-7F46-7B4A0C4ECA2D}"/>
                </a:ext>
              </a:extLst>
            </p:cNvPr>
            <p:cNvSpPr/>
            <p:nvPr/>
          </p:nvSpPr>
          <p:spPr>
            <a:xfrm>
              <a:off x="7554951" y="4458908"/>
              <a:ext cx="45248" cy="139006"/>
            </a:xfrm>
            <a:prstGeom prst="arc">
              <a:avLst/>
            </a:prstGeom>
            <a:ln w="28575">
              <a:solidFill>
                <a:srgbClr val="7030A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 sz="12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9" name="円弧 428">
              <a:extLst>
                <a:ext uri="{FF2B5EF4-FFF2-40B4-BE49-F238E27FC236}">
                  <a16:creationId xmlns:a16="http://schemas.microsoft.com/office/drawing/2014/main" id="{E160C2C3-72E7-97DE-E74C-347BA51EBF69}"/>
                </a:ext>
              </a:extLst>
            </p:cNvPr>
            <p:cNvSpPr/>
            <p:nvPr/>
          </p:nvSpPr>
          <p:spPr>
            <a:xfrm>
              <a:off x="7621082" y="4476283"/>
              <a:ext cx="45248" cy="139006"/>
            </a:xfrm>
            <a:prstGeom prst="arc">
              <a:avLst/>
            </a:prstGeom>
            <a:ln w="28575">
              <a:solidFill>
                <a:srgbClr val="7030A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 sz="12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0" name="円弧 429">
              <a:extLst>
                <a:ext uri="{FF2B5EF4-FFF2-40B4-BE49-F238E27FC236}">
                  <a16:creationId xmlns:a16="http://schemas.microsoft.com/office/drawing/2014/main" id="{805DDF23-227B-5292-F20F-DD8C5193CB48}"/>
                </a:ext>
              </a:extLst>
            </p:cNvPr>
            <p:cNvSpPr/>
            <p:nvPr/>
          </p:nvSpPr>
          <p:spPr>
            <a:xfrm>
              <a:off x="7706356" y="4497134"/>
              <a:ext cx="46989" cy="137269"/>
            </a:xfrm>
            <a:prstGeom prst="arc">
              <a:avLst/>
            </a:prstGeom>
            <a:ln w="28575">
              <a:solidFill>
                <a:srgbClr val="7030A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 sz="12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31" name="グループ化 4">
              <a:extLst>
                <a:ext uri="{FF2B5EF4-FFF2-40B4-BE49-F238E27FC236}">
                  <a16:creationId xmlns:a16="http://schemas.microsoft.com/office/drawing/2014/main" id="{C32690D8-228C-89AF-4C78-8DBF25FBE6AD}"/>
                </a:ext>
              </a:extLst>
            </p:cNvPr>
            <p:cNvGrpSpPr>
              <a:grpSpLocks/>
            </p:cNvGrpSpPr>
            <p:nvPr/>
          </p:nvGrpSpPr>
          <p:grpSpPr bwMode="auto">
            <a:xfrm rot="-223381">
              <a:off x="6817965" y="4293096"/>
              <a:ext cx="607694" cy="302146"/>
              <a:chOff x="6817965" y="4293096"/>
              <a:chExt cx="607694" cy="302146"/>
            </a:xfrm>
          </p:grpSpPr>
          <p:sp>
            <p:nvSpPr>
              <p:cNvPr id="476" name="円弧 475">
                <a:extLst>
                  <a:ext uri="{FF2B5EF4-FFF2-40B4-BE49-F238E27FC236}">
                    <a16:creationId xmlns:a16="http://schemas.microsoft.com/office/drawing/2014/main" id="{6352E668-EB55-ABB3-D5D6-F8DE0FD601C0}"/>
                  </a:ext>
                </a:extLst>
              </p:cNvPr>
              <p:cNvSpPr/>
              <p:nvPr/>
            </p:nvSpPr>
            <p:spPr>
              <a:xfrm>
                <a:off x="7137484" y="4377982"/>
                <a:ext cx="45248" cy="128581"/>
              </a:xfrm>
              <a:prstGeom prst="arc">
                <a:avLst/>
              </a:prstGeom>
              <a:ln w="28575">
                <a:solidFill>
                  <a:srgbClr val="7030A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ja-JP" altLang="en-US" sz="12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77" name="円弧 476">
                <a:extLst>
                  <a:ext uri="{FF2B5EF4-FFF2-40B4-BE49-F238E27FC236}">
                    <a16:creationId xmlns:a16="http://schemas.microsoft.com/office/drawing/2014/main" id="{93CCAFD8-CE6B-6603-E7ED-1D9EB0839528}"/>
                  </a:ext>
                </a:extLst>
              </p:cNvPr>
              <p:cNvSpPr/>
              <p:nvPr/>
            </p:nvSpPr>
            <p:spPr>
              <a:xfrm>
                <a:off x="7227603" y="4408226"/>
                <a:ext cx="45248" cy="139006"/>
              </a:xfrm>
              <a:prstGeom prst="arc">
                <a:avLst/>
              </a:prstGeom>
              <a:ln w="28575">
                <a:solidFill>
                  <a:srgbClr val="7030A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ja-JP" altLang="en-US" sz="12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78" name="円弧 477">
                <a:extLst>
                  <a:ext uri="{FF2B5EF4-FFF2-40B4-BE49-F238E27FC236}">
                    <a16:creationId xmlns:a16="http://schemas.microsoft.com/office/drawing/2014/main" id="{FCD1CA4E-7174-BE27-3D54-02EDE9A118F8}"/>
                  </a:ext>
                </a:extLst>
              </p:cNvPr>
              <p:cNvSpPr/>
              <p:nvPr/>
            </p:nvSpPr>
            <p:spPr>
              <a:xfrm>
                <a:off x="7295219" y="4414361"/>
                <a:ext cx="45248" cy="139006"/>
              </a:xfrm>
              <a:prstGeom prst="arc">
                <a:avLst/>
              </a:prstGeom>
              <a:ln w="28575">
                <a:solidFill>
                  <a:srgbClr val="7030A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ja-JP" altLang="en-US" sz="12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79" name="円弧 478">
                <a:extLst>
                  <a:ext uri="{FF2B5EF4-FFF2-40B4-BE49-F238E27FC236}">
                    <a16:creationId xmlns:a16="http://schemas.microsoft.com/office/drawing/2014/main" id="{B26CCC92-2DEB-3E37-28DC-D696A5D77A2F}"/>
                  </a:ext>
                </a:extLst>
              </p:cNvPr>
              <p:cNvSpPr/>
              <p:nvPr/>
            </p:nvSpPr>
            <p:spPr>
              <a:xfrm>
                <a:off x="7380129" y="4454691"/>
                <a:ext cx="45248" cy="128581"/>
              </a:xfrm>
              <a:prstGeom prst="arc">
                <a:avLst/>
              </a:prstGeom>
              <a:ln w="28575">
                <a:solidFill>
                  <a:srgbClr val="7030A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ja-JP" altLang="en-US" sz="12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80" name="円弧 479">
                <a:extLst>
                  <a:ext uri="{FF2B5EF4-FFF2-40B4-BE49-F238E27FC236}">
                    <a16:creationId xmlns:a16="http://schemas.microsoft.com/office/drawing/2014/main" id="{1870854D-8713-CC45-C4F5-C307020D1D5F}"/>
                  </a:ext>
                </a:extLst>
              </p:cNvPr>
              <p:cNvSpPr/>
              <p:nvPr/>
            </p:nvSpPr>
            <p:spPr>
              <a:xfrm>
                <a:off x="6818653" y="4292843"/>
                <a:ext cx="45248" cy="128581"/>
              </a:xfrm>
              <a:prstGeom prst="arc">
                <a:avLst/>
              </a:prstGeom>
              <a:ln w="28575">
                <a:solidFill>
                  <a:srgbClr val="7030A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ja-JP" altLang="en-US" sz="12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81" name="円弧 480">
                <a:extLst>
                  <a:ext uri="{FF2B5EF4-FFF2-40B4-BE49-F238E27FC236}">
                    <a16:creationId xmlns:a16="http://schemas.microsoft.com/office/drawing/2014/main" id="{7ECA2057-9238-ADFC-7A29-3DB1B9C9428A}"/>
                  </a:ext>
                </a:extLst>
              </p:cNvPr>
              <p:cNvSpPr/>
              <p:nvPr/>
            </p:nvSpPr>
            <p:spPr>
              <a:xfrm>
                <a:off x="6903563" y="4322748"/>
                <a:ext cx="45248" cy="139006"/>
              </a:xfrm>
              <a:prstGeom prst="arc">
                <a:avLst/>
              </a:prstGeom>
              <a:ln w="28575">
                <a:solidFill>
                  <a:srgbClr val="7030A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ja-JP" altLang="en-US" sz="12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82" name="円弧 481">
                <a:extLst>
                  <a:ext uri="{FF2B5EF4-FFF2-40B4-BE49-F238E27FC236}">
                    <a16:creationId xmlns:a16="http://schemas.microsoft.com/office/drawing/2014/main" id="{869CA416-3548-3A7F-C12E-B37C3311B0D6}"/>
                  </a:ext>
                </a:extLst>
              </p:cNvPr>
              <p:cNvSpPr/>
              <p:nvPr/>
            </p:nvSpPr>
            <p:spPr>
              <a:xfrm>
                <a:off x="6971178" y="4328881"/>
                <a:ext cx="45248" cy="139006"/>
              </a:xfrm>
              <a:prstGeom prst="arc">
                <a:avLst/>
              </a:prstGeom>
              <a:ln w="28575">
                <a:solidFill>
                  <a:srgbClr val="7030A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ja-JP" altLang="en-US" sz="12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83" name="円弧 482">
                <a:extLst>
                  <a:ext uri="{FF2B5EF4-FFF2-40B4-BE49-F238E27FC236}">
                    <a16:creationId xmlns:a16="http://schemas.microsoft.com/office/drawing/2014/main" id="{9A65B30A-A7E6-A690-E24C-D13034E9CE42}"/>
                  </a:ext>
                </a:extLst>
              </p:cNvPr>
              <p:cNvSpPr/>
              <p:nvPr/>
            </p:nvSpPr>
            <p:spPr>
              <a:xfrm>
                <a:off x="7056709" y="4360545"/>
                <a:ext cx="45248" cy="126843"/>
              </a:xfrm>
              <a:prstGeom prst="arc">
                <a:avLst/>
              </a:prstGeom>
              <a:ln w="28575">
                <a:solidFill>
                  <a:srgbClr val="7030A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ja-JP" altLang="en-US" sz="12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432" name="グループ化 6">
              <a:extLst>
                <a:ext uri="{FF2B5EF4-FFF2-40B4-BE49-F238E27FC236}">
                  <a16:creationId xmlns:a16="http://schemas.microsoft.com/office/drawing/2014/main" id="{1B8A5711-1AD3-6866-BC5F-5003114A6015}"/>
                </a:ext>
              </a:extLst>
            </p:cNvPr>
            <p:cNvGrpSpPr>
              <a:grpSpLocks/>
            </p:cNvGrpSpPr>
            <p:nvPr/>
          </p:nvGrpSpPr>
          <p:grpSpPr bwMode="auto">
            <a:xfrm rot="-535240">
              <a:off x="6141396" y="4190961"/>
              <a:ext cx="607694" cy="302146"/>
              <a:chOff x="8269136" y="4733131"/>
              <a:chExt cx="607694" cy="302146"/>
            </a:xfrm>
          </p:grpSpPr>
          <p:sp>
            <p:nvSpPr>
              <p:cNvPr id="468" name="円弧 467">
                <a:extLst>
                  <a:ext uri="{FF2B5EF4-FFF2-40B4-BE49-F238E27FC236}">
                    <a16:creationId xmlns:a16="http://schemas.microsoft.com/office/drawing/2014/main" id="{E5B75278-46D2-2D2A-9503-ABB428627D5F}"/>
                  </a:ext>
                </a:extLst>
              </p:cNvPr>
              <p:cNvSpPr/>
              <p:nvPr/>
            </p:nvSpPr>
            <p:spPr>
              <a:xfrm>
                <a:off x="8593215" y="4818361"/>
                <a:ext cx="45248" cy="139006"/>
              </a:xfrm>
              <a:prstGeom prst="arc">
                <a:avLst/>
              </a:prstGeom>
              <a:ln w="28575">
                <a:solidFill>
                  <a:srgbClr val="7030A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ja-JP" altLang="en-US" sz="12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69" name="円弧 468">
                <a:extLst>
                  <a:ext uri="{FF2B5EF4-FFF2-40B4-BE49-F238E27FC236}">
                    <a16:creationId xmlns:a16="http://schemas.microsoft.com/office/drawing/2014/main" id="{00E03A9D-7E0B-D0D9-9D12-73FE3174CA20}"/>
                  </a:ext>
                </a:extLst>
              </p:cNvPr>
              <p:cNvSpPr/>
              <p:nvPr/>
            </p:nvSpPr>
            <p:spPr>
              <a:xfrm>
                <a:off x="8678198" y="4849268"/>
                <a:ext cx="45248" cy="139006"/>
              </a:xfrm>
              <a:prstGeom prst="arc">
                <a:avLst/>
              </a:prstGeom>
              <a:ln w="28575">
                <a:solidFill>
                  <a:srgbClr val="7030A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ja-JP" altLang="en-US" sz="12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70" name="円弧 469">
                <a:extLst>
                  <a:ext uri="{FF2B5EF4-FFF2-40B4-BE49-F238E27FC236}">
                    <a16:creationId xmlns:a16="http://schemas.microsoft.com/office/drawing/2014/main" id="{A29DFB34-33F2-091D-40D3-2E290A1E9EA5}"/>
                  </a:ext>
                </a:extLst>
              </p:cNvPr>
              <p:cNvSpPr/>
              <p:nvPr/>
            </p:nvSpPr>
            <p:spPr>
              <a:xfrm>
                <a:off x="8745888" y="4866912"/>
                <a:ext cx="45248" cy="139006"/>
              </a:xfrm>
              <a:prstGeom prst="arc">
                <a:avLst/>
              </a:prstGeom>
              <a:ln w="28575">
                <a:solidFill>
                  <a:srgbClr val="7030A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ja-JP" altLang="en-US" sz="12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71" name="円弧 470">
                <a:extLst>
                  <a:ext uri="{FF2B5EF4-FFF2-40B4-BE49-F238E27FC236}">
                    <a16:creationId xmlns:a16="http://schemas.microsoft.com/office/drawing/2014/main" id="{86A84E0D-48C2-58FA-1A37-C26B7EFE3C79}"/>
                  </a:ext>
                </a:extLst>
              </p:cNvPr>
              <p:cNvSpPr/>
              <p:nvPr/>
            </p:nvSpPr>
            <p:spPr>
              <a:xfrm>
                <a:off x="8831141" y="4896102"/>
                <a:ext cx="45248" cy="139006"/>
              </a:xfrm>
              <a:prstGeom prst="arc">
                <a:avLst/>
              </a:prstGeom>
              <a:ln w="28575">
                <a:solidFill>
                  <a:srgbClr val="7030A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ja-JP" altLang="en-US" sz="12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72" name="円弧 471">
                <a:extLst>
                  <a:ext uri="{FF2B5EF4-FFF2-40B4-BE49-F238E27FC236}">
                    <a16:creationId xmlns:a16="http://schemas.microsoft.com/office/drawing/2014/main" id="{61866C12-E22E-AE97-C348-1B6540756C56}"/>
                  </a:ext>
                </a:extLst>
              </p:cNvPr>
              <p:cNvSpPr/>
              <p:nvPr/>
            </p:nvSpPr>
            <p:spPr>
              <a:xfrm>
                <a:off x="8268517" y="4732297"/>
                <a:ext cx="45248" cy="139006"/>
              </a:xfrm>
              <a:prstGeom prst="arc">
                <a:avLst/>
              </a:prstGeom>
              <a:ln w="28575">
                <a:solidFill>
                  <a:srgbClr val="7030A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ja-JP" altLang="en-US" sz="12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73" name="円弧 472">
                <a:extLst>
                  <a:ext uri="{FF2B5EF4-FFF2-40B4-BE49-F238E27FC236}">
                    <a16:creationId xmlns:a16="http://schemas.microsoft.com/office/drawing/2014/main" id="{454983A2-8146-E6BE-23EA-31073A7DAA2C}"/>
                  </a:ext>
                </a:extLst>
              </p:cNvPr>
              <p:cNvSpPr/>
              <p:nvPr/>
            </p:nvSpPr>
            <p:spPr>
              <a:xfrm>
                <a:off x="8351680" y="4752366"/>
                <a:ext cx="45248" cy="139006"/>
              </a:xfrm>
              <a:prstGeom prst="arc">
                <a:avLst/>
              </a:prstGeom>
              <a:ln w="28575">
                <a:solidFill>
                  <a:srgbClr val="7030A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ja-JP" altLang="en-US" sz="12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74" name="円弧 473">
                <a:extLst>
                  <a:ext uri="{FF2B5EF4-FFF2-40B4-BE49-F238E27FC236}">
                    <a16:creationId xmlns:a16="http://schemas.microsoft.com/office/drawing/2014/main" id="{08FE8A1F-4984-7359-A254-9384317BF49B}"/>
                  </a:ext>
                </a:extLst>
              </p:cNvPr>
              <p:cNvSpPr/>
              <p:nvPr/>
            </p:nvSpPr>
            <p:spPr>
              <a:xfrm>
                <a:off x="8421225" y="4768552"/>
                <a:ext cx="45248" cy="140744"/>
              </a:xfrm>
              <a:prstGeom prst="arc">
                <a:avLst/>
              </a:prstGeom>
              <a:ln w="28575">
                <a:solidFill>
                  <a:srgbClr val="7030A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ja-JP" altLang="en-US" sz="12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75" name="円弧 474">
                <a:extLst>
                  <a:ext uri="{FF2B5EF4-FFF2-40B4-BE49-F238E27FC236}">
                    <a16:creationId xmlns:a16="http://schemas.microsoft.com/office/drawing/2014/main" id="{40850CCC-B823-33A2-D534-A7460EFE4C05}"/>
                  </a:ext>
                </a:extLst>
              </p:cNvPr>
              <p:cNvSpPr/>
              <p:nvPr/>
            </p:nvSpPr>
            <p:spPr>
              <a:xfrm>
                <a:off x="8498017" y="4796406"/>
                <a:ext cx="45248" cy="139006"/>
              </a:xfrm>
              <a:prstGeom prst="arc">
                <a:avLst/>
              </a:prstGeom>
              <a:ln w="28575">
                <a:solidFill>
                  <a:srgbClr val="7030A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ja-JP" altLang="en-US" sz="12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433" name="グループ化 142">
              <a:extLst>
                <a:ext uri="{FF2B5EF4-FFF2-40B4-BE49-F238E27FC236}">
                  <a16:creationId xmlns:a16="http://schemas.microsoft.com/office/drawing/2014/main" id="{62B95724-CC7D-B2FF-CB3C-10D67319F19E}"/>
                </a:ext>
              </a:extLst>
            </p:cNvPr>
            <p:cNvGrpSpPr>
              <a:grpSpLocks/>
            </p:cNvGrpSpPr>
            <p:nvPr/>
          </p:nvGrpSpPr>
          <p:grpSpPr bwMode="auto">
            <a:xfrm rot="-684627">
              <a:off x="5484044" y="4116212"/>
              <a:ext cx="607694" cy="302146"/>
              <a:chOff x="8269136" y="4733131"/>
              <a:chExt cx="607694" cy="302146"/>
            </a:xfrm>
          </p:grpSpPr>
          <p:sp>
            <p:nvSpPr>
              <p:cNvPr id="460" name="円弧 459">
                <a:extLst>
                  <a:ext uri="{FF2B5EF4-FFF2-40B4-BE49-F238E27FC236}">
                    <a16:creationId xmlns:a16="http://schemas.microsoft.com/office/drawing/2014/main" id="{C0BEDC81-E23D-DD60-0096-254FCFC990D3}"/>
                  </a:ext>
                </a:extLst>
              </p:cNvPr>
              <p:cNvSpPr/>
              <p:nvPr/>
            </p:nvSpPr>
            <p:spPr>
              <a:xfrm>
                <a:off x="8580941" y="4816045"/>
                <a:ext cx="45248" cy="139006"/>
              </a:xfrm>
              <a:prstGeom prst="arc">
                <a:avLst/>
              </a:prstGeom>
              <a:ln w="28575">
                <a:solidFill>
                  <a:srgbClr val="7030A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ja-JP" altLang="en-US" sz="12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61" name="円弧 460">
                <a:extLst>
                  <a:ext uri="{FF2B5EF4-FFF2-40B4-BE49-F238E27FC236}">
                    <a16:creationId xmlns:a16="http://schemas.microsoft.com/office/drawing/2014/main" id="{E4563C89-0068-6F82-9D47-102E4DCCFE38}"/>
                  </a:ext>
                </a:extLst>
              </p:cNvPr>
              <p:cNvSpPr/>
              <p:nvPr/>
            </p:nvSpPr>
            <p:spPr>
              <a:xfrm>
                <a:off x="8668789" y="4845997"/>
                <a:ext cx="43507" cy="140744"/>
              </a:xfrm>
              <a:prstGeom prst="arc">
                <a:avLst/>
              </a:prstGeom>
              <a:ln w="28575">
                <a:solidFill>
                  <a:srgbClr val="7030A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ja-JP" altLang="en-US" sz="12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62" name="円弧 461">
                <a:extLst>
                  <a:ext uri="{FF2B5EF4-FFF2-40B4-BE49-F238E27FC236}">
                    <a16:creationId xmlns:a16="http://schemas.microsoft.com/office/drawing/2014/main" id="{54864302-8E78-9316-AA88-39D976AC60AA}"/>
                  </a:ext>
                </a:extLst>
              </p:cNvPr>
              <p:cNvSpPr/>
              <p:nvPr/>
            </p:nvSpPr>
            <p:spPr>
              <a:xfrm>
                <a:off x="8734441" y="4864703"/>
                <a:ext cx="45248" cy="139006"/>
              </a:xfrm>
              <a:prstGeom prst="arc">
                <a:avLst/>
              </a:prstGeom>
              <a:ln w="28575">
                <a:solidFill>
                  <a:srgbClr val="7030A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ja-JP" altLang="en-US" sz="12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63" name="円弧 462">
                <a:extLst>
                  <a:ext uri="{FF2B5EF4-FFF2-40B4-BE49-F238E27FC236}">
                    <a16:creationId xmlns:a16="http://schemas.microsoft.com/office/drawing/2014/main" id="{6978BB1B-5D8C-8DA3-5CEA-2EA505BD2345}"/>
                  </a:ext>
                </a:extLst>
              </p:cNvPr>
              <p:cNvSpPr/>
              <p:nvPr/>
            </p:nvSpPr>
            <p:spPr>
              <a:xfrm>
                <a:off x="8830973" y="4896562"/>
                <a:ext cx="45248" cy="139006"/>
              </a:xfrm>
              <a:prstGeom prst="arc">
                <a:avLst/>
              </a:prstGeom>
              <a:ln w="28575">
                <a:solidFill>
                  <a:srgbClr val="7030A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ja-JP" altLang="en-US" sz="12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64" name="円弧 463">
                <a:extLst>
                  <a:ext uri="{FF2B5EF4-FFF2-40B4-BE49-F238E27FC236}">
                    <a16:creationId xmlns:a16="http://schemas.microsoft.com/office/drawing/2014/main" id="{C03978FF-03AB-E991-ACFB-CD4A296F293C}"/>
                  </a:ext>
                </a:extLst>
              </p:cNvPr>
              <p:cNvSpPr/>
              <p:nvPr/>
            </p:nvSpPr>
            <p:spPr>
              <a:xfrm>
                <a:off x="8257539" y="4729605"/>
                <a:ext cx="45248" cy="139006"/>
              </a:xfrm>
              <a:prstGeom prst="arc">
                <a:avLst/>
              </a:prstGeom>
              <a:ln w="28575">
                <a:solidFill>
                  <a:srgbClr val="7030A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ja-JP" altLang="en-US" sz="12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65" name="円弧 464">
                <a:extLst>
                  <a:ext uri="{FF2B5EF4-FFF2-40B4-BE49-F238E27FC236}">
                    <a16:creationId xmlns:a16="http://schemas.microsoft.com/office/drawing/2014/main" id="{3F4B3C29-F72A-26ED-4219-C6BC25A1B9C7}"/>
                  </a:ext>
                </a:extLst>
              </p:cNvPr>
              <p:cNvSpPr/>
              <p:nvPr/>
            </p:nvSpPr>
            <p:spPr>
              <a:xfrm>
                <a:off x="8346231" y="4756339"/>
                <a:ext cx="45248" cy="139006"/>
              </a:xfrm>
              <a:prstGeom prst="arc">
                <a:avLst/>
              </a:prstGeom>
              <a:ln w="28575">
                <a:solidFill>
                  <a:srgbClr val="7030A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ja-JP" altLang="en-US" sz="12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66" name="円弧 465">
                <a:extLst>
                  <a:ext uri="{FF2B5EF4-FFF2-40B4-BE49-F238E27FC236}">
                    <a16:creationId xmlns:a16="http://schemas.microsoft.com/office/drawing/2014/main" id="{8E188E5C-819C-4CE8-D9C8-4F8021155FEF}"/>
                  </a:ext>
                </a:extLst>
              </p:cNvPr>
              <p:cNvSpPr/>
              <p:nvPr/>
            </p:nvSpPr>
            <p:spPr>
              <a:xfrm>
                <a:off x="8411039" y="4778263"/>
                <a:ext cx="45248" cy="139006"/>
              </a:xfrm>
              <a:prstGeom prst="arc">
                <a:avLst/>
              </a:prstGeom>
              <a:ln w="28575">
                <a:solidFill>
                  <a:srgbClr val="7030A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ja-JP" altLang="en-US" sz="12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67" name="円弧 466">
                <a:extLst>
                  <a:ext uri="{FF2B5EF4-FFF2-40B4-BE49-F238E27FC236}">
                    <a16:creationId xmlns:a16="http://schemas.microsoft.com/office/drawing/2014/main" id="{D564C782-73D5-0A85-C62C-B67B7130290A}"/>
                  </a:ext>
                </a:extLst>
              </p:cNvPr>
              <p:cNvSpPr/>
              <p:nvPr/>
            </p:nvSpPr>
            <p:spPr>
              <a:xfrm>
                <a:off x="8495990" y="4797153"/>
                <a:ext cx="45248" cy="139006"/>
              </a:xfrm>
              <a:prstGeom prst="arc">
                <a:avLst/>
              </a:prstGeom>
              <a:ln w="28575">
                <a:solidFill>
                  <a:srgbClr val="7030A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ja-JP" altLang="en-US" sz="12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434" name="グループ化 9">
              <a:extLst>
                <a:ext uri="{FF2B5EF4-FFF2-40B4-BE49-F238E27FC236}">
                  <a16:creationId xmlns:a16="http://schemas.microsoft.com/office/drawing/2014/main" id="{DAB79CE9-DFDE-CB85-5FFD-187B77B5DB3C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4814529" y="4136108"/>
              <a:ext cx="630340" cy="184070"/>
              <a:chOff x="4814529" y="4136108"/>
              <a:chExt cx="630340" cy="184070"/>
            </a:xfrm>
          </p:grpSpPr>
          <p:sp>
            <p:nvSpPr>
              <p:cNvPr id="452" name="円弧 451">
                <a:extLst>
                  <a:ext uri="{FF2B5EF4-FFF2-40B4-BE49-F238E27FC236}">
                    <a16:creationId xmlns:a16="http://schemas.microsoft.com/office/drawing/2014/main" id="{9ADBE91E-C524-268A-94CB-6094C657782A}"/>
                  </a:ext>
                </a:extLst>
              </p:cNvPr>
              <p:cNvSpPr/>
              <p:nvPr/>
            </p:nvSpPr>
            <p:spPr>
              <a:xfrm rot="20781614">
                <a:off x="5149862" y="4161783"/>
                <a:ext cx="45248" cy="139007"/>
              </a:xfrm>
              <a:prstGeom prst="arc">
                <a:avLst/>
              </a:prstGeom>
              <a:ln w="28575">
                <a:solidFill>
                  <a:srgbClr val="7030A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ja-JP" altLang="en-US" sz="12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3" name="円弧 452">
                <a:extLst>
                  <a:ext uri="{FF2B5EF4-FFF2-40B4-BE49-F238E27FC236}">
                    <a16:creationId xmlns:a16="http://schemas.microsoft.com/office/drawing/2014/main" id="{B7CC3988-7D2F-127D-F641-D7894ED9BE01}"/>
                  </a:ext>
                </a:extLst>
              </p:cNvPr>
              <p:cNvSpPr/>
              <p:nvPr/>
            </p:nvSpPr>
            <p:spPr>
              <a:xfrm rot="20781614">
                <a:off x="5240357" y="4170470"/>
                <a:ext cx="45248" cy="139007"/>
              </a:xfrm>
              <a:prstGeom prst="arc">
                <a:avLst/>
              </a:prstGeom>
              <a:ln w="28575">
                <a:solidFill>
                  <a:srgbClr val="7030A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ja-JP" altLang="en-US" sz="12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4" name="円弧 453">
                <a:extLst>
                  <a:ext uri="{FF2B5EF4-FFF2-40B4-BE49-F238E27FC236}">
                    <a16:creationId xmlns:a16="http://schemas.microsoft.com/office/drawing/2014/main" id="{AAFBE76C-5465-DF66-9619-579C40B448E6}"/>
                  </a:ext>
                </a:extLst>
              </p:cNvPr>
              <p:cNvSpPr/>
              <p:nvPr/>
            </p:nvSpPr>
            <p:spPr>
              <a:xfrm rot="20781614">
                <a:off x="5309969" y="4172208"/>
                <a:ext cx="45248" cy="139007"/>
              </a:xfrm>
              <a:prstGeom prst="arc">
                <a:avLst/>
              </a:prstGeom>
              <a:ln w="28575">
                <a:solidFill>
                  <a:srgbClr val="7030A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ja-JP" altLang="en-US" sz="12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5" name="円弧 454">
                <a:extLst>
                  <a:ext uri="{FF2B5EF4-FFF2-40B4-BE49-F238E27FC236}">
                    <a16:creationId xmlns:a16="http://schemas.microsoft.com/office/drawing/2014/main" id="{6C515198-27A9-DCF7-1785-75F39651902A}"/>
                  </a:ext>
                </a:extLst>
              </p:cNvPr>
              <p:cNvSpPr/>
              <p:nvPr/>
            </p:nvSpPr>
            <p:spPr>
              <a:xfrm rot="20781614">
                <a:off x="5400464" y="4180896"/>
                <a:ext cx="45248" cy="139007"/>
              </a:xfrm>
              <a:prstGeom prst="arc">
                <a:avLst/>
              </a:prstGeom>
              <a:ln w="28575">
                <a:solidFill>
                  <a:srgbClr val="7030A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ja-JP" altLang="en-US" sz="12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6" name="円弧 455">
                <a:extLst>
                  <a:ext uri="{FF2B5EF4-FFF2-40B4-BE49-F238E27FC236}">
                    <a16:creationId xmlns:a16="http://schemas.microsoft.com/office/drawing/2014/main" id="{B2A42248-9ACD-22B4-2CA7-0E0AD167D710}"/>
                  </a:ext>
                </a:extLst>
              </p:cNvPr>
              <p:cNvSpPr/>
              <p:nvPr/>
            </p:nvSpPr>
            <p:spPr>
              <a:xfrm rot="20781614">
                <a:off x="4813984" y="4135718"/>
                <a:ext cx="45248" cy="139007"/>
              </a:xfrm>
              <a:prstGeom prst="arc">
                <a:avLst/>
              </a:prstGeom>
              <a:ln w="28575">
                <a:solidFill>
                  <a:srgbClr val="7030A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ja-JP" altLang="en-US" sz="12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7" name="円弧 456">
                <a:extLst>
                  <a:ext uri="{FF2B5EF4-FFF2-40B4-BE49-F238E27FC236}">
                    <a16:creationId xmlns:a16="http://schemas.microsoft.com/office/drawing/2014/main" id="{D3C705A1-B5E3-4165-CA98-210B3926E271}"/>
                  </a:ext>
                </a:extLst>
              </p:cNvPr>
              <p:cNvSpPr/>
              <p:nvPr/>
            </p:nvSpPr>
            <p:spPr>
              <a:xfrm rot="20781614">
                <a:off x="4904480" y="4144407"/>
                <a:ext cx="45248" cy="139007"/>
              </a:xfrm>
              <a:prstGeom prst="arc">
                <a:avLst/>
              </a:prstGeom>
              <a:ln w="28575">
                <a:solidFill>
                  <a:srgbClr val="7030A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ja-JP" altLang="en-US" sz="12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8" name="円弧 457">
                <a:extLst>
                  <a:ext uri="{FF2B5EF4-FFF2-40B4-BE49-F238E27FC236}">
                    <a16:creationId xmlns:a16="http://schemas.microsoft.com/office/drawing/2014/main" id="{9CDBDAE8-31F2-AC74-B4DA-946FBD76C280}"/>
                  </a:ext>
                </a:extLst>
              </p:cNvPr>
              <p:cNvSpPr/>
              <p:nvPr/>
            </p:nvSpPr>
            <p:spPr>
              <a:xfrm rot="20781614">
                <a:off x="4974091" y="4146144"/>
                <a:ext cx="45248" cy="139007"/>
              </a:xfrm>
              <a:prstGeom prst="arc">
                <a:avLst/>
              </a:prstGeom>
              <a:ln w="28575">
                <a:solidFill>
                  <a:srgbClr val="7030A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ja-JP" altLang="en-US" sz="12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9" name="円弧 458">
                <a:extLst>
                  <a:ext uri="{FF2B5EF4-FFF2-40B4-BE49-F238E27FC236}">
                    <a16:creationId xmlns:a16="http://schemas.microsoft.com/office/drawing/2014/main" id="{0CB18D92-5D73-6037-DB17-0481FFC489F7}"/>
                  </a:ext>
                </a:extLst>
              </p:cNvPr>
              <p:cNvSpPr/>
              <p:nvPr/>
            </p:nvSpPr>
            <p:spPr>
              <a:xfrm rot="20781614">
                <a:off x="5061106" y="4165258"/>
                <a:ext cx="46989" cy="139007"/>
              </a:xfrm>
              <a:prstGeom prst="arc">
                <a:avLst/>
              </a:prstGeom>
              <a:ln w="28575">
                <a:solidFill>
                  <a:srgbClr val="7030A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ja-JP" altLang="en-US" sz="12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435" name="グループ化 8">
              <a:extLst>
                <a:ext uri="{FF2B5EF4-FFF2-40B4-BE49-F238E27FC236}">
                  <a16:creationId xmlns:a16="http://schemas.microsoft.com/office/drawing/2014/main" id="{DE92698F-2FE9-F37D-E944-0296F6C8D429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4156152" y="4083591"/>
              <a:ext cx="624768" cy="192871"/>
              <a:chOff x="4156152" y="4083591"/>
              <a:chExt cx="624768" cy="192871"/>
            </a:xfrm>
          </p:grpSpPr>
          <p:sp>
            <p:nvSpPr>
              <p:cNvPr id="444" name="円弧 443">
                <a:extLst>
                  <a:ext uri="{FF2B5EF4-FFF2-40B4-BE49-F238E27FC236}">
                    <a16:creationId xmlns:a16="http://schemas.microsoft.com/office/drawing/2014/main" id="{3EFC07EA-FD76-A3F9-3FA3-5CD4DED6C4F4}"/>
                  </a:ext>
                </a:extLst>
              </p:cNvPr>
              <p:cNvSpPr/>
              <p:nvPr/>
            </p:nvSpPr>
            <p:spPr>
              <a:xfrm rot="21064760">
                <a:off x="4488549" y="4118342"/>
                <a:ext cx="45248" cy="137269"/>
              </a:xfrm>
              <a:prstGeom prst="arc">
                <a:avLst/>
              </a:prstGeom>
              <a:ln w="28575">
                <a:solidFill>
                  <a:srgbClr val="7030A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ja-JP" altLang="en-US" sz="12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45" name="円弧 444">
                <a:extLst>
                  <a:ext uri="{FF2B5EF4-FFF2-40B4-BE49-F238E27FC236}">
                    <a16:creationId xmlns:a16="http://schemas.microsoft.com/office/drawing/2014/main" id="{BAFCA4E7-F0F4-28B3-C88D-098E55B71A7A}"/>
                  </a:ext>
                </a:extLst>
              </p:cNvPr>
              <p:cNvSpPr/>
              <p:nvPr/>
            </p:nvSpPr>
            <p:spPr>
              <a:xfrm rot="21064760">
                <a:off x="4577304" y="4114867"/>
                <a:ext cx="45248" cy="139006"/>
              </a:xfrm>
              <a:prstGeom prst="arc">
                <a:avLst/>
              </a:prstGeom>
              <a:ln w="28575">
                <a:solidFill>
                  <a:srgbClr val="7030A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ja-JP" altLang="en-US" sz="12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46" name="円弧 445">
                <a:extLst>
                  <a:ext uri="{FF2B5EF4-FFF2-40B4-BE49-F238E27FC236}">
                    <a16:creationId xmlns:a16="http://schemas.microsoft.com/office/drawing/2014/main" id="{D9D8BDB8-B8BE-BD31-551E-89D388792969}"/>
                  </a:ext>
                </a:extLst>
              </p:cNvPr>
              <p:cNvSpPr/>
              <p:nvPr/>
            </p:nvSpPr>
            <p:spPr>
              <a:xfrm rot="21064760">
                <a:off x="4646916" y="4121817"/>
                <a:ext cx="45248" cy="139006"/>
              </a:xfrm>
              <a:prstGeom prst="arc">
                <a:avLst/>
              </a:prstGeom>
              <a:ln w="28575">
                <a:solidFill>
                  <a:srgbClr val="7030A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ja-JP" altLang="en-US" sz="12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47" name="円弧 446">
                <a:extLst>
                  <a:ext uri="{FF2B5EF4-FFF2-40B4-BE49-F238E27FC236}">
                    <a16:creationId xmlns:a16="http://schemas.microsoft.com/office/drawing/2014/main" id="{8940D181-112B-7F2B-ED8A-502C886A85E1}"/>
                  </a:ext>
                </a:extLst>
              </p:cNvPr>
              <p:cNvSpPr/>
              <p:nvPr/>
            </p:nvSpPr>
            <p:spPr>
              <a:xfrm rot="21064760">
                <a:off x="4735672" y="4139193"/>
                <a:ext cx="45248" cy="137269"/>
              </a:xfrm>
              <a:prstGeom prst="arc">
                <a:avLst/>
              </a:prstGeom>
              <a:ln w="28575">
                <a:solidFill>
                  <a:srgbClr val="7030A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ja-JP" altLang="en-US" sz="12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48" name="円弧 447">
                <a:extLst>
                  <a:ext uri="{FF2B5EF4-FFF2-40B4-BE49-F238E27FC236}">
                    <a16:creationId xmlns:a16="http://schemas.microsoft.com/office/drawing/2014/main" id="{C601BB09-5600-227E-0BB8-7F986C652486}"/>
                  </a:ext>
                </a:extLst>
              </p:cNvPr>
              <p:cNvSpPr/>
              <p:nvPr/>
            </p:nvSpPr>
            <p:spPr>
              <a:xfrm rot="21064760">
                <a:off x="4156152" y="4083591"/>
                <a:ext cx="45248" cy="137269"/>
              </a:xfrm>
              <a:prstGeom prst="arc">
                <a:avLst/>
              </a:prstGeom>
              <a:ln w="28575">
                <a:solidFill>
                  <a:srgbClr val="7030A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ja-JP" altLang="en-US" sz="12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49" name="円弧 448">
                <a:extLst>
                  <a:ext uri="{FF2B5EF4-FFF2-40B4-BE49-F238E27FC236}">
                    <a16:creationId xmlns:a16="http://schemas.microsoft.com/office/drawing/2014/main" id="{3615B7D1-5A46-AB64-247C-CC08817D8A60}"/>
                  </a:ext>
                </a:extLst>
              </p:cNvPr>
              <p:cNvSpPr/>
              <p:nvPr/>
            </p:nvSpPr>
            <p:spPr>
              <a:xfrm rot="21064760">
                <a:off x="4244908" y="4099229"/>
                <a:ext cx="45248" cy="139006"/>
              </a:xfrm>
              <a:prstGeom prst="arc">
                <a:avLst/>
              </a:prstGeom>
              <a:ln w="28575">
                <a:solidFill>
                  <a:srgbClr val="7030A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ja-JP" altLang="en-US" sz="12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0" name="円弧 449">
                <a:extLst>
                  <a:ext uri="{FF2B5EF4-FFF2-40B4-BE49-F238E27FC236}">
                    <a16:creationId xmlns:a16="http://schemas.microsoft.com/office/drawing/2014/main" id="{7003C1E0-319C-12FD-62D5-62854E6838E3}"/>
                  </a:ext>
                </a:extLst>
              </p:cNvPr>
              <p:cNvSpPr/>
              <p:nvPr/>
            </p:nvSpPr>
            <p:spPr>
              <a:xfrm rot="21064760">
                <a:off x="4314519" y="4106179"/>
                <a:ext cx="45248" cy="139007"/>
              </a:xfrm>
              <a:prstGeom prst="arc">
                <a:avLst/>
              </a:prstGeom>
              <a:ln w="28575">
                <a:solidFill>
                  <a:srgbClr val="7030A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ja-JP" altLang="en-US" sz="12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1" name="円弧 450">
                <a:extLst>
                  <a:ext uri="{FF2B5EF4-FFF2-40B4-BE49-F238E27FC236}">
                    <a16:creationId xmlns:a16="http://schemas.microsoft.com/office/drawing/2014/main" id="{FC57496B-C583-A28D-098E-A3915280D816}"/>
                  </a:ext>
                </a:extLst>
              </p:cNvPr>
              <p:cNvSpPr/>
              <p:nvPr/>
            </p:nvSpPr>
            <p:spPr>
              <a:xfrm rot="21064760">
                <a:off x="4401535" y="4113130"/>
                <a:ext cx="45248" cy="139006"/>
              </a:xfrm>
              <a:prstGeom prst="arc">
                <a:avLst/>
              </a:prstGeom>
              <a:ln w="28575">
                <a:solidFill>
                  <a:srgbClr val="7030A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ja-JP" altLang="en-US" sz="12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436" name="円弧 435">
              <a:extLst>
                <a:ext uri="{FF2B5EF4-FFF2-40B4-BE49-F238E27FC236}">
                  <a16:creationId xmlns:a16="http://schemas.microsoft.com/office/drawing/2014/main" id="{F214A92B-F8C1-CEDA-1B3B-ED2BB3988CA8}"/>
                </a:ext>
              </a:extLst>
            </p:cNvPr>
            <p:cNvSpPr/>
            <p:nvPr/>
          </p:nvSpPr>
          <p:spPr>
            <a:xfrm rot="21064760">
              <a:off x="3820275" y="4080115"/>
              <a:ext cx="46987" cy="139006"/>
            </a:xfrm>
            <a:prstGeom prst="arc">
              <a:avLst/>
            </a:prstGeom>
            <a:ln w="28575">
              <a:solidFill>
                <a:srgbClr val="7030A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 sz="12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7" name="円弧 436">
              <a:extLst>
                <a:ext uri="{FF2B5EF4-FFF2-40B4-BE49-F238E27FC236}">
                  <a16:creationId xmlns:a16="http://schemas.microsoft.com/office/drawing/2014/main" id="{3281EF93-E142-60A4-490F-E8AD496B7D87}"/>
                </a:ext>
              </a:extLst>
            </p:cNvPr>
            <p:cNvSpPr/>
            <p:nvPr/>
          </p:nvSpPr>
          <p:spPr>
            <a:xfrm rot="21064760">
              <a:off x="3910771" y="4076640"/>
              <a:ext cx="45248" cy="139006"/>
            </a:xfrm>
            <a:prstGeom prst="arc">
              <a:avLst/>
            </a:prstGeom>
            <a:ln w="28575">
              <a:solidFill>
                <a:srgbClr val="7030A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8" name="円弧 437">
              <a:extLst>
                <a:ext uri="{FF2B5EF4-FFF2-40B4-BE49-F238E27FC236}">
                  <a16:creationId xmlns:a16="http://schemas.microsoft.com/office/drawing/2014/main" id="{8719A46D-3798-E84C-9A32-12F3DEC5C0CD}"/>
                </a:ext>
              </a:extLst>
            </p:cNvPr>
            <p:cNvSpPr/>
            <p:nvPr/>
          </p:nvSpPr>
          <p:spPr>
            <a:xfrm rot="21064760">
              <a:off x="3978642" y="4083590"/>
              <a:ext cx="46989" cy="139006"/>
            </a:xfrm>
            <a:prstGeom prst="arc">
              <a:avLst/>
            </a:prstGeom>
            <a:ln w="28575">
              <a:solidFill>
                <a:srgbClr val="7030A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 sz="12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9" name="円弧 438">
              <a:extLst>
                <a:ext uri="{FF2B5EF4-FFF2-40B4-BE49-F238E27FC236}">
                  <a16:creationId xmlns:a16="http://schemas.microsoft.com/office/drawing/2014/main" id="{87EE74FC-B72F-44F5-A661-E73AAD156ABE}"/>
                </a:ext>
              </a:extLst>
            </p:cNvPr>
            <p:cNvSpPr/>
            <p:nvPr/>
          </p:nvSpPr>
          <p:spPr>
            <a:xfrm rot="21064760">
              <a:off x="4069137" y="4090541"/>
              <a:ext cx="45248" cy="139006"/>
            </a:xfrm>
            <a:prstGeom prst="arc">
              <a:avLst/>
            </a:prstGeom>
            <a:ln w="28575">
              <a:solidFill>
                <a:srgbClr val="7030A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 sz="12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0" name="円弧 439">
              <a:extLst>
                <a:ext uri="{FF2B5EF4-FFF2-40B4-BE49-F238E27FC236}">
                  <a16:creationId xmlns:a16="http://schemas.microsoft.com/office/drawing/2014/main" id="{220F2C4F-EB4A-66B2-28E6-B689AE62E86B}"/>
                </a:ext>
              </a:extLst>
            </p:cNvPr>
            <p:cNvSpPr/>
            <p:nvPr/>
          </p:nvSpPr>
          <p:spPr>
            <a:xfrm rot="21064760">
              <a:off x="3487878" y="4055789"/>
              <a:ext cx="45248" cy="139006"/>
            </a:xfrm>
            <a:prstGeom prst="arc">
              <a:avLst/>
            </a:prstGeom>
            <a:ln w="28575">
              <a:solidFill>
                <a:srgbClr val="7030A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 sz="12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1" name="円弧 440">
              <a:extLst>
                <a:ext uri="{FF2B5EF4-FFF2-40B4-BE49-F238E27FC236}">
                  <a16:creationId xmlns:a16="http://schemas.microsoft.com/office/drawing/2014/main" id="{A24A44ED-FBF8-263C-E652-2A12D0375CC3}"/>
                </a:ext>
              </a:extLst>
            </p:cNvPr>
            <p:cNvSpPr/>
            <p:nvPr/>
          </p:nvSpPr>
          <p:spPr>
            <a:xfrm rot="21064760">
              <a:off x="3576634" y="4052314"/>
              <a:ext cx="46987" cy="139006"/>
            </a:xfrm>
            <a:prstGeom prst="arc">
              <a:avLst/>
            </a:prstGeom>
            <a:solidFill>
              <a:srgbClr val="7030A0"/>
            </a:solidFill>
            <a:ln w="28575">
              <a:solidFill>
                <a:srgbClr val="7030A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 sz="12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2" name="円弧 441">
              <a:extLst>
                <a:ext uri="{FF2B5EF4-FFF2-40B4-BE49-F238E27FC236}">
                  <a16:creationId xmlns:a16="http://schemas.microsoft.com/office/drawing/2014/main" id="{DFF29E1F-BD67-E6C6-F673-304F55E13B88}"/>
                </a:ext>
              </a:extLst>
            </p:cNvPr>
            <p:cNvSpPr/>
            <p:nvPr/>
          </p:nvSpPr>
          <p:spPr>
            <a:xfrm rot="21064760">
              <a:off x="3646246" y="4059264"/>
              <a:ext cx="45248" cy="139006"/>
            </a:xfrm>
            <a:prstGeom prst="arc">
              <a:avLst/>
            </a:prstGeom>
            <a:ln w="28575">
              <a:solidFill>
                <a:srgbClr val="7030A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 sz="12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3" name="円弧 442">
              <a:extLst>
                <a:ext uri="{FF2B5EF4-FFF2-40B4-BE49-F238E27FC236}">
                  <a16:creationId xmlns:a16="http://schemas.microsoft.com/office/drawing/2014/main" id="{8C3E0876-A7E3-2265-62A1-097EB4436E78}"/>
                </a:ext>
              </a:extLst>
            </p:cNvPr>
            <p:cNvSpPr/>
            <p:nvPr/>
          </p:nvSpPr>
          <p:spPr>
            <a:xfrm rot="21064760">
              <a:off x="3733260" y="4069690"/>
              <a:ext cx="46987" cy="139006"/>
            </a:xfrm>
            <a:prstGeom prst="arc">
              <a:avLst/>
            </a:prstGeom>
            <a:ln w="28575">
              <a:solidFill>
                <a:srgbClr val="7030A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 sz="12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84" name="テキスト ボックス 483">
            <a:extLst>
              <a:ext uri="{FF2B5EF4-FFF2-40B4-BE49-F238E27FC236}">
                <a16:creationId xmlns:a16="http://schemas.microsoft.com/office/drawing/2014/main" id="{F77CF5DD-EF68-1E24-7BC8-C4F83752714E}"/>
              </a:ext>
            </a:extLst>
          </p:cNvPr>
          <p:cNvSpPr txBox="1"/>
          <p:nvPr/>
        </p:nvSpPr>
        <p:spPr>
          <a:xfrm>
            <a:off x="7700996" y="4338567"/>
            <a:ext cx="444500" cy="276999"/>
          </a:xfrm>
          <a:prstGeom prst="rect">
            <a:avLst/>
          </a:prstGeom>
          <a:solidFill>
            <a:schemeClr val="tx2">
              <a:lumMod val="40000"/>
              <a:lumOff val="6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>
                <a:cs typeface="Arial" panose="020B0604020202020204" pitchFamily="34" charset="0"/>
              </a:rPr>
              <a:t>a1</a:t>
            </a:r>
            <a:endParaRPr kumimoji="1" lang="ja-JP" altLang="en-US" sz="1200" b="1" dirty="0">
              <a:cs typeface="Arial" panose="020B0604020202020204" pitchFamily="34" charset="0"/>
            </a:endParaRPr>
          </a:p>
        </p:txBody>
      </p:sp>
      <p:sp>
        <p:nvSpPr>
          <p:cNvPr id="485" name="テキスト ボックス 484">
            <a:extLst>
              <a:ext uri="{FF2B5EF4-FFF2-40B4-BE49-F238E27FC236}">
                <a16:creationId xmlns:a16="http://schemas.microsoft.com/office/drawing/2014/main" id="{10BF64F1-4CFC-CD51-48E7-C8CDA6583BBF}"/>
              </a:ext>
            </a:extLst>
          </p:cNvPr>
          <p:cNvSpPr txBox="1"/>
          <p:nvPr/>
        </p:nvSpPr>
        <p:spPr>
          <a:xfrm>
            <a:off x="7349724" y="4338567"/>
            <a:ext cx="444500" cy="276999"/>
          </a:xfrm>
          <a:prstGeom prst="rect">
            <a:avLst/>
          </a:prstGeom>
          <a:solidFill>
            <a:schemeClr val="tx2">
              <a:lumMod val="40000"/>
              <a:lumOff val="6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>
                <a:cs typeface="Arial" panose="020B0604020202020204" pitchFamily="34" charset="0"/>
              </a:rPr>
              <a:t>a2</a:t>
            </a:r>
            <a:endParaRPr kumimoji="1" lang="ja-JP" altLang="en-US" sz="1200" b="1" dirty="0">
              <a:cs typeface="Arial" panose="020B0604020202020204" pitchFamily="34" charset="0"/>
            </a:endParaRPr>
          </a:p>
        </p:txBody>
      </p:sp>
      <p:sp>
        <p:nvSpPr>
          <p:cNvPr id="486" name="テキスト ボックス 485">
            <a:extLst>
              <a:ext uri="{FF2B5EF4-FFF2-40B4-BE49-F238E27FC236}">
                <a16:creationId xmlns:a16="http://schemas.microsoft.com/office/drawing/2014/main" id="{01815666-3ED3-8FAC-EA1D-1591C5B34505}"/>
              </a:ext>
            </a:extLst>
          </p:cNvPr>
          <p:cNvSpPr txBox="1"/>
          <p:nvPr/>
        </p:nvSpPr>
        <p:spPr>
          <a:xfrm>
            <a:off x="6998451" y="4338567"/>
            <a:ext cx="444500" cy="276999"/>
          </a:xfrm>
          <a:prstGeom prst="rect">
            <a:avLst/>
          </a:prstGeom>
          <a:solidFill>
            <a:schemeClr val="tx2">
              <a:lumMod val="40000"/>
              <a:lumOff val="6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>
                <a:cs typeface="Arial" panose="020B0604020202020204" pitchFamily="34" charset="0"/>
              </a:rPr>
              <a:t>a3</a:t>
            </a:r>
            <a:endParaRPr kumimoji="1" lang="ja-JP" altLang="en-US" sz="1200" b="1" dirty="0">
              <a:cs typeface="Arial" panose="020B0604020202020204" pitchFamily="34" charset="0"/>
            </a:endParaRPr>
          </a:p>
        </p:txBody>
      </p:sp>
      <p:sp>
        <p:nvSpPr>
          <p:cNvPr id="487" name="テキスト ボックス 486">
            <a:extLst>
              <a:ext uri="{FF2B5EF4-FFF2-40B4-BE49-F238E27FC236}">
                <a16:creationId xmlns:a16="http://schemas.microsoft.com/office/drawing/2014/main" id="{32283866-8C2F-1EAF-39C9-8C9368F92629}"/>
              </a:ext>
            </a:extLst>
          </p:cNvPr>
          <p:cNvSpPr txBox="1"/>
          <p:nvPr/>
        </p:nvSpPr>
        <p:spPr>
          <a:xfrm>
            <a:off x="6647178" y="4338567"/>
            <a:ext cx="444500" cy="276999"/>
          </a:xfrm>
          <a:prstGeom prst="rect">
            <a:avLst/>
          </a:prstGeom>
          <a:solidFill>
            <a:schemeClr val="tx2">
              <a:lumMod val="40000"/>
              <a:lumOff val="6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>
                <a:cs typeface="Arial" panose="020B0604020202020204" pitchFamily="34" charset="0"/>
              </a:rPr>
              <a:t>a4</a:t>
            </a:r>
            <a:endParaRPr kumimoji="1" lang="ja-JP" altLang="en-US" sz="1200" b="1" dirty="0">
              <a:cs typeface="Arial" panose="020B0604020202020204" pitchFamily="34" charset="0"/>
            </a:endParaRPr>
          </a:p>
        </p:txBody>
      </p:sp>
      <p:sp>
        <p:nvSpPr>
          <p:cNvPr id="488" name="テキスト ボックス 487">
            <a:extLst>
              <a:ext uri="{FF2B5EF4-FFF2-40B4-BE49-F238E27FC236}">
                <a16:creationId xmlns:a16="http://schemas.microsoft.com/office/drawing/2014/main" id="{7FD0E669-701C-3470-91D9-5988469DD16A}"/>
              </a:ext>
            </a:extLst>
          </p:cNvPr>
          <p:cNvSpPr txBox="1"/>
          <p:nvPr/>
        </p:nvSpPr>
        <p:spPr>
          <a:xfrm>
            <a:off x="6295905" y="4338567"/>
            <a:ext cx="444500" cy="276999"/>
          </a:xfrm>
          <a:prstGeom prst="rect">
            <a:avLst/>
          </a:prstGeom>
          <a:solidFill>
            <a:schemeClr val="tx2">
              <a:lumMod val="40000"/>
              <a:lumOff val="6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>
                <a:cs typeface="Arial" panose="020B0604020202020204" pitchFamily="34" charset="0"/>
              </a:rPr>
              <a:t>a5</a:t>
            </a:r>
            <a:endParaRPr kumimoji="1" lang="ja-JP" altLang="en-US" sz="1200" b="1" dirty="0">
              <a:cs typeface="Arial" panose="020B0604020202020204" pitchFamily="34" charset="0"/>
            </a:endParaRPr>
          </a:p>
        </p:txBody>
      </p:sp>
      <p:sp>
        <p:nvSpPr>
          <p:cNvPr id="489" name="星 5 311">
            <a:extLst>
              <a:ext uri="{FF2B5EF4-FFF2-40B4-BE49-F238E27FC236}">
                <a16:creationId xmlns:a16="http://schemas.microsoft.com/office/drawing/2014/main" id="{3FB05C98-4F03-DC51-E000-FEDD395D1EDA}"/>
              </a:ext>
            </a:extLst>
          </p:cNvPr>
          <p:cNvSpPr/>
          <p:nvPr/>
        </p:nvSpPr>
        <p:spPr>
          <a:xfrm>
            <a:off x="7845213" y="4600608"/>
            <a:ext cx="179387" cy="285750"/>
          </a:xfrm>
          <a:prstGeom prst="star5">
            <a:avLst/>
          </a:prstGeom>
          <a:solidFill>
            <a:srgbClr val="FFFF00"/>
          </a:solidFill>
          <a:ln w="127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 sz="1200" b="1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0" name="星 5 312">
            <a:extLst>
              <a:ext uri="{FF2B5EF4-FFF2-40B4-BE49-F238E27FC236}">
                <a16:creationId xmlns:a16="http://schemas.microsoft.com/office/drawing/2014/main" id="{49B0EA5E-2744-F1F2-2100-D2C0E3DDFA6C}"/>
              </a:ext>
            </a:extLst>
          </p:cNvPr>
          <p:cNvSpPr/>
          <p:nvPr/>
        </p:nvSpPr>
        <p:spPr>
          <a:xfrm>
            <a:off x="7476913" y="4584733"/>
            <a:ext cx="179387" cy="285750"/>
          </a:xfrm>
          <a:prstGeom prst="star5">
            <a:avLst/>
          </a:prstGeom>
          <a:solidFill>
            <a:srgbClr val="FFFF00"/>
          </a:solidFill>
          <a:ln w="127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 sz="1200" b="1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1" name="星 5 313">
            <a:extLst>
              <a:ext uri="{FF2B5EF4-FFF2-40B4-BE49-F238E27FC236}">
                <a16:creationId xmlns:a16="http://schemas.microsoft.com/office/drawing/2014/main" id="{A1DE8E5C-C300-6711-07F0-FC49DF90082C}"/>
              </a:ext>
            </a:extLst>
          </p:cNvPr>
          <p:cNvSpPr/>
          <p:nvPr/>
        </p:nvSpPr>
        <p:spPr>
          <a:xfrm>
            <a:off x="7129250" y="4556158"/>
            <a:ext cx="179388" cy="284162"/>
          </a:xfrm>
          <a:prstGeom prst="star5">
            <a:avLst/>
          </a:prstGeom>
          <a:solidFill>
            <a:srgbClr val="FFFF00"/>
          </a:solidFill>
          <a:ln w="127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 sz="1200" b="1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2" name="星 5 314">
            <a:extLst>
              <a:ext uri="{FF2B5EF4-FFF2-40B4-BE49-F238E27FC236}">
                <a16:creationId xmlns:a16="http://schemas.microsoft.com/office/drawing/2014/main" id="{AB9E7100-1D1A-8637-9DE1-4F8590163BF6}"/>
              </a:ext>
            </a:extLst>
          </p:cNvPr>
          <p:cNvSpPr/>
          <p:nvPr/>
        </p:nvSpPr>
        <p:spPr>
          <a:xfrm>
            <a:off x="6803813" y="4529170"/>
            <a:ext cx="179387" cy="284163"/>
          </a:xfrm>
          <a:prstGeom prst="star5">
            <a:avLst/>
          </a:prstGeom>
          <a:solidFill>
            <a:srgbClr val="FFFF00"/>
          </a:solidFill>
          <a:ln w="127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 sz="1200" b="1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3" name="星 5 315">
            <a:extLst>
              <a:ext uri="{FF2B5EF4-FFF2-40B4-BE49-F238E27FC236}">
                <a16:creationId xmlns:a16="http://schemas.microsoft.com/office/drawing/2014/main" id="{736457FB-E5BD-560E-132B-D1F0071761C2}"/>
              </a:ext>
            </a:extLst>
          </p:cNvPr>
          <p:cNvSpPr/>
          <p:nvPr/>
        </p:nvSpPr>
        <p:spPr>
          <a:xfrm>
            <a:off x="6448213" y="4502183"/>
            <a:ext cx="179387" cy="284162"/>
          </a:xfrm>
          <a:prstGeom prst="star5">
            <a:avLst/>
          </a:prstGeom>
          <a:solidFill>
            <a:srgbClr val="FFFF00"/>
          </a:solidFill>
          <a:ln w="127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 sz="1200" b="1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8EAFDD52-7265-8EE6-7A5A-3BB4BEEE04B1}"/>
              </a:ext>
            </a:extLst>
          </p:cNvPr>
          <p:cNvSpPr txBox="1"/>
          <p:nvPr/>
        </p:nvSpPr>
        <p:spPr>
          <a:xfrm>
            <a:off x="179512" y="188640"/>
            <a:ext cx="24193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/>
              <a:t>Supplementary Figure 4</a:t>
            </a:r>
          </a:p>
        </p:txBody>
      </p:sp>
    </p:spTree>
    <p:extLst>
      <p:ext uri="{BB962C8B-B14F-4D97-AF65-F5344CB8AC3E}">
        <p14:creationId xmlns:p14="http://schemas.microsoft.com/office/powerpoint/2010/main" val="1049779250"/>
      </p:ext>
    </p:extLst>
  </p:cSld>
  <p:clrMapOvr>
    <a:masterClrMapping/>
  </p:clrMapOvr>
  <p:transition spd="slow"/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897B822C-FCD8-A6A6-742A-DE4C8ECC2D1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23728" y="1443224"/>
            <a:ext cx="4691720" cy="471889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" name="Text Box 2">
            <a:extLst>
              <a:ext uri="{FF2B5EF4-FFF2-40B4-BE49-F238E27FC236}">
                <a16:creationId xmlns:a16="http://schemas.microsoft.com/office/drawing/2014/main" id="{CD268165-881D-B7C7-78D1-9D925B0097C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9564" y="6237312"/>
            <a:ext cx="8352928" cy="276963"/>
          </a:xfrm>
          <a:prstGeom prst="rect">
            <a:avLst/>
          </a:prstGeom>
          <a:noFill/>
          <a:ln w="285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square" lIns="91407" tIns="45702" rIns="91407" bIns="45702">
            <a:spAutoFit/>
          </a:bodyPr>
          <a:lstStyle>
            <a:lvl1pPr defTabSz="1082675" eaLnBrk="0" hangingPunct="0">
              <a:defRPr kumimoji="1" sz="21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50" charset="-128"/>
              </a:defRPr>
            </a:lvl1pPr>
            <a:lvl2pPr marL="742950" indent="-285750" defTabSz="1082675" eaLnBrk="0" hangingPunct="0">
              <a:defRPr kumimoji="1" sz="21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50" charset="-128"/>
              </a:defRPr>
            </a:lvl2pPr>
            <a:lvl3pPr marL="1143000" indent="-228600" defTabSz="1082675" eaLnBrk="0" hangingPunct="0">
              <a:defRPr kumimoji="1" sz="21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50" charset="-128"/>
              </a:defRPr>
            </a:lvl3pPr>
            <a:lvl4pPr marL="1600200" indent="-228600" defTabSz="1082675" eaLnBrk="0" hangingPunct="0">
              <a:defRPr kumimoji="1" sz="21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50" charset="-128"/>
              </a:defRPr>
            </a:lvl4pPr>
            <a:lvl5pPr marL="2057400" indent="-228600" defTabSz="1082675" eaLnBrk="0" hangingPunct="0">
              <a:defRPr kumimoji="1" sz="21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50" charset="-128"/>
              </a:defRPr>
            </a:lvl5pPr>
            <a:lvl6pPr marL="2514600" indent="-228600" defTabSz="1082675" eaLnBrk="0" fontAlgn="base" hangingPunct="0">
              <a:spcBef>
                <a:spcPct val="0"/>
              </a:spcBef>
              <a:spcAft>
                <a:spcPct val="0"/>
              </a:spcAft>
              <a:defRPr kumimoji="1" sz="21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50" charset="-128"/>
              </a:defRPr>
            </a:lvl6pPr>
            <a:lvl7pPr marL="2971800" indent="-228600" defTabSz="1082675" eaLnBrk="0" fontAlgn="base" hangingPunct="0">
              <a:spcBef>
                <a:spcPct val="0"/>
              </a:spcBef>
              <a:spcAft>
                <a:spcPct val="0"/>
              </a:spcAft>
              <a:defRPr kumimoji="1" sz="21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50" charset="-128"/>
              </a:defRPr>
            </a:lvl7pPr>
            <a:lvl8pPr marL="3429000" indent="-228600" defTabSz="1082675" eaLnBrk="0" fontAlgn="base" hangingPunct="0">
              <a:spcBef>
                <a:spcPct val="0"/>
              </a:spcBef>
              <a:spcAft>
                <a:spcPct val="0"/>
              </a:spcAft>
              <a:defRPr kumimoji="1" sz="21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50" charset="-128"/>
              </a:defRPr>
            </a:lvl8pPr>
            <a:lvl9pPr marL="3886200" indent="-228600" defTabSz="1082675" eaLnBrk="0" fontAlgn="base" hangingPunct="0">
              <a:spcBef>
                <a:spcPct val="0"/>
              </a:spcBef>
              <a:spcAft>
                <a:spcPct val="0"/>
              </a:spcAft>
              <a:defRPr kumimoji="1" sz="21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50" charset="-128"/>
              </a:defRPr>
            </a:lvl9pPr>
          </a:lstStyle>
          <a:p>
            <a:pPr algn="ctr" eaLnBrk="1" hangingPunct="1">
              <a:spcBef>
                <a:spcPct val="50000"/>
              </a:spcBef>
            </a:pPr>
            <a:r>
              <a:rPr lang="en-US" altLang="ja-JP" sz="1200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anose="020B0604020202020204" pitchFamily="34" charset="0"/>
                <a:ea typeface="HGS創英角ﾎﾟｯﾌﾟ体" panose="040B0A00000000000000" pitchFamily="50" charset="-128"/>
                <a:cs typeface="Arial" panose="020B0604020202020204" pitchFamily="34" charset="0"/>
              </a:rPr>
              <a:t>Anatomical index has the highest AUC (0.7897)</a:t>
            </a: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ECB68D94-1E72-AEBE-0CA9-C3DAA77C0FB6}"/>
              </a:ext>
            </a:extLst>
          </p:cNvPr>
          <p:cNvSpPr txBox="1"/>
          <p:nvPr/>
        </p:nvSpPr>
        <p:spPr>
          <a:xfrm>
            <a:off x="189675" y="205225"/>
            <a:ext cx="23661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/>
              <a:t>Supplementary Figure 5</a:t>
            </a: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BED43B88-539C-9977-294F-1AD94A97DEF0}"/>
              </a:ext>
            </a:extLst>
          </p:cNvPr>
          <p:cNvSpPr txBox="1"/>
          <p:nvPr/>
        </p:nvSpPr>
        <p:spPr>
          <a:xfrm>
            <a:off x="3203848" y="5574432"/>
            <a:ext cx="1080120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cs typeface="Arial" panose="020B0604020202020204" pitchFamily="34" charset="0"/>
              </a:rPr>
              <a:t>AI  AUC: 0.7897</a:t>
            </a:r>
            <a:endParaRPr kumimoji="1" lang="ja-JP" altLang="en-US" sz="900" dirty="0"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38B1B595-F978-A7BD-9D7B-2295388EB062}"/>
              </a:ext>
            </a:extLst>
          </p:cNvPr>
          <p:cNvSpPr txBox="1"/>
          <p:nvPr/>
        </p:nvSpPr>
        <p:spPr>
          <a:xfrm>
            <a:off x="3203848" y="5805264"/>
            <a:ext cx="1080120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cs typeface="Arial" panose="020B0604020202020204" pitchFamily="34" charset="0"/>
              </a:rPr>
              <a:t>AH  AUC: 0.7312</a:t>
            </a:r>
            <a:endParaRPr kumimoji="1" lang="ja-JP" altLang="en-US" sz="900" dirty="0"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9CA01186-E99B-2AC1-6ED2-B169A3C99255}"/>
              </a:ext>
            </a:extLst>
          </p:cNvPr>
          <p:cNvSpPr txBox="1"/>
          <p:nvPr/>
        </p:nvSpPr>
        <p:spPr>
          <a:xfrm>
            <a:off x="4973644" y="5574432"/>
            <a:ext cx="1152128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900" dirty="0">
                <a:cs typeface="Arial" panose="020B0604020202020204" pitchFamily="34" charset="0"/>
              </a:rPr>
              <a:t>PTD</a:t>
            </a:r>
            <a:r>
              <a:rPr kumimoji="1" lang="en-US" altLang="ja-JP" sz="900" dirty="0">
                <a:cs typeface="Arial" panose="020B0604020202020204" pitchFamily="34" charset="0"/>
              </a:rPr>
              <a:t>  AUC: 0.5857</a:t>
            </a:r>
            <a:endParaRPr kumimoji="1" lang="ja-JP" altLang="en-US" sz="900" dirty="0"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7348308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4D1B1726-D9E0-76A3-6CCD-C982135561EF}"/>
              </a:ext>
            </a:extLst>
          </p:cNvPr>
          <p:cNvSpPr txBox="1"/>
          <p:nvPr/>
        </p:nvSpPr>
        <p:spPr>
          <a:xfrm>
            <a:off x="189675" y="205225"/>
            <a:ext cx="23661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/>
              <a:t>Supplementary Figure 6</a:t>
            </a:r>
          </a:p>
        </p:txBody>
      </p:sp>
      <p:graphicFrame>
        <p:nvGraphicFramePr>
          <p:cNvPr id="5" name="グラフ 4">
            <a:extLst>
              <a:ext uri="{FF2B5EF4-FFF2-40B4-BE49-F238E27FC236}">
                <a16:creationId xmlns:a16="http://schemas.microsoft.com/office/drawing/2014/main" id="{3D06DC2B-7A25-FCE1-0ED5-4F9BB86A581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19329182"/>
              </p:ext>
            </p:extLst>
          </p:nvPr>
        </p:nvGraphicFramePr>
        <p:xfrm>
          <a:off x="707457" y="908720"/>
          <a:ext cx="7729086" cy="532758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16CB9F4B-C04B-6CCA-7414-D49F094C6ADB}"/>
              </a:ext>
            </a:extLst>
          </p:cNvPr>
          <p:cNvSpPr txBox="1"/>
          <p:nvPr/>
        </p:nvSpPr>
        <p:spPr>
          <a:xfrm>
            <a:off x="6948264" y="1052736"/>
            <a:ext cx="79208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3 / 4</a:t>
            </a:r>
          </a:p>
          <a:p>
            <a:pPr algn="ctr"/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(75%)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96B0CDAE-B1F2-9BD9-8A08-CF3AE6A29745}"/>
              </a:ext>
            </a:extLst>
          </p:cNvPr>
          <p:cNvSpPr txBox="1"/>
          <p:nvPr/>
        </p:nvSpPr>
        <p:spPr>
          <a:xfrm>
            <a:off x="1747548" y="4653136"/>
            <a:ext cx="75236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0 / 71</a:t>
            </a:r>
            <a:r>
              <a:rPr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(0%)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4085F9D8-1684-8020-60E1-77AD6A304B51}"/>
              </a:ext>
            </a:extLst>
          </p:cNvPr>
          <p:cNvSpPr txBox="1"/>
          <p:nvPr/>
        </p:nvSpPr>
        <p:spPr>
          <a:xfrm>
            <a:off x="3419872" y="4450130"/>
            <a:ext cx="89093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/ 86</a:t>
            </a:r>
          </a:p>
          <a:p>
            <a:pPr algn="ctr"/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(5.8%)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4470B477-6C01-5807-7DD9-37E45C582EE7}"/>
              </a:ext>
            </a:extLst>
          </p:cNvPr>
          <p:cNvSpPr txBox="1"/>
          <p:nvPr/>
        </p:nvSpPr>
        <p:spPr>
          <a:xfrm>
            <a:off x="5076056" y="2937880"/>
            <a:ext cx="99877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/ 41</a:t>
            </a:r>
          </a:p>
          <a:p>
            <a:pPr algn="ctr"/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(36.6%)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0EA8ADF3-BA74-EEE7-2380-F29FD6694E27}"/>
              </a:ext>
            </a:extLst>
          </p:cNvPr>
          <p:cNvSpPr txBox="1"/>
          <p:nvPr/>
        </p:nvSpPr>
        <p:spPr>
          <a:xfrm>
            <a:off x="3491880" y="5851979"/>
            <a:ext cx="2232248" cy="360040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of risk factors</a:t>
            </a:r>
            <a:endParaRPr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55872396"/>
      </p:ext>
    </p:extLst>
  </p:cSld>
  <p:clrMapOvr>
    <a:masterClrMapping/>
  </p:clrMapOvr>
</p:sld>
</file>

<file path=ppt/theme/theme1.xml><?xml version="1.0" encoding="utf-8"?>
<a:theme xmlns:a="http://schemas.openxmlformats.org/drawingml/2006/main" name="2_デザインの設定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3_デザインの設定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デザインの設定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1_デザインの設定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5.xml><?xml version="1.0" encoding="utf-8"?>
<a:theme xmlns:a="http://schemas.openxmlformats.org/drawingml/2006/main" name="Office Theme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6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7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Thatch</Template>
  <TotalTime>19778</TotalTime>
  <Words>226</Words>
  <Application>Microsoft Office PowerPoint</Application>
  <PresentationFormat>画面に合わせる (4:3)</PresentationFormat>
  <Paragraphs>69</Paragraphs>
  <Slides>6</Slides>
  <Notes>5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8</vt:i4>
      </vt:variant>
      <vt:variant>
        <vt:lpstr>テーマ</vt:lpstr>
      </vt:variant>
      <vt:variant>
        <vt:i4>5</vt:i4>
      </vt:variant>
      <vt:variant>
        <vt:lpstr>スライド タイトル</vt:lpstr>
      </vt:variant>
      <vt:variant>
        <vt:i4>6</vt:i4>
      </vt:variant>
    </vt:vector>
  </HeadingPairs>
  <TitlesOfParts>
    <vt:vector size="19" baseType="lpstr">
      <vt:lpstr>ParkAvenue BT</vt:lpstr>
      <vt:lpstr>Arial</vt:lpstr>
      <vt:lpstr>Calibri</vt:lpstr>
      <vt:lpstr>Calibri Light</vt:lpstr>
      <vt:lpstr>Microsoft Uighur</vt:lpstr>
      <vt:lpstr>MV Boli</vt:lpstr>
      <vt:lpstr>Tahoma</vt:lpstr>
      <vt:lpstr>Times New Roman</vt:lpstr>
      <vt:lpstr>2_デザインの設定</vt:lpstr>
      <vt:lpstr>3_デザインの設定</vt:lpstr>
      <vt:lpstr>デザインの設定</vt:lpstr>
      <vt:lpstr>1_デザインの設定</vt:lpstr>
      <vt:lpstr>Office Theme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FJ-USER</dc:creator>
  <cp:lastModifiedBy>髙橋 慶太</cp:lastModifiedBy>
  <cp:revision>1016</cp:revision>
  <cp:lastPrinted>2015-10-05T11:10:17Z</cp:lastPrinted>
  <dcterms:created xsi:type="dcterms:W3CDTF">2013-09-09T23:14:15Z</dcterms:created>
  <dcterms:modified xsi:type="dcterms:W3CDTF">2023-04-14T01:01:39Z</dcterms:modified>
</cp:coreProperties>
</file>